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87" d="100"/>
          <a:sy n="87" d="100"/>
        </p:scale>
        <p:origin x="29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A1F23-E6EA-4BE3-874A-549F58B2711E}" type="datetimeFigureOut">
              <a:rPr lang="ko-KR" altLang="en-US" smtClean="0"/>
              <a:t>2019-03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7CF3-F823-4C1A-9051-BAD3F538E4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0181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A1F23-E6EA-4BE3-874A-549F58B2711E}" type="datetimeFigureOut">
              <a:rPr lang="ko-KR" altLang="en-US" smtClean="0"/>
              <a:t>2019-03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7CF3-F823-4C1A-9051-BAD3F538E4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7352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A1F23-E6EA-4BE3-874A-549F58B2711E}" type="datetimeFigureOut">
              <a:rPr lang="ko-KR" altLang="en-US" smtClean="0"/>
              <a:t>2019-03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7CF3-F823-4C1A-9051-BAD3F538E4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04194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A1F23-E6EA-4BE3-874A-549F58B2711E}" type="datetimeFigureOut">
              <a:rPr lang="ko-KR" altLang="en-US" smtClean="0"/>
              <a:t>2019-03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7CF3-F823-4C1A-9051-BAD3F538E4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1810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A1F23-E6EA-4BE3-874A-549F58B2711E}" type="datetimeFigureOut">
              <a:rPr lang="ko-KR" altLang="en-US" smtClean="0"/>
              <a:t>2019-03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7CF3-F823-4C1A-9051-BAD3F538E4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4330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A1F23-E6EA-4BE3-874A-549F58B2711E}" type="datetimeFigureOut">
              <a:rPr lang="ko-KR" altLang="en-US" smtClean="0"/>
              <a:t>2019-03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7CF3-F823-4C1A-9051-BAD3F538E4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81288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A1F23-E6EA-4BE3-874A-549F58B2711E}" type="datetimeFigureOut">
              <a:rPr lang="ko-KR" altLang="en-US" smtClean="0"/>
              <a:t>2019-03-1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7CF3-F823-4C1A-9051-BAD3F538E4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21610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A1F23-E6EA-4BE3-874A-549F58B2711E}" type="datetimeFigureOut">
              <a:rPr lang="ko-KR" altLang="en-US" smtClean="0"/>
              <a:t>2019-03-1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7CF3-F823-4C1A-9051-BAD3F538E4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68769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A1F23-E6EA-4BE3-874A-549F58B2711E}" type="datetimeFigureOut">
              <a:rPr lang="ko-KR" altLang="en-US" smtClean="0"/>
              <a:t>2019-03-1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7CF3-F823-4C1A-9051-BAD3F538E4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35840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A1F23-E6EA-4BE3-874A-549F58B2711E}" type="datetimeFigureOut">
              <a:rPr lang="ko-KR" altLang="en-US" smtClean="0"/>
              <a:t>2019-03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7CF3-F823-4C1A-9051-BAD3F538E4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63885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A1F23-E6EA-4BE3-874A-549F58B2711E}" type="datetimeFigureOut">
              <a:rPr lang="ko-KR" altLang="en-US" smtClean="0"/>
              <a:t>2019-03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47CF3-F823-4C1A-9051-BAD3F538E4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70637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DA1F23-E6EA-4BE3-874A-549F58B2711E}" type="datetimeFigureOut">
              <a:rPr lang="ko-KR" altLang="en-US" smtClean="0"/>
              <a:t>2019-03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F47CF3-F823-4C1A-9051-BAD3F538E4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4402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6" name="내용 개체 틀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53314" y="330745"/>
            <a:ext cx="4245702" cy="239569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211607" y="3162102"/>
            <a:ext cx="1799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MS1 Spectrum</a:t>
            </a:r>
            <a:endParaRPr lang="ko-KR" alt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8523656" y="609165"/>
            <a:ext cx="2120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MS/MS Spectrum</a:t>
            </a:r>
            <a:endParaRPr lang="ko-KR" altLang="en-US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54820" y="6525919"/>
            <a:ext cx="9688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Peptide </a:t>
            </a:r>
            <a:r>
              <a:rPr lang="en-US" altLang="ko-KR" b="1" dirty="0" smtClean="0"/>
              <a:t>identification and quantification by </a:t>
            </a:r>
            <a:r>
              <a:rPr lang="en-US" altLang="ko-KR" b="1" dirty="0" err="1" smtClean="0"/>
              <a:t>MaxQuant</a:t>
            </a:r>
            <a:r>
              <a:rPr lang="en-US" altLang="ko-KR" b="1" dirty="0"/>
              <a:t> </a:t>
            </a:r>
            <a:r>
              <a:rPr lang="en-US" altLang="ko-KR" b="1" dirty="0" smtClean="0"/>
              <a:t>: SQVTEDDLLQTVSR spectrum </a:t>
            </a:r>
            <a:endParaRPr lang="ko-KR" altLang="en-US" b="1" dirty="0"/>
          </a:p>
        </p:txBody>
      </p:sp>
      <p:pic>
        <p:nvPicPr>
          <p:cNvPr id="23" name="그림 22"/>
          <p:cNvPicPr>
            <a:picLocks noChangeAspect="1"/>
          </p:cNvPicPr>
          <p:nvPr/>
        </p:nvPicPr>
        <p:blipFill rotWithShape="1">
          <a:blip r:embed="rId3"/>
          <a:srcRect r="535"/>
          <a:stretch/>
        </p:blipFill>
        <p:spPr>
          <a:xfrm>
            <a:off x="6288667" y="3893882"/>
            <a:ext cx="5291374" cy="2564795"/>
          </a:xfrm>
          <a:prstGeom prst="rect">
            <a:avLst/>
          </a:prstGeom>
        </p:spPr>
      </p:pic>
      <p:pic>
        <p:nvPicPr>
          <p:cNvPr id="25" name="그림 2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89319" y="3968764"/>
            <a:ext cx="3513670" cy="453881"/>
          </a:xfrm>
          <a:prstGeom prst="rect">
            <a:avLst/>
          </a:prstGeom>
        </p:spPr>
      </p:pic>
      <p:grpSp>
        <p:nvGrpSpPr>
          <p:cNvPr id="338" name="그룹 337"/>
          <p:cNvGrpSpPr/>
          <p:nvPr/>
        </p:nvGrpSpPr>
        <p:grpSpPr>
          <a:xfrm>
            <a:off x="828356" y="409414"/>
            <a:ext cx="3884553" cy="2063070"/>
            <a:chOff x="862013" y="620713"/>
            <a:chExt cx="4649787" cy="2624138"/>
          </a:xfrm>
        </p:grpSpPr>
        <p:sp>
          <p:nvSpPr>
            <p:cNvPr id="30" name="AutoShape 3"/>
            <p:cNvSpPr>
              <a:spLocks noChangeAspect="1" noChangeArrowheads="1" noTextEdit="1"/>
            </p:cNvSpPr>
            <p:nvPr/>
          </p:nvSpPr>
          <p:spPr bwMode="auto">
            <a:xfrm>
              <a:off x="862013" y="620713"/>
              <a:ext cx="4649787" cy="26241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grpSp>
          <p:nvGrpSpPr>
            <p:cNvPr id="31" name="Group 205"/>
            <p:cNvGrpSpPr>
              <a:grpSpLocks/>
            </p:cNvGrpSpPr>
            <p:nvPr/>
          </p:nvGrpSpPr>
          <p:grpSpPr bwMode="auto">
            <a:xfrm>
              <a:off x="933451" y="784226"/>
              <a:ext cx="4330700" cy="2460625"/>
              <a:chOff x="588" y="494"/>
              <a:chExt cx="2728" cy="1550"/>
            </a:xfrm>
          </p:grpSpPr>
          <p:sp>
            <p:nvSpPr>
              <p:cNvPr id="140" name="Line 7"/>
              <p:cNvSpPr>
                <a:spLocks noChangeShapeType="1"/>
              </p:cNvSpPr>
              <p:nvPr/>
            </p:nvSpPr>
            <p:spPr bwMode="auto">
              <a:xfrm>
                <a:off x="657" y="1943"/>
                <a:ext cx="265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41" name="Line 8"/>
              <p:cNvSpPr>
                <a:spLocks noChangeShapeType="1"/>
              </p:cNvSpPr>
              <p:nvPr/>
            </p:nvSpPr>
            <p:spPr bwMode="auto">
              <a:xfrm>
                <a:off x="684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42" name="Line 9"/>
              <p:cNvSpPr>
                <a:spLocks noChangeShapeType="1"/>
              </p:cNvSpPr>
              <p:nvPr/>
            </p:nvSpPr>
            <p:spPr bwMode="auto">
              <a:xfrm>
                <a:off x="751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43" name="Line 10"/>
              <p:cNvSpPr>
                <a:spLocks noChangeShapeType="1"/>
              </p:cNvSpPr>
              <p:nvPr/>
            </p:nvSpPr>
            <p:spPr bwMode="auto">
              <a:xfrm>
                <a:off x="784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44" name="Line 11"/>
              <p:cNvSpPr>
                <a:spLocks noChangeShapeType="1"/>
              </p:cNvSpPr>
              <p:nvPr/>
            </p:nvSpPr>
            <p:spPr bwMode="auto">
              <a:xfrm>
                <a:off x="818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45" name="Line 12"/>
              <p:cNvSpPr>
                <a:spLocks noChangeShapeType="1"/>
              </p:cNvSpPr>
              <p:nvPr/>
            </p:nvSpPr>
            <p:spPr bwMode="auto">
              <a:xfrm>
                <a:off x="883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46" name="Line 13"/>
              <p:cNvSpPr>
                <a:spLocks noChangeShapeType="1"/>
              </p:cNvSpPr>
              <p:nvPr/>
            </p:nvSpPr>
            <p:spPr bwMode="auto">
              <a:xfrm>
                <a:off x="918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47" name="Line 14"/>
              <p:cNvSpPr>
                <a:spLocks noChangeShapeType="1"/>
              </p:cNvSpPr>
              <p:nvPr/>
            </p:nvSpPr>
            <p:spPr bwMode="auto">
              <a:xfrm>
                <a:off x="950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48" name="Line 15"/>
              <p:cNvSpPr>
                <a:spLocks noChangeShapeType="1"/>
              </p:cNvSpPr>
              <p:nvPr/>
            </p:nvSpPr>
            <p:spPr bwMode="auto">
              <a:xfrm>
                <a:off x="1017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49" name="Line 16"/>
              <p:cNvSpPr>
                <a:spLocks noChangeShapeType="1"/>
              </p:cNvSpPr>
              <p:nvPr/>
            </p:nvSpPr>
            <p:spPr bwMode="auto">
              <a:xfrm>
                <a:off x="1050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50" name="Line 17"/>
              <p:cNvSpPr>
                <a:spLocks noChangeShapeType="1"/>
              </p:cNvSpPr>
              <p:nvPr/>
            </p:nvSpPr>
            <p:spPr bwMode="auto">
              <a:xfrm>
                <a:off x="1084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51" name="Line 18"/>
              <p:cNvSpPr>
                <a:spLocks noChangeShapeType="1"/>
              </p:cNvSpPr>
              <p:nvPr/>
            </p:nvSpPr>
            <p:spPr bwMode="auto">
              <a:xfrm>
                <a:off x="1151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52" name="Line 19"/>
              <p:cNvSpPr>
                <a:spLocks noChangeShapeType="1"/>
              </p:cNvSpPr>
              <p:nvPr/>
            </p:nvSpPr>
            <p:spPr bwMode="auto">
              <a:xfrm>
                <a:off x="1184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53" name="Line 20"/>
              <p:cNvSpPr>
                <a:spLocks noChangeShapeType="1"/>
              </p:cNvSpPr>
              <p:nvPr/>
            </p:nvSpPr>
            <p:spPr bwMode="auto">
              <a:xfrm>
                <a:off x="1216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54" name="Line 21"/>
              <p:cNvSpPr>
                <a:spLocks noChangeShapeType="1"/>
              </p:cNvSpPr>
              <p:nvPr/>
            </p:nvSpPr>
            <p:spPr bwMode="auto">
              <a:xfrm>
                <a:off x="1283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55" name="Line 22"/>
              <p:cNvSpPr>
                <a:spLocks noChangeShapeType="1"/>
              </p:cNvSpPr>
              <p:nvPr/>
            </p:nvSpPr>
            <p:spPr bwMode="auto">
              <a:xfrm>
                <a:off x="1318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56" name="Line 23"/>
              <p:cNvSpPr>
                <a:spLocks noChangeShapeType="1"/>
              </p:cNvSpPr>
              <p:nvPr/>
            </p:nvSpPr>
            <p:spPr bwMode="auto">
              <a:xfrm>
                <a:off x="1350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57" name="Line 24"/>
              <p:cNvSpPr>
                <a:spLocks noChangeShapeType="1"/>
              </p:cNvSpPr>
              <p:nvPr/>
            </p:nvSpPr>
            <p:spPr bwMode="auto">
              <a:xfrm>
                <a:off x="1417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58" name="Line 25"/>
              <p:cNvSpPr>
                <a:spLocks noChangeShapeType="1"/>
              </p:cNvSpPr>
              <p:nvPr/>
            </p:nvSpPr>
            <p:spPr bwMode="auto">
              <a:xfrm>
                <a:off x="1450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59" name="Line 26"/>
              <p:cNvSpPr>
                <a:spLocks noChangeShapeType="1"/>
              </p:cNvSpPr>
              <p:nvPr/>
            </p:nvSpPr>
            <p:spPr bwMode="auto">
              <a:xfrm>
                <a:off x="1484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60" name="Line 27"/>
              <p:cNvSpPr>
                <a:spLocks noChangeShapeType="1"/>
              </p:cNvSpPr>
              <p:nvPr/>
            </p:nvSpPr>
            <p:spPr bwMode="auto">
              <a:xfrm>
                <a:off x="1550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61" name="Line 28"/>
              <p:cNvSpPr>
                <a:spLocks noChangeShapeType="1"/>
              </p:cNvSpPr>
              <p:nvPr/>
            </p:nvSpPr>
            <p:spPr bwMode="auto">
              <a:xfrm>
                <a:off x="1584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62" name="Line 29"/>
              <p:cNvSpPr>
                <a:spLocks noChangeShapeType="1"/>
              </p:cNvSpPr>
              <p:nvPr/>
            </p:nvSpPr>
            <p:spPr bwMode="auto">
              <a:xfrm>
                <a:off x="1617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63" name="Line 30"/>
              <p:cNvSpPr>
                <a:spLocks noChangeShapeType="1"/>
              </p:cNvSpPr>
              <p:nvPr/>
            </p:nvSpPr>
            <p:spPr bwMode="auto">
              <a:xfrm>
                <a:off x="1683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64" name="Line 31"/>
              <p:cNvSpPr>
                <a:spLocks noChangeShapeType="1"/>
              </p:cNvSpPr>
              <p:nvPr/>
            </p:nvSpPr>
            <p:spPr bwMode="auto">
              <a:xfrm>
                <a:off x="1716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65" name="Line 32"/>
              <p:cNvSpPr>
                <a:spLocks noChangeShapeType="1"/>
              </p:cNvSpPr>
              <p:nvPr/>
            </p:nvSpPr>
            <p:spPr bwMode="auto">
              <a:xfrm>
                <a:off x="1750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66" name="Line 33"/>
              <p:cNvSpPr>
                <a:spLocks noChangeShapeType="1"/>
              </p:cNvSpPr>
              <p:nvPr/>
            </p:nvSpPr>
            <p:spPr bwMode="auto">
              <a:xfrm>
                <a:off x="1817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67" name="Line 34"/>
              <p:cNvSpPr>
                <a:spLocks noChangeShapeType="1"/>
              </p:cNvSpPr>
              <p:nvPr/>
            </p:nvSpPr>
            <p:spPr bwMode="auto">
              <a:xfrm>
                <a:off x="1850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68" name="Line 35"/>
              <p:cNvSpPr>
                <a:spLocks noChangeShapeType="1"/>
              </p:cNvSpPr>
              <p:nvPr/>
            </p:nvSpPr>
            <p:spPr bwMode="auto">
              <a:xfrm>
                <a:off x="1883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69" name="Line 36"/>
              <p:cNvSpPr>
                <a:spLocks noChangeShapeType="1"/>
              </p:cNvSpPr>
              <p:nvPr/>
            </p:nvSpPr>
            <p:spPr bwMode="auto">
              <a:xfrm>
                <a:off x="1950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0" name="Line 37"/>
              <p:cNvSpPr>
                <a:spLocks noChangeShapeType="1"/>
              </p:cNvSpPr>
              <p:nvPr/>
            </p:nvSpPr>
            <p:spPr bwMode="auto">
              <a:xfrm>
                <a:off x="1982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1" name="Line 38"/>
              <p:cNvSpPr>
                <a:spLocks noChangeShapeType="1"/>
              </p:cNvSpPr>
              <p:nvPr/>
            </p:nvSpPr>
            <p:spPr bwMode="auto">
              <a:xfrm>
                <a:off x="2017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2" name="Line 39"/>
              <p:cNvSpPr>
                <a:spLocks noChangeShapeType="1"/>
              </p:cNvSpPr>
              <p:nvPr/>
            </p:nvSpPr>
            <p:spPr bwMode="auto">
              <a:xfrm>
                <a:off x="2084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3" name="Line 40"/>
              <p:cNvSpPr>
                <a:spLocks noChangeShapeType="1"/>
              </p:cNvSpPr>
              <p:nvPr/>
            </p:nvSpPr>
            <p:spPr bwMode="auto">
              <a:xfrm>
                <a:off x="2116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" name="Line 41"/>
              <p:cNvSpPr>
                <a:spLocks noChangeShapeType="1"/>
              </p:cNvSpPr>
              <p:nvPr/>
            </p:nvSpPr>
            <p:spPr bwMode="auto">
              <a:xfrm>
                <a:off x="2149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5" name="Line 42"/>
              <p:cNvSpPr>
                <a:spLocks noChangeShapeType="1"/>
              </p:cNvSpPr>
              <p:nvPr/>
            </p:nvSpPr>
            <p:spPr bwMode="auto">
              <a:xfrm>
                <a:off x="2216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6" name="Line 43"/>
              <p:cNvSpPr>
                <a:spLocks noChangeShapeType="1"/>
              </p:cNvSpPr>
              <p:nvPr/>
            </p:nvSpPr>
            <p:spPr bwMode="auto">
              <a:xfrm>
                <a:off x="2250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7" name="Line 44"/>
              <p:cNvSpPr>
                <a:spLocks noChangeShapeType="1"/>
              </p:cNvSpPr>
              <p:nvPr/>
            </p:nvSpPr>
            <p:spPr bwMode="auto">
              <a:xfrm>
                <a:off x="2283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8" name="Line 45"/>
              <p:cNvSpPr>
                <a:spLocks noChangeShapeType="1"/>
              </p:cNvSpPr>
              <p:nvPr/>
            </p:nvSpPr>
            <p:spPr bwMode="auto">
              <a:xfrm>
                <a:off x="2350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9" name="Line 46"/>
              <p:cNvSpPr>
                <a:spLocks noChangeShapeType="1"/>
              </p:cNvSpPr>
              <p:nvPr/>
            </p:nvSpPr>
            <p:spPr bwMode="auto">
              <a:xfrm>
                <a:off x="2382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0" name="Line 47"/>
              <p:cNvSpPr>
                <a:spLocks noChangeShapeType="1"/>
              </p:cNvSpPr>
              <p:nvPr/>
            </p:nvSpPr>
            <p:spPr bwMode="auto">
              <a:xfrm>
                <a:off x="2417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1" name="Line 48"/>
              <p:cNvSpPr>
                <a:spLocks noChangeShapeType="1"/>
              </p:cNvSpPr>
              <p:nvPr/>
            </p:nvSpPr>
            <p:spPr bwMode="auto">
              <a:xfrm>
                <a:off x="2482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2" name="Line 49"/>
              <p:cNvSpPr>
                <a:spLocks noChangeShapeType="1"/>
              </p:cNvSpPr>
              <p:nvPr/>
            </p:nvSpPr>
            <p:spPr bwMode="auto">
              <a:xfrm>
                <a:off x="2516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3" name="Line 50"/>
              <p:cNvSpPr>
                <a:spLocks noChangeShapeType="1"/>
              </p:cNvSpPr>
              <p:nvPr/>
            </p:nvSpPr>
            <p:spPr bwMode="auto">
              <a:xfrm>
                <a:off x="2549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4" name="Line 51"/>
              <p:cNvSpPr>
                <a:spLocks noChangeShapeType="1"/>
              </p:cNvSpPr>
              <p:nvPr/>
            </p:nvSpPr>
            <p:spPr bwMode="auto">
              <a:xfrm>
                <a:off x="2616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5" name="Line 52"/>
              <p:cNvSpPr>
                <a:spLocks noChangeShapeType="1"/>
              </p:cNvSpPr>
              <p:nvPr/>
            </p:nvSpPr>
            <p:spPr bwMode="auto">
              <a:xfrm>
                <a:off x="2648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6" name="Line 53"/>
              <p:cNvSpPr>
                <a:spLocks noChangeShapeType="1"/>
              </p:cNvSpPr>
              <p:nvPr/>
            </p:nvSpPr>
            <p:spPr bwMode="auto">
              <a:xfrm>
                <a:off x="2683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7" name="Line 54"/>
              <p:cNvSpPr>
                <a:spLocks noChangeShapeType="1"/>
              </p:cNvSpPr>
              <p:nvPr/>
            </p:nvSpPr>
            <p:spPr bwMode="auto">
              <a:xfrm>
                <a:off x="2750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8" name="Line 55"/>
              <p:cNvSpPr>
                <a:spLocks noChangeShapeType="1"/>
              </p:cNvSpPr>
              <p:nvPr/>
            </p:nvSpPr>
            <p:spPr bwMode="auto">
              <a:xfrm>
                <a:off x="2782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9" name="Line 56"/>
              <p:cNvSpPr>
                <a:spLocks noChangeShapeType="1"/>
              </p:cNvSpPr>
              <p:nvPr/>
            </p:nvSpPr>
            <p:spPr bwMode="auto">
              <a:xfrm>
                <a:off x="2815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90" name="Line 57"/>
              <p:cNvSpPr>
                <a:spLocks noChangeShapeType="1"/>
              </p:cNvSpPr>
              <p:nvPr/>
            </p:nvSpPr>
            <p:spPr bwMode="auto">
              <a:xfrm>
                <a:off x="2882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91" name="Line 58"/>
              <p:cNvSpPr>
                <a:spLocks noChangeShapeType="1"/>
              </p:cNvSpPr>
              <p:nvPr/>
            </p:nvSpPr>
            <p:spPr bwMode="auto">
              <a:xfrm>
                <a:off x="2916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92" name="Line 59"/>
              <p:cNvSpPr>
                <a:spLocks noChangeShapeType="1"/>
              </p:cNvSpPr>
              <p:nvPr/>
            </p:nvSpPr>
            <p:spPr bwMode="auto">
              <a:xfrm>
                <a:off x="2949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93" name="Line 60"/>
              <p:cNvSpPr>
                <a:spLocks noChangeShapeType="1"/>
              </p:cNvSpPr>
              <p:nvPr/>
            </p:nvSpPr>
            <p:spPr bwMode="auto">
              <a:xfrm>
                <a:off x="3016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94" name="Line 61"/>
              <p:cNvSpPr>
                <a:spLocks noChangeShapeType="1"/>
              </p:cNvSpPr>
              <p:nvPr/>
            </p:nvSpPr>
            <p:spPr bwMode="auto">
              <a:xfrm>
                <a:off x="3048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95" name="Line 62"/>
              <p:cNvSpPr>
                <a:spLocks noChangeShapeType="1"/>
              </p:cNvSpPr>
              <p:nvPr/>
            </p:nvSpPr>
            <p:spPr bwMode="auto">
              <a:xfrm>
                <a:off x="3083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96" name="Line 63"/>
              <p:cNvSpPr>
                <a:spLocks noChangeShapeType="1"/>
              </p:cNvSpPr>
              <p:nvPr/>
            </p:nvSpPr>
            <p:spPr bwMode="auto">
              <a:xfrm>
                <a:off x="3148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97" name="Line 64"/>
              <p:cNvSpPr>
                <a:spLocks noChangeShapeType="1"/>
              </p:cNvSpPr>
              <p:nvPr/>
            </p:nvSpPr>
            <p:spPr bwMode="auto">
              <a:xfrm>
                <a:off x="3182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98" name="Line 65"/>
              <p:cNvSpPr>
                <a:spLocks noChangeShapeType="1"/>
              </p:cNvSpPr>
              <p:nvPr/>
            </p:nvSpPr>
            <p:spPr bwMode="auto">
              <a:xfrm>
                <a:off x="3215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99" name="Line 66"/>
              <p:cNvSpPr>
                <a:spLocks noChangeShapeType="1"/>
              </p:cNvSpPr>
              <p:nvPr/>
            </p:nvSpPr>
            <p:spPr bwMode="auto">
              <a:xfrm>
                <a:off x="3282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00" name="Line 67"/>
              <p:cNvSpPr>
                <a:spLocks noChangeShapeType="1"/>
              </p:cNvSpPr>
              <p:nvPr/>
            </p:nvSpPr>
            <p:spPr bwMode="auto">
              <a:xfrm>
                <a:off x="3315" y="1943"/>
                <a:ext cx="0" cy="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01" name="Line 68"/>
              <p:cNvSpPr>
                <a:spLocks noChangeShapeType="1"/>
              </p:cNvSpPr>
              <p:nvPr/>
            </p:nvSpPr>
            <p:spPr bwMode="auto">
              <a:xfrm>
                <a:off x="717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02" name="Rectangle 69"/>
              <p:cNvSpPr>
                <a:spLocks noChangeArrowheads="1"/>
              </p:cNvSpPr>
              <p:nvPr/>
            </p:nvSpPr>
            <p:spPr bwMode="auto">
              <a:xfrm>
                <a:off x="692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6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3" name="Line 70"/>
              <p:cNvSpPr>
                <a:spLocks noChangeShapeType="1"/>
              </p:cNvSpPr>
              <p:nvPr/>
            </p:nvSpPr>
            <p:spPr bwMode="auto">
              <a:xfrm>
                <a:off x="851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04" name="Rectangle 71"/>
              <p:cNvSpPr>
                <a:spLocks noChangeArrowheads="1"/>
              </p:cNvSpPr>
              <p:nvPr/>
            </p:nvSpPr>
            <p:spPr bwMode="auto">
              <a:xfrm>
                <a:off x="826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8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5" name="Line 72"/>
              <p:cNvSpPr>
                <a:spLocks noChangeShapeType="1"/>
              </p:cNvSpPr>
              <p:nvPr/>
            </p:nvSpPr>
            <p:spPr bwMode="auto">
              <a:xfrm>
                <a:off x="985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06" name="Rectangle 73"/>
              <p:cNvSpPr>
                <a:spLocks noChangeArrowheads="1"/>
              </p:cNvSpPr>
              <p:nvPr/>
            </p:nvSpPr>
            <p:spPr bwMode="auto">
              <a:xfrm>
                <a:off x="960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7" name="Line 74"/>
              <p:cNvSpPr>
                <a:spLocks noChangeShapeType="1"/>
              </p:cNvSpPr>
              <p:nvPr/>
            </p:nvSpPr>
            <p:spPr bwMode="auto">
              <a:xfrm>
                <a:off x="1117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08" name="Rectangle 75"/>
              <p:cNvSpPr>
                <a:spLocks noChangeArrowheads="1"/>
              </p:cNvSpPr>
              <p:nvPr/>
            </p:nvSpPr>
            <p:spPr bwMode="auto">
              <a:xfrm>
                <a:off x="1092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2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9" name="Line 76"/>
              <p:cNvSpPr>
                <a:spLocks noChangeShapeType="1"/>
              </p:cNvSpPr>
              <p:nvPr/>
            </p:nvSpPr>
            <p:spPr bwMode="auto">
              <a:xfrm>
                <a:off x="1251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0" name="Rectangle 77"/>
              <p:cNvSpPr>
                <a:spLocks noChangeArrowheads="1"/>
              </p:cNvSpPr>
              <p:nvPr/>
            </p:nvSpPr>
            <p:spPr bwMode="auto">
              <a:xfrm>
                <a:off x="1226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4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1" name="Line 78"/>
              <p:cNvSpPr>
                <a:spLocks noChangeShapeType="1"/>
              </p:cNvSpPr>
              <p:nvPr/>
            </p:nvSpPr>
            <p:spPr bwMode="auto">
              <a:xfrm>
                <a:off x="1383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2" name="Rectangle 79"/>
              <p:cNvSpPr>
                <a:spLocks noChangeArrowheads="1"/>
              </p:cNvSpPr>
              <p:nvPr/>
            </p:nvSpPr>
            <p:spPr bwMode="auto">
              <a:xfrm>
                <a:off x="1358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6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3" name="Line 80"/>
              <p:cNvSpPr>
                <a:spLocks noChangeShapeType="1"/>
              </p:cNvSpPr>
              <p:nvPr/>
            </p:nvSpPr>
            <p:spPr bwMode="auto">
              <a:xfrm>
                <a:off x="1517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4" name="Rectangle 81"/>
              <p:cNvSpPr>
                <a:spLocks noChangeArrowheads="1"/>
              </p:cNvSpPr>
              <p:nvPr/>
            </p:nvSpPr>
            <p:spPr bwMode="auto">
              <a:xfrm>
                <a:off x="1492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8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5" name="Line 82"/>
              <p:cNvSpPr>
                <a:spLocks noChangeShapeType="1"/>
              </p:cNvSpPr>
              <p:nvPr/>
            </p:nvSpPr>
            <p:spPr bwMode="auto">
              <a:xfrm>
                <a:off x="1651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6" name="Rectangle 83"/>
              <p:cNvSpPr>
                <a:spLocks noChangeArrowheads="1"/>
              </p:cNvSpPr>
              <p:nvPr/>
            </p:nvSpPr>
            <p:spPr bwMode="auto">
              <a:xfrm>
                <a:off x="1626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7" name="Line 84"/>
              <p:cNvSpPr>
                <a:spLocks noChangeShapeType="1"/>
              </p:cNvSpPr>
              <p:nvPr/>
            </p:nvSpPr>
            <p:spPr bwMode="auto">
              <a:xfrm>
                <a:off x="1783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8" name="Rectangle 85"/>
              <p:cNvSpPr>
                <a:spLocks noChangeArrowheads="1"/>
              </p:cNvSpPr>
              <p:nvPr/>
            </p:nvSpPr>
            <p:spPr bwMode="auto">
              <a:xfrm>
                <a:off x="1758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2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9" name="Line 86"/>
              <p:cNvSpPr>
                <a:spLocks noChangeShapeType="1"/>
              </p:cNvSpPr>
              <p:nvPr/>
            </p:nvSpPr>
            <p:spPr bwMode="auto">
              <a:xfrm>
                <a:off x="1917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0" name="Rectangle 87"/>
              <p:cNvSpPr>
                <a:spLocks noChangeArrowheads="1"/>
              </p:cNvSpPr>
              <p:nvPr/>
            </p:nvSpPr>
            <p:spPr bwMode="auto">
              <a:xfrm>
                <a:off x="1892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4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1" name="Line 88"/>
              <p:cNvSpPr>
                <a:spLocks noChangeShapeType="1"/>
              </p:cNvSpPr>
              <p:nvPr/>
            </p:nvSpPr>
            <p:spPr bwMode="auto">
              <a:xfrm>
                <a:off x="2049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2" name="Rectangle 89"/>
              <p:cNvSpPr>
                <a:spLocks noChangeArrowheads="1"/>
              </p:cNvSpPr>
              <p:nvPr/>
            </p:nvSpPr>
            <p:spPr bwMode="auto">
              <a:xfrm>
                <a:off x="2024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6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3" name="Line 90"/>
              <p:cNvSpPr>
                <a:spLocks noChangeShapeType="1"/>
              </p:cNvSpPr>
              <p:nvPr/>
            </p:nvSpPr>
            <p:spPr bwMode="auto">
              <a:xfrm>
                <a:off x="2183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4" name="Rectangle 91"/>
              <p:cNvSpPr>
                <a:spLocks noChangeArrowheads="1"/>
              </p:cNvSpPr>
              <p:nvPr/>
            </p:nvSpPr>
            <p:spPr bwMode="auto">
              <a:xfrm>
                <a:off x="2158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8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5" name="Line 92"/>
              <p:cNvSpPr>
                <a:spLocks noChangeShapeType="1"/>
              </p:cNvSpPr>
              <p:nvPr/>
            </p:nvSpPr>
            <p:spPr bwMode="auto">
              <a:xfrm>
                <a:off x="2315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6" name="Rectangle 93"/>
              <p:cNvSpPr>
                <a:spLocks noChangeArrowheads="1"/>
              </p:cNvSpPr>
              <p:nvPr/>
            </p:nvSpPr>
            <p:spPr bwMode="auto">
              <a:xfrm>
                <a:off x="2290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7" name="Line 94"/>
              <p:cNvSpPr>
                <a:spLocks noChangeShapeType="1"/>
              </p:cNvSpPr>
              <p:nvPr/>
            </p:nvSpPr>
            <p:spPr bwMode="auto">
              <a:xfrm>
                <a:off x="2449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8" name="Rectangle 95"/>
              <p:cNvSpPr>
                <a:spLocks noChangeArrowheads="1"/>
              </p:cNvSpPr>
              <p:nvPr/>
            </p:nvSpPr>
            <p:spPr bwMode="auto">
              <a:xfrm>
                <a:off x="2424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2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9" name="Line 96"/>
              <p:cNvSpPr>
                <a:spLocks noChangeShapeType="1"/>
              </p:cNvSpPr>
              <p:nvPr/>
            </p:nvSpPr>
            <p:spPr bwMode="auto">
              <a:xfrm>
                <a:off x="2583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0" name="Rectangle 97"/>
              <p:cNvSpPr>
                <a:spLocks noChangeArrowheads="1"/>
              </p:cNvSpPr>
              <p:nvPr/>
            </p:nvSpPr>
            <p:spPr bwMode="auto">
              <a:xfrm>
                <a:off x="2558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4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1" name="Line 98"/>
              <p:cNvSpPr>
                <a:spLocks noChangeShapeType="1"/>
              </p:cNvSpPr>
              <p:nvPr/>
            </p:nvSpPr>
            <p:spPr bwMode="auto">
              <a:xfrm>
                <a:off x="2715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2" name="Rectangle 99"/>
              <p:cNvSpPr>
                <a:spLocks noChangeArrowheads="1"/>
              </p:cNvSpPr>
              <p:nvPr/>
            </p:nvSpPr>
            <p:spPr bwMode="auto">
              <a:xfrm>
                <a:off x="2690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6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3" name="Line 100"/>
              <p:cNvSpPr>
                <a:spLocks noChangeShapeType="1"/>
              </p:cNvSpPr>
              <p:nvPr/>
            </p:nvSpPr>
            <p:spPr bwMode="auto">
              <a:xfrm>
                <a:off x="2849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4" name="Rectangle 101"/>
              <p:cNvSpPr>
                <a:spLocks noChangeArrowheads="1"/>
              </p:cNvSpPr>
              <p:nvPr/>
            </p:nvSpPr>
            <p:spPr bwMode="auto">
              <a:xfrm>
                <a:off x="2824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8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5" name="Line 102"/>
              <p:cNvSpPr>
                <a:spLocks noChangeShapeType="1"/>
              </p:cNvSpPr>
              <p:nvPr/>
            </p:nvSpPr>
            <p:spPr bwMode="auto">
              <a:xfrm>
                <a:off x="2981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6" name="Rectangle 103"/>
              <p:cNvSpPr>
                <a:spLocks noChangeArrowheads="1"/>
              </p:cNvSpPr>
              <p:nvPr/>
            </p:nvSpPr>
            <p:spPr bwMode="auto">
              <a:xfrm>
                <a:off x="2956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7" name="Line 104"/>
              <p:cNvSpPr>
                <a:spLocks noChangeShapeType="1"/>
              </p:cNvSpPr>
              <p:nvPr/>
            </p:nvSpPr>
            <p:spPr bwMode="auto">
              <a:xfrm>
                <a:off x="3115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8" name="Rectangle 105"/>
              <p:cNvSpPr>
                <a:spLocks noChangeArrowheads="1"/>
              </p:cNvSpPr>
              <p:nvPr/>
            </p:nvSpPr>
            <p:spPr bwMode="auto">
              <a:xfrm>
                <a:off x="3090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2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9" name="Line 106"/>
              <p:cNvSpPr>
                <a:spLocks noChangeShapeType="1"/>
              </p:cNvSpPr>
              <p:nvPr/>
            </p:nvSpPr>
            <p:spPr bwMode="auto">
              <a:xfrm>
                <a:off x="3249" y="1943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40" name="Rectangle 107"/>
              <p:cNvSpPr>
                <a:spLocks noChangeArrowheads="1"/>
              </p:cNvSpPr>
              <p:nvPr/>
            </p:nvSpPr>
            <p:spPr bwMode="auto">
              <a:xfrm>
                <a:off x="3224" y="1961"/>
                <a:ext cx="5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4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1" name="Rectangle 108"/>
              <p:cNvSpPr>
                <a:spLocks noChangeArrowheads="1"/>
              </p:cNvSpPr>
              <p:nvPr/>
            </p:nvSpPr>
            <p:spPr bwMode="auto">
              <a:xfrm>
                <a:off x="1901" y="1999"/>
                <a:ext cx="170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Time (min)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2" name="Line 109"/>
              <p:cNvSpPr>
                <a:spLocks noChangeShapeType="1"/>
              </p:cNvSpPr>
              <p:nvPr/>
            </p:nvSpPr>
            <p:spPr bwMode="auto">
              <a:xfrm flipV="1">
                <a:off x="657" y="494"/>
                <a:ext cx="0" cy="144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43" name="Line 110"/>
              <p:cNvSpPr>
                <a:spLocks noChangeShapeType="1"/>
              </p:cNvSpPr>
              <p:nvPr/>
            </p:nvSpPr>
            <p:spPr bwMode="auto">
              <a:xfrm flipH="1">
                <a:off x="644" y="1928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44" name="Line 111"/>
              <p:cNvSpPr>
                <a:spLocks noChangeShapeType="1"/>
              </p:cNvSpPr>
              <p:nvPr/>
            </p:nvSpPr>
            <p:spPr bwMode="auto">
              <a:xfrm flipH="1">
                <a:off x="644" y="1914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45" name="Line 112"/>
              <p:cNvSpPr>
                <a:spLocks noChangeShapeType="1"/>
              </p:cNvSpPr>
              <p:nvPr/>
            </p:nvSpPr>
            <p:spPr bwMode="auto">
              <a:xfrm flipH="1">
                <a:off x="644" y="1899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46" name="Line 113"/>
              <p:cNvSpPr>
                <a:spLocks noChangeShapeType="1"/>
              </p:cNvSpPr>
              <p:nvPr/>
            </p:nvSpPr>
            <p:spPr bwMode="auto">
              <a:xfrm flipH="1">
                <a:off x="644" y="1885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47" name="Line 114"/>
              <p:cNvSpPr>
                <a:spLocks noChangeShapeType="1"/>
              </p:cNvSpPr>
              <p:nvPr/>
            </p:nvSpPr>
            <p:spPr bwMode="auto">
              <a:xfrm flipH="1">
                <a:off x="644" y="1856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48" name="Line 115"/>
              <p:cNvSpPr>
                <a:spLocks noChangeShapeType="1"/>
              </p:cNvSpPr>
              <p:nvPr/>
            </p:nvSpPr>
            <p:spPr bwMode="auto">
              <a:xfrm flipH="1">
                <a:off x="644" y="1842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49" name="Line 116"/>
              <p:cNvSpPr>
                <a:spLocks noChangeShapeType="1"/>
              </p:cNvSpPr>
              <p:nvPr/>
            </p:nvSpPr>
            <p:spPr bwMode="auto">
              <a:xfrm flipH="1">
                <a:off x="644" y="1827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50" name="Line 117"/>
              <p:cNvSpPr>
                <a:spLocks noChangeShapeType="1"/>
              </p:cNvSpPr>
              <p:nvPr/>
            </p:nvSpPr>
            <p:spPr bwMode="auto">
              <a:xfrm flipH="1">
                <a:off x="644" y="1813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51" name="Line 118"/>
              <p:cNvSpPr>
                <a:spLocks noChangeShapeType="1"/>
              </p:cNvSpPr>
              <p:nvPr/>
            </p:nvSpPr>
            <p:spPr bwMode="auto">
              <a:xfrm flipH="1">
                <a:off x="644" y="1784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52" name="Line 119"/>
              <p:cNvSpPr>
                <a:spLocks noChangeShapeType="1"/>
              </p:cNvSpPr>
              <p:nvPr/>
            </p:nvSpPr>
            <p:spPr bwMode="auto">
              <a:xfrm flipH="1">
                <a:off x="644" y="1769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53" name="Line 120"/>
              <p:cNvSpPr>
                <a:spLocks noChangeShapeType="1"/>
              </p:cNvSpPr>
              <p:nvPr/>
            </p:nvSpPr>
            <p:spPr bwMode="auto">
              <a:xfrm flipH="1">
                <a:off x="644" y="1755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54" name="Line 121"/>
              <p:cNvSpPr>
                <a:spLocks noChangeShapeType="1"/>
              </p:cNvSpPr>
              <p:nvPr/>
            </p:nvSpPr>
            <p:spPr bwMode="auto">
              <a:xfrm flipH="1">
                <a:off x="644" y="1740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55" name="Line 122"/>
              <p:cNvSpPr>
                <a:spLocks noChangeShapeType="1"/>
              </p:cNvSpPr>
              <p:nvPr/>
            </p:nvSpPr>
            <p:spPr bwMode="auto">
              <a:xfrm flipH="1">
                <a:off x="644" y="1711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56" name="Line 123"/>
              <p:cNvSpPr>
                <a:spLocks noChangeShapeType="1"/>
              </p:cNvSpPr>
              <p:nvPr/>
            </p:nvSpPr>
            <p:spPr bwMode="auto">
              <a:xfrm flipH="1">
                <a:off x="644" y="1697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57" name="Line 124"/>
              <p:cNvSpPr>
                <a:spLocks noChangeShapeType="1"/>
              </p:cNvSpPr>
              <p:nvPr/>
            </p:nvSpPr>
            <p:spPr bwMode="auto">
              <a:xfrm flipH="1">
                <a:off x="644" y="1682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58" name="Line 125"/>
              <p:cNvSpPr>
                <a:spLocks noChangeShapeType="1"/>
              </p:cNvSpPr>
              <p:nvPr/>
            </p:nvSpPr>
            <p:spPr bwMode="auto">
              <a:xfrm flipH="1">
                <a:off x="644" y="1668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59" name="Line 126"/>
              <p:cNvSpPr>
                <a:spLocks noChangeShapeType="1"/>
              </p:cNvSpPr>
              <p:nvPr/>
            </p:nvSpPr>
            <p:spPr bwMode="auto">
              <a:xfrm flipH="1">
                <a:off x="644" y="1639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60" name="Line 127"/>
              <p:cNvSpPr>
                <a:spLocks noChangeShapeType="1"/>
              </p:cNvSpPr>
              <p:nvPr/>
            </p:nvSpPr>
            <p:spPr bwMode="auto">
              <a:xfrm flipH="1">
                <a:off x="644" y="1624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61" name="Line 128"/>
              <p:cNvSpPr>
                <a:spLocks noChangeShapeType="1"/>
              </p:cNvSpPr>
              <p:nvPr/>
            </p:nvSpPr>
            <p:spPr bwMode="auto">
              <a:xfrm flipH="1">
                <a:off x="644" y="1610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62" name="Line 129"/>
              <p:cNvSpPr>
                <a:spLocks noChangeShapeType="1"/>
              </p:cNvSpPr>
              <p:nvPr/>
            </p:nvSpPr>
            <p:spPr bwMode="auto">
              <a:xfrm flipH="1">
                <a:off x="644" y="1596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63" name="Line 130"/>
              <p:cNvSpPr>
                <a:spLocks noChangeShapeType="1"/>
              </p:cNvSpPr>
              <p:nvPr/>
            </p:nvSpPr>
            <p:spPr bwMode="auto">
              <a:xfrm flipH="1">
                <a:off x="644" y="1567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64" name="Line 131"/>
              <p:cNvSpPr>
                <a:spLocks noChangeShapeType="1"/>
              </p:cNvSpPr>
              <p:nvPr/>
            </p:nvSpPr>
            <p:spPr bwMode="auto">
              <a:xfrm flipH="1">
                <a:off x="644" y="1552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65" name="Line 132"/>
              <p:cNvSpPr>
                <a:spLocks noChangeShapeType="1"/>
              </p:cNvSpPr>
              <p:nvPr/>
            </p:nvSpPr>
            <p:spPr bwMode="auto">
              <a:xfrm flipH="1">
                <a:off x="644" y="1538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66" name="Line 133"/>
              <p:cNvSpPr>
                <a:spLocks noChangeShapeType="1"/>
              </p:cNvSpPr>
              <p:nvPr/>
            </p:nvSpPr>
            <p:spPr bwMode="auto">
              <a:xfrm flipH="1">
                <a:off x="644" y="1523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67" name="Line 134"/>
              <p:cNvSpPr>
                <a:spLocks noChangeShapeType="1"/>
              </p:cNvSpPr>
              <p:nvPr/>
            </p:nvSpPr>
            <p:spPr bwMode="auto">
              <a:xfrm flipH="1">
                <a:off x="644" y="1494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68" name="Line 135"/>
              <p:cNvSpPr>
                <a:spLocks noChangeShapeType="1"/>
              </p:cNvSpPr>
              <p:nvPr/>
            </p:nvSpPr>
            <p:spPr bwMode="auto">
              <a:xfrm flipH="1">
                <a:off x="644" y="1480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69" name="Line 136"/>
              <p:cNvSpPr>
                <a:spLocks noChangeShapeType="1"/>
              </p:cNvSpPr>
              <p:nvPr/>
            </p:nvSpPr>
            <p:spPr bwMode="auto">
              <a:xfrm flipH="1">
                <a:off x="644" y="1465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0" name="Line 137"/>
              <p:cNvSpPr>
                <a:spLocks noChangeShapeType="1"/>
              </p:cNvSpPr>
              <p:nvPr/>
            </p:nvSpPr>
            <p:spPr bwMode="auto">
              <a:xfrm flipH="1">
                <a:off x="644" y="1451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1" name="Line 138"/>
              <p:cNvSpPr>
                <a:spLocks noChangeShapeType="1"/>
              </p:cNvSpPr>
              <p:nvPr/>
            </p:nvSpPr>
            <p:spPr bwMode="auto">
              <a:xfrm flipH="1">
                <a:off x="644" y="1422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2" name="Line 139"/>
              <p:cNvSpPr>
                <a:spLocks noChangeShapeType="1"/>
              </p:cNvSpPr>
              <p:nvPr/>
            </p:nvSpPr>
            <p:spPr bwMode="auto">
              <a:xfrm flipH="1">
                <a:off x="644" y="1407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3" name="Line 140"/>
              <p:cNvSpPr>
                <a:spLocks noChangeShapeType="1"/>
              </p:cNvSpPr>
              <p:nvPr/>
            </p:nvSpPr>
            <p:spPr bwMode="auto">
              <a:xfrm flipH="1">
                <a:off x="644" y="1393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4" name="Line 141"/>
              <p:cNvSpPr>
                <a:spLocks noChangeShapeType="1"/>
              </p:cNvSpPr>
              <p:nvPr/>
            </p:nvSpPr>
            <p:spPr bwMode="auto">
              <a:xfrm flipH="1">
                <a:off x="644" y="1379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5" name="Line 142"/>
              <p:cNvSpPr>
                <a:spLocks noChangeShapeType="1"/>
              </p:cNvSpPr>
              <p:nvPr/>
            </p:nvSpPr>
            <p:spPr bwMode="auto">
              <a:xfrm flipH="1">
                <a:off x="644" y="1350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6" name="Line 143"/>
              <p:cNvSpPr>
                <a:spLocks noChangeShapeType="1"/>
              </p:cNvSpPr>
              <p:nvPr/>
            </p:nvSpPr>
            <p:spPr bwMode="auto">
              <a:xfrm flipH="1">
                <a:off x="644" y="1335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7" name="Line 144"/>
              <p:cNvSpPr>
                <a:spLocks noChangeShapeType="1"/>
              </p:cNvSpPr>
              <p:nvPr/>
            </p:nvSpPr>
            <p:spPr bwMode="auto">
              <a:xfrm flipH="1">
                <a:off x="644" y="1321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8" name="Line 145"/>
              <p:cNvSpPr>
                <a:spLocks noChangeShapeType="1"/>
              </p:cNvSpPr>
              <p:nvPr/>
            </p:nvSpPr>
            <p:spPr bwMode="auto">
              <a:xfrm flipH="1">
                <a:off x="644" y="1306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79" name="Line 146"/>
              <p:cNvSpPr>
                <a:spLocks noChangeShapeType="1"/>
              </p:cNvSpPr>
              <p:nvPr/>
            </p:nvSpPr>
            <p:spPr bwMode="auto">
              <a:xfrm flipH="1">
                <a:off x="644" y="1277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0" name="Line 147"/>
              <p:cNvSpPr>
                <a:spLocks noChangeShapeType="1"/>
              </p:cNvSpPr>
              <p:nvPr/>
            </p:nvSpPr>
            <p:spPr bwMode="auto">
              <a:xfrm flipH="1">
                <a:off x="644" y="1263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1" name="Line 148"/>
              <p:cNvSpPr>
                <a:spLocks noChangeShapeType="1"/>
              </p:cNvSpPr>
              <p:nvPr/>
            </p:nvSpPr>
            <p:spPr bwMode="auto">
              <a:xfrm flipH="1">
                <a:off x="644" y="1248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2" name="Line 149"/>
              <p:cNvSpPr>
                <a:spLocks noChangeShapeType="1"/>
              </p:cNvSpPr>
              <p:nvPr/>
            </p:nvSpPr>
            <p:spPr bwMode="auto">
              <a:xfrm flipH="1">
                <a:off x="644" y="1234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3" name="Line 150"/>
              <p:cNvSpPr>
                <a:spLocks noChangeShapeType="1"/>
              </p:cNvSpPr>
              <p:nvPr/>
            </p:nvSpPr>
            <p:spPr bwMode="auto">
              <a:xfrm flipH="1">
                <a:off x="644" y="1205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4" name="Line 151"/>
              <p:cNvSpPr>
                <a:spLocks noChangeShapeType="1"/>
              </p:cNvSpPr>
              <p:nvPr/>
            </p:nvSpPr>
            <p:spPr bwMode="auto">
              <a:xfrm flipH="1">
                <a:off x="644" y="1190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5" name="Line 152"/>
              <p:cNvSpPr>
                <a:spLocks noChangeShapeType="1"/>
              </p:cNvSpPr>
              <p:nvPr/>
            </p:nvSpPr>
            <p:spPr bwMode="auto">
              <a:xfrm flipH="1">
                <a:off x="644" y="1176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6" name="Line 153"/>
              <p:cNvSpPr>
                <a:spLocks noChangeShapeType="1"/>
              </p:cNvSpPr>
              <p:nvPr/>
            </p:nvSpPr>
            <p:spPr bwMode="auto">
              <a:xfrm flipH="1">
                <a:off x="644" y="1161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7" name="Line 154"/>
              <p:cNvSpPr>
                <a:spLocks noChangeShapeType="1"/>
              </p:cNvSpPr>
              <p:nvPr/>
            </p:nvSpPr>
            <p:spPr bwMode="auto">
              <a:xfrm flipH="1">
                <a:off x="644" y="1133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8" name="Line 155"/>
              <p:cNvSpPr>
                <a:spLocks noChangeShapeType="1"/>
              </p:cNvSpPr>
              <p:nvPr/>
            </p:nvSpPr>
            <p:spPr bwMode="auto">
              <a:xfrm flipH="1">
                <a:off x="644" y="1118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89" name="Line 156"/>
              <p:cNvSpPr>
                <a:spLocks noChangeShapeType="1"/>
              </p:cNvSpPr>
              <p:nvPr/>
            </p:nvSpPr>
            <p:spPr bwMode="auto">
              <a:xfrm flipH="1">
                <a:off x="644" y="1104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0" name="Line 157"/>
              <p:cNvSpPr>
                <a:spLocks noChangeShapeType="1"/>
              </p:cNvSpPr>
              <p:nvPr/>
            </p:nvSpPr>
            <p:spPr bwMode="auto">
              <a:xfrm flipH="1">
                <a:off x="644" y="1089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1" name="Line 158"/>
              <p:cNvSpPr>
                <a:spLocks noChangeShapeType="1"/>
              </p:cNvSpPr>
              <p:nvPr/>
            </p:nvSpPr>
            <p:spPr bwMode="auto">
              <a:xfrm flipH="1">
                <a:off x="644" y="1060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2" name="Line 159"/>
              <p:cNvSpPr>
                <a:spLocks noChangeShapeType="1"/>
              </p:cNvSpPr>
              <p:nvPr/>
            </p:nvSpPr>
            <p:spPr bwMode="auto">
              <a:xfrm flipH="1">
                <a:off x="644" y="1046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3" name="Line 160"/>
              <p:cNvSpPr>
                <a:spLocks noChangeShapeType="1"/>
              </p:cNvSpPr>
              <p:nvPr/>
            </p:nvSpPr>
            <p:spPr bwMode="auto">
              <a:xfrm flipH="1">
                <a:off x="644" y="1031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4" name="Line 161"/>
              <p:cNvSpPr>
                <a:spLocks noChangeShapeType="1"/>
              </p:cNvSpPr>
              <p:nvPr/>
            </p:nvSpPr>
            <p:spPr bwMode="auto">
              <a:xfrm flipH="1">
                <a:off x="644" y="1017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5" name="Line 162"/>
              <p:cNvSpPr>
                <a:spLocks noChangeShapeType="1"/>
              </p:cNvSpPr>
              <p:nvPr/>
            </p:nvSpPr>
            <p:spPr bwMode="auto">
              <a:xfrm flipH="1">
                <a:off x="644" y="988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6" name="Line 163"/>
              <p:cNvSpPr>
                <a:spLocks noChangeShapeType="1"/>
              </p:cNvSpPr>
              <p:nvPr/>
            </p:nvSpPr>
            <p:spPr bwMode="auto">
              <a:xfrm flipH="1">
                <a:off x="644" y="973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7" name="Line 164"/>
              <p:cNvSpPr>
                <a:spLocks noChangeShapeType="1"/>
              </p:cNvSpPr>
              <p:nvPr/>
            </p:nvSpPr>
            <p:spPr bwMode="auto">
              <a:xfrm flipH="1">
                <a:off x="644" y="959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8" name="Line 165"/>
              <p:cNvSpPr>
                <a:spLocks noChangeShapeType="1"/>
              </p:cNvSpPr>
              <p:nvPr/>
            </p:nvSpPr>
            <p:spPr bwMode="auto">
              <a:xfrm flipH="1">
                <a:off x="644" y="944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99" name="Line 166"/>
              <p:cNvSpPr>
                <a:spLocks noChangeShapeType="1"/>
              </p:cNvSpPr>
              <p:nvPr/>
            </p:nvSpPr>
            <p:spPr bwMode="auto">
              <a:xfrm flipH="1">
                <a:off x="644" y="916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0" name="Line 167"/>
              <p:cNvSpPr>
                <a:spLocks noChangeShapeType="1"/>
              </p:cNvSpPr>
              <p:nvPr/>
            </p:nvSpPr>
            <p:spPr bwMode="auto">
              <a:xfrm flipH="1">
                <a:off x="644" y="901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1" name="Line 168"/>
              <p:cNvSpPr>
                <a:spLocks noChangeShapeType="1"/>
              </p:cNvSpPr>
              <p:nvPr/>
            </p:nvSpPr>
            <p:spPr bwMode="auto">
              <a:xfrm flipH="1">
                <a:off x="644" y="887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2" name="Line 169"/>
              <p:cNvSpPr>
                <a:spLocks noChangeShapeType="1"/>
              </p:cNvSpPr>
              <p:nvPr/>
            </p:nvSpPr>
            <p:spPr bwMode="auto">
              <a:xfrm flipH="1">
                <a:off x="644" y="872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3" name="Line 170"/>
              <p:cNvSpPr>
                <a:spLocks noChangeShapeType="1"/>
              </p:cNvSpPr>
              <p:nvPr/>
            </p:nvSpPr>
            <p:spPr bwMode="auto">
              <a:xfrm flipH="1">
                <a:off x="644" y="843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4" name="Line 171"/>
              <p:cNvSpPr>
                <a:spLocks noChangeShapeType="1"/>
              </p:cNvSpPr>
              <p:nvPr/>
            </p:nvSpPr>
            <p:spPr bwMode="auto">
              <a:xfrm flipH="1">
                <a:off x="644" y="829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5" name="Line 172"/>
              <p:cNvSpPr>
                <a:spLocks noChangeShapeType="1"/>
              </p:cNvSpPr>
              <p:nvPr/>
            </p:nvSpPr>
            <p:spPr bwMode="auto">
              <a:xfrm flipH="1">
                <a:off x="644" y="814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6" name="Line 173"/>
              <p:cNvSpPr>
                <a:spLocks noChangeShapeType="1"/>
              </p:cNvSpPr>
              <p:nvPr/>
            </p:nvSpPr>
            <p:spPr bwMode="auto">
              <a:xfrm flipH="1">
                <a:off x="644" y="800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7" name="Line 174"/>
              <p:cNvSpPr>
                <a:spLocks noChangeShapeType="1"/>
              </p:cNvSpPr>
              <p:nvPr/>
            </p:nvSpPr>
            <p:spPr bwMode="auto">
              <a:xfrm flipH="1">
                <a:off x="644" y="771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8" name="Line 175"/>
              <p:cNvSpPr>
                <a:spLocks noChangeShapeType="1"/>
              </p:cNvSpPr>
              <p:nvPr/>
            </p:nvSpPr>
            <p:spPr bwMode="auto">
              <a:xfrm flipH="1">
                <a:off x="644" y="756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09" name="Line 176"/>
              <p:cNvSpPr>
                <a:spLocks noChangeShapeType="1"/>
              </p:cNvSpPr>
              <p:nvPr/>
            </p:nvSpPr>
            <p:spPr bwMode="auto">
              <a:xfrm flipH="1">
                <a:off x="644" y="742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0" name="Line 177"/>
              <p:cNvSpPr>
                <a:spLocks noChangeShapeType="1"/>
              </p:cNvSpPr>
              <p:nvPr/>
            </p:nvSpPr>
            <p:spPr bwMode="auto">
              <a:xfrm flipH="1">
                <a:off x="644" y="727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1" name="Line 178"/>
              <p:cNvSpPr>
                <a:spLocks noChangeShapeType="1"/>
              </p:cNvSpPr>
              <p:nvPr/>
            </p:nvSpPr>
            <p:spPr bwMode="auto">
              <a:xfrm flipH="1">
                <a:off x="644" y="698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2" name="Line 179"/>
              <p:cNvSpPr>
                <a:spLocks noChangeShapeType="1"/>
              </p:cNvSpPr>
              <p:nvPr/>
            </p:nvSpPr>
            <p:spPr bwMode="auto">
              <a:xfrm flipH="1">
                <a:off x="644" y="684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3" name="Line 180"/>
              <p:cNvSpPr>
                <a:spLocks noChangeShapeType="1"/>
              </p:cNvSpPr>
              <p:nvPr/>
            </p:nvSpPr>
            <p:spPr bwMode="auto">
              <a:xfrm flipH="1">
                <a:off x="644" y="670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4" name="Line 181"/>
              <p:cNvSpPr>
                <a:spLocks noChangeShapeType="1"/>
              </p:cNvSpPr>
              <p:nvPr/>
            </p:nvSpPr>
            <p:spPr bwMode="auto">
              <a:xfrm flipH="1">
                <a:off x="644" y="655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5" name="Line 182"/>
              <p:cNvSpPr>
                <a:spLocks noChangeShapeType="1"/>
              </p:cNvSpPr>
              <p:nvPr/>
            </p:nvSpPr>
            <p:spPr bwMode="auto">
              <a:xfrm flipH="1">
                <a:off x="644" y="626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6" name="Line 183"/>
              <p:cNvSpPr>
                <a:spLocks noChangeShapeType="1"/>
              </p:cNvSpPr>
              <p:nvPr/>
            </p:nvSpPr>
            <p:spPr bwMode="auto">
              <a:xfrm flipH="1">
                <a:off x="644" y="612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7" name="Line 184"/>
              <p:cNvSpPr>
                <a:spLocks noChangeShapeType="1"/>
              </p:cNvSpPr>
              <p:nvPr/>
            </p:nvSpPr>
            <p:spPr bwMode="auto">
              <a:xfrm flipH="1">
                <a:off x="644" y="597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8" name="Line 185"/>
              <p:cNvSpPr>
                <a:spLocks noChangeShapeType="1"/>
              </p:cNvSpPr>
              <p:nvPr/>
            </p:nvSpPr>
            <p:spPr bwMode="auto">
              <a:xfrm flipH="1">
                <a:off x="644" y="583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19" name="Line 186"/>
              <p:cNvSpPr>
                <a:spLocks noChangeShapeType="1"/>
              </p:cNvSpPr>
              <p:nvPr/>
            </p:nvSpPr>
            <p:spPr bwMode="auto">
              <a:xfrm flipH="1">
                <a:off x="644" y="554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20" name="Line 187"/>
              <p:cNvSpPr>
                <a:spLocks noChangeShapeType="1"/>
              </p:cNvSpPr>
              <p:nvPr/>
            </p:nvSpPr>
            <p:spPr bwMode="auto">
              <a:xfrm flipH="1">
                <a:off x="644" y="539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21" name="Line 188"/>
              <p:cNvSpPr>
                <a:spLocks noChangeShapeType="1"/>
              </p:cNvSpPr>
              <p:nvPr/>
            </p:nvSpPr>
            <p:spPr bwMode="auto">
              <a:xfrm flipH="1">
                <a:off x="644" y="525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22" name="Line 189"/>
              <p:cNvSpPr>
                <a:spLocks noChangeShapeType="1"/>
              </p:cNvSpPr>
              <p:nvPr/>
            </p:nvSpPr>
            <p:spPr bwMode="auto">
              <a:xfrm flipH="1">
                <a:off x="644" y="510"/>
                <a:ext cx="1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23" name="Line 190"/>
              <p:cNvSpPr>
                <a:spLocks noChangeShapeType="1"/>
              </p:cNvSpPr>
              <p:nvPr/>
            </p:nvSpPr>
            <p:spPr bwMode="auto">
              <a:xfrm flipH="1">
                <a:off x="639" y="1870"/>
                <a:ext cx="1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24" name="Rectangle 191"/>
              <p:cNvSpPr>
                <a:spLocks noChangeArrowheads="1"/>
              </p:cNvSpPr>
              <p:nvPr/>
            </p:nvSpPr>
            <p:spPr bwMode="auto">
              <a:xfrm>
                <a:off x="606" y="1854"/>
                <a:ext cx="33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5" name="Line 192"/>
              <p:cNvSpPr>
                <a:spLocks noChangeShapeType="1"/>
              </p:cNvSpPr>
              <p:nvPr/>
            </p:nvSpPr>
            <p:spPr bwMode="auto">
              <a:xfrm flipH="1">
                <a:off x="639" y="1798"/>
                <a:ext cx="1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26" name="Rectangle 193"/>
              <p:cNvSpPr>
                <a:spLocks noChangeArrowheads="1"/>
              </p:cNvSpPr>
              <p:nvPr/>
            </p:nvSpPr>
            <p:spPr bwMode="auto">
              <a:xfrm>
                <a:off x="588" y="1782"/>
                <a:ext cx="51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7" name="Line 194"/>
              <p:cNvSpPr>
                <a:spLocks noChangeShapeType="1"/>
              </p:cNvSpPr>
              <p:nvPr/>
            </p:nvSpPr>
            <p:spPr bwMode="auto">
              <a:xfrm flipH="1">
                <a:off x="639" y="1726"/>
                <a:ext cx="1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28" name="Rectangle 195"/>
              <p:cNvSpPr>
                <a:spLocks noChangeArrowheads="1"/>
              </p:cNvSpPr>
              <p:nvPr/>
            </p:nvSpPr>
            <p:spPr bwMode="auto">
              <a:xfrm>
                <a:off x="588" y="1710"/>
                <a:ext cx="51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9" name="Line 196"/>
              <p:cNvSpPr>
                <a:spLocks noChangeShapeType="1"/>
              </p:cNvSpPr>
              <p:nvPr/>
            </p:nvSpPr>
            <p:spPr bwMode="auto">
              <a:xfrm flipH="1">
                <a:off x="639" y="1653"/>
                <a:ext cx="1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30" name="Rectangle 197"/>
              <p:cNvSpPr>
                <a:spLocks noChangeArrowheads="1"/>
              </p:cNvSpPr>
              <p:nvPr/>
            </p:nvSpPr>
            <p:spPr bwMode="auto">
              <a:xfrm>
                <a:off x="588" y="1637"/>
                <a:ext cx="51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1" name="Line 198"/>
              <p:cNvSpPr>
                <a:spLocks noChangeShapeType="1"/>
              </p:cNvSpPr>
              <p:nvPr/>
            </p:nvSpPr>
            <p:spPr bwMode="auto">
              <a:xfrm flipH="1">
                <a:off x="639" y="1581"/>
                <a:ext cx="1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32" name="Rectangle 199"/>
              <p:cNvSpPr>
                <a:spLocks noChangeArrowheads="1"/>
              </p:cNvSpPr>
              <p:nvPr/>
            </p:nvSpPr>
            <p:spPr bwMode="auto">
              <a:xfrm>
                <a:off x="588" y="1565"/>
                <a:ext cx="51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5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3" name="Line 200"/>
              <p:cNvSpPr>
                <a:spLocks noChangeShapeType="1"/>
              </p:cNvSpPr>
              <p:nvPr/>
            </p:nvSpPr>
            <p:spPr bwMode="auto">
              <a:xfrm flipH="1">
                <a:off x="639" y="1509"/>
                <a:ext cx="1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34" name="Rectangle 201"/>
              <p:cNvSpPr>
                <a:spLocks noChangeArrowheads="1"/>
              </p:cNvSpPr>
              <p:nvPr/>
            </p:nvSpPr>
            <p:spPr bwMode="auto">
              <a:xfrm>
                <a:off x="588" y="1493"/>
                <a:ext cx="51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5" name="Line 202"/>
              <p:cNvSpPr>
                <a:spLocks noChangeShapeType="1"/>
              </p:cNvSpPr>
              <p:nvPr/>
            </p:nvSpPr>
            <p:spPr bwMode="auto">
              <a:xfrm flipH="1">
                <a:off x="639" y="1436"/>
                <a:ext cx="1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336" name="Rectangle 203"/>
              <p:cNvSpPr>
                <a:spLocks noChangeArrowheads="1"/>
              </p:cNvSpPr>
              <p:nvPr/>
            </p:nvSpPr>
            <p:spPr bwMode="auto">
              <a:xfrm>
                <a:off x="588" y="1420"/>
                <a:ext cx="51" cy="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5</a:t>
                </a:r>
                <a:endParaRPr kumimoji="0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7" name="Line 204"/>
              <p:cNvSpPr>
                <a:spLocks noChangeShapeType="1"/>
              </p:cNvSpPr>
              <p:nvPr/>
            </p:nvSpPr>
            <p:spPr bwMode="auto">
              <a:xfrm flipH="1">
                <a:off x="639" y="1364"/>
                <a:ext cx="1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</p:grpSp>
        <p:sp>
          <p:nvSpPr>
            <p:cNvPr id="32" name="Rectangle 206"/>
            <p:cNvSpPr>
              <a:spLocks noChangeArrowheads="1"/>
            </p:cNvSpPr>
            <p:nvPr/>
          </p:nvSpPr>
          <p:spPr bwMode="auto">
            <a:xfrm>
              <a:off x="933450" y="2139950"/>
              <a:ext cx="80962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Line 207"/>
            <p:cNvSpPr>
              <a:spLocks noChangeShapeType="1"/>
            </p:cNvSpPr>
            <p:nvPr/>
          </p:nvSpPr>
          <p:spPr bwMode="auto">
            <a:xfrm flipH="1">
              <a:off x="1014413" y="2051050"/>
              <a:ext cx="285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" name="Rectangle 208"/>
            <p:cNvSpPr>
              <a:spLocks noChangeArrowheads="1"/>
            </p:cNvSpPr>
            <p:nvPr/>
          </p:nvSpPr>
          <p:spPr bwMode="auto">
            <a:xfrm>
              <a:off x="933450" y="2025650"/>
              <a:ext cx="80962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5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Line 209"/>
            <p:cNvSpPr>
              <a:spLocks noChangeShapeType="1"/>
            </p:cNvSpPr>
            <p:nvPr/>
          </p:nvSpPr>
          <p:spPr bwMode="auto">
            <a:xfrm flipH="1">
              <a:off x="1014413" y="1935163"/>
              <a:ext cx="285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" name="Rectangle 210"/>
            <p:cNvSpPr>
              <a:spLocks noChangeArrowheads="1"/>
            </p:cNvSpPr>
            <p:nvPr/>
          </p:nvSpPr>
          <p:spPr bwMode="auto">
            <a:xfrm>
              <a:off x="933450" y="1909763"/>
              <a:ext cx="80962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Line 211"/>
            <p:cNvSpPr>
              <a:spLocks noChangeShapeType="1"/>
            </p:cNvSpPr>
            <p:nvPr/>
          </p:nvSpPr>
          <p:spPr bwMode="auto">
            <a:xfrm flipH="1">
              <a:off x="1014413" y="1820863"/>
              <a:ext cx="285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" name="Rectangle 212"/>
            <p:cNvSpPr>
              <a:spLocks noChangeArrowheads="1"/>
            </p:cNvSpPr>
            <p:nvPr/>
          </p:nvSpPr>
          <p:spPr bwMode="auto">
            <a:xfrm>
              <a:off x="933450" y="1795463"/>
              <a:ext cx="80962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5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Line 213"/>
            <p:cNvSpPr>
              <a:spLocks noChangeShapeType="1"/>
            </p:cNvSpPr>
            <p:nvPr/>
          </p:nvSpPr>
          <p:spPr bwMode="auto">
            <a:xfrm flipH="1">
              <a:off x="1014413" y="1706563"/>
              <a:ext cx="285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" name="Rectangle 214"/>
            <p:cNvSpPr>
              <a:spLocks noChangeArrowheads="1"/>
            </p:cNvSpPr>
            <p:nvPr/>
          </p:nvSpPr>
          <p:spPr bwMode="auto">
            <a:xfrm>
              <a:off x="933450" y="1681163"/>
              <a:ext cx="80962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Line 215"/>
            <p:cNvSpPr>
              <a:spLocks noChangeShapeType="1"/>
            </p:cNvSpPr>
            <p:nvPr/>
          </p:nvSpPr>
          <p:spPr bwMode="auto">
            <a:xfrm flipH="1">
              <a:off x="1014413" y="1590675"/>
              <a:ext cx="285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" name="Rectangle 216"/>
            <p:cNvSpPr>
              <a:spLocks noChangeArrowheads="1"/>
            </p:cNvSpPr>
            <p:nvPr/>
          </p:nvSpPr>
          <p:spPr bwMode="auto">
            <a:xfrm>
              <a:off x="933450" y="1565275"/>
              <a:ext cx="80962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5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Line 217"/>
            <p:cNvSpPr>
              <a:spLocks noChangeShapeType="1"/>
            </p:cNvSpPr>
            <p:nvPr/>
          </p:nvSpPr>
          <p:spPr bwMode="auto">
            <a:xfrm flipH="1">
              <a:off x="1014413" y="1476375"/>
              <a:ext cx="285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" name="Rectangle 218"/>
            <p:cNvSpPr>
              <a:spLocks noChangeArrowheads="1"/>
            </p:cNvSpPr>
            <p:nvPr/>
          </p:nvSpPr>
          <p:spPr bwMode="auto">
            <a:xfrm>
              <a:off x="933450" y="1450975"/>
              <a:ext cx="80962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Line 219"/>
            <p:cNvSpPr>
              <a:spLocks noChangeShapeType="1"/>
            </p:cNvSpPr>
            <p:nvPr/>
          </p:nvSpPr>
          <p:spPr bwMode="auto">
            <a:xfrm flipH="1">
              <a:off x="1014413" y="1362075"/>
              <a:ext cx="285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" name="Rectangle 220"/>
            <p:cNvSpPr>
              <a:spLocks noChangeArrowheads="1"/>
            </p:cNvSpPr>
            <p:nvPr/>
          </p:nvSpPr>
          <p:spPr bwMode="auto">
            <a:xfrm>
              <a:off x="933450" y="1335088"/>
              <a:ext cx="80962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5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Line 221"/>
            <p:cNvSpPr>
              <a:spLocks noChangeShapeType="1"/>
            </p:cNvSpPr>
            <p:nvPr/>
          </p:nvSpPr>
          <p:spPr bwMode="auto">
            <a:xfrm flipH="1">
              <a:off x="1014413" y="1246188"/>
              <a:ext cx="285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" name="Rectangle 222"/>
            <p:cNvSpPr>
              <a:spLocks noChangeArrowheads="1"/>
            </p:cNvSpPr>
            <p:nvPr/>
          </p:nvSpPr>
          <p:spPr bwMode="auto">
            <a:xfrm>
              <a:off x="933450" y="1220788"/>
              <a:ext cx="80962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Line 223"/>
            <p:cNvSpPr>
              <a:spLocks noChangeShapeType="1"/>
            </p:cNvSpPr>
            <p:nvPr/>
          </p:nvSpPr>
          <p:spPr bwMode="auto">
            <a:xfrm flipH="1">
              <a:off x="1014413" y="1131888"/>
              <a:ext cx="285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" name="Rectangle 224"/>
            <p:cNvSpPr>
              <a:spLocks noChangeArrowheads="1"/>
            </p:cNvSpPr>
            <p:nvPr/>
          </p:nvSpPr>
          <p:spPr bwMode="auto">
            <a:xfrm>
              <a:off x="933450" y="1106488"/>
              <a:ext cx="80962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5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Line 225"/>
            <p:cNvSpPr>
              <a:spLocks noChangeShapeType="1"/>
            </p:cNvSpPr>
            <p:nvPr/>
          </p:nvSpPr>
          <p:spPr bwMode="auto">
            <a:xfrm flipH="1">
              <a:off x="1014413" y="1017588"/>
              <a:ext cx="285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" name="Rectangle 226"/>
            <p:cNvSpPr>
              <a:spLocks noChangeArrowheads="1"/>
            </p:cNvSpPr>
            <p:nvPr/>
          </p:nvSpPr>
          <p:spPr bwMode="auto">
            <a:xfrm>
              <a:off x="933450" y="990600"/>
              <a:ext cx="80962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Line 227"/>
            <p:cNvSpPr>
              <a:spLocks noChangeShapeType="1"/>
            </p:cNvSpPr>
            <p:nvPr/>
          </p:nvSpPr>
          <p:spPr bwMode="auto">
            <a:xfrm flipH="1">
              <a:off x="1014413" y="901700"/>
              <a:ext cx="285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" name="Rectangle 228"/>
            <p:cNvSpPr>
              <a:spLocks noChangeArrowheads="1"/>
            </p:cNvSpPr>
            <p:nvPr/>
          </p:nvSpPr>
          <p:spPr bwMode="auto">
            <a:xfrm>
              <a:off x="933450" y="876300"/>
              <a:ext cx="80962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5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Line 229"/>
            <p:cNvSpPr>
              <a:spLocks noChangeShapeType="1"/>
            </p:cNvSpPr>
            <p:nvPr/>
          </p:nvSpPr>
          <p:spPr bwMode="auto">
            <a:xfrm flipH="1">
              <a:off x="1014413" y="784225"/>
              <a:ext cx="285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6" name="Rectangle 230"/>
            <p:cNvSpPr>
              <a:spLocks noChangeArrowheads="1"/>
            </p:cNvSpPr>
            <p:nvPr/>
          </p:nvSpPr>
          <p:spPr bwMode="auto">
            <a:xfrm>
              <a:off x="904875" y="758825"/>
              <a:ext cx="109537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231"/>
            <p:cNvSpPr>
              <a:spLocks noChangeArrowheads="1"/>
            </p:cNvSpPr>
            <p:nvPr/>
          </p:nvSpPr>
          <p:spPr bwMode="auto">
            <a:xfrm rot="16200000">
              <a:off x="676276" y="1897063"/>
              <a:ext cx="4730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elative Abundance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Freeform 232"/>
            <p:cNvSpPr>
              <a:spLocks/>
            </p:cNvSpPr>
            <p:nvPr/>
          </p:nvSpPr>
          <p:spPr bwMode="auto">
            <a:xfrm>
              <a:off x="1042988" y="784225"/>
              <a:ext cx="4221162" cy="2297112"/>
            </a:xfrm>
            <a:custGeom>
              <a:avLst/>
              <a:gdLst>
                <a:gd name="T0" fmla="*/ 22 w 1469"/>
                <a:gd name="T1" fmla="*/ 800 h 800"/>
                <a:gd name="T2" fmla="*/ 45 w 1469"/>
                <a:gd name="T3" fmla="*/ 800 h 800"/>
                <a:gd name="T4" fmla="*/ 68 w 1469"/>
                <a:gd name="T5" fmla="*/ 800 h 800"/>
                <a:gd name="T6" fmla="*/ 91 w 1469"/>
                <a:gd name="T7" fmla="*/ 800 h 800"/>
                <a:gd name="T8" fmla="*/ 114 w 1469"/>
                <a:gd name="T9" fmla="*/ 795 h 800"/>
                <a:gd name="T10" fmla="*/ 137 w 1469"/>
                <a:gd name="T11" fmla="*/ 789 h 800"/>
                <a:gd name="T12" fmla="*/ 160 w 1469"/>
                <a:gd name="T13" fmla="*/ 792 h 800"/>
                <a:gd name="T14" fmla="*/ 183 w 1469"/>
                <a:gd name="T15" fmla="*/ 800 h 800"/>
                <a:gd name="T16" fmla="*/ 206 w 1469"/>
                <a:gd name="T17" fmla="*/ 799 h 800"/>
                <a:gd name="T18" fmla="*/ 229 w 1469"/>
                <a:gd name="T19" fmla="*/ 799 h 800"/>
                <a:gd name="T20" fmla="*/ 252 w 1469"/>
                <a:gd name="T21" fmla="*/ 800 h 800"/>
                <a:gd name="T22" fmla="*/ 275 w 1469"/>
                <a:gd name="T23" fmla="*/ 797 h 800"/>
                <a:gd name="T24" fmla="*/ 298 w 1469"/>
                <a:gd name="T25" fmla="*/ 800 h 800"/>
                <a:gd name="T26" fmla="*/ 321 w 1469"/>
                <a:gd name="T27" fmla="*/ 800 h 800"/>
                <a:gd name="T28" fmla="*/ 344 w 1469"/>
                <a:gd name="T29" fmla="*/ 794 h 800"/>
                <a:gd name="T30" fmla="*/ 367 w 1469"/>
                <a:gd name="T31" fmla="*/ 793 h 800"/>
                <a:gd name="T32" fmla="*/ 390 w 1469"/>
                <a:gd name="T33" fmla="*/ 800 h 800"/>
                <a:gd name="T34" fmla="*/ 413 w 1469"/>
                <a:gd name="T35" fmla="*/ 800 h 800"/>
                <a:gd name="T36" fmla="*/ 436 w 1469"/>
                <a:gd name="T37" fmla="*/ 800 h 800"/>
                <a:gd name="T38" fmla="*/ 459 w 1469"/>
                <a:gd name="T39" fmla="*/ 785 h 800"/>
                <a:gd name="T40" fmla="*/ 482 w 1469"/>
                <a:gd name="T41" fmla="*/ 797 h 800"/>
                <a:gd name="T42" fmla="*/ 505 w 1469"/>
                <a:gd name="T43" fmla="*/ 789 h 800"/>
                <a:gd name="T44" fmla="*/ 528 w 1469"/>
                <a:gd name="T45" fmla="*/ 800 h 800"/>
                <a:gd name="T46" fmla="*/ 551 w 1469"/>
                <a:gd name="T47" fmla="*/ 800 h 800"/>
                <a:gd name="T48" fmla="*/ 574 w 1469"/>
                <a:gd name="T49" fmla="*/ 734 h 800"/>
                <a:gd name="T50" fmla="*/ 597 w 1469"/>
                <a:gd name="T51" fmla="*/ 800 h 800"/>
                <a:gd name="T52" fmla="*/ 620 w 1469"/>
                <a:gd name="T53" fmla="*/ 800 h 800"/>
                <a:gd name="T54" fmla="*/ 643 w 1469"/>
                <a:gd name="T55" fmla="*/ 800 h 800"/>
                <a:gd name="T56" fmla="*/ 666 w 1469"/>
                <a:gd name="T57" fmla="*/ 800 h 800"/>
                <a:gd name="T58" fmla="*/ 689 w 1469"/>
                <a:gd name="T59" fmla="*/ 800 h 800"/>
                <a:gd name="T60" fmla="*/ 712 w 1469"/>
                <a:gd name="T61" fmla="*/ 789 h 800"/>
                <a:gd name="T62" fmla="*/ 735 w 1469"/>
                <a:gd name="T63" fmla="*/ 800 h 800"/>
                <a:gd name="T64" fmla="*/ 758 w 1469"/>
                <a:gd name="T65" fmla="*/ 769 h 800"/>
                <a:gd name="T66" fmla="*/ 781 w 1469"/>
                <a:gd name="T67" fmla="*/ 800 h 800"/>
                <a:gd name="T68" fmla="*/ 804 w 1469"/>
                <a:gd name="T69" fmla="*/ 743 h 800"/>
                <a:gd name="T70" fmla="*/ 827 w 1469"/>
                <a:gd name="T71" fmla="*/ 765 h 800"/>
                <a:gd name="T72" fmla="*/ 850 w 1469"/>
                <a:gd name="T73" fmla="*/ 782 h 800"/>
                <a:gd name="T74" fmla="*/ 873 w 1469"/>
                <a:gd name="T75" fmla="*/ 800 h 800"/>
                <a:gd name="T76" fmla="*/ 896 w 1469"/>
                <a:gd name="T77" fmla="*/ 788 h 800"/>
                <a:gd name="T78" fmla="*/ 919 w 1469"/>
                <a:gd name="T79" fmla="*/ 800 h 800"/>
                <a:gd name="T80" fmla="*/ 942 w 1469"/>
                <a:gd name="T81" fmla="*/ 800 h 800"/>
                <a:gd name="T82" fmla="*/ 965 w 1469"/>
                <a:gd name="T83" fmla="*/ 778 h 800"/>
                <a:gd name="T84" fmla="*/ 988 w 1469"/>
                <a:gd name="T85" fmla="*/ 800 h 800"/>
                <a:gd name="T86" fmla="*/ 1011 w 1469"/>
                <a:gd name="T87" fmla="*/ 795 h 800"/>
                <a:gd name="T88" fmla="*/ 1034 w 1469"/>
                <a:gd name="T89" fmla="*/ 800 h 800"/>
                <a:gd name="T90" fmla="*/ 1057 w 1469"/>
                <a:gd name="T91" fmla="*/ 775 h 800"/>
                <a:gd name="T92" fmla="*/ 1080 w 1469"/>
                <a:gd name="T93" fmla="*/ 793 h 800"/>
                <a:gd name="T94" fmla="*/ 1103 w 1469"/>
                <a:gd name="T95" fmla="*/ 790 h 800"/>
                <a:gd name="T96" fmla="*/ 1126 w 1469"/>
                <a:gd name="T97" fmla="*/ 800 h 800"/>
                <a:gd name="T98" fmla="*/ 1149 w 1469"/>
                <a:gd name="T99" fmla="*/ 800 h 800"/>
                <a:gd name="T100" fmla="*/ 1172 w 1469"/>
                <a:gd name="T101" fmla="*/ 778 h 800"/>
                <a:gd name="T102" fmla="*/ 1195 w 1469"/>
                <a:gd name="T103" fmla="*/ 796 h 800"/>
                <a:gd name="T104" fmla="*/ 1218 w 1469"/>
                <a:gd name="T105" fmla="*/ 800 h 800"/>
                <a:gd name="T106" fmla="*/ 1241 w 1469"/>
                <a:gd name="T107" fmla="*/ 794 h 800"/>
                <a:gd name="T108" fmla="*/ 1264 w 1469"/>
                <a:gd name="T109" fmla="*/ 795 h 800"/>
                <a:gd name="T110" fmla="*/ 1287 w 1469"/>
                <a:gd name="T111" fmla="*/ 800 h 800"/>
                <a:gd name="T112" fmla="*/ 1310 w 1469"/>
                <a:gd name="T113" fmla="*/ 800 h 800"/>
                <a:gd name="T114" fmla="*/ 1333 w 1469"/>
                <a:gd name="T115" fmla="*/ 799 h 800"/>
                <a:gd name="T116" fmla="*/ 1356 w 1469"/>
                <a:gd name="T117" fmla="*/ 796 h 800"/>
                <a:gd name="T118" fmla="*/ 1379 w 1469"/>
                <a:gd name="T119" fmla="*/ 799 h 800"/>
                <a:gd name="T120" fmla="*/ 1402 w 1469"/>
                <a:gd name="T121" fmla="*/ 799 h 800"/>
                <a:gd name="T122" fmla="*/ 1425 w 1469"/>
                <a:gd name="T123" fmla="*/ 797 h 800"/>
                <a:gd name="T124" fmla="*/ 1448 w 1469"/>
                <a:gd name="T125" fmla="*/ 800 h 8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469" h="800">
                  <a:moveTo>
                    <a:pt x="0" y="800"/>
                  </a:moveTo>
                  <a:lnTo>
                    <a:pt x="0" y="800"/>
                  </a:lnTo>
                  <a:lnTo>
                    <a:pt x="1" y="800"/>
                  </a:lnTo>
                  <a:lnTo>
                    <a:pt x="1" y="800"/>
                  </a:lnTo>
                  <a:lnTo>
                    <a:pt x="2" y="800"/>
                  </a:lnTo>
                  <a:lnTo>
                    <a:pt x="2" y="800"/>
                  </a:lnTo>
                  <a:lnTo>
                    <a:pt x="3" y="800"/>
                  </a:lnTo>
                  <a:lnTo>
                    <a:pt x="3" y="800"/>
                  </a:lnTo>
                  <a:lnTo>
                    <a:pt x="4" y="800"/>
                  </a:lnTo>
                  <a:lnTo>
                    <a:pt x="4" y="800"/>
                  </a:lnTo>
                  <a:lnTo>
                    <a:pt x="5" y="800"/>
                  </a:lnTo>
                  <a:lnTo>
                    <a:pt x="5" y="800"/>
                  </a:lnTo>
                  <a:lnTo>
                    <a:pt x="6" y="800"/>
                  </a:lnTo>
                  <a:lnTo>
                    <a:pt x="6" y="800"/>
                  </a:lnTo>
                  <a:lnTo>
                    <a:pt x="7" y="800"/>
                  </a:lnTo>
                  <a:lnTo>
                    <a:pt x="7" y="800"/>
                  </a:lnTo>
                  <a:lnTo>
                    <a:pt x="8" y="800"/>
                  </a:lnTo>
                  <a:lnTo>
                    <a:pt x="8" y="800"/>
                  </a:lnTo>
                  <a:lnTo>
                    <a:pt x="9" y="800"/>
                  </a:lnTo>
                  <a:lnTo>
                    <a:pt x="9" y="800"/>
                  </a:lnTo>
                  <a:lnTo>
                    <a:pt x="10" y="800"/>
                  </a:lnTo>
                  <a:lnTo>
                    <a:pt x="10" y="800"/>
                  </a:lnTo>
                  <a:lnTo>
                    <a:pt x="11" y="800"/>
                  </a:lnTo>
                  <a:lnTo>
                    <a:pt x="11" y="800"/>
                  </a:lnTo>
                  <a:lnTo>
                    <a:pt x="12" y="800"/>
                  </a:lnTo>
                  <a:lnTo>
                    <a:pt x="12" y="800"/>
                  </a:lnTo>
                  <a:lnTo>
                    <a:pt x="13" y="800"/>
                  </a:lnTo>
                  <a:lnTo>
                    <a:pt x="13" y="800"/>
                  </a:lnTo>
                  <a:lnTo>
                    <a:pt x="14" y="800"/>
                  </a:lnTo>
                  <a:lnTo>
                    <a:pt x="14" y="800"/>
                  </a:lnTo>
                  <a:lnTo>
                    <a:pt x="15" y="800"/>
                  </a:lnTo>
                  <a:lnTo>
                    <a:pt x="15" y="800"/>
                  </a:lnTo>
                  <a:lnTo>
                    <a:pt x="16" y="800"/>
                  </a:lnTo>
                  <a:lnTo>
                    <a:pt x="16" y="800"/>
                  </a:lnTo>
                  <a:lnTo>
                    <a:pt x="17" y="800"/>
                  </a:lnTo>
                  <a:lnTo>
                    <a:pt x="17" y="800"/>
                  </a:lnTo>
                  <a:lnTo>
                    <a:pt x="18" y="800"/>
                  </a:lnTo>
                  <a:lnTo>
                    <a:pt x="18" y="800"/>
                  </a:lnTo>
                  <a:lnTo>
                    <a:pt x="19" y="800"/>
                  </a:lnTo>
                  <a:lnTo>
                    <a:pt x="19" y="800"/>
                  </a:lnTo>
                  <a:lnTo>
                    <a:pt x="20" y="800"/>
                  </a:lnTo>
                  <a:lnTo>
                    <a:pt x="20" y="800"/>
                  </a:lnTo>
                  <a:lnTo>
                    <a:pt x="21" y="800"/>
                  </a:lnTo>
                  <a:lnTo>
                    <a:pt x="21" y="800"/>
                  </a:lnTo>
                  <a:lnTo>
                    <a:pt x="22" y="800"/>
                  </a:lnTo>
                  <a:lnTo>
                    <a:pt x="22" y="800"/>
                  </a:lnTo>
                  <a:lnTo>
                    <a:pt x="23" y="800"/>
                  </a:lnTo>
                  <a:lnTo>
                    <a:pt x="23" y="800"/>
                  </a:lnTo>
                  <a:lnTo>
                    <a:pt x="24" y="800"/>
                  </a:lnTo>
                  <a:lnTo>
                    <a:pt x="24" y="800"/>
                  </a:lnTo>
                  <a:lnTo>
                    <a:pt x="25" y="800"/>
                  </a:lnTo>
                  <a:lnTo>
                    <a:pt x="25" y="800"/>
                  </a:lnTo>
                  <a:lnTo>
                    <a:pt x="26" y="800"/>
                  </a:lnTo>
                  <a:lnTo>
                    <a:pt x="26" y="800"/>
                  </a:lnTo>
                  <a:lnTo>
                    <a:pt x="27" y="800"/>
                  </a:lnTo>
                  <a:lnTo>
                    <a:pt x="27" y="800"/>
                  </a:lnTo>
                  <a:lnTo>
                    <a:pt x="28" y="800"/>
                  </a:lnTo>
                  <a:lnTo>
                    <a:pt x="28" y="800"/>
                  </a:lnTo>
                  <a:lnTo>
                    <a:pt x="29" y="800"/>
                  </a:lnTo>
                  <a:lnTo>
                    <a:pt x="29" y="800"/>
                  </a:lnTo>
                  <a:lnTo>
                    <a:pt x="30" y="800"/>
                  </a:lnTo>
                  <a:lnTo>
                    <a:pt x="30" y="800"/>
                  </a:lnTo>
                  <a:lnTo>
                    <a:pt x="31" y="800"/>
                  </a:lnTo>
                  <a:lnTo>
                    <a:pt x="31" y="800"/>
                  </a:lnTo>
                  <a:lnTo>
                    <a:pt x="32" y="800"/>
                  </a:lnTo>
                  <a:lnTo>
                    <a:pt x="32" y="800"/>
                  </a:lnTo>
                  <a:lnTo>
                    <a:pt x="33" y="800"/>
                  </a:lnTo>
                  <a:lnTo>
                    <a:pt x="33" y="800"/>
                  </a:lnTo>
                  <a:lnTo>
                    <a:pt x="34" y="800"/>
                  </a:lnTo>
                  <a:lnTo>
                    <a:pt x="34" y="800"/>
                  </a:lnTo>
                  <a:lnTo>
                    <a:pt x="35" y="800"/>
                  </a:lnTo>
                  <a:lnTo>
                    <a:pt x="35" y="800"/>
                  </a:lnTo>
                  <a:lnTo>
                    <a:pt x="36" y="800"/>
                  </a:lnTo>
                  <a:lnTo>
                    <a:pt x="36" y="800"/>
                  </a:lnTo>
                  <a:lnTo>
                    <a:pt x="37" y="800"/>
                  </a:lnTo>
                  <a:lnTo>
                    <a:pt x="37" y="800"/>
                  </a:lnTo>
                  <a:lnTo>
                    <a:pt x="38" y="800"/>
                  </a:lnTo>
                  <a:lnTo>
                    <a:pt x="38" y="800"/>
                  </a:lnTo>
                  <a:lnTo>
                    <a:pt x="39" y="800"/>
                  </a:lnTo>
                  <a:lnTo>
                    <a:pt x="39" y="800"/>
                  </a:lnTo>
                  <a:lnTo>
                    <a:pt x="40" y="800"/>
                  </a:lnTo>
                  <a:lnTo>
                    <a:pt x="40" y="800"/>
                  </a:lnTo>
                  <a:lnTo>
                    <a:pt x="41" y="800"/>
                  </a:lnTo>
                  <a:lnTo>
                    <a:pt x="41" y="800"/>
                  </a:lnTo>
                  <a:lnTo>
                    <a:pt x="42" y="800"/>
                  </a:lnTo>
                  <a:lnTo>
                    <a:pt x="42" y="800"/>
                  </a:lnTo>
                  <a:lnTo>
                    <a:pt x="43" y="800"/>
                  </a:lnTo>
                  <a:lnTo>
                    <a:pt x="43" y="800"/>
                  </a:lnTo>
                  <a:lnTo>
                    <a:pt x="44" y="800"/>
                  </a:lnTo>
                  <a:lnTo>
                    <a:pt x="44" y="800"/>
                  </a:lnTo>
                  <a:lnTo>
                    <a:pt x="45" y="800"/>
                  </a:lnTo>
                  <a:lnTo>
                    <a:pt x="45" y="800"/>
                  </a:lnTo>
                  <a:lnTo>
                    <a:pt x="46" y="800"/>
                  </a:lnTo>
                  <a:lnTo>
                    <a:pt x="46" y="800"/>
                  </a:lnTo>
                  <a:lnTo>
                    <a:pt x="47" y="800"/>
                  </a:lnTo>
                  <a:lnTo>
                    <a:pt x="47" y="800"/>
                  </a:lnTo>
                  <a:lnTo>
                    <a:pt x="48" y="800"/>
                  </a:lnTo>
                  <a:lnTo>
                    <a:pt x="48" y="800"/>
                  </a:lnTo>
                  <a:lnTo>
                    <a:pt x="49" y="800"/>
                  </a:lnTo>
                  <a:lnTo>
                    <a:pt x="49" y="800"/>
                  </a:lnTo>
                  <a:lnTo>
                    <a:pt x="50" y="800"/>
                  </a:lnTo>
                  <a:lnTo>
                    <a:pt x="50" y="800"/>
                  </a:lnTo>
                  <a:lnTo>
                    <a:pt x="51" y="800"/>
                  </a:lnTo>
                  <a:lnTo>
                    <a:pt x="51" y="800"/>
                  </a:lnTo>
                  <a:lnTo>
                    <a:pt x="52" y="800"/>
                  </a:lnTo>
                  <a:lnTo>
                    <a:pt x="52" y="800"/>
                  </a:lnTo>
                  <a:lnTo>
                    <a:pt x="53" y="800"/>
                  </a:lnTo>
                  <a:lnTo>
                    <a:pt x="53" y="800"/>
                  </a:lnTo>
                  <a:lnTo>
                    <a:pt x="54" y="800"/>
                  </a:lnTo>
                  <a:lnTo>
                    <a:pt x="54" y="800"/>
                  </a:lnTo>
                  <a:lnTo>
                    <a:pt x="55" y="800"/>
                  </a:lnTo>
                  <a:lnTo>
                    <a:pt x="55" y="800"/>
                  </a:lnTo>
                  <a:lnTo>
                    <a:pt x="56" y="800"/>
                  </a:lnTo>
                  <a:lnTo>
                    <a:pt x="56" y="800"/>
                  </a:lnTo>
                  <a:lnTo>
                    <a:pt x="57" y="800"/>
                  </a:lnTo>
                  <a:lnTo>
                    <a:pt x="57" y="800"/>
                  </a:lnTo>
                  <a:lnTo>
                    <a:pt x="58" y="800"/>
                  </a:lnTo>
                  <a:lnTo>
                    <a:pt x="58" y="800"/>
                  </a:lnTo>
                  <a:lnTo>
                    <a:pt x="59" y="800"/>
                  </a:lnTo>
                  <a:lnTo>
                    <a:pt x="59" y="800"/>
                  </a:lnTo>
                  <a:lnTo>
                    <a:pt x="60" y="800"/>
                  </a:lnTo>
                  <a:lnTo>
                    <a:pt x="60" y="800"/>
                  </a:lnTo>
                  <a:lnTo>
                    <a:pt x="61" y="800"/>
                  </a:lnTo>
                  <a:lnTo>
                    <a:pt x="61" y="800"/>
                  </a:lnTo>
                  <a:lnTo>
                    <a:pt x="62" y="800"/>
                  </a:lnTo>
                  <a:lnTo>
                    <a:pt x="62" y="800"/>
                  </a:lnTo>
                  <a:lnTo>
                    <a:pt x="63" y="800"/>
                  </a:lnTo>
                  <a:lnTo>
                    <a:pt x="63" y="800"/>
                  </a:lnTo>
                  <a:lnTo>
                    <a:pt x="64" y="800"/>
                  </a:lnTo>
                  <a:lnTo>
                    <a:pt x="64" y="800"/>
                  </a:lnTo>
                  <a:lnTo>
                    <a:pt x="65" y="800"/>
                  </a:lnTo>
                  <a:lnTo>
                    <a:pt x="65" y="800"/>
                  </a:lnTo>
                  <a:lnTo>
                    <a:pt x="66" y="800"/>
                  </a:lnTo>
                  <a:lnTo>
                    <a:pt x="66" y="800"/>
                  </a:lnTo>
                  <a:lnTo>
                    <a:pt x="67" y="800"/>
                  </a:lnTo>
                  <a:lnTo>
                    <a:pt x="67" y="800"/>
                  </a:lnTo>
                  <a:lnTo>
                    <a:pt x="68" y="800"/>
                  </a:lnTo>
                  <a:lnTo>
                    <a:pt x="68" y="800"/>
                  </a:lnTo>
                  <a:lnTo>
                    <a:pt x="69" y="800"/>
                  </a:lnTo>
                  <a:lnTo>
                    <a:pt x="69" y="800"/>
                  </a:lnTo>
                  <a:lnTo>
                    <a:pt x="70" y="800"/>
                  </a:lnTo>
                  <a:lnTo>
                    <a:pt x="70" y="800"/>
                  </a:lnTo>
                  <a:lnTo>
                    <a:pt x="71" y="800"/>
                  </a:lnTo>
                  <a:lnTo>
                    <a:pt x="71" y="799"/>
                  </a:lnTo>
                  <a:lnTo>
                    <a:pt x="72" y="800"/>
                  </a:lnTo>
                  <a:lnTo>
                    <a:pt x="72" y="795"/>
                  </a:lnTo>
                  <a:lnTo>
                    <a:pt x="73" y="794"/>
                  </a:lnTo>
                  <a:lnTo>
                    <a:pt x="73" y="800"/>
                  </a:lnTo>
                  <a:lnTo>
                    <a:pt x="74" y="800"/>
                  </a:lnTo>
                  <a:lnTo>
                    <a:pt x="74" y="790"/>
                  </a:lnTo>
                  <a:lnTo>
                    <a:pt x="75" y="788"/>
                  </a:lnTo>
                  <a:lnTo>
                    <a:pt x="75" y="800"/>
                  </a:lnTo>
                  <a:lnTo>
                    <a:pt x="76" y="800"/>
                  </a:lnTo>
                  <a:lnTo>
                    <a:pt x="76" y="796"/>
                  </a:lnTo>
                  <a:lnTo>
                    <a:pt x="77" y="800"/>
                  </a:lnTo>
                  <a:lnTo>
                    <a:pt x="77" y="799"/>
                  </a:lnTo>
                  <a:lnTo>
                    <a:pt x="78" y="800"/>
                  </a:lnTo>
                  <a:lnTo>
                    <a:pt x="78" y="800"/>
                  </a:lnTo>
                  <a:lnTo>
                    <a:pt x="79" y="800"/>
                  </a:lnTo>
                  <a:lnTo>
                    <a:pt x="79" y="800"/>
                  </a:lnTo>
                  <a:lnTo>
                    <a:pt x="80" y="800"/>
                  </a:lnTo>
                  <a:lnTo>
                    <a:pt x="80" y="800"/>
                  </a:lnTo>
                  <a:lnTo>
                    <a:pt x="81" y="800"/>
                  </a:lnTo>
                  <a:lnTo>
                    <a:pt x="81" y="800"/>
                  </a:lnTo>
                  <a:lnTo>
                    <a:pt x="82" y="800"/>
                  </a:lnTo>
                  <a:lnTo>
                    <a:pt x="82" y="800"/>
                  </a:lnTo>
                  <a:lnTo>
                    <a:pt x="83" y="800"/>
                  </a:lnTo>
                  <a:lnTo>
                    <a:pt x="83" y="800"/>
                  </a:lnTo>
                  <a:lnTo>
                    <a:pt x="84" y="800"/>
                  </a:lnTo>
                  <a:lnTo>
                    <a:pt x="84" y="799"/>
                  </a:lnTo>
                  <a:lnTo>
                    <a:pt x="85" y="800"/>
                  </a:lnTo>
                  <a:lnTo>
                    <a:pt x="85" y="791"/>
                  </a:lnTo>
                  <a:lnTo>
                    <a:pt x="86" y="790"/>
                  </a:lnTo>
                  <a:lnTo>
                    <a:pt x="86" y="800"/>
                  </a:lnTo>
                  <a:lnTo>
                    <a:pt x="87" y="800"/>
                  </a:lnTo>
                  <a:lnTo>
                    <a:pt x="87" y="796"/>
                  </a:lnTo>
                  <a:lnTo>
                    <a:pt x="88" y="800"/>
                  </a:lnTo>
                  <a:lnTo>
                    <a:pt x="88" y="800"/>
                  </a:lnTo>
                  <a:lnTo>
                    <a:pt x="89" y="800"/>
                  </a:lnTo>
                  <a:lnTo>
                    <a:pt x="89" y="800"/>
                  </a:lnTo>
                  <a:lnTo>
                    <a:pt x="90" y="800"/>
                  </a:lnTo>
                  <a:lnTo>
                    <a:pt x="90" y="800"/>
                  </a:lnTo>
                  <a:lnTo>
                    <a:pt x="91" y="799"/>
                  </a:lnTo>
                  <a:lnTo>
                    <a:pt x="91" y="800"/>
                  </a:lnTo>
                  <a:lnTo>
                    <a:pt x="92" y="799"/>
                  </a:lnTo>
                  <a:lnTo>
                    <a:pt x="92" y="800"/>
                  </a:lnTo>
                  <a:lnTo>
                    <a:pt x="93" y="800"/>
                  </a:lnTo>
                  <a:lnTo>
                    <a:pt x="93" y="800"/>
                  </a:lnTo>
                  <a:lnTo>
                    <a:pt x="94" y="800"/>
                  </a:lnTo>
                  <a:lnTo>
                    <a:pt x="94" y="800"/>
                  </a:lnTo>
                  <a:lnTo>
                    <a:pt x="95" y="800"/>
                  </a:lnTo>
                  <a:lnTo>
                    <a:pt x="95" y="800"/>
                  </a:lnTo>
                  <a:lnTo>
                    <a:pt x="96" y="799"/>
                  </a:lnTo>
                  <a:lnTo>
                    <a:pt x="96" y="800"/>
                  </a:lnTo>
                  <a:lnTo>
                    <a:pt x="97" y="800"/>
                  </a:lnTo>
                  <a:lnTo>
                    <a:pt x="97" y="800"/>
                  </a:lnTo>
                  <a:lnTo>
                    <a:pt x="98" y="800"/>
                  </a:lnTo>
                  <a:lnTo>
                    <a:pt x="98" y="800"/>
                  </a:lnTo>
                  <a:lnTo>
                    <a:pt x="99" y="800"/>
                  </a:lnTo>
                  <a:lnTo>
                    <a:pt x="99" y="800"/>
                  </a:lnTo>
                  <a:lnTo>
                    <a:pt x="100" y="799"/>
                  </a:lnTo>
                  <a:lnTo>
                    <a:pt x="100" y="800"/>
                  </a:lnTo>
                  <a:lnTo>
                    <a:pt x="101" y="800"/>
                  </a:lnTo>
                  <a:lnTo>
                    <a:pt x="101" y="797"/>
                  </a:lnTo>
                  <a:lnTo>
                    <a:pt x="102" y="796"/>
                  </a:lnTo>
                  <a:lnTo>
                    <a:pt x="102" y="800"/>
                  </a:lnTo>
                  <a:lnTo>
                    <a:pt x="103" y="800"/>
                  </a:lnTo>
                  <a:lnTo>
                    <a:pt x="103" y="799"/>
                  </a:lnTo>
                  <a:lnTo>
                    <a:pt x="104" y="800"/>
                  </a:lnTo>
                  <a:lnTo>
                    <a:pt x="104" y="800"/>
                  </a:lnTo>
                  <a:lnTo>
                    <a:pt x="105" y="799"/>
                  </a:lnTo>
                  <a:lnTo>
                    <a:pt x="105" y="800"/>
                  </a:lnTo>
                  <a:lnTo>
                    <a:pt x="106" y="800"/>
                  </a:lnTo>
                  <a:lnTo>
                    <a:pt x="106" y="798"/>
                  </a:lnTo>
                  <a:lnTo>
                    <a:pt x="107" y="796"/>
                  </a:lnTo>
                  <a:lnTo>
                    <a:pt x="107" y="800"/>
                  </a:lnTo>
                  <a:lnTo>
                    <a:pt x="108" y="798"/>
                  </a:lnTo>
                  <a:lnTo>
                    <a:pt x="108" y="800"/>
                  </a:lnTo>
                  <a:lnTo>
                    <a:pt x="109" y="800"/>
                  </a:lnTo>
                  <a:lnTo>
                    <a:pt x="109" y="800"/>
                  </a:lnTo>
                  <a:lnTo>
                    <a:pt x="110" y="800"/>
                  </a:lnTo>
                  <a:lnTo>
                    <a:pt x="110" y="800"/>
                  </a:lnTo>
                  <a:lnTo>
                    <a:pt x="111" y="800"/>
                  </a:lnTo>
                  <a:lnTo>
                    <a:pt x="111" y="800"/>
                  </a:lnTo>
                  <a:lnTo>
                    <a:pt x="112" y="799"/>
                  </a:lnTo>
                  <a:lnTo>
                    <a:pt x="112" y="800"/>
                  </a:lnTo>
                  <a:lnTo>
                    <a:pt x="113" y="800"/>
                  </a:lnTo>
                  <a:lnTo>
                    <a:pt x="113" y="798"/>
                  </a:lnTo>
                  <a:lnTo>
                    <a:pt x="114" y="800"/>
                  </a:lnTo>
                  <a:lnTo>
                    <a:pt x="114" y="795"/>
                  </a:lnTo>
                  <a:lnTo>
                    <a:pt x="115" y="800"/>
                  </a:lnTo>
                  <a:lnTo>
                    <a:pt x="115" y="770"/>
                  </a:lnTo>
                  <a:lnTo>
                    <a:pt x="116" y="800"/>
                  </a:lnTo>
                  <a:lnTo>
                    <a:pt x="116" y="760"/>
                  </a:lnTo>
                  <a:lnTo>
                    <a:pt x="117" y="800"/>
                  </a:lnTo>
                  <a:lnTo>
                    <a:pt x="117" y="781"/>
                  </a:lnTo>
                  <a:lnTo>
                    <a:pt x="118" y="800"/>
                  </a:lnTo>
                  <a:lnTo>
                    <a:pt x="118" y="796"/>
                  </a:lnTo>
                  <a:lnTo>
                    <a:pt x="119" y="800"/>
                  </a:lnTo>
                  <a:lnTo>
                    <a:pt x="119" y="798"/>
                  </a:lnTo>
                  <a:lnTo>
                    <a:pt x="120" y="800"/>
                  </a:lnTo>
                  <a:lnTo>
                    <a:pt x="120" y="797"/>
                  </a:lnTo>
                  <a:lnTo>
                    <a:pt x="121" y="800"/>
                  </a:lnTo>
                  <a:lnTo>
                    <a:pt x="121" y="797"/>
                  </a:lnTo>
                  <a:lnTo>
                    <a:pt x="122" y="800"/>
                  </a:lnTo>
                  <a:lnTo>
                    <a:pt x="122" y="795"/>
                  </a:lnTo>
                  <a:lnTo>
                    <a:pt x="123" y="800"/>
                  </a:lnTo>
                  <a:lnTo>
                    <a:pt x="123" y="799"/>
                  </a:lnTo>
                  <a:lnTo>
                    <a:pt x="124" y="800"/>
                  </a:lnTo>
                  <a:lnTo>
                    <a:pt x="124" y="800"/>
                  </a:lnTo>
                  <a:lnTo>
                    <a:pt x="125" y="800"/>
                  </a:lnTo>
                  <a:lnTo>
                    <a:pt x="125" y="799"/>
                  </a:lnTo>
                  <a:lnTo>
                    <a:pt x="126" y="800"/>
                  </a:lnTo>
                  <a:lnTo>
                    <a:pt x="126" y="798"/>
                  </a:lnTo>
                  <a:lnTo>
                    <a:pt x="127" y="800"/>
                  </a:lnTo>
                  <a:lnTo>
                    <a:pt x="127" y="798"/>
                  </a:lnTo>
                  <a:lnTo>
                    <a:pt x="128" y="800"/>
                  </a:lnTo>
                  <a:lnTo>
                    <a:pt x="128" y="799"/>
                  </a:lnTo>
                  <a:lnTo>
                    <a:pt x="129" y="800"/>
                  </a:lnTo>
                  <a:lnTo>
                    <a:pt x="129" y="798"/>
                  </a:lnTo>
                  <a:lnTo>
                    <a:pt x="130" y="800"/>
                  </a:lnTo>
                  <a:lnTo>
                    <a:pt x="130" y="796"/>
                  </a:lnTo>
                  <a:lnTo>
                    <a:pt x="131" y="800"/>
                  </a:lnTo>
                  <a:lnTo>
                    <a:pt x="131" y="791"/>
                  </a:lnTo>
                  <a:lnTo>
                    <a:pt x="132" y="800"/>
                  </a:lnTo>
                  <a:lnTo>
                    <a:pt x="132" y="793"/>
                  </a:lnTo>
                  <a:lnTo>
                    <a:pt x="133" y="800"/>
                  </a:lnTo>
                  <a:lnTo>
                    <a:pt x="133" y="790"/>
                  </a:lnTo>
                  <a:lnTo>
                    <a:pt x="134" y="800"/>
                  </a:lnTo>
                  <a:lnTo>
                    <a:pt x="134" y="776"/>
                  </a:lnTo>
                  <a:lnTo>
                    <a:pt x="135" y="800"/>
                  </a:lnTo>
                  <a:lnTo>
                    <a:pt x="135" y="776"/>
                  </a:lnTo>
                  <a:lnTo>
                    <a:pt x="136" y="800"/>
                  </a:lnTo>
                  <a:lnTo>
                    <a:pt x="136" y="787"/>
                  </a:lnTo>
                  <a:lnTo>
                    <a:pt x="137" y="800"/>
                  </a:lnTo>
                  <a:lnTo>
                    <a:pt x="137" y="789"/>
                  </a:lnTo>
                  <a:lnTo>
                    <a:pt x="138" y="800"/>
                  </a:lnTo>
                  <a:lnTo>
                    <a:pt x="138" y="796"/>
                  </a:lnTo>
                  <a:lnTo>
                    <a:pt x="139" y="800"/>
                  </a:lnTo>
                  <a:lnTo>
                    <a:pt x="139" y="799"/>
                  </a:lnTo>
                  <a:lnTo>
                    <a:pt x="140" y="800"/>
                  </a:lnTo>
                  <a:lnTo>
                    <a:pt x="140" y="799"/>
                  </a:lnTo>
                  <a:lnTo>
                    <a:pt x="141" y="800"/>
                  </a:lnTo>
                  <a:lnTo>
                    <a:pt x="141" y="799"/>
                  </a:lnTo>
                  <a:lnTo>
                    <a:pt x="142" y="800"/>
                  </a:lnTo>
                  <a:lnTo>
                    <a:pt x="142" y="799"/>
                  </a:lnTo>
                  <a:lnTo>
                    <a:pt x="143" y="800"/>
                  </a:lnTo>
                  <a:lnTo>
                    <a:pt x="143" y="798"/>
                  </a:lnTo>
                  <a:lnTo>
                    <a:pt x="144" y="800"/>
                  </a:lnTo>
                  <a:lnTo>
                    <a:pt x="144" y="796"/>
                  </a:lnTo>
                  <a:lnTo>
                    <a:pt x="145" y="800"/>
                  </a:lnTo>
                  <a:lnTo>
                    <a:pt x="145" y="794"/>
                  </a:lnTo>
                  <a:lnTo>
                    <a:pt x="146" y="800"/>
                  </a:lnTo>
                  <a:lnTo>
                    <a:pt x="146" y="797"/>
                  </a:lnTo>
                  <a:lnTo>
                    <a:pt x="147" y="800"/>
                  </a:lnTo>
                  <a:lnTo>
                    <a:pt x="147" y="799"/>
                  </a:lnTo>
                  <a:lnTo>
                    <a:pt x="148" y="800"/>
                  </a:lnTo>
                  <a:lnTo>
                    <a:pt x="148" y="800"/>
                  </a:lnTo>
                  <a:lnTo>
                    <a:pt x="149" y="800"/>
                  </a:lnTo>
                  <a:lnTo>
                    <a:pt x="149" y="799"/>
                  </a:lnTo>
                  <a:lnTo>
                    <a:pt x="150" y="800"/>
                  </a:lnTo>
                  <a:lnTo>
                    <a:pt x="150" y="799"/>
                  </a:lnTo>
                  <a:lnTo>
                    <a:pt x="151" y="800"/>
                  </a:lnTo>
                  <a:lnTo>
                    <a:pt x="151" y="799"/>
                  </a:lnTo>
                  <a:lnTo>
                    <a:pt x="152" y="800"/>
                  </a:lnTo>
                  <a:lnTo>
                    <a:pt x="152" y="800"/>
                  </a:lnTo>
                  <a:lnTo>
                    <a:pt x="153" y="800"/>
                  </a:lnTo>
                  <a:lnTo>
                    <a:pt x="153" y="800"/>
                  </a:lnTo>
                  <a:lnTo>
                    <a:pt x="154" y="800"/>
                  </a:lnTo>
                  <a:lnTo>
                    <a:pt x="154" y="800"/>
                  </a:lnTo>
                  <a:lnTo>
                    <a:pt x="155" y="800"/>
                  </a:lnTo>
                  <a:lnTo>
                    <a:pt x="155" y="800"/>
                  </a:lnTo>
                  <a:lnTo>
                    <a:pt x="156" y="800"/>
                  </a:lnTo>
                  <a:lnTo>
                    <a:pt x="156" y="800"/>
                  </a:lnTo>
                  <a:lnTo>
                    <a:pt x="157" y="800"/>
                  </a:lnTo>
                  <a:lnTo>
                    <a:pt x="157" y="800"/>
                  </a:lnTo>
                  <a:lnTo>
                    <a:pt x="158" y="800"/>
                  </a:lnTo>
                  <a:lnTo>
                    <a:pt x="158" y="795"/>
                  </a:lnTo>
                  <a:lnTo>
                    <a:pt x="159" y="800"/>
                  </a:lnTo>
                  <a:lnTo>
                    <a:pt x="159" y="794"/>
                  </a:lnTo>
                  <a:lnTo>
                    <a:pt x="160" y="800"/>
                  </a:lnTo>
                  <a:lnTo>
                    <a:pt x="160" y="792"/>
                  </a:lnTo>
                  <a:lnTo>
                    <a:pt x="161" y="800"/>
                  </a:lnTo>
                  <a:lnTo>
                    <a:pt x="161" y="794"/>
                  </a:lnTo>
                  <a:lnTo>
                    <a:pt x="162" y="800"/>
                  </a:lnTo>
                  <a:lnTo>
                    <a:pt x="162" y="795"/>
                  </a:lnTo>
                  <a:lnTo>
                    <a:pt x="163" y="800"/>
                  </a:lnTo>
                  <a:lnTo>
                    <a:pt x="163" y="796"/>
                  </a:lnTo>
                  <a:lnTo>
                    <a:pt x="164" y="800"/>
                  </a:lnTo>
                  <a:lnTo>
                    <a:pt x="164" y="797"/>
                  </a:lnTo>
                  <a:lnTo>
                    <a:pt x="165" y="800"/>
                  </a:lnTo>
                  <a:lnTo>
                    <a:pt x="165" y="798"/>
                  </a:lnTo>
                  <a:lnTo>
                    <a:pt x="166" y="800"/>
                  </a:lnTo>
                  <a:lnTo>
                    <a:pt x="166" y="798"/>
                  </a:lnTo>
                  <a:lnTo>
                    <a:pt x="167" y="800"/>
                  </a:lnTo>
                  <a:lnTo>
                    <a:pt x="167" y="799"/>
                  </a:lnTo>
                  <a:lnTo>
                    <a:pt x="168" y="800"/>
                  </a:lnTo>
                  <a:lnTo>
                    <a:pt x="168" y="800"/>
                  </a:lnTo>
                  <a:lnTo>
                    <a:pt x="169" y="800"/>
                  </a:lnTo>
                  <a:lnTo>
                    <a:pt x="169" y="800"/>
                  </a:lnTo>
                  <a:lnTo>
                    <a:pt x="170" y="800"/>
                  </a:lnTo>
                  <a:lnTo>
                    <a:pt x="170" y="797"/>
                  </a:lnTo>
                  <a:lnTo>
                    <a:pt x="171" y="800"/>
                  </a:lnTo>
                  <a:lnTo>
                    <a:pt x="171" y="795"/>
                  </a:lnTo>
                  <a:lnTo>
                    <a:pt x="172" y="800"/>
                  </a:lnTo>
                  <a:lnTo>
                    <a:pt x="172" y="796"/>
                  </a:lnTo>
                  <a:lnTo>
                    <a:pt x="173" y="800"/>
                  </a:lnTo>
                  <a:lnTo>
                    <a:pt x="173" y="798"/>
                  </a:lnTo>
                  <a:lnTo>
                    <a:pt x="174" y="800"/>
                  </a:lnTo>
                  <a:lnTo>
                    <a:pt x="174" y="800"/>
                  </a:lnTo>
                  <a:lnTo>
                    <a:pt x="175" y="800"/>
                  </a:lnTo>
                  <a:lnTo>
                    <a:pt x="175" y="800"/>
                  </a:lnTo>
                  <a:lnTo>
                    <a:pt x="176" y="800"/>
                  </a:lnTo>
                  <a:lnTo>
                    <a:pt x="176" y="800"/>
                  </a:lnTo>
                  <a:lnTo>
                    <a:pt x="177" y="800"/>
                  </a:lnTo>
                  <a:lnTo>
                    <a:pt x="177" y="800"/>
                  </a:lnTo>
                  <a:lnTo>
                    <a:pt x="178" y="800"/>
                  </a:lnTo>
                  <a:lnTo>
                    <a:pt x="178" y="800"/>
                  </a:lnTo>
                  <a:lnTo>
                    <a:pt x="179" y="800"/>
                  </a:lnTo>
                  <a:lnTo>
                    <a:pt x="179" y="800"/>
                  </a:lnTo>
                  <a:lnTo>
                    <a:pt x="180" y="800"/>
                  </a:lnTo>
                  <a:lnTo>
                    <a:pt x="180" y="800"/>
                  </a:lnTo>
                  <a:lnTo>
                    <a:pt x="181" y="799"/>
                  </a:lnTo>
                  <a:lnTo>
                    <a:pt x="181" y="800"/>
                  </a:lnTo>
                  <a:lnTo>
                    <a:pt x="182" y="799"/>
                  </a:lnTo>
                  <a:lnTo>
                    <a:pt x="182" y="800"/>
                  </a:lnTo>
                  <a:lnTo>
                    <a:pt x="183" y="799"/>
                  </a:lnTo>
                  <a:lnTo>
                    <a:pt x="183" y="800"/>
                  </a:lnTo>
                  <a:lnTo>
                    <a:pt x="184" y="799"/>
                  </a:lnTo>
                  <a:lnTo>
                    <a:pt x="184" y="800"/>
                  </a:lnTo>
                  <a:lnTo>
                    <a:pt x="185" y="799"/>
                  </a:lnTo>
                  <a:lnTo>
                    <a:pt x="185" y="800"/>
                  </a:lnTo>
                  <a:lnTo>
                    <a:pt x="186" y="798"/>
                  </a:lnTo>
                  <a:lnTo>
                    <a:pt x="186" y="800"/>
                  </a:lnTo>
                  <a:lnTo>
                    <a:pt x="187" y="798"/>
                  </a:lnTo>
                  <a:lnTo>
                    <a:pt x="187" y="800"/>
                  </a:lnTo>
                  <a:lnTo>
                    <a:pt x="188" y="799"/>
                  </a:lnTo>
                  <a:lnTo>
                    <a:pt x="188" y="800"/>
                  </a:lnTo>
                  <a:lnTo>
                    <a:pt x="189" y="800"/>
                  </a:lnTo>
                  <a:lnTo>
                    <a:pt x="189" y="799"/>
                  </a:lnTo>
                  <a:lnTo>
                    <a:pt x="190" y="800"/>
                  </a:lnTo>
                  <a:lnTo>
                    <a:pt x="190" y="799"/>
                  </a:lnTo>
                  <a:lnTo>
                    <a:pt x="191" y="800"/>
                  </a:lnTo>
                  <a:lnTo>
                    <a:pt x="191" y="799"/>
                  </a:lnTo>
                  <a:lnTo>
                    <a:pt x="192" y="800"/>
                  </a:lnTo>
                  <a:lnTo>
                    <a:pt x="192" y="799"/>
                  </a:lnTo>
                  <a:lnTo>
                    <a:pt x="193" y="800"/>
                  </a:lnTo>
                  <a:lnTo>
                    <a:pt x="193" y="800"/>
                  </a:lnTo>
                  <a:lnTo>
                    <a:pt x="194" y="800"/>
                  </a:lnTo>
                  <a:lnTo>
                    <a:pt x="194" y="800"/>
                  </a:lnTo>
                  <a:lnTo>
                    <a:pt x="195" y="800"/>
                  </a:lnTo>
                  <a:lnTo>
                    <a:pt x="195" y="800"/>
                  </a:lnTo>
                  <a:lnTo>
                    <a:pt x="196" y="800"/>
                  </a:lnTo>
                  <a:lnTo>
                    <a:pt x="196" y="800"/>
                  </a:lnTo>
                  <a:lnTo>
                    <a:pt x="197" y="800"/>
                  </a:lnTo>
                  <a:lnTo>
                    <a:pt x="197" y="799"/>
                  </a:lnTo>
                  <a:lnTo>
                    <a:pt x="198" y="800"/>
                  </a:lnTo>
                  <a:lnTo>
                    <a:pt x="198" y="800"/>
                  </a:lnTo>
                  <a:lnTo>
                    <a:pt x="199" y="800"/>
                  </a:lnTo>
                  <a:lnTo>
                    <a:pt x="199" y="800"/>
                  </a:lnTo>
                  <a:lnTo>
                    <a:pt x="200" y="800"/>
                  </a:lnTo>
                  <a:lnTo>
                    <a:pt x="200" y="800"/>
                  </a:lnTo>
                  <a:lnTo>
                    <a:pt x="201" y="800"/>
                  </a:lnTo>
                  <a:lnTo>
                    <a:pt x="201" y="800"/>
                  </a:lnTo>
                  <a:lnTo>
                    <a:pt x="202" y="800"/>
                  </a:lnTo>
                  <a:lnTo>
                    <a:pt x="202" y="799"/>
                  </a:lnTo>
                  <a:lnTo>
                    <a:pt x="203" y="799"/>
                  </a:lnTo>
                  <a:lnTo>
                    <a:pt x="203" y="800"/>
                  </a:lnTo>
                  <a:lnTo>
                    <a:pt x="204" y="800"/>
                  </a:lnTo>
                  <a:lnTo>
                    <a:pt x="204" y="798"/>
                  </a:lnTo>
                  <a:lnTo>
                    <a:pt x="205" y="800"/>
                  </a:lnTo>
                  <a:lnTo>
                    <a:pt x="205" y="799"/>
                  </a:lnTo>
                  <a:lnTo>
                    <a:pt x="206" y="800"/>
                  </a:lnTo>
                  <a:lnTo>
                    <a:pt x="206" y="799"/>
                  </a:lnTo>
                  <a:lnTo>
                    <a:pt x="207" y="799"/>
                  </a:lnTo>
                  <a:lnTo>
                    <a:pt x="207" y="800"/>
                  </a:lnTo>
                  <a:lnTo>
                    <a:pt x="208" y="800"/>
                  </a:lnTo>
                  <a:lnTo>
                    <a:pt x="208" y="800"/>
                  </a:lnTo>
                  <a:lnTo>
                    <a:pt x="209" y="799"/>
                  </a:lnTo>
                  <a:lnTo>
                    <a:pt x="209" y="800"/>
                  </a:lnTo>
                  <a:lnTo>
                    <a:pt x="210" y="799"/>
                  </a:lnTo>
                  <a:lnTo>
                    <a:pt x="210" y="800"/>
                  </a:lnTo>
                  <a:lnTo>
                    <a:pt x="211" y="800"/>
                  </a:lnTo>
                  <a:lnTo>
                    <a:pt x="211" y="800"/>
                  </a:lnTo>
                  <a:lnTo>
                    <a:pt x="212" y="800"/>
                  </a:lnTo>
                  <a:lnTo>
                    <a:pt x="212" y="800"/>
                  </a:lnTo>
                  <a:lnTo>
                    <a:pt x="213" y="800"/>
                  </a:lnTo>
                  <a:lnTo>
                    <a:pt x="213" y="800"/>
                  </a:lnTo>
                  <a:lnTo>
                    <a:pt x="214" y="800"/>
                  </a:lnTo>
                  <a:lnTo>
                    <a:pt x="214" y="800"/>
                  </a:lnTo>
                  <a:lnTo>
                    <a:pt x="215" y="799"/>
                  </a:lnTo>
                  <a:lnTo>
                    <a:pt x="215" y="800"/>
                  </a:lnTo>
                  <a:lnTo>
                    <a:pt x="216" y="799"/>
                  </a:lnTo>
                  <a:lnTo>
                    <a:pt x="216" y="800"/>
                  </a:lnTo>
                  <a:lnTo>
                    <a:pt x="217" y="799"/>
                  </a:lnTo>
                  <a:lnTo>
                    <a:pt x="217" y="800"/>
                  </a:lnTo>
                  <a:lnTo>
                    <a:pt x="218" y="800"/>
                  </a:lnTo>
                  <a:lnTo>
                    <a:pt x="218" y="798"/>
                  </a:lnTo>
                  <a:lnTo>
                    <a:pt x="219" y="800"/>
                  </a:lnTo>
                  <a:lnTo>
                    <a:pt x="219" y="798"/>
                  </a:lnTo>
                  <a:lnTo>
                    <a:pt x="220" y="800"/>
                  </a:lnTo>
                  <a:lnTo>
                    <a:pt x="220" y="798"/>
                  </a:lnTo>
                  <a:lnTo>
                    <a:pt x="221" y="797"/>
                  </a:lnTo>
                  <a:lnTo>
                    <a:pt x="221" y="800"/>
                  </a:lnTo>
                  <a:lnTo>
                    <a:pt x="222" y="798"/>
                  </a:lnTo>
                  <a:lnTo>
                    <a:pt x="222" y="800"/>
                  </a:lnTo>
                  <a:lnTo>
                    <a:pt x="223" y="798"/>
                  </a:lnTo>
                  <a:lnTo>
                    <a:pt x="223" y="800"/>
                  </a:lnTo>
                  <a:lnTo>
                    <a:pt x="224" y="800"/>
                  </a:lnTo>
                  <a:lnTo>
                    <a:pt x="224" y="799"/>
                  </a:lnTo>
                  <a:lnTo>
                    <a:pt x="225" y="799"/>
                  </a:lnTo>
                  <a:lnTo>
                    <a:pt x="225" y="800"/>
                  </a:lnTo>
                  <a:lnTo>
                    <a:pt x="226" y="800"/>
                  </a:lnTo>
                  <a:lnTo>
                    <a:pt x="226" y="798"/>
                  </a:lnTo>
                  <a:lnTo>
                    <a:pt x="227" y="800"/>
                  </a:lnTo>
                  <a:lnTo>
                    <a:pt x="227" y="798"/>
                  </a:lnTo>
                  <a:lnTo>
                    <a:pt x="228" y="800"/>
                  </a:lnTo>
                  <a:lnTo>
                    <a:pt x="228" y="799"/>
                  </a:lnTo>
                  <a:lnTo>
                    <a:pt x="229" y="800"/>
                  </a:lnTo>
                  <a:lnTo>
                    <a:pt x="229" y="799"/>
                  </a:lnTo>
                  <a:lnTo>
                    <a:pt x="230" y="797"/>
                  </a:lnTo>
                  <a:lnTo>
                    <a:pt x="230" y="800"/>
                  </a:lnTo>
                  <a:lnTo>
                    <a:pt x="231" y="797"/>
                  </a:lnTo>
                  <a:lnTo>
                    <a:pt x="231" y="800"/>
                  </a:lnTo>
                  <a:lnTo>
                    <a:pt x="232" y="795"/>
                  </a:lnTo>
                  <a:lnTo>
                    <a:pt x="232" y="800"/>
                  </a:lnTo>
                  <a:lnTo>
                    <a:pt x="233" y="797"/>
                  </a:lnTo>
                  <a:lnTo>
                    <a:pt x="233" y="800"/>
                  </a:lnTo>
                  <a:lnTo>
                    <a:pt x="234" y="797"/>
                  </a:lnTo>
                  <a:lnTo>
                    <a:pt x="234" y="800"/>
                  </a:lnTo>
                  <a:lnTo>
                    <a:pt x="235" y="800"/>
                  </a:lnTo>
                  <a:lnTo>
                    <a:pt x="235" y="795"/>
                  </a:lnTo>
                  <a:lnTo>
                    <a:pt x="236" y="800"/>
                  </a:lnTo>
                  <a:lnTo>
                    <a:pt x="236" y="786"/>
                  </a:lnTo>
                  <a:lnTo>
                    <a:pt x="237" y="800"/>
                  </a:lnTo>
                  <a:lnTo>
                    <a:pt x="237" y="789"/>
                  </a:lnTo>
                  <a:lnTo>
                    <a:pt x="238" y="800"/>
                  </a:lnTo>
                  <a:lnTo>
                    <a:pt x="238" y="791"/>
                  </a:lnTo>
                  <a:lnTo>
                    <a:pt x="239" y="800"/>
                  </a:lnTo>
                  <a:lnTo>
                    <a:pt x="239" y="791"/>
                  </a:lnTo>
                  <a:lnTo>
                    <a:pt x="240" y="800"/>
                  </a:lnTo>
                  <a:lnTo>
                    <a:pt x="240" y="791"/>
                  </a:lnTo>
                  <a:lnTo>
                    <a:pt x="241" y="800"/>
                  </a:lnTo>
                  <a:lnTo>
                    <a:pt x="241" y="797"/>
                  </a:lnTo>
                  <a:lnTo>
                    <a:pt x="242" y="800"/>
                  </a:lnTo>
                  <a:lnTo>
                    <a:pt x="242" y="798"/>
                  </a:lnTo>
                  <a:lnTo>
                    <a:pt x="243" y="796"/>
                  </a:lnTo>
                  <a:lnTo>
                    <a:pt x="243" y="800"/>
                  </a:lnTo>
                  <a:lnTo>
                    <a:pt x="244" y="793"/>
                  </a:lnTo>
                  <a:lnTo>
                    <a:pt x="244" y="800"/>
                  </a:lnTo>
                  <a:lnTo>
                    <a:pt x="245" y="794"/>
                  </a:lnTo>
                  <a:lnTo>
                    <a:pt x="245" y="800"/>
                  </a:lnTo>
                  <a:lnTo>
                    <a:pt x="246" y="796"/>
                  </a:lnTo>
                  <a:lnTo>
                    <a:pt x="246" y="800"/>
                  </a:lnTo>
                  <a:lnTo>
                    <a:pt x="247" y="795"/>
                  </a:lnTo>
                  <a:lnTo>
                    <a:pt x="247" y="800"/>
                  </a:lnTo>
                  <a:lnTo>
                    <a:pt x="248" y="800"/>
                  </a:lnTo>
                  <a:lnTo>
                    <a:pt x="248" y="796"/>
                  </a:lnTo>
                  <a:lnTo>
                    <a:pt x="249" y="796"/>
                  </a:lnTo>
                  <a:lnTo>
                    <a:pt x="249" y="800"/>
                  </a:lnTo>
                  <a:lnTo>
                    <a:pt x="250" y="789"/>
                  </a:lnTo>
                  <a:lnTo>
                    <a:pt x="250" y="800"/>
                  </a:lnTo>
                  <a:lnTo>
                    <a:pt x="251" y="788"/>
                  </a:lnTo>
                  <a:lnTo>
                    <a:pt x="251" y="800"/>
                  </a:lnTo>
                  <a:lnTo>
                    <a:pt x="252" y="791"/>
                  </a:lnTo>
                  <a:lnTo>
                    <a:pt x="252" y="800"/>
                  </a:lnTo>
                  <a:lnTo>
                    <a:pt x="253" y="795"/>
                  </a:lnTo>
                  <a:lnTo>
                    <a:pt x="253" y="800"/>
                  </a:lnTo>
                  <a:lnTo>
                    <a:pt x="254" y="800"/>
                  </a:lnTo>
                  <a:lnTo>
                    <a:pt x="254" y="788"/>
                  </a:lnTo>
                  <a:lnTo>
                    <a:pt x="255" y="800"/>
                  </a:lnTo>
                  <a:lnTo>
                    <a:pt x="255" y="785"/>
                  </a:lnTo>
                  <a:lnTo>
                    <a:pt x="256" y="800"/>
                  </a:lnTo>
                  <a:lnTo>
                    <a:pt x="256" y="785"/>
                  </a:lnTo>
                  <a:lnTo>
                    <a:pt x="257" y="800"/>
                  </a:lnTo>
                  <a:lnTo>
                    <a:pt x="257" y="783"/>
                  </a:lnTo>
                  <a:lnTo>
                    <a:pt x="258" y="800"/>
                  </a:lnTo>
                  <a:lnTo>
                    <a:pt x="258" y="788"/>
                  </a:lnTo>
                  <a:lnTo>
                    <a:pt x="259" y="800"/>
                  </a:lnTo>
                  <a:lnTo>
                    <a:pt x="259" y="782"/>
                  </a:lnTo>
                  <a:lnTo>
                    <a:pt x="260" y="800"/>
                  </a:lnTo>
                  <a:lnTo>
                    <a:pt x="260" y="768"/>
                  </a:lnTo>
                  <a:lnTo>
                    <a:pt x="261" y="800"/>
                  </a:lnTo>
                  <a:lnTo>
                    <a:pt x="261" y="781"/>
                  </a:lnTo>
                  <a:lnTo>
                    <a:pt x="262" y="794"/>
                  </a:lnTo>
                  <a:lnTo>
                    <a:pt x="262" y="800"/>
                  </a:lnTo>
                  <a:lnTo>
                    <a:pt x="263" y="800"/>
                  </a:lnTo>
                  <a:lnTo>
                    <a:pt x="263" y="799"/>
                  </a:lnTo>
                  <a:lnTo>
                    <a:pt x="264" y="800"/>
                  </a:lnTo>
                  <a:lnTo>
                    <a:pt x="264" y="798"/>
                  </a:lnTo>
                  <a:lnTo>
                    <a:pt x="265" y="800"/>
                  </a:lnTo>
                  <a:lnTo>
                    <a:pt x="265" y="797"/>
                  </a:lnTo>
                  <a:lnTo>
                    <a:pt x="266" y="800"/>
                  </a:lnTo>
                  <a:lnTo>
                    <a:pt x="266" y="791"/>
                  </a:lnTo>
                  <a:lnTo>
                    <a:pt x="267" y="800"/>
                  </a:lnTo>
                  <a:lnTo>
                    <a:pt x="267" y="788"/>
                  </a:lnTo>
                  <a:lnTo>
                    <a:pt x="268" y="793"/>
                  </a:lnTo>
                  <a:lnTo>
                    <a:pt x="268" y="800"/>
                  </a:lnTo>
                  <a:lnTo>
                    <a:pt x="269" y="788"/>
                  </a:lnTo>
                  <a:lnTo>
                    <a:pt x="269" y="800"/>
                  </a:lnTo>
                  <a:lnTo>
                    <a:pt x="270" y="800"/>
                  </a:lnTo>
                  <a:lnTo>
                    <a:pt x="270" y="766"/>
                  </a:lnTo>
                  <a:lnTo>
                    <a:pt x="271" y="759"/>
                  </a:lnTo>
                  <a:lnTo>
                    <a:pt x="271" y="800"/>
                  </a:lnTo>
                  <a:lnTo>
                    <a:pt x="272" y="777"/>
                  </a:lnTo>
                  <a:lnTo>
                    <a:pt x="272" y="800"/>
                  </a:lnTo>
                  <a:lnTo>
                    <a:pt x="273" y="783"/>
                  </a:lnTo>
                  <a:lnTo>
                    <a:pt x="273" y="800"/>
                  </a:lnTo>
                  <a:lnTo>
                    <a:pt x="274" y="800"/>
                  </a:lnTo>
                  <a:lnTo>
                    <a:pt x="274" y="798"/>
                  </a:lnTo>
                  <a:lnTo>
                    <a:pt x="275" y="800"/>
                  </a:lnTo>
                  <a:lnTo>
                    <a:pt x="275" y="797"/>
                  </a:lnTo>
                  <a:lnTo>
                    <a:pt x="276" y="800"/>
                  </a:lnTo>
                  <a:lnTo>
                    <a:pt x="276" y="795"/>
                  </a:lnTo>
                  <a:lnTo>
                    <a:pt x="277" y="800"/>
                  </a:lnTo>
                  <a:lnTo>
                    <a:pt x="277" y="791"/>
                  </a:lnTo>
                  <a:lnTo>
                    <a:pt x="278" y="800"/>
                  </a:lnTo>
                  <a:lnTo>
                    <a:pt x="278" y="791"/>
                  </a:lnTo>
                  <a:lnTo>
                    <a:pt x="279" y="772"/>
                  </a:lnTo>
                  <a:lnTo>
                    <a:pt x="279" y="800"/>
                  </a:lnTo>
                  <a:lnTo>
                    <a:pt x="280" y="800"/>
                  </a:lnTo>
                  <a:lnTo>
                    <a:pt x="280" y="753"/>
                  </a:lnTo>
                  <a:lnTo>
                    <a:pt x="281" y="755"/>
                  </a:lnTo>
                  <a:lnTo>
                    <a:pt x="281" y="800"/>
                  </a:lnTo>
                  <a:lnTo>
                    <a:pt x="282" y="800"/>
                  </a:lnTo>
                  <a:lnTo>
                    <a:pt x="282" y="773"/>
                  </a:lnTo>
                  <a:lnTo>
                    <a:pt x="283" y="793"/>
                  </a:lnTo>
                  <a:lnTo>
                    <a:pt x="283" y="800"/>
                  </a:lnTo>
                  <a:lnTo>
                    <a:pt x="284" y="800"/>
                  </a:lnTo>
                  <a:lnTo>
                    <a:pt x="284" y="795"/>
                  </a:lnTo>
                  <a:lnTo>
                    <a:pt x="285" y="793"/>
                  </a:lnTo>
                  <a:lnTo>
                    <a:pt x="285" y="800"/>
                  </a:lnTo>
                  <a:lnTo>
                    <a:pt x="286" y="795"/>
                  </a:lnTo>
                  <a:lnTo>
                    <a:pt x="286" y="800"/>
                  </a:lnTo>
                  <a:lnTo>
                    <a:pt x="287" y="796"/>
                  </a:lnTo>
                  <a:lnTo>
                    <a:pt x="287" y="800"/>
                  </a:lnTo>
                  <a:lnTo>
                    <a:pt x="288" y="794"/>
                  </a:lnTo>
                  <a:lnTo>
                    <a:pt x="288" y="800"/>
                  </a:lnTo>
                  <a:lnTo>
                    <a:pt x="289" y="800"/>
                  </a:lnTo>
                  <a:lnTo>
                    <a:pt x="289" y="784"/>
                  </a:lnTo>
                  <a:lnTo>
                    <a:pt x="290" y="774"/>
                  </a:lnTo>
                  <a:lnTo>
                    <a:pt x="290" y="800"/>
                  </a:lnTo>
                  <a:lnTo>
                    <a:pt x="291" y="743"/>
                  </a:lnTo>
                  <a:lnTo>
                    <a:pt x="291" y="800"/>
                  </a:lnTo>
                  <a:lnTo>
                    <a:pt x="292" y="800"/>
                  </a:lnTo>
                  <a:lnTo>
                    <a:pt x="292" y="750"/>
                  </a:lnTo>
                  <a:lnTo>
                    <a:pt x="293" y="800"/>
                  </a:lnTo>
                  <a:lnTo>
                    <a:pt x="293" y="778"/>
                  </a:lnTo>
                  <a:lnTo>
                    <a:pt x="294" y="800"/>
                  </a:lnTo>
                  <a:lnTo>
                    <a:pt x="294" y="793"/>
                  </a:lnTo>
                  <a:lnTo>
                    <a:pt x="295" y="800"/>
                  </a:lnTo>
                  <a:lnTo>
                    <a:pt x="295" y="795"/>
                  </a:lnTo>
                  <a:lnTo>
                    <a:pt x="296" y="800"/>
                  </a:lnTo>
                  <a:lnTo>
                    <a:pt x="296" y="790"/>
                  </a:lnTo>
                  <a:lnTo>
                    <a:pt x="297" y="800"/>
                  </a:lnTo>
                  <a:lnTo>
                    <a:pt x="297" y="793"/>
                  </a:lnTo>
                  <a:lnTo>
                    <a:pt x="298" y="798"/>
                  </a:lnTo>
                  <a:lnTo>
                    <a:pt x="298" y="800"/>
                  </a:lnTo>
                  <a:lnTo>
                    <a:pt x="299" y="798"/>
                  </a:lnTo>
                  <a:lnTo>
                    <a:pt x="299" y="800"/>
                  </a:lnTo>
                  <a:lnTo>
                    <a:pt x="300" y="795"/>
                  </a:lnTo>
                  <a:lnTo>
                    <a:pt x="300" y="800"/>
                  </a:lnTo>
                  <a:lnTo>
                    <a:pt x="301" y="800"/>
                  </a:lnTo>
                  <a:lnTo>
                    <a:pt x="301" y="793"/>
                  </a:lnTo>
                  <a:lnTo>
                    <a:pt x="302" y="800"/>
                  </a:lnTo>
                  <a:lnTo>
                    <a:pt x="302" y="786"/>
                  </a:lnTo>
                  <a:lnTo>
                    <a:pt x="303" y="800"/>
                  </a:lnTo>
                  <a:lnTo>
                    <a:pt x="303" y="746"/>
                  </a:lnTo>
                  <a:lnTo>
                    <a:pt x="304" y="800"/>
                  </a:lnTo>
                  <a:lnTo>
                    <a:pt x="304" y="749"/>
                  </a:lnTo>
                  <a:lnTo>
                    <a:pt x="305" y="800"/>
                  </a:lnTo>
                  <a:lnTo>
                    <a:pt x="305" y="774"/>
                  </a:lnTo>
                  <a:lnTo>
                    <a:pt x="306" y="792"/>
                  </a:lnTo>
                  <a:lnTo>
                    <a:pt x="306" y="800"/>
                  </a:lnTo>
                  <a:lnTo>
                    <a:pt x="307" y="798"/>
                  </a:lnTo>
                  <a:lnTo>
                    <a:pt x="307" y="800"/>
                  </a:lnTo>
                  <a:lnTo>
                    <a:pt x="308" y="800"/>
                  </a:lnTo>
                  <a:lnTo>
                    <a:pt x="308" y="793"/>
                  </a:lnTo>
                  <a:lnTo>
                    <a:pt x="309" y="800"/>
                  </a:lnTo>
                  <a:lnTo>
                    <a:pt x="309" y="770"/>
                  </a:lnTo>
                  <a:lnTo>
                    <a:pt x="310" y="748"/>
                  </a:lnTo>
                  <a:lnTo>
                    <a:pt x="310" y="800"/>
                  </a:lnTo>
                  <a:lnTo>
                    <a:pt x="311" y="800"/>
                  </a:lnTo>
                  <a:lnTo>
                    <a:pt x="311" y="768"/>
                  </a:lnTo>
                  <a:lnTo>
                    <a:pt x="312" y="800"/>
                  </a:lnTo>
                  <a:lnTo>
                    <a:pt x="312" y="786"/>
                  </a:lnTo>
                  <a:lnTo>
                    <a:pt x="313" y="791"/>
                  </a:lnTo>
                  <a:lnTo>
                    <a:pt x="313" y="800"/>
                  </a:lnTo>
                  <a:lnTo>
                    <a:pt x="314" y="800"/>
                  </a:lnTo>
                  <a:lnTo>
                    <a:pt x="314" y="776"/>
                  </a:lnTo>
                  <a:lnTo>
                    <a:pt x="315" y="800"/>
                  </a:lnTo>
                  <a:lnTo>
                    <a:pt x="315" y="774"/>
                  </a:lnTo>
                  <a:lnTo>
                    <a:pt x="316" y="787"/>
                  </a:lnTo>
                  <a:lnTo>
                    <a:pt x="316" y="800"/>
                  </a:lnTo>
                  <a:lnTo>
                    <a:pt x="317" y="800"/>
                  </a:lnTo>
                  <a:lnTo>
                    <a:pt x="317" y="795"/>
                  </a:lnTo>
                  <a:lnTo>
                    <a:pt x="318" y="800"/>
                  </a:lnTo>
                  <a:lnTo>
                    <a:pt x="318" y="793"/>
                  </a:lnTo>
                  <a:lnTo>
                    <a:pt x="319" y="800"/>
                  </a:lnTo>
                  <a:lnTo>
                    <a:pt x="319" y="772"/>
                  </a:lnTo>
                  <a:lnTo>
                    <a:pt x="320" y="800"/>
                  </a:lnTo>
                  <a:lnTo>
                    <a:pt x="320" y="729"/>
                  </a:lnTo>
                  <a:lnTo>
                    <a:pt x="321" y="685"/>
                  </a:lnTo>
                  <a:lnTo>
                    <a:pt x="321" y="800"/>
                  </a:lnTo>
                  <a:lnTo>
                    <a:pt x="322" y="800"/>
                  </a:lnTo>
                  <a:lnTo>
                    <a:pt x="322" y="708"/>
                  </a:lnTo>
                  <a:lnTo>
                    <a:pt x="323" y="800"/>
                  </a:lnTo>
                  <a:lnTo>
                    <a:pt x="323" y="689"/>
                  </a:lnTo>
                  <a:lnTo>
                    <a:pt x="324" y="800"/>
                  </a:lnTo>
                  <a:lnTo>
                    <a:pt x="324" y="678"/>
                  </a:lnTo>
                  <a:lnTo>
                    <a:pt x="325" y="691"/>
                  </a:lnTo>
                  <a:lnTo>
                    <a:pt x="325" y="800"/>
                  </a:lnTo>
                  <a:lnTo>
                    <a:pt x="326" y="734"/>
                  </a:lnTo>
                  <a:lnTo>
                    <a:pt x="326" y="800"/>
                  </a:lnTo>
                  <a:lnTo>
                    <a:pt x="327" y="800"/>
                  </a:lnTo>
                  <a:lnTo>
                    <a:pt x="327" y="767"/>
                  </a:lnTo>
                  <a:lnTo>
                    <a:pt x="328" y="800"/>
                  </a:lnTo>
                  <a:lnTo>
                    <a:pt x="328" y="784"/>
                  </a:lnTo>
                  <a:lnTo>
                    <a:pt x="329" y="800"/>
                  </a:lnTo>
                  <a:lnTo>
                    <a:pt x="329" y="781"/>
                  </a:lnTo>
                  <a:lnTo>
                    <a:pt x="330" y="800"/>
                  </a:lnTo>
                  <a:lnTo>
                    <a:pt x="330" y="781"/>
                  </a:lnTo>
                  <a:lnTo>
                    <a:pt x="331" y="785"/>
                  </a:lnTo>
                  <a:lnTo>
                    <a:pt x="331" y="800"/>
                  </a:lnTo>
                  <a:lnTo>
                    <a:pt x="332" y="800"/>
                  </a:lnTo>
                  <a:lnTo>
                    <a:pt x="332" y="793"/>
                  </a:lnTo>
                  <a:lnTo>
                    <a:pt x="333" y="800"/>
                  </a:lnTo>
                  <a:lnTo>
                    <a:pt x="333" y="785"/>
                  </a:lnTo>
                  <a:lnTo>
                    <a:pt x="334" y="800"/>
                  </a:lnTo>
                  <a:lnTo>
                    <a:pt x="334" y="784"/>
                  </a:lnTo>
                  <a:lnTo>
                    <a:pt x="335" y="800"/>
                  </a:lnTo>
                  <a:lnTo>
                    <a:pt x="335" y="792"/>
                  </a:lnTo>
                  <a:lnTo>
                    <a:pt x="336" y="800"/>
                  </a:lnTo>
                  <a:lnTo>
                    <a:pt x="336" y="793"/>
                  </a:lnTo>
                  <a:lnTo>
                    <a:pt x="337" y="800"/>
                  </a:lnTo>
                  <a:lnTo>
                    <a:pt x="337" y="781"/>
                  </a:lnTo>
                  <a:lnTo>
                    <a:pt x="338" y="777"/>
                  </a:lnTo>
                  <a:lnTo>
                    <a:pt x="338" y="800"/>
                  </a:lnTo>
                  <a:lnTo>
                    <a:pt x="339" y="788"/>
                  </a:lnTo>
                  <a:lnTo>
                    <a:pt x="339" y="800"/>
                  </a:lnTo>
                  <a:lnTo>
                    <a:pt x="340" y="800"/>
                  </a:lnTo>
                  <a:lnTo>
                    <a:pt x="340" y="795"/>
                  </a:lnTo>
                  <a:lnTo>
                    <a:pt x="341" y="800"/>
                  </a:lnTo>
                  <a:lnTo>
                    <a:pt x="341" y="790"/>
                  </a:lnTo>
                  <a:lnTo>
                    <a:pt x="342" y="789"/>
                  </a:lnTo>
                  <a:lnTo>
                    <a:pt x="342" y="800"/>
                  </a:lnTo>
                  <a:lnTo>
                    <a:pt x="343" y="789"/>
                  </a:lnTo>
                  <a:lnTo>
                    <a:pt x="343" y="800"/>
                  </a:lnTo>
                  <a:lnTo>
                    <a:pt x="344" y="800"/>
                  </a:lnTo>
                  <a:lnTo>
                    <a:pt x="344" y="794"/>
                  </a:lnTo>
                  <a:lnTo>
                    <a:pt x="345" y="797"/>
                  </a:lnTo>
                  <a:lnTo>
                    <a:pt x="345" y="800"/>
                  </a:lnTo>
                  <a:lnTo>
                    <a:pt x="346" y="797"/>
                  </a:lnTo>
                  <a:lnTo>
                    <a:pt x="346" y="800"/>
                  </a:lnTo>
                  <a:lnTo>
                    <a:pt x="347" y="800"/>
                  </a:lnTo>
                  <a:lnTo>
                    <a:pt x="347" y="800"/>
                  </a:lnTo>
                  <a:lnTo>
                    <a:pt x="348" y="800"/>
                  </a:lnTo>
                  <a:lnTo>
                    <a:pt x="348" y="799"/>
                  </a:lnTo>
                  <a:lnTo>
                    <a:pt x="349" y="800"/>
                  </a:lnTo>
                  <a:lnTo>
                    <a:pt x="349" y="799"/>
                  </a:lnTo>
                  <a:lnTo>
                    <a:pt x="350" y="800"/>
                  </a:lnTo>
                  <a:lnTo>
                    <a:pt x="350" y="796"/>
                  </a:lnTo>
                  <a:lnTo>
                    <a:pt x="351" y="800"/>
                  </a:lnTo>
                  <a:lnTo>
                    <a:pt x="351" y="787"/>
                  </a:lnTo>
                  <a:lnTo>
                    <a:pt x="352" y="800"/>
                  </a:lnTo>
                  <a:lnTo>
                    <a:pt x="352" y="778"/>
                  </a:lnTo>
                  <a:lnTo>
                    <a:pt x="353" y="778"/>
                  </a:lnTo>
                  <a:lnTo>
                    <a:pt x="353" y="800"/>
                  </a:lnTo>
                  <a:lnTo>
                    <a:pt x="354" y="800"/>
                  </a:lnTo>
                  <a:lnTo>
                    <a:pt x="354" y="777"/>
                  </a:lnTo>
                  <a:lnTo>
                    <a:pt x="355" y="784"/>
                  </a:lnTo>
                  <a:lnTo>
                    <a:pt x="355" y="800"/>
                  </a:lnTo>
                  <a:lnTo>
                    <a:pt x="356" y="791"/>
                  </a:lnTo>
                  <a:lnTo>
                    <a:pt x="356" y="800"/>
                  </a:lnTo>
                  <a:lnTo>
                    <a:pt x="357" y="795"/>
                  </a:lnTo>
                  <a:lnTo>
                    <a:pt x="357" y="800"/>
                  </a:lnTo>
                  <a:lnTo>
                    <a:pt x="358" y="795"/>
                  </a:lnTo>
                  <a:lnTo>
                    <a:pt x="358" y="800"/>
                  </a:lnTo>
                  <a:lnTo>
                    <a:pt x="359" y="798"/>
                  </a:lnTo>
                  <a:lnTo>
                    <a:pt x="359" y="800"/>
                  </a:lnTo>
                  <a:lnTo>
                    <a:pt x="360" y="798"/>
                  </a:lnTo>
                  <a:lnTo>
                    <a:pt x="360" y="800"/>
                  </a:lnTo>
                  <a:lnTo>
                    <a:pt x="361" y="799"/>
                  </a:lnTo>
                  <a:lnTo>
                    <a:pt x="361" y="800"/>
                  </a:lnTo>
                  <a:lnTo>
                    <a:pt x="362" y="800"/>
                  </a:lnTo>
                  <a:lnTo>
                    <a:pt x="362" y="797"/>
                  </a:lnTo>
                  <a:lnTo>
                    <a:pt x="363" y="800"/>
                  </a:lnTo>
                  <a:lnTo>
                    <a:pt x="363" y="797"/>
                  </a:lnTo>
                  <a:lnTo>
                    <a:pt x="364" y="800"/>
                  </a:lnTo>
                  <a:lnTo>
                    <a:pt x="364" y="798"/>
                  </a:lnTo>
                  <a:lnTo>
                    <a:pt x="365" y="800"/>
                  </a:lnTo>
                  <a:lnTo>
                    <a:pt x="365" y="799"/>
                  </a:lnTo>
                  <a:lnTo>
                    <a:pt x="366" y="800"/>
                  </a:lnTo>
                  <a:lnTo>
                    <a:pt x="366" y="799"/>
                  </a:lnTo>
                  <a:lnTo>
                    <a:pt x="367" y="800"/>
                  </a:lnTo>
                  <a:lnTo>
                    <a:pt x="367" y="793"/>
                  </a:lnTo>
                  <a:lnTo>
                    <a:pt x="368" y="800"/>
                  </a:lnTo>
                  <a:lnTo>
                    <a:pt x="368" y="782"/>
                  </a:lnTo>
                  <a:lnTo>
                    <a:pt x="369" y="800"/>
                  </a:lnTo>
                  <a:lnTo>
                    <a:pt x="369" y="779"/>
                  </a:lnTo>
                  <a:lnTo>
                    <a:pt x="370" y="789"/>
                  </a:lnTo>
                  <a:lnTo>
                    <a:pt x="370" y="800"/>
                  </a:lnTo>
                  <a:lnTo>
                    <a:pt x="371" y="796"/>
                  </a:lnTo>
                  <a:lnTo>
                    <a:pt x="371" y="800"/>
                  </a:lnTo>
                  <a:lnTo>
                    <a:pt x="372" y="790"/>
                  </a:lnTo>
                  <a:lnTo>
                    <a:pt x="372" y="800"/>
                  </a:lnTo>
                  <a:lnTo>
                    <a:pt x="373" y="768"/>
                  </a:lnTo>
                  <a:lnTo>
                    <a:pt x="373" y="800"/>
                  </a:lnTo>
                  <a:lnTo>
                    <a:pt x="374" y="800"/>
                  </a:lnTo>
                  <a:lnTo>
                    <a:pt x="374" y="743"/>
                  </a:lnTo>
                  <a:lnTo>
                    <a:pt x="375" y="751"/>
                  </a:lnTo>
                  <a:lnTo>
                    <a:pt x="375" y="800"/>
                  </a:lnTo>
                  <a:lnTo>
                    <a:pt x="376" y="776"/>
                  </a:lnTo>
                  <a:lnTo>
                    <a:pt x="376" y="800"/>
                  </a:lnTo>
                  <a:lnTo>
                    <a:pt x="377" y="792"/>
                  </a:lnTo>
                  <a:lnTo>
                    <a:pt x="377" y="800"/>
                  </a:lnTo>
                  <a:lnTo>
                    <a:pt x="378" y="798"/>
                  </a:lnTo>
                  <a:lnTo>
                    <a:pt x="378" y="800"/>
                  </a:lnTo>
                  <a:lnTo>
                    <a:pt x="379" y="800"/>
                  </a:lnTo>
                  <a:lnTo>
                    <a:pt x="379" y="798"/>
                  </a:lnTo>
                  <a:lnTo>
                    <a:pt x="380" y="800"/>
                  </a:lnTo>
                  <a:lnTo>
                    <a:pt x="380" y="794"/>
                  </a:lnTo>
                  <a:lnTo>
                    <a:pt x="381" y="786"/>
                  </a:lnTo>
                  <a:lnTo>
                    <a:pt x="381" y="800"/>
                  </a:lnTo>
                  <a:lnTo>
                    <a:pt x="382" y="800"/>
                  </a:lnTo>
                  <a:lnTo>
                    <a:pt x="382" y="783"/>
                  </a:lnTo>
                  <a:lnTo>
                    <a:pt x="383" y="800"/>
                  </a:lnTo>
                  <a:lnTo>
                    <a:pt x="383" y="787"/>
                  </a:lnTo>
                  <a:lnTo>
                    <a:pt x="384" y="800"/>
                  </a:lnTo>
                  <a:lnTo>
                    <a:pt x="384" y="785"/>
                  </a:lnTo>
                  <a:lnTo>
                    <a:pt x="385" y="780"/>
                  </a:lnTo>
                  <a:lnTo>
                    <a:pt x="385" y="800"/>
                  </a:lnTo>
                  <a:lnTo>
                    <a:pt x="386" y="785"/>
                  </a:lnTo>
                  <a:lnTo>
                    <a:pt x="386" y="800"/>
                  </a:lnTo>
                  <a:lnTo>
                    <a:pt x="387" y="792"/>
                  </a:lnTo>
                  <a:lnTo>
                    <a:pt x="387" y="800"/>
                  </a:lnTo>
                  <a:lnTo>
                    <a:pt x="388" y="800"/>
                  </a:lnTo>
                  <a:lnTo>
                    <a:pt x="388" y="795"/>
                  </a:lnTo>
                  <a:lnTo>
                    <a:pt x="389" y="800"/>
                  </a:lnTo>
                  <a:lnTo>
                    <a:pt x="389" y="795"/>
                  </a:lnTo>
                  <a:lnTo>
                    <a:pt x="390" y="795"/>
                  </a:lnTo>
                  <a:lnTo>
                    <a:pt x="390" y="800"/>
                  </a:lnTo>
                  <a:lnTo>
                    <a:pt x="391" y="798"/>
                  </a:lnTo>
                  <a:lnTo>
                    <a:pt x="391" y="800"/>
                  </a:lnTo>
                  <a:lnTo>
                    <a:pt x="392" y="800"/>
                  </a:lnTo>
                  <a:lnTo>
                    <a:pt x="392" y="794"/>
                  </a:lnTo>
                  <a:lnTo>
                    <a:pt x="393" y="800"/>
                  </a:lnTo>
                  <a:lnTo>
                    <a:pt x="393" y="793"/>
                  </a:lnTo>
                  <a:lnTo>
                    <a:pt x="394" y="800"/>
                  </a:lnTo>
                  <a:lnTo>
                    <a:pt x="394" y="792"/>
                  </a:lnTo>
                  <a:lnTo>
                    <a:pt x="395" y="800"/>
                  </a:lnTo>
                  <a:lnTo>
                    <a:pt x="395" y="783"/>
                  </a:lnTo>
                  <a:lnTo>
                    <a:pt x="396" y="800"/>
                  </a:lnTo>
                  <a:lnTo>
                    <a:pt x="396" y="764"/>
                  </a:lnTo>
                  <a:lnTo>
                    <a:pt x="397" y="791"/>
                  </a:lnTo>
                  <a:lnTo>
                    <a:pt x="397" y="800"/>
                  </a:lnTo>
                  <a:lnTo>
                    <a:pt x="398" y="794"/>
                  </a:lnTo>
                  <a:lnTo>
                    <a:pt x="398" y="800"/>
                  </a:lnTo>
                  <a:lnTo>
                    <a:pt x="399" y="792"/>
                  </a:lnTo>
                  <a:lnTo>
                    <a:pt x="399" y="800"/>
                  </a:lnTo>
                  <a:lnTo>
                    <a:pt x="400" y="795"/>
                  </a:lnTo>
                  <a:lnTo>
                    <a:pt x="400" y="800"/>
                  </a:lnTo>
                  <a:lnTo>
                    <a:pt x="401" y="795"/>
                  </a:lnTo>
                  <a:lnTo>
                    <a:pt x="401" y="800"/>
                  </a:lnTo>
                  <a:lnTo>
                    <a:pt x="402" y="794"/>
                  </a:lnTo>
                  <a:lnTo>
                    <a:pt x="402" y="800"/>
                  </a:lnTo>
                  <a:lnTo>
                    <a:pt x="403" y="800"/>
                  </a:lnTo>
                  <a:lnTo>
                    <a:pt x="403" y="797"/>
                  </a:lnTo>
                  <a:lnTo>
                    <a:pt x="404" y="800"/>
                  </a:lnTo>
                  <a:lnTo>
                    <a:pt x="404" y="799"/>
                  </a:lnTo>
                  <a:lnTo>
                    <a:pt x="405" y="799"/>
                  </a:lnTo>
                  <a:lnTo>
                    <a:pt x="405" y="800"/>
                  </a:lnTo>
                  <a:lnTo>
                    <a:pt x="406" y="800"/>
                  </a:lnTo>
                  <a:lnTo>
                    <a:pt x="406" y="799"/>
                  </a:lnTo>
                  <a:lnTo>
                    <a:pt x="407" y="797"/>
                  </a:lnTo>
                  <a:lnTo>
                    <a:pt x="407" y="800"/>
                  </a:lnTo>
                  <a:lnTo>
                    <a:pt x="408" y="800"/>
                  </a:lnTo>
                  <a:lnTo>
                    <a:pt x="408" y="796"/>
                  </a:lnTo>
                  <a:lnTo>
                    <a:pt x="409" y="791"/>
                  </a:lnTo>
                  <a:lnTo>
                    <a:pt x="409" y="800"/>
                  </a:lnTo>
                  <a:lnTo>
                    <a:pt x="410" y="800"/>
                  </a:lnTo>
                  <a:lnTo>
                    <a:pt x="410" y="783"/>
                  </a:lnTo>
                  <a:lnTo>
                    <a:pt x="411" y="800"/>
                  </a:lnTo>
                  <a:lnTo>
                    <a:pt x="411" y="776"/>
                  </a:lnTo>
                  <a:lnTo>
                    <a:pt x="412" y="800"/>
                  </a:lnTo>
                  <a:lnTo>
                    <a:pt x="412" y="784"/>
                  </a:lnTo>
                  <a:lnTo>
                    <a:pt x="413" y="792"/>
                  </a:lnTo>
                  <a:lnTo>
                    <a:pt x="413" y="800"/>
                  </a:lnTo>
                  <a:lnTo>
                    <a:pt x="414" y="791"/>
                  </a:lnTo>
                  <a:lnTo>
                    <a:pt x="414" y="800"/>
                  </a:lnTo>
                  <a:lnTo>
                    <a:pt x="415" y="800"/>
                  </a:lnTo>
                  <a:lnTo>
                    <a:pt x="415" y="794"/>
                  </a:lnTo>
                  <a:lnTo>
                    <a:pt x="416" y="792"/>
                  </a:lnTo>
                  <a:lnTo>
                    <a:pt x="416" y="800"/>
                  </a:lnTo>
                  <a:lnTo>
                    <a:pt x="417" y="783"/>
                  </a:lnTo>
                  <a:lnTo>
                    <a:pt x="417" y="800"/>
                  </a:lnTo>
                  <a:lnTo>
                    <a:pt x="418" y="785"/>
                  </a:lnTo>
                  <a:lnTo>
                    <a:pt x="418" y="800"/>
                  </a:lnTo>
                  <a:lnTo>
                    <a:pt x="419" y="786"/>
                  </a:lnTo>
                  <a:lnTo>
                    <a:pt x="419" y="800"/>
                  </a:lnTo>
                  <a:lnTo>
                    <a:pt x="420" y="792"/>
                  </a:lnTo>
                  <a:lnTo>
                    <a:pt x="420" y="800"/>
                  </a:lnTo>
                  <a:lnTo>
                    <a:pt x="421" y="800"/>
                  </a:lnTo>
                  <a:lnTo>
                    <a:pt x="421" y="797"/>
                  </a:lnTo>
                  <a:lnTo>
                    <a:pt x="422" y="800"/>
                  </a:lnTo>
                  <a:lnTo>
                    <a:pt x="422" y="794"/>
                  </a:lnTo>
                  <a:lnTo>
                    <a:pt x="423" y="800"/>
                  </a:lnTo>
                  <a:lnTo>
                    <a:pt x="423" y="794"/>
                  </a:lnTo>
                  <a:lnTo>
                    <a:pt x="424" y="800"/>
                  </a:lnTo>
                  <a:lnTo>
                    <a:pt x="424" y="797"/>
                  </a:lnTo>
                  <a:lnTo>
                    <a:pt x="425" y="800"/>
                  </a:lnTo>
                  <a:lnTo>
                    <a:pt x="425" y="799"/>
                  </a:lnTo>
                  <a:lnTo>
                    <a:pt x="426" y="800"/>
                  </a:lnTo>
                  <a:lnTo>
                    <a:pt x="426" y="797"/>
                  </a:lnTo>
                  <a:lnTo>
                    <a:pt x="427" y="800"/>
                  </a:lnTo>
                  <a:lnTo>
                    <a:pt x="427" y="786"/>
                  </a:lnTo>
                  <a:lnTo>
                    <a:pt x="428" y="800"/>
                  </a:lnTo>
                  <a:lnTo>
                    <a:pt x="428" y="774"/>
                  </a:lnTo>
                  <a:lnTo>
                    <a:pt x="429" y="800"/>
                  </a:lnTo>
                  <a:lnTo>
                    <a:pt x="429" y="773"/>
                  </a:lnTo>
                  <a:lnTo>
                    <a:pt x="430" y="800"/>
                  </a:lnTo>
                  <a:lnTo>
                    <a:pt x="430" y="783"/>
                  </a:lnTo>
                  <a:lnTo>
                    <a:pt x="431" y="800"/>
                  </a:lnTo>
                  <a:lnTo>
                    <a:pt x="431" y="793"/>
                  </a:lnTo>
                  <a:lnTo>
                    <a:pt x="432" y="791"/>
                  </a:lnTo>
                  <a:lnTo>
                    <a:pt x="432" y="800"/>
                  </a:lnTo>
                  <a:lnTo>
                    <a:pt x="433" y="800"/>
                  </a:lnTo>
                  <a:lnTo>
                    <a:pt x="433" y="784"/>
                  </a:lnTo>
                  <a:lnTo>
                    <a:pt x="434" y="782"/>
                  </a:lnTo>
                  <a:lnTo>
                    <a:pt x="434" y="800"/>
                  </a:lnTo>
                  <a:lnTo>
                    <a:pt x="435" y="776"/>
                  </a:lnTo>
                  <a:lnTo>
                    <a:pt x="435" y="800"/>
                  </a:lnTo>
                  <a:lnTo>
                    <a:pt x="436" y="785"/>
                  </a:lnTo>
                  <a:lnTo>
                    <a:pt x="436" y="800"/>
                  </a:lnTo>
                  <a:lnTo>
                    <a:pt x="437" y="793"/>
                  </a:lnTo>
                  <a:lnTo>
                    <a:pt x="437" y="800"/>
                  </a:lnTo>
                  <a:lnTo>
                    <a:pt x="438" y="800"/>
                  </a:lnTo>
                  <a:lnTo>
                    <a:pt x="438" y="794"/>
                  </a:lnTo>
                  <a:lnTo>
                    <a:pt x="439" y="800"/>
                  </a:lnTo>
                  <a:lnTo>
                    <a:pt x="439" y="792"/>
                  </a:lnTo>
                  <a:lnTo>
                    <a:pt x="440" y="800"/>
                  </a:lnTo>
                  <a:lnTo>
                    <a:pt x="440" y="793"/>
                  </a:lnTo>
                  <a:lnTo>
                    <a:pt x="441" y="800"/>
                  </a:lnTo>
                  <a:lnTo>
                    <a:pt x="441" y="796"/>
                  </a:lnTo>
                  <a:lnTo>
                    <a:pt x="442" y="796"/>
                  </a:lnTo>
                  <a:lnTo>
                    <a:pt x="442" y="800"/>
                  </a:lnTo>
                  <a:lnTo>
                    <a:pt x="443" y="794"/>
                  </a:lnTo>
                  <a:lnTo>
                    <a:pt x="443" y="800"/>
                  </a:lnTo>
                  <a:lnTo>
                    <a:pt x="444" y="800"/>
                  </a:lnTo>
                  <a:lnTo>
                    <a:pt x="444" y="793"/>
                  </a:lnTo>
                  <a:lnTo>
                    <a:pt x="445" y="765"/>
                  </a:lnTo>
                  <a:lnTo>
                    <a:pt x="445" y="800"/>
                  </a:lnTo>
                  <a:lnTo>
                    <a:pt x="446" y="748"/>
                  </a:lnTo>
                  <a:lnTo>
                    <a:pt x="446" y="800"/>
                  </a:lnTo>
                  <a:lnTo>
                    <a:pt x="447" y="800"/>
                  </a:lnTo>
                  <a:lnTo>
                    <a:pt x="447" y="733"/>
                  </a:lnTo>
                  <a:lnTo>
                    <a:pt x="448" y="706"/>
                  </a:lnTo>
                  <a:lnTo>
                    <a:pt x="448" y="800"/>
                  </a:lnTo>
                  <a:lnTo>
                    <a:pt x="449" y="800"/>
                  </a:lnTo>
                  <a:lnTo>
                    <a:pt x="449" y="704"/>
                  </a:lnTo>
                  <a:lnTo>
                    <a:pt x="450" y="800"/>
                  </a:lnTo>
                  <a:lnTo>
                    <a:pt x="450" y="665"/>
                  </a:lnTo>
                  <a:lnTo>
                    <a:pt x="451" y="800"/>
                  </a:lnTo>
                  <a:lnTo>
                    <a:pt x="451" y="753"/>
                  </a:lnTo>
                  <a:lnTo>
                    <a:pt x="452" y="800"/>
                  </a:lnTo>
                  <a:lnTo>
                    <a:pt x="452" y="781"/>
                  </a:lnTo>
                  <a:lnTo>
                    <a:pt x="453" y="788"/>
                  </a:lnTo>
                  <a:lnTo>
                    <a:pt x="453" y="800"/>
                  </a:lnTo>
                  <a:lnTo>
                    <a:pt x="454" y="793"/>
                  </a:lnTo>
                  <a:lnTo>
                    <a:pt x="454" y="800"/>
                  </a:lnTo>
                  <a:lnTo>
                    <a:pt x="455" y="790"/>
                  </a:lnTo>
                  <a:lnTo>
                    <a:pt x="455" y="800"/>
                  </a:lnTo>
                  <a:lnTo>
                    <a:pt x="456" y="800"/>
                  </a:lnTo>
                  <a:lnTo>
                    <a:pt x="456" y="792"/>
                  </a:lnTo>
                  <a:lnTo>
                    <a:pt x="457" y="800"/>
                  </a:lnTo>
                  <a:lnTo>
                    <a:pt x="457" y="793"/>
                  </a:lnTo>
                  <a:lnTo>
                    <a:pt x="458" y="789"/>
                  </a:lnTo>
                  <a:lnTo>
                    <a:pt x="458" y="800"/>
                  </a:lnTo>
                  <a:lnTo>
                    <a:pt x="459" y="800"/>
                  </a:lnTo>
                  <a:lnTo>
                    <a:pt x="459" y="785"/>
                  </a:lnTo>
                  <a:lnTo>
                    <a:pt x="460" y="800"/>
                  </a:lnTo>
                  <a:lnTo>
                    <a:pt x="460" y="788"/>
                  </a:lnTo>
                  <a:lnTo>
                    <a:pt x="461" y="788"/>
                  </a:lnTo>
                  <a:lnTo>
                    <a:pt x="461" y="800"/>
                  </a:lnTo>
                  <a:lnTo>
                    <a:pt x="462" y="785"/>
                  </a:lnTo>
                  <a:lnTo>
                    <a:pt x="462" y="800"/>
                  </a:lnTo>
                  <a:lnTo>
                    <a:pt x="463" y="793"/>
                  </a:lnTo>
                  <a:lnTo>
                    <a:pt x="463" y="800"/>
                  </a:lnTo>
                  <a:lnTo>
                    <a:pt x="464" y="796"/>
                  </a:lnTo>
                  <a:lnTo>
                    <a:pt x="464" y="800"/>
                  </a:lnTo>
                  <a:lnTo>
                    <a:pt x="465" y="800"/>
                  </a:lnTo>
                  <a:lnTo>
                    <a:pt x="465" y="790"/>
                  </a:lnTo>
                  <a:lnTo>
                    <a:pt x="466" y="800"/>
                  </a:lnTo>
                  <a:lnTo>
                    <a:pt x="466" y="781"/>
                  </a:lnTo>
                  <a:lnTo>
                    <a:pt x="467" y="800"/>
                  </a:lnTo>
                  <a:lnTo>
                    <a:pt x="467" y="747"/>
                  </a:lnTo>
                  <a:lnTo>
                    <a:pt x="468" y="800"/>
                  </a:lnTo>
                  <a:lnTo>
                    <a:pt x="468" y="718"/>
                  </a:lnTo>
                  <a:lnTo>
                    <a:pt x="469" y="800"/>
                  </a:lnTo>
                  <a:lnTo>
                    <a:pt x="469" y="689"/>
                  </a:lnTo>
                  <a:lnTo>
                    <a:pt x="470" y="800"/>
                  </a:lnTo>
                  <a:lnTo>
                    <a:pt x="470" y="623"/>
                  </a:lnTo>
                  <a:lnTo>
                    <a:pt x="471" y="800"/>
                  </a:lnTo>
                  <a:lnTo>
                    <a:pt x="471" y="672"/>
                  </a:lnTo>
                  <a:lnTo>
                    <a:pt x="472" y="676"/>
                  </a:lnTo>
                  <a:lnTo>
                    <a:pt x="472" y="800"/>
                  </a:lnTo>
                  <a:lnTo>
                    <a:pt x="473" y="800"/>
                  </a:lnTo>
                  <a:lnTo>
                    <a:pt x="473" y="688"/>
                  </a:lnTo>
                  <a:lnTo>
                    <a:pt x="474" y="664"/>
                  </a:lnTo>
                  <a:lnTo>
                    <a:pt x="474" y="800"/>
                  </a:lnTo>
                  <a:lnTo>
                    <a:pt x="475" y="800"/>
                  </a:lnTo>
                  <a:lnTo>
                    <a:pt x="475" y="628"/>
                  </a:lnTo>
                  <a:lnTo>
                    <a:pt x="476" y="660"/>
                  </a:lnTo>
                  <a:lnTo>
                    <a:pt x="476" y="800"/>
                  </a:lnTo>
                  <a:lnTo>
                    <a:pt x="477" y="726"/>
                  </a:lnTo>
                  <a:lnTo>
                    <a:pt x="477" y="800"/>
                  </a:lnTo>
                  <a:lnTo>
                    <a:pt x="478" y="768"/>
                  </a:lnTo>
                  <a:lnTo>
                    <a:pt x="478" y="800"/>
                  </a:lnTo>
                  <a:lnTo>
                    <a:pt x="479" y="800"/>
                  </a:lnTo>
                  <a:lnTo>
                    <a:pt x="479" y="782"/>
                  </a:lnTo>
                  <a:lnTo>
                    <a:pt x="480" y="800"/>
                  </a:lnTo>
                  <a:lnTo>
                    <a:pt x="480" y="786"/>
                  </a:lnTo>
                  <a:lnTo>
                    <a:pt x="481" y="800"/>
                  </a:lnTo>
                  <a:lnTo>
                    <a:pt x="481" y="792"/>
                  </a:lnTo>
                  <a:lnTo>
                    <a:pt x="482" y="800"/>
                  </a:lnTo>
                  <a:lnTo>
                    <a:pt x="482" y="797"/>
                  </a:lnTo>
                  <a:lnTo>
                    <a:pt x="483" y="800"/>
                  </a:lnTo>
                  <a:lnTo>
                    <a:pt x="483" y="796"/>
                  </a:lnTo>
                  <a:lnTo>
                    <a:pt x="484" y="800"/>
                  </a:lnTo>
                  <a:lnTo>
                    <a:pt x="484" y="792"/>
                  </a:lnTo>
                  <a:lnTo>
                    <a:pt x="485" y="791"/>
                  </a:lnTo>
                  <a:lnTo>
                    <a:pt x="485" y="800"/>
                  </a:lnTo>
                  <a:lnTo>
                    <a:pt x="486" y="797"/>
                  </a:lnTo>
                  <a:lnTo>
                    <a:pt x="486" y="800"/>
                  </a:lnTo>
                  <a:lnTo>
                    <a:pt x="487" y="800"/>
                  </a:lnTo>
                  <a:lnTo>
                    <a:pt x="487" y="797"/>
                  </a:lnTo>
                  <a:lnTo>
                    <a:pt x="488" y="792"/>
                  </a:lnTo>
                  <a:lnTo>
                    <a:pt x="488" y="800"/>
                  </a:lnTo>
                  <a:lnTo>
                    <a:pt x="489" y="800"/>
                  </a:lnTo>
                  <a:lnTo>
                    <a:pt x="489" y="790"/>
                  </a:lnTo>
                  <a:lnTo>
                    <a:pt x="490" y="800"/>
                  </a:lnTo>
                  <a:lnTo>
                    <a:pt x="490" y="766"/>
                  </a:lnTo>
                  <a:lnTo>
                    <a:pt x="491" y="738"/>
                  </a:lnTo>
                  <a:lnTo>
                    <a:pt x="491" y="800"/>
                  </a:lnTo>
                  <a:lnTo>
                    <a:pt x="492" y="720"/>
                  </a:lnTo>
                  <a:lnTo>
                    <a:pt x="492" y="800"/>
                  </a:lnTo>
                  <a:lnTo>
                    <a:pt x="493" y="800"/>
                  </a:lnTo>
                  <a:lnTo>
                    <a:pt x="493" y="776"/>
                  </a:lnTo>
                  <a:lnTo>
                    <a:pt x="494" y="800"/>
                  </a:lnTo>
                  <a:lnTo>
                    <a:pt x="494" y="788"/>
                  </a:lnTo>
                  <a:lnTo>
                    <a:pt x="495" y="800"/>
                  </a:lnTo>
                  <a:lnTo>
                    <a:pt x="495" y="789"/>
                  </a:lnTo>
                  <a:lnTo>
                    <a:pt x="496" y="800"/>
                  </a:lnTo>
                  <a:lnTo>
                    <a:pt x="496" y="790"/>
                  </a:lnTo>
                  <a:lnTo>
                    <a:pt x="497" y="800"/>
                  </a:lnTo>
                  <a:lnTo>
                    <a:pt x="497" y="778"/>
                  </a:lnTo>
                  <a:lnTo>
                    <a:pt x="498" y="789"/>
                  </a:lnTo>
                  <a:lnTo>
                    <a:pt x="498" y="800"/>
                  </a:lnTo>
                  <a:lnTo>
                    <a:pt x="499" y="800"/>
                  </a:lnTo>
                  <a:lnTo>
                    <a:pt x="499" y="794"/>
                  </a:lnTo>
                  <a:lnTo>
                    <a:pt x="500" y="800"/>
                  </a:lnTo>
                  <a:lnTo>
                    <a:pt x="500" y="796"/>
                  </a:lnTo>
                  <a:lnTo>
                    <a:pt x="501" y="796"/>
                  </a:lnTo>
                  <a:lnTo>
                    <a:pt x="501" y="800"/>
                  </a:lnTo>
                  <a:lnTo>
                    <a:pt x="502" y="800"/>
                  </a:lnTo>
                  <a:lnTo>
                    <a:pt x="502" y="797"/>
                  </a:lnTo>
                  <a:lnTo>
                    <a:pt x="503" y="792"/>
                  </a:lnTo>
                  <a:lnTo>
                    <a:pt x="503" y="800"/>
                  </a:lnTo>
                  <a:lnTo>
                    <a:pt x="504" y="790"/>
                  </a:lnTo>
                  <a:lnTo>
                    <a:pt x="504" y="800"/>
                  </a:lnTo>
                  <a:lnTo>
                    <a:pt x="505" y="800"/>
                  </a:lnTo>
                  <a:lnTo>
                    <a:pt x="505" y="789"/>
                  </a:lnTo>
                  <a:lnTo>
                    <a:pt x="506" y="800"/>
                  </a:lnTo>
                  <a:lnTo>
                    <a:pt x="506" y="793"/>
                  </a:lnTo>
                  <a:lnTo>
                    <a:pt x="507" y="800"/>
                  </a:lnTo>
                  <a:lnTo>
                    <a:pt x="507" y="778"/>
                  </a:lnTo>
                  <a:lnTo>
                    <a:pt x="508" y="763"/>
                  </a:lnTo>
                  <a:lnTo>
                    <a:pt x="508" y="800"/>
                  </a:lnTo>
                  <a:lnTo>
                    <a:pt x="509" y="800"/>
                  </a:lnTo>
                  <a:lnTo>
                    <a:pt x="509" y="670"/>
                  </a:lnTo>
                  <a:lnTo>
                    <a:pt x="510" y="800"/>
                  </a:lnTo>
                  <a:lnTo>
                    <a:pt x="510" y="784"/>
                  </a:lnTo>
                  <a:lnTo>
                    <a:pt x="511" y="751"/>
                  </a:lnTo>
                  <a:lnTo>
                    <a:pt x="511" y="800"/>
                  </a:lnTo>
                  <a:lnTo>
                    <a:pt x="512" y="800"/>
                  </a:lnTo>
                  <a:lnTo>
                    <a:pt x="512" y="751"/>
                  </a:lnTo>
                  <a:lnTo>
                    <a:pt x="513" y="754"/>
                  </a:lnTo>
                  <a:lnTo>
                    <a:pt x="513" y="800"/>
                  </a:lnTo>
                  <a:lnTo>
                    <a:pt x="514" y="800"/>
                  </a:lnTo>
                  <a:lnTo>
                    <a:pt x="514" y="773"/>
                  </a:lnTo>
                  <a:lnTo>
                    <a:pt x="515" y="800"/>
                  </a:lnTo>
                  <a:lnTo>
                    <a:pt x="515" y="770"/>
                  </a:lnTo>
                  <a:lnTo>
                    <a:pt x="516" y="800"/>
                  </a:lnTo>
                  <a:lnTo>
                    <a:pt x="516" y="789"/>
                  </a:lnTo>
                  <a:lnTo>
                    <a:pt x="517" y="800"/>
                  </a:lnTo>
                  <a:lnTo>
                    <a:pt x="517" y="788"/>
                  </a:lnTo>
                  <a:lnTo>
                    <a:pt x="518" y="787"/>
                  </a:lnTo>
                  <a:lnTo>
                    <a:pt x="518" y="800"/>
                  </a:lnTo>
                  <a:lnTo>
                    <a:pt x="519" y="800"/>
                  </a:lnTo>
                  <a:lnTo>
                    <a:pt x="519" y="784"/>
                  </a:lnTo>
                  <a:lnTo>
                    <a:pt x="520" y="800"/>
                  </a:lnTo>
                  <a:lnTo>
                    <a:pt x="520" y="783"/>
                  </a:lnTo>
                  <a:lnTo>
                    <a:pt x="521" y="800"/>
                  </a:lnTo>
                  <a:lnTo>
                    <a:pt x="521" y="792"/>
                  </a:lnTo>
                  <a:lnTo>
                    <a:pt x="522" y="800"/>
                  </a:lnTo>
                  <a:lnTo>
                    <a:pt x="522" y="746"/>
                  </a:lnTo>
                  <a:lnTo>
                    <a:pt x="523" y="709"/>
                  </a:lnTo>
                  <a:lnTo>
                    <a:pt x="523" y="800"/>
                  </a:lnTo>
                  <a:lnTo>
                    <a:pt x="524" y="720"/>
                  </a:lnTo>
                  <a:lnTo>
                    <a:pt x="524" y="800"/>
                  </a:lnTo>
                  <a:lnTo>
                    <a:pt x="525" y="752"/>
                  </a:lnTo>
                  <a:lnTo>
                    <a:pt x="525" y="800"/>
                  </a:lnTo>
                  <a:lnTo>
                    <a:pt x="526" y="779"/>
                  </a:lnTo>
                  <a:lnTo>
                    <a:pt x="526" y="800"/>
                  </a:lnTo>
                  <a:lnTo>
                    <a:pt x="527" y="800"/>
                  </a:lnTo>
                  <a:lnTo>
                    <a:pt x="527" y="786"/>
                  </a:lnTo>
                  <a:lnTo>
                    <a:pt x="528" y="792"/>
                  </a:lnTo>
                  <a:lnTo>
                    <a:pt x="528" y="800"/>
                  </a:lnTo>
                  <a:lnTo>
                    <a:pt x="529" y="794"/>
                  </a:lnTo>
                  <a:lnTo>
                    <a:pt x="529" y="800"/>
                  </a:lnTo>
                  <a:lnTo>
                    <a:pt x="530" y="800"/>
                  </a:lnTo>
                  <a:lnTo>
                    <a:pt x="530" y="771"/>
                  </a:lnTo>
                  <a:lnTo>
                    <a:pt x="531" y="800"/>
                  </a:lnTo>
                  <a:lnTo>
                    <a:pt x="531" y="770"/>
                  </a:lnTo>
                  <a:lnTo>
                    <a:pt x="532" y="800"/>
                  </a:lnTo>
                  <a:lnTo>
                    <a:pt x="532" y="780"/>
                  </a:lnTo>
                  <a:lnTo>
                    <a:pt x="533" y="800"/>
                  </a:lnTo>
                  <a:lnTo>
                    <a:pt x="533" y="790"/>
                  </a:lnTo>
                  <a:lnTo>
                    <a:pt x="534" y="800"/>
                  </a:lnTo>
                  <a:lnTo>
                    <a:pt x="534" y="795"/>
                  </a:lnTo>
                  <a:lnTo>
                    <a:pt x="535" y="800"/>
                  </a:lnTo>
                  <a:lnTo>
                    <a:pt x="535" y="792"/>
                  </a:lnTo>
                  <a:lnTo>
                    <a:pt x="536" y="800"/>
                  </a:lnTo>
                  <a:lnTo>
                    <a:pt x="536" y="765"/>
                  </a:lnTo>
                  <a:lnTo>
                    <a:pt x="537" y="735"/>
                  </a:lnTo>
                  <a:lnTo>
                    <a:pt x="537" y="800"/>
                  </a:lnTo>
                  <a:lnTo>
                    <a:pt x="538" y="745"/>
                  </a:lnTo>
                  <a:lnTo>
                    <a:pt x="538" y="800"/>
                  </a:lnTo>
                  <a:lnTo>
                    <a:pt x="539" y="800"/>
                  </a:lnTo>
                  <a:lnTo>
                    <a:pt x="539" y="779"/>
                  </a:lnTo>
                  <a:lnTo>
                    <a:pt x="540" y="800"/>
                  </a:lnTo>
                  <a:lnTo>
                    <a:pt x="540" y="792"/>
                  </a:lnTo>
                  <a:lnTo>
                    <a:pt x="541" y="790"/>
                  </a:lnTo>
                  <a:lnTo>
                    <a:pt x="541" y="800"/>
                  </a:lnTo>
                  <a:lnTo>
                    <a:pt x="542" y="800"/>
                  </a:lnTo>
                  <a:lnTo>
                    <a:pt x="542" y="761"/>
                  </a:lnTo>
                  <a:lnTo>
                    <a:pt x="543" y="772"/>
                  </a:lnTo>
                  <a:lnTo>
                    <a:pt x="543" y="800"/>
                  </a:lnTo>
                  <a:lnTo>
                    <a:pt x="544" y="800"/>
                  </a:lnTo>
                  <a:lnTo>
                    <a:pt x="544" y="778"/>
                  </a:lnTo>
                  <a:lnTo>
                    <a:pt x="545" y="791"/>
                  </a:lnTo>
                  <a:lnTo>
                    <a:pt x="545" y="800"/>
                  </a:lnTo>
                  <a:lnTo>
                    <a:pt x="546" y="767"/>
                  </a:lnTo>
                  <a:lnTo>
                    <a:pt x="546" y="800"/>
                  </a:lnTo>
                  <a:lnTo>
                    <a:pt x="547" y="650"/>
                  </a:lnTo>
                  <a:lnTo>
                    <a:pt x="547" y="800"/>
                  </a:lnTo>
                  <a:lnTo>
                    <a:pt x="548" y="800"/>
                  </a:lnTo>
                  <a:lnTo>
                    <a:pt x="548" y="720"/>
                  </a:lnTo>
                  <a:lnTo>
                    <a:pt x="549" y="800"/>
                  </a:lnTo>
                  <a:lnTo>
                    <a:pt x="549" y="751"/>
                  </a:lnTo>
                  <a:lnTo>
                    <a:pt x="550" y="740"/>
                  </a:lnTo>
                  <a:lnTo>
                    <a:pt x="550" y="800"/>
                  </a:lnTo>
                  <a:lnTo>
                    <a:pt x="551" y="784"/>
                  </a:lnTo>
                  <a:lnTo>
                    <a:pt x="551" y="800"/>
                  </a:lnTo>
                  <a:lnTo>
                    <a:pt x="552" y="789"/>
                  </a:lnTo>
                  <a:lnTo>
                    <a:pt x="552" y="800"/>
                  </a:lnTo>
                  <a:lnTo>
                    <a:pt x="553" y="734"/>
                  </a:lnTo>
                  <a:lnTo>
                    <a:pt x="553" y="800"/>
                  </a:lnTo>
                  <a:lnTo>
                    <a:pt x="554" y="715"/>
                  </a:lnTo>
                  <a:lnTo>
                    <a:pt x="554" y="800"/>
                  </a:lnTo>
                  <a:lnTo>
                    <a:pt x="555" y="686"/>
                  </a:lnTo>
                  <a:lnTo>
                    <a:pt x="555" y="800"/>
                  </a:lnTo>
                  <a:lnTo>
                    <a:pt x="556" y="800"/>
                  </a:lnTo>
                  <a:lnTo>
                    <a:pt x="556" y="738"/>
                  </a:lnTo>
                  <a:lnTo>
                    <a:pt x="557" y="800"/>
                  </a:lnTo>
                  <a:lnTo>
                    <a:pt x="557" y="749"/>
                  </a:lnTo>
                  <a:lnTo>
                    <a:pt x="558" y="800"/>
                  </a:lnTo>
                  <a:lnTo>
                    <a:pt x="558" y="714"/>
                  </a:lnTo>
                  <a:lnTo>
                    <a:pt x="559" y="800"/>
                  </a:lnTo>
                  <a:lnTo>
                    <a:pt x="559" y="721"/>
                  </a:lnTo>
                  <a:lnTo>
                    <a:pt x="560" y="800"/>
                  </a:lnTo>
                  <a:lnTo>
                    <a:pt x="560" y="662"/>
                  </a:lnTo>
                  <a:lnTo>
                    <a:pt x="561" y="800"/>
                  </a:lnTo>
                  <a:lnTo>
                    <a:pt x="561" y="694"/>
                  </a:lnTo>
                  <a:lnTo>
                    <a:pt x="562" y="800"/>
                  </a:lnTo>
                  <a:lnTo>
                    <a:pt x="562" y="728"/>
                  </a:lnTo>
                  <a:lnTo>
                    <a:pt x="563" y="800"/>
                  </a:lnTo>
                  <a:lnTo>
                    <a:pt x="563" y="746"/>
                  </a:lnTo>
                  <a:lnTo>
                    <a:pt x="564" y="755"/>
                  </a:lnTo>
                  <a:lnTo>
                    <a:pt x="564" y="800"/>
                  </a:lnTo>
                  <a:lnTo>
                    <a:pt x="565" y="769"/>
                  </a:lnTo>
                  <a:lnTo>
                    <a:pt x="565" y="800"/>
                  </a:lnTo>
                  <a:lnTo>
                    <a:pt x="566" y="800"/>
                  </a:lnTo>
                  <a:lnTo>
                    <a:pt x="566" y="778"/>
                  </a:lnTo>
                  <a:lnTo>
                    <a:pt x="567" y="724"/>
                  </a:lnTo>
                  <a:lnTo>
                    <a:pt x="567" y="800"/>
                  </a:lnTo>
                  <a:lnTo>
                    <a:pt x="568" y="673"/>
                  </a:lnTo>
                  <a:lnTo>
                    <a:pt x="568" y="800"/>
                  </a:lnTo>
                  <a:lnTo>
                    <a:pt x="569" y="800"/>
                  </a:lnTo>
                  <a:lnTo>
                    <a:pt x="569" y="784"/>
                  </a:lnTo>
                  <a:lnTo>
                    <a:pt x="570" y="773"/>
                  </a:lnTo>
                  <a:lnTo>
                    <a:pt x="570" y="800"/>
                  </a:lnTo>
                  <a:lnTo>
                    <a:pt x="571" y="800"/>
                  </a:lnTo>
                  <a:lnTo>
                    <a:pt x="571" y="775"/>
                  </a:lnTo>
                  <a:lnTo>
                    <a:pt x="572" y="800"/>
                  </a:lnTo>
                  <a:lnTo>
                    <a:pt x="572" y="779"/>
                  </a:lnTo>
                  <a:lnTo>
                    <a:pt x="573" y="800"/>
                  </a:lnTo>
                  <a:lnTo>
                    <a:pt x="573" y="739"/>
                  </a:lnTo>
                  <a:lnTo>
                    <a:pt x="574" y="800"/>
                  </a:lnTo>
                  <a:lnTo>
                    <a:pt x="574" y="734"/>
                  </a:lnTo>
                  <a:lnTo>
                    <a:pt x="575" y="800"/>
                  </a:lnTo>
                  <a:lnTo>
                    <a:pt x="575" y="763"/>
                  </a:lnTo>
                  <a:lnTo>
                    <a:pt x="576" y="800"/>
                  </a:lnTo>
                  <a:lnTo>
                    <a:pt x="576" y="769"/>
                  </a:lnTo>
                  <a:lnTo>
                    <a:pt x="577" y="800"/>
                  </a:lnTo>
                  <a:lnTo>
                    <a:pt x="577" y="782"/>
                  </a:lnTo>
                  <a:lnTo>
                    <a:pt x="578" y="800"/>
                  </a:lnTo>
                  <a:lnTo>
                    <a:pt x="578" y="786"/>
                  </a:lnTo>
                  <a:lnTo>
                    <a:pt x="579" y="791"/>
                  </a:lnTo>
                  <a:lnTo>
                    <a:pt x="579" y="800"/>
                  </a:lnTo>
                  <a:lnTo>
                    <a:pt x="580" y="800"/>
                  </a:lnTo>
                  <a:lnTo>
                    <a:pt x="580" y="794"/>
                  </a:lnTo>
                  <a:lnTo>
                    <a:pt x="581" y="794"/>
                  </a:lnTo>
                  <a:lnTo>
                    <a:pt x="581" y="800"/>
                  </a:lnTo>
                  <a:lnTo>
                    <a:pt x="582" y="792"/>
                  </a:lnTo>
                  <a:lnTo>
                    <a:pt x="582" y="800"/>
                  </a:lnTo>
                  <a:lnTo>
                    <a:pt x="583" y="800"/>
                  </a:lnTo>
                  <a:lnTo>
                    <a:pt x="583" y="759"/>
                  </a:lnTo>
                  <a:lnTo>
                    <a:pt x="584" y="774"/>
                  </a:lnTo>
                  <a:lnTo>
                    <a:pt x="584" y="800"/>
                  </a:lnTo>
                  <a:lnTo>
                    <a:pt x="585" y="789"/>
                  </a:lnTo>
                  <a:lnTo>
                    <a:pt x="585" y="800"/>
                  </a:lnTo>
                  <a:lnTo>
                    <a:pt x="586" y="800"/>
                  </a:lnTo>
                  <a:lnTo>
                    <a:pt x="586" y="783"/>
                  </a:lnTo>
                  <a:lnTo>
                    <a:pt x="587" y="800"/>
                  </a:lnTo>
                  <a:lnTo>
                    <a:pt x="587" y="792"/>
                  </a:lnTo>
                  <a:lnTo>
                    <a:pt x="588" y="800"/>
                  </a:lnTo>
                  <a:lnTo>
                    <a:pt x="588" y="793"/>
                  </a:lnTo>
                  <a:lnTo>
                    <a:pt x="589" y="800"/>
                  </a:lnTo>
                  <a:lnTo>
                    <a:pt x="589" y="796"/>
                  </a:lnTo>
                  <a:lnTo>
                    <a:pt x="590" y="800"/>
                  </a:lnTo>
                  <a:lnTo>
                    <a:pt x="590" y="797"/>
                  </a:lnTo>
                  <a:lnTo>
                    <a:pt x="591" y="798"/>
                  </a:lnTo>
                  <a:lnTo>
                    <a:pt x="591" y="800"/>
                  </a:lnTo>
                  <a:lnTo>
                    <a:pt x="592" y="800"/>
                  </a:lnTo>
                  <a:lnTo>
                    <a:pt x="592" y="794"/>
                  </a:lnTo>
                  <a:lnTo>
                    <a:pt x="593" y="798"/>
                  </a:lnTo>
                  <a:lnTo>
                    <a:pt x="593" y="800"/>
                  </a:lnTo>
                  <a:lnTo>
                    <a:pt x="594" y="800"/>
                  </a:lnTo>
                  <a:lnTo>
                    <a:pt x="594" y="799"/>
                  </a:lnTo>
                  <a:lnTo>
                    <a:pt x="595" y="796"/>
                  </a:lnTo>
                  <a:lnTo>
                    <a:pt x="595" y="800"/>
                  </a:lnTo>
                  <a:lnTo>
                    <a:pt x="596" y="800"/>
                  </a:lnTo>
                  <a:lnTo>
                    <a:pt x="596" y="770"/>
                  </a:lnTo>
                  <a:lnTo>
                    <a:pt x="597" y="779"/>
                  </a:lnTo>
                  <a:lnTo>
                    <a:pt x="597" y="800"/>
                  </a:lnTo>
                  <a:lnTo>
                    <a:pt x="598" y="790"/>
                  </a:lnTo>
                  <a:lnTo>
                    <a:pt x="598" y="800"/>
                  </a:lnTo>
                  <a:lnTo>
                    <a:pt x="599" y="800"/>
                  </a:lnTo>
                  <a:lnTo>
                    <a:pt x="599" y="793"/>
                  </a:lnTo>
                  <a:lnTo>
                    <a:pt x="600" y="797"/>
                  </a:lnTo>
                  <a:lnTo>
                    <a:pt x="600" y="800"/>
                  </a:lnTo>
                  <a:lnTo>
                    <a:pt x="601" y="800"/>
                  </a:lnTo>
                  <a:lnTo>
                    <a:pt x="601" y="798"/>
                  </a:lnTo>
                  <a:lnTo>
                    <a:pt x="602" y="800"/>
                  </a:lnTo>
                  <a:lnTo>
                    <a:pt x="602" y="750"/>
                  </a:lnTo>
                  <a:lnTo>
                    <a:pt x="603" y="722"/>
                  </a:lnTo>
                  <a:lnTo>
                    <a:pt x="603" y="800"/>
                  </a:lnTo>
                  <a:lnTo>
                    <a:pt x="604" y="771"/>
                  </a:lnTo>
                  <a:lnTo>
                    <a:pt x="604" y="800"/>
                  </a:lnTo>
                  <a:lnTo>
                    <a:pt x="605" y="787"/>
                  </a:lnTo>
                  <a:lnTo>
                    <a:pt x="605" y="800"/>
                  </a:lnTo>
                  <a:lnTo>
                    <a:pt x="606" y="800"/>
                  </a:lnTo>
                  <a:lnTo>
                    <a:pt x="606" y="790"/>
                  </a:lnTo>
                  <a:lnTo>
                    <a:pt x="607" y="793"/>
                  </a:lnTo>
                  <a:lnTo>
                    <a:pt x="607" y="800"/>
                  </a:lnTo>
                  <a:lnTo>
                    <a:pt x="608" y="800"/>
                  </a:lnTo>
                  <a:lnTo>
                    <a:pt x="608" y="780"/>
                  </a:lnTo>
                  <a:lnTo>
                    <a:pt x="609" y="786"/>
                  </a:lnTo>
                  <a:lnTo>
                    <a:pt x="609" y="800"/>
                  </a:lnTo>
                  <a:lnTo>
                    <a:pt x="610" y="796"/>
                  </a:lnTo>
                  <a:lnTo>
                    <a:pt x="610" y="800"/>
                  </a:lnTo>
                  <a:lnTo>
                    <a:pt x="611" y="781"/>
                  </a:lnTo>
                  <a:lnTo>
                    <a:pt x="611" y="800"/>
                  </a:lnTo>
                  <a:lnTo>
                    <a:pt x="612" y="800"/>
                  </a:lnTo>
                  <a:lnTo>
                    <a:pt x="612" y="797"/>
                  </a:lnTo>
                  <a:lnTo>
                    <a:pt x="613" y="800"/>
                  </a:lnTo>
                  <a:lnTo>
                    <a:pt x="613" y="788"/>
                  </a:lnTo>
                  <a:lnTo>
                    <a:pt x="614" y="785"/>
                  </a:lnTo>
                  <a:lnTo>
                    <a:pt x="614" y="800"/>
                  </a:lnTo>
                  <a:lnTo>
                    <a:pt x="615" y="799"/>
                  </a:lnTo>
                  <a:lnTo>
                    <a:pt x="615" y="800"/>
                  </a:lnTo>
                  <a:lnTo>
                    <a:pt x="616" y="800"/>
                  </a:lnTo>
                  <a:lnTo>
                    <a:pt x="616" y="799"/>
                  </a:lnTo>
                  <a:lnTo>
                    <a:pt x="617" y="800"/>
                  </a:lnTo>
                  <a:lnTo>
                    <a:pt x="617" y="795"/>
                  </a:lnTo>
                  <a:lnTo>
                    <a:pt x="618" y="800"/>
                  </a:lnTo>
                  <a:lnTo>
                    <a:pt x="618" y="795"/>
                  </a:lnTo>
                  <a:lnTo>
                    <a:pt x="619" y="799"/>
                  </a:lnTo>
                  <a:lnTo>
                    <a:pt x="619" y="800"/>
                  </a:lnTo>
                  <a:lnTo>
                    <a:pt x="620" y="800"/>
                  </a:lnTo>
                  <a:lnTo>
                    <a:pt x="620" y="800"/>
                  </a:lnTo>
                  <a:lnTo>
                    <a:pt x="621" y="800"/>
                  </a:lnTo>
                  <a:lnTo>
                    <a:pt x="621" y="797"/>
                  </a:lnTo>
                  <a:lnTo>
                    <a:pt x="622" y="800"/>
                  </a:lnTo>
                  <a:lnTo>
                    <a:pt x="622" y="794"/>
                  </a:lnTo>
                  <a:lnTo>
                    <a:pt x="623" y="800"/>
                  </a:lnTo>
                  <a:lnTo>
                    <a:pt x="623" y="799"/>
                  </a:lnTo>
                  <a:lnTo>
                    <a:pt x="624" y="800"/>
                  </a:lnTo>
                  <a:lnTo>
                    <a:pt x="624" y="797"/>
                  </a:lnTo>
                  <a:lnTo>
                    <a:pt x="625" y="797"/>
                  </a:lnTo>
                  <a:lnTo>
                    <a:pt x="625" y="800"/>
                  </a:lnTo>
                  <a:lnTo>
                    <a:pt x="626" y="798"/>
                  </a:lnTo>
                  <a:lnTo>
                    <a:pt x="626" y="800"/>
                  </a:lnTo>
                  <a:lnTo>
                    <a:pt x="627" y="800"/>
                  </a:lnTo>
                  <a:lnTo>
                    <a:pt x="627" y="796"/>
                  </a:lnTo>
                  <a:lnTo>
                    <a:pt x="628" y="800"/>
                  </a:lnTo>
                  <a:lnTo>
                    <a:pt x="628" y="739"/>
                  </a:lnTo>
                  <a:lnTo>
                    <a:pt x="629" y="800"/>
                  </a:lnTo>
                  <a:lnTo>
                    <a:pt x="629" y="696"/>
                  </a:lnTo>
                  <a:lnTo>
                    <a:pt x="630" y="800"/>
                  </a:lnTo>
                  <a:lnTo>
                    <a:pt x="630" y="707"/>
                  </a:lnTo>
                  <a:lnTo>
                    <a:pt x="631" y="729"/>
                  </a:lnTo>
                  <a:lnTo>
                    <a:pt x="631" y="800"/>
                  </a:lnTo>
                  <a:lnTo>
                    <a:pt x="632" y="800"/>
                  </a:lnTo>
                  <a:lnTo>
                    <a:pt x="632" y="751"/>
                  </a:lnTo>
                  <a:lnTo>
                    <a:pt x="633" y="800"/>
                  </a:lnTo>
                  <a:lnTo>
                    <a:pt x="633" y="770"/>
                  </a:lnTo>
                  <a:lnTo>
                    <a:pt x="634" y="800"/>
                  </a:lnTo>
                  <a:lnTo>
                    <a:pt x="634" y="713"/>
                  </a:lnTo>
                  <a:lnTo>
                    <a:pt x="635" y="800"/>
                  </a:lnTo>
                  <a:lnTo>
                    <a:pt x="635" y="736"/>
                  </a:lnTo>
                  <a:lnTo>
                    <a:pt x="636" y="770"/>
                  </a:lnTo>
                  <a:lnTo>
                    <a:pt x="636" y="800"/>
                  </a:lnTo>
                  <a:lnTo>
                    <a:pt x="637" y="800"/>
                  </a:lnTo>
                  <a:lnTo>
                    <a:pt x="637" y="733"/>
                  </a:lnTo>
                  <a:lnTo>
                    <a:pt x="638" y="800"/>
                  </a:lnTo>
                  <a:lnTo>
                    <a:pt x="638" y="750"/>
                  </a:lnTo>
                  <a:lnTo>
                    <a:pt x="639" y="800"/>
                  </a:lnTo>
                  <a:lnTo>
                    <a:pt x="639" y="770"/>
                  </a:lnTo>
                  <a:lnTo>
                    <a:pt x="640" y="733"/>
                  </a:lnTo>
                  <a:lnTo>
                    <a:pt x="640" y="800"/>
                  </a:lnTo>
                  <a:lnTo>
                    <a:pt x="641" y="800"/>
                  </a:lnTo>
                  <a:lnTo>
                    <a:pt x="641" y="711"/>
                  </a:lnTo>
                  <a:lnTo>
                    <a:pt x="642" y="800"/>
                  </a:lnTo>
                  <a:lnTo>
                    <a:pt x="642" y="701"/>
                  </a:lnTo>
                  <a:lnTo>
                    <a:pt x="643" y="758"/>
                  </a:lnTo>
                  <a:lnTo>
                    <a:pt x="643" y="800"/>
                  </a:lnTo>
                  <a:lnTo>
                    <a:pt x="644" y="785"/>
                  </a:lnTo>
                  <a:lnTo>
                    <a:pt x="644" y="800"/>
                  </a:lnTo>
                  <a:lnTo>
                    <a:pt x="645" y="800"/>
                  </a:lnTo>
                  <a:lnTo>
                    <a:pt x="645" y="785"/>
                  </a:lnTo>
                  <a:lnTo>
                    <a:pt x="646" y="800"/>
                  </a:lnTo>
                  <a:lnTo>
                    <a:pt x="646" y="770"/>
                  </a:lnTo>
                  <a:lnTo>
                    <a:pt x="647" y="800"/>
                  </a:lnTo>
                  <a:lnTo>
                    <a:pt x="647" y="760"/>
                  </a:lnTo>
                  <a:lnTo>
                    <a:pt x="648" y="800"/>
                  </a:lnTo>
                  <a:lnTo>
                    <a:pt x="648" y="766"/>
                  </a:lnTo>
                  <a:lnTo>
                    <a:pt x="649" y="774"/>
                  </a:lnTo>
                  <a:lnTo>
                    <a:pt x="649" y="800"/>
                  </a:lnTo>
                  <a:lnTo>
                    <a:pt x="650" y="779"/>
                  </a:lnTo>
                  <a:lnTo>
                    <a:pt x="650" y="800"/>
                  </a:lnTo>
                  <a:lnTo>
                    <a:pt x="651" y="800"/>
                  </a:lnTo>
                  <a:lnTo>
                    <a:pt x="651" y="792"/>
                  </a:lnTo>
                  <a:lnTo>
                    <a:pt x="652" y="794"/>
                  </a:lnTo>
                  <a:lnTo>
                    <a:pt x="652" y="800"/>
                  </a:lnTo>
                  <a:lnTo>
                    <a:pt x="653" y="783"/>
                  </a:lnTo>
                  <a:lnTo>
                    <a:pt x="653" y="800"/>
                  </a:lnTo>
                  <a:lnTo>
                    <a:pt x="654" y="785"/>
                  </a:lnTo>
                  <a:lnTo>
                    <a:pt x="654" y="800"/>
                  </a:lnTo>
                  <a:lnTo>
                    <a:pt x="655" y="800"/>
                  </a:lnTo>
                  <a:lnTo>
                    <a:pt x="655" y="792"/>
                  </a:lnTo>
                  <a:lnTo>
                    <a:pt x="656" y="786"/>
                  </a:lnTo>
                  <a:lnTo>
                    <a:pt x="656" y="800"/>
                  </a:lnTo>
                  <a:lnTo>
                    <a:pt x="657" y="800"/>
                  </a:lnTo>
                  <a:lnTo>
                    <a:pt x="657" y="781"/>
                  </a:lnTo>
                  <a:lnTo>
                    <a:pt x="658" y="800"/>
                  </a:lnTo>
                  <a:lnTo>
                    <a:pt x="658" y="772"/>
                  </a:lnTo>
                  <a:lnTo>
                    <a:pt x="659" y="800"/>
                  </a:lnTo>
                  <a:lnTo>
                    <a:pt x="659" y="755"/>
                  </a:lnTo>
                  <a:lnTo>
                    <a:pt x="660" y="743"/>
                  </a:lnTo>
                  <a:lnTo>
                    <a:pt x="660" y="800"/>
                  </a:lnTo>
                  <a:lnTo>
                    <a:pt x="661" y="752"/>
                  </a:lnTo>
                  <a:lnTo>
                    <a:pt x="661" y="800"/>
                  </a:lnTo>
                  <a:lnTo>
                    <a:pt x="662" y="774"/>
                  </a:lnTo>
                  <a:lnTo>
                    <a:pt x="662" y="800"/>
                  </a:lnTo>
                  <a:lnTo>
                    <a:pt x="663" y="800"/>
                  </a:lnTo>
                  <a:lnTo>
                    <a:pt x="663" y="793"/>
                  </a:lnTo>
                  <a:lnTo>
                    <a:pt x="664" y="800"/>
                  </a:lnTo>
                  <a:lnTo>
                    <a:pt x="664" y="792"/>
                  </a:lnTo>
                  <a:lnTo>
                    <a:pt x="665" y="800"/>
                  </a:lnTo>
                  <a:lnTo>
                    <a:pt x="665" y="789"/>
                  </a:lnTo>
                  <a:lnTo>
                    <a:pt x="666" y="780"/>
                  </a:lnTo>
                  <a:lnTo>
                    <a:pt x="666" y="800"/>
                  </a:lnTo>
                  <a:lnTo>
                    <a:pt x="667" y="661"/>
                  </a:lnTo>
                  <a:lnTo>
                    <a:pt x="667" y="800"/>
                  </a:lnTo>
                  <a:lnTo>
                    <a:pt x="668" y="800"/>
                  </a:lnTo>
                  <a:lnTo>
                    <a:pt x="668" y="714"/>
                  </a:lnTo>
                  <a:lnTo>
                    <a:pt x="669" y="755"/>
                  </a:lnTo>
                  <a:lnTo>
                    <a:pt x="669" y="800"/>
                  </a:lnTo>
                  <a:lnTo>
                    <a:pt x="670" y="800"/>
                  </a:lnTo>
                  <a:lnTo>
                    <a:pt x="670" y="768"/>
                  </a:lnTo>
                  <a:lnTo>
                    <a:pt x="671" y="800"/>
                  </a:lnTo>
                  <a:lnTo>
                    <a:pt x="671" y="518"/>
                  </a:lnTo>
                  <a:lnTo>
                    <a:pt x="672" y="800"/>
                  </a:lnTo>
                  <a:lnTo>
                    <a:pt x="672" y="764"/>
                  </a:lnTo>
                  <a:lnTo>
                    <a:pt x="673" y="800"/>
                  </a:lnTo>
                  <a:lnTo>
                    <a:pt x="673" y="756"/>
                  </a:lnTo>
                  <a:lnTo>
                    <a:pt x="674" y="800"/>
                  </a:lnTo>
                  <a:lnTo>
                    <a:pt x="674" y="747"/>
                  </a:lnTo>
                  <a:lnTo>
                    <a:pt x="675" y="752"/>
                  </a:lnTo>
                  <a:lnTo>
                    <a:pt x="675" y="800"/>
                  </a:lnTo>
                  <a:lnTo>
                    <a:pt x="676" y="800"/>
                  </a:lnTo>
                  <a:lnTo>
                    <a:pt x="676" y="727"/>
                  </a:lnTo>
                  <a:lnTo>
                    <a:pt x="677" y="579"/>
                  </a:lnTo>
                  <a:lnTo>
                    <a:pt x="677" y="800"/>
                  </a:lnTo>
                  <a:lnTo>
                    <a:pt x="678" y="709"/>
                  </a:lnTo>
                  <a:lnTo>
                    <a:pt x="678" y="800"/>
                  </a:lnTo>
                  <a:lnTo>
                    <a:pt x="679" y="771"/>
                  </a:lnTo>
                  <a:lnTo>
                    <a:pt x="679" y="800"/>
                  </a:lnTo>
                  <a:lnTo>
                    <a:pt x="680" y="800"/>
                  </a:lnTo>
                  <a:lnTo>
                    <a:pt x="680" y="763"/>
                  </a:lnTo>
                  <a:lnTo>
                    <a:pt x="681" y="800"/>
                  </a:lnTo>
                  <a:lnTo>
                    <a:pt x="681" y="750"/>
                  </a:lnTo>
                  <a:lnTo>
                    <a:pt x="682" y="800"/>
                  </a:lnTo>
                  <a:lnTo>
                    <a:pt x="682" y="760"/>
                  </a:lnTo>
                  <a:lnTo>
                    <a:pt x="683" y="800"/>
                  </a:lnTo>
                  <a:lnTo>
                    <a:pt x="683" y="749"/>
                  </a:lnTo>
                  <a:lnTo>
                    <a:pt x="684" y="761"/>
                  </a:lnTo>
                  <a:lnTo>
                    <a:pt x="684" y="800"/>
                  </a:lnTo>
                  <a:lnTo>
                    <a:pt x="685" y="773"/>
                  </a:lnTo>
                  <a:lnTo>
                    <a:pt x="685" y="800"/>
                  </a:lnTo>
                  <a:lnTo>
                    <a:pt x="686" y="800"/>
                  </a:lnTo>
                  <a:lnTo>
                    <a:pt x="686" y="764"/>
                  </a:lnTo>
                  <a:lnTo>
                    <a:pt x="687" y="800"/>
                  </a:lnTo>
                  <a:lnTo>
                    <a:pt x="687" y="775"/>
                  </a:lnTo>
                  <a:lnTo>
                    <a:pt x="688" y="766"/>
                  </a:lnTo>
                  <a:lnTo>
                    <a:pt x="688" y="800"/>
                  </a:lnTo>
                  <a:lnTo>
                    <a:pt x="689" y="778"/>
                  </a:lnTo>
                  <a:lnTo>
                    <a:pt x="689" y="800"/>
                  </a:lnTo>
                  <a:lnTo>
                    <a:pt x="690" y="779"/>
                  </a:lnTo>
                  <a:lnTo>
                    <a:pt x="690" y="800"/>
                  </a:lnTo>
                  <a:lnTo>
                    <a:pt x="691" y="800"/>
                  </a:lnTo>
                  <a:lnTo>
                    <a:pt x="691" y="756"/>
                  </a:lnTo>
                  <a:lnTo>
                    <a:pt x="692" y="772"/>
                  </a:lnTo>
                  <a:lnTo>
                    <a:pt x="692" y="800"/>
                  </a:lnTo>
                  <a:lnTo>
                    <a:pt x="693" y="800"/>
                  </a:lnTo>
                  <a:lnTo>
                    <a:pt x="693" y="778"/>
                  </a:lnTo>
                  <a:lnTo>
                    <a:pt x="694" y="768"/>
                  </a:lnTo>
                  <a:lnTo>
                    <a:pt x="694" y="800"/>
                  </a:lnTo>
                  <a:lnTo>
                    <a:pt x="695" y="774"/>
                  </a:lnTo>
                  <a:lnTo>
                    <a:pt x="695" y="800"/>
                  </a:lnTo>
                  <a:lnTo>
                    <a:pt x="696" y="788"/>
                  </a:lnTo>
                  <a:lnTo>
                    <a:pt x="696" y="800"/>
                  </a:lnTo>
                  <a:lnTo>
                    <a:pt x="697" y="778"/>
                  </a:lnTo>
                  <a:lnTo>
                    <a:pt x="697" y="800"/>
                  </a:lnTo>
                  <a:lnTo>
                    <a:pt x="698" y="800"/>
                  </a:lnTo>
                  <a:lnTo>
                    <a:pt x="698" y="765"/>
                  </a:lnTo>
                  <a:lnTo>
                    <a:pt x="699" y="800"/>
                  </a:lnTo>
                  <a:lnTo>
                    <a:pt x="699" y="767"/>
                  </a:lnTo>
                  <a:lnTo>
                    <a:pt x="700" y="761"/>
                  </a:lnTo>
                  <a:lnTo>
                    <a:pt x="700" y="800"/>
                  </a:lnTo>
                  <a:lnTo>
                    <a:pt x="701" y="800"/>
                  </a:lnTo>
                  <a:lnTo>
                    <a:pt x="701" y="767"/>
                  </a:lnTo>
                  <a:lnTo>
                    <a:pt x="702" y="800"/>
                  </a:lnTo>
                  <a:lnTo>
                    <a:pt x="702" y="767"/>
                  </a:lnTo>
                  <a:lnTo>
                    <a:pt x="703" y="800"/>
                  </a:lnTo>
                  <a:lnTo>
                    <a:pt x="703" y="779"/>
                  </a:lnTo>
                  <a:lnTo>
                    <a:pt x="704" y="775"/>
                  </a:lnTo>
                  <a:lnTo>
                    <a:pt x="704" y="800"/>
                  </a:lnTo>
                  <a:lnTo>
                    <a:pt x="705" y="800"/>
                  </a:lnTo>
                  <a:lnTo>
                    <a:pt x="705" y="786"/>
                  </a:lnTo>
                  <a:lnTo>
                    <a:pt x="706" y="792"/>
                  </a:lnTo>
                  <a:lnTo>
                    <a:pt x="706" y="800"/>
                  </a:lnTo>
                  <a:lnTo>
                    <a:pt x="707" y="789"/>
                  </a:lnTo>
                  <a:lnTo>
                    <a:pt x="707" y="800"/>
                  </a:lnTo>
                  <a:lnTo>
                    <a:pt x="708" y="787"/>
                  </a:lnTo>
                  <a:lnTo>
                    <a:pt x="708" y="800"/>
                  </a:lnTo>
                  <a:lnTo>
                    <a:pt x="709" y="791"/>
                  </a:lnTo>
                  <a:lnTo>
                    <a:pt x="709" y="800"/>
                  </a:lnTo>
                  <a:lnTo>
                    <a:pt x="710" y="800"/>
                  </a:lnTo>
                  <a:lnTo>
                    <a:pt x="710" y="782"/>
                  </a:lnTo>
                  <a:lnTo>
                    <a:pt x="711" y="800"/>
                  </a:lnTo>
                  <a:lnTo>
                    <a:pt x="711" y="773"/>
                  </a:lnTo>
                  <a:lnTo>
                    <a:pt x="712" y="800"/>
                  </a:lnTo>
                  <a:lnTo>
                    <a:pt x="712" y="789"/>
                  </a:lnTo>
                  <a:lnTo>
                    <a:pt x="713" y="800"/>
                  </a:lnTo>
                  <a:lnTo>
                    <a:pt x="713" y="788"/>
                  </a:lnTo>
                  <a:lnTo>
                    <a:pt x="714" y="800"/>
                  </a:lnTo>
                  <a:lnTo>
                    <a:pt x="714" y="798"/>
                  </a:lnTo>
                  <a:lnTo>
                    <a:pt x="715" y="800"/>
                  </a:lnTo>
                  <a:lnTo>
                    <a:pt x="715" y="799"/>
                  </a:lnTo>
                  <a:lnTo>
                    <a:pt x="716" y="800"/>
                  </a:lnTo>
                  <a:lnTo>
                    <a:pt x="716" y="798"/>
                  </a:lnTo>
                  <a:lnTo>
                    <a:pt x="717" y="800"/>
                  </a:lnTo>
                  <a:lnTo>
                    <a:pt x="717" y="797"/>
                  </a:lnTo>
                  <a:lnTo>
                    <a:pt x="718" y="800"/>
                  </a:lnTo>
                  <a:lnTo>
                    <a:pt x="718" y="786"/>
                  </a:lnTo>
                  <a:lnTo>
                    <a:pt x="719" y="800"/>
                  </a:lnTo>
                  <a:lnTo>
                    <a:pt x="719" y="799"/>
                  </a:lnTo>
                  <a:lnTo>
                    <a:pt x="720" y="800"/>
                  </a:lnTo>
                  <a:lnTo>
                    <a:pt x="720" y="800"/>
                  </a:lnTo>
                  <a:lnTo>
                    <a:pt x="721" y="800"/>
                  </a:lnTo>
                  <a:lnTo>
                    <a:pt x="721" y="800"/>
                  </a:lnTo>
                  <a:lnTo>
                    <a:pt x="722" y="800"/>
                  </a:lnTo>
                  <a:lnTo>
                    <a:pt x="722" y="799"/>
                  </a:lnTo>
                  <a:lnTo>
                    <a:pt x="723" y="800"/>
                  </a:lnTo>
                  <a:lnTo>
                    <a:pt x="723" y="778"/>
                  </a:lnTo>
                  <a:lnTo>
                    <a:pt x="724" y="800"/>
                  </a:lnTo>
                  <a:lnTo>
                    <a:pt x="724" y="758"/>
                  </a:lnTo>
                  <a:lnTo>
                    <a:pt x="725" y="800"/>
                  </a:lnTo>
                  <a:lnTo>
                    <a:pt x="725" y="721"/>
                  </a:lnTo>
                  <a:lnTo>
                    <a:pt x="726" y="800"/>
                  </a:lnTo>
                  <a:lnTo>
                    <a:pt x="726" y="748"/>
                  </a:lnTo>
                  <a:lnTo>
                    <a:pt x="727" y="762"/>
                  </a:lnTo>
                  <a:lnTo>
                    <a:pt x="727" y="800"/>
                  </a:lnTo>
                  <a:lnTo>
                    <a:pt x="728" y="800"/>
                  </a:lnTo>
                  <a:lnTo>
                    <a:pt x="728" y="754"/>
                  </a:lnTo>
                  <a:lnTo>
                    <a:pt x="729" y="800"/>
                  </a:lnTo>
                  <a:lnTo>
                    <a:pt x="729" y="784"/>
                  </a:lnTo>
                  <a:lnTo>
                    <a:pt x="730" y="784"/>
                  </a:lnTo>
                  <a:lnTo>
                    <a:pt x="730" y="800"/>
                  </a:lnTo>
                  <a:lnTo>
                    <a:pt x="731" y="793"/>
                  </a:lnTo>
                  <a:lnTo>
                    <a:pt x="731" y="800"/>
                  </a:lnTo>
                  <a:lnTo>
                    <a:pt x="732" y="800"/>
                  </a:lnTo>
                  <a:lnTo>
                    <a:pt x="732" y="749"/>
                  </a:lnTo>
                  <a:lnTo>
                    <a:pt x="733" y="800"/>
                  </a:lnTo>
                  <a:lnTo>
                    <a:pt x="733" y="741"/>
                  </a:lnTo>
                  <a:lnTo>
                    <a:pt x="734" y="652"/>
                  </a:lnTo>
                  <a:lnTo>
                    <a:pt x="734" y="800"/>
                  </a:lnTo>
                  <a:lnTo>
                    <a:pt x="735" y="729"/>
                  </a:lnTo>
                  <a:lnTo>
                    <a:pt x="735" y="800"/>
                  </a:lnTo>
                  <a:lnTo>
                    <a:pt x="736" y="800"/>
                  </a:lnTo>
                  <a:lnTo>
                    <a:pt x="736" y="749"/>
                  </a:lnTo>
                  <a:lnTo>
                    <a:pt x="737" y="779"/>
                  </a:lnTo>
                  <a:lnTo>
                    <a:pt x="737" y="800"/>
                  </a:lnTo>
                  <a:lnTo>
                    <a:pt x="738" y="750"/>
                  </a:lnTo>
                  <a:lnTo>
                    <a:pt x="738" y="800"/>
                  </a:lnTo>
                  <a:lnTo>
                    <a:pt x="739" y="800"/>
                  </a:lnTo>
                  <a:lnTo>
                    <a:pt x="739" y="792"/>
                  </a:lnTo>
                  <a:lnTo>
                    <a:pt x="740" y="800"/>
                  </a:lnTo>
                  <a:lnTo>
                    <a:pt x="740" y="790"/>
                  </a:lnTo>
                  <a:lnTo>
                    <a:pt x="741" y="790"/>
                  </a:lnTo>
                  <a:lnTo>
                    <a:pt x="741" y="800"/>
                  </a:lnTo>
                  <a:lnTo>
                    <a:pt x="742" y="781"/>
                  </a:lnTo>
                  <a:lnTo>
                    <a:pt x="742" y="800"/>
                  </a:lnTo>
                  <a:lnTo>
                    <a:pt x="743" y="800"/>
                  </a:lnTo>
                  <a:lnTo>
                    <a:pt x="743" y="772"/>
                  </a:lnTo>
                  <a:lnTo>
                    <a:pt x="744" y="800"/>
                  </a:lnTo>
                  <a:lnTo>
                    <a:pt x="744" y="774"/>
                  </a:lnTo>
                  <a:lnTo>
                    <a:pt x="745" y="800"/>
                  </a:lnTo>
                  <a:lnTo>
                    <a:pt x="745" y="775"/>
                  </a:lnTo>
                  <a:lnTo>
                    <a:pt x="746" y="776"/>
                  </a:lnTo>
                  <a:lnTo>
                    <a:pt x="746" y="800"/>
                  </a:lnTo>
                  <a:lnTo>
                    <a:pt x="747" y="759"/>
                  </a:lnTo>
                  <a:lnTo>
                    <a:pt x="747" y="800"/>
                  </a:lnTo>
                  <a:lnTo>
                    <a:pt x="748" y="800"/>
                  </a:lnTo>
                  <a:lnTo>
                    <a:pt x="748" y="760"/>
                  </a:lnTo>
                  <a:lnTo>
                    <a:pt x="749" y="771"/>
                  </a:lnTo>
                  <a:lnTo>
                    <a:pt x="749" y="800"/>
                  </a:lnTo>
                  <a:lnTo>
                    <a:pt x="750" y="756"/>
                  </a:lnTo>
                  <a:lnTo>
                    <a:pt x="750" y="800"/>
                  </a:lnTo>
                  <a:lnTo>
                    <a:pt x="751" y="800"/>
                  </a:lnTo>
                  <a:lnTo>
                    <a:pt x="751" y="776"/>
                  </a:lnTo>
                  <a:lnTo>
                    <a:pt x="752" y="786"/>
                  </a:lnTo>
                  <a:lnTo>
                    <a:pt x="752" y="800"/>
                  </a:lnTo>
                  <a:lnTo>
                    <a:pt x="753" y="778"/>
                  </a:lnTo>
                  <a:lnTo>
                    <a:pt x="753" y="800"/>
                  </a:lnTo>
                  <a:lnTo>
                    <a:pt x="754" y="800"/>
                  </a:lnTo>
                  <a:lnTo>
                    <a:pt x="754" y="774"/>
                  </a:lnTo>
                  <a:lnTo>
                    <a:pt x="755" y="781"/>
                  </a:lnTo>
                  <a:lnTo>
                    <a:pt x="755" y="800"/>
                  </a:lnTo>
                  <a:lnTo>
                    <a:pt x="756" y="750"/>
                  </a:lnTo>
                  <a:lnTo>
                    <a:pt x="756" y="800"/>
                  </a:lnTo>
                  <a:lnTo>
                    <a:pt x="757" y="754"/>
                  </a:lnTo>
                  <a:lnTo>
                    <a:pt x="757" y="800"/>
                  </a:lnTo>
                  <a:lnTo>
                    <a:pt x="758" y="800"/>
                  </a:lnTo>
                  <a:lnTo>
                    <a:pt x="758" y="769"/>
                  </a:lnTo>
                  <a:lnTo>
                    <a:pt x="759" y="800"/>
                  </a:lnTo>
                  <a:lnTo>
                    <a:pt x="759" y="745"/>
                  </a:lnTo>
                  <a:lnTo>
                    <a:pt x="760" y="800"/>
                  </a:lnTo>
                  <a:lnTo>
                    <a:pt x="760" y="782"/>
                  </a:lnTo>
                  <a:lnTo>
                    <a:pt x="761" y="800"/>
                  </a:lnTo>
                  <a:lnTo>
                    <a:pt x="761" y="785"/>
                  </a:lnTo>
                  <a:lnTo>
                    <a:pt x="762" y="800"/>
                  </a:lnTo>
                  <a:lnTo>
                    <a:pt x="762" y="786"/>
                  </a:lnTo>
                  <a:lnTo>
                    <a:pt x="763" y="800"/>
                  </a:lnTo>
                  <a:lnTo>
                    <a:pt x="763" y="788"/>
                  </a:lnTo>
                  <a:lnTo>
                    <a:pt x="764" y="800"/>
                  </a:lnTo>
                  <a:lnTo>
                    <a:pt x="764" y="783"/>
                  </a:lnTo>
                  <a:lnTo>
                    <a:pt x="765" y="800"/>
                  </a:lnTo>
                  <a:lnTo>
                    <a:pt x="765" y="784"/>
                  </a:lnTo>
                  <a:lnTo>
                    <a:pt x="766" y="758"/>
                  </a:lnTo>
                  <a:lnTo>
                    <a:pt x="766" y="800"/>
                  </a:lnTo>
                  <a:lnTo>
                    <a:pt x="767" y="747"/>
                  </a:lnTo>
                  <a:lnTo>
                    <a:pt x="767" y="800"/>
                  </a:lnTo>
                  <a:lnTo>
                    <a:pt x="768" y="715"/>
                  </a:lnTo>
                  <a:lnTo>
                    <a:pt x="768" y="800"/>
                  </a:lnTo>
                  <a:lnTo>
                    <a:pt x="769" y="748"/>
                  </a:lnTo>
                  <a:lnTo>
                    <a:pt x="769" y="800"/>
                  </a:lnTo>
                  <a:lnTo>
                    <a:pt x="770" y="800"/>
                  </a:lnTo>
                  <a:lnTo>
                    <a:pt x="770" y="760"/>
                  </a:lnTo>
                  <a:lnTo>
                    <a:pt x="771" y="738"/>
                  </a:lnTo>
                  <a:lnTo>
                    <a:pt x="771" y="800"/>
                  </a:lnTo>
                  <a:lnTo>
                    <a:pt x="772" y="656"/>
                  </a:lnTo>
                  <a:lnTo>
                    <a:pt x="772" y="800"/>
                  </a:lnTo>
                  <a:lnTo>
                    <a:pt x="773" y="800"/>
                  </a:lnTo>
                  <a:lnTo>
                    <a:pt x="773" y="600"/>
                  </a:lnTo>
                  <a:lnTo>
                    <a:pt x="774" y="669"/>
                  </a:lnTo>
                  <a:lnTo>
                    <a:pt x="774" y="800"/>
                  </a:lnTo>
                  <a:lnTo>
                    <a:pt x="775" y="800"/>
                  </a:lnTo>
                  <a:lnTo>
                    <a:pt x="775" y="750"/>
                  </a:lnTo>
                  <a:lnTo>
                    <a:pt x="776" y="751"/>
                  </a:lnTo>
                  <a:lnTo>
                    <a:pt x="776" y="800"/>
                  </a:lnTo>
                  <a:lnTo>
                    <a:pt x="777" y="767"/>
                  </a:lnTo>
                  <a:lnTo>
                    <a:pt x="777" y="800"/>
                  </a:lnTo>
                  <a:lnTo>
                    <a:pt x="778" y="780"/>
                  </a:lnTo>
                  <a:lnTo>
                    <a:pt x="778" y="800"/>
                  </a:lnTo>
                  <a:lnTo>
                    <a:pt x="779" y="737"/>
                  </a:lnTo>
                  <a:lnTo>
                    <a:pt x="779" y="800"/>
                  </a:lnTo>
                  <a:lnTo>
                    <a:pt x="780" y="800"/>
                  </a:lnTo>
                  <a:lnTo>
                    <a:pt x="780" y="789"/>
                  </a:lnTo>
                  <a:lnTo>
                    <a:pt x="781" y="722"/>
                  </a:lnTo>
                  <a:lnTo>
                    <a:pt x="781" y="800"/>
                  </a:lnTo>
                  <a:lnTo>
                    <a:pt x="782" y="800"/>
                  </a:lnTo>
                  <a:lnTo>
                    <a:pt x="782" y="767"/>
                  </a:lnTo>
                  <a:lnTo>
                    <a:pt x="783" y="764"/>
                  </a:lnTo>
                  <a:lnTo>
                    <a:pt x="783" y="800"/>
                  </a:lnTo>
                  <a:lnTo>
                    <a:pt x="784" y="800"/>
                  </a:lnTo>
                  <a:lnTo>
                    <a:pt x="784" y="770"/>
                  </a:lnTo>
                  <a:lnTo>
                    <a:pt x="785" y="779"/>
                  </a:lnTo>
                  <a:lnTo>
                    <a:pt x="785" y="800"/>
                  </a:lnTo>
                  <a:lnTo>
                    <a:pt x="786" y="785"/>
                  </a:lnTo>
                  <a:lnTo>
                    <a:pt x="786" y="800"/>
                  </a:lnTo>
                  <a:lnTo>
                    <a:pt x="787" y="785"/>
                  </a:lnTo>
                  <a:lnTo>
                    <a:pt x="787" y="800"/>
                  </a:lnTo>
                  <a:lnTo>
                    <a:pt x="788" y="770"/>
                  </a:lnTo>
                  <a:lnTo>
                    <a:pt x="788" y="800"/>
                  </a:lnTo>
                  <a:lnTo>
                    <a:pt x="789" y="716"/>
                  </a:lnTo>
                  <a:lnTo>
                    <a:pt x="789" y="800"/>
                  </a:lnTo>
                  <a:lnTo>
                    <a:pt x="790" y="800"/>
                  </a:lnTo>
                  <a:lnTo>
                    <a:pt x="790" y="660"/>
                  </a:lnTo>
                  <a:lnTo>
                    <a:pt x="791" y="800"/>
                  </a:lnTo>
                  <a:lnTo>
                    <a:pt x="791" y="452"/>
                  </a:lnTo>
                  <a:lnTo>
                    <a:pt x="792" y="683"/>
                  </a:lnTo>
                  <a:lnTo>
                    <a:pt x="792" y="800"/>
                  </a:lnTo>
                  <a:lnTo>
                    <a:pt x="793" y="555"/>
                  </a:lnTo>
                  <a:lnTo>
                    <a:pt x="793" y="800"/>
                  </a:lnTo>
                  <a:lnTo>
                    <a:pt x="794" y="0"/>
                  </a:lnTo>
                  <a:lnTo>
                    <a:pt x="794" y="800"/>
                  </a:lnTo>
                  <a:lnTo>
                    <a:pt x="795" y="800"/>
                  </a:lnTo>
                  <a:lnTo>
                    <a:pt x="795" y="16"/>
                  </a:lnTo>
                  <a:lnTo>
                    <a:pt x="796" y="800"/>
                  </a:lnTo>
                  <a:lnTo>
                    <a:pt x="796" y="718"/>
                  </a:lnTo>
                  <a:lnTo>
                    <a:pt x="797" y="800"/>
                  </a:lnTo>
                  <a:lnTo>
                    <a:pt x="797" y="729"/>
                  </a:lnTo>
                  <a:lnTo>
                    <a:pt x="798" y="800"/>
                  </a:lnTo>
                  <a:lnTo>
                    <a:pt x="798" y="428"/>
                  </a:lnTo>
                  <a:lnTo>
                    <a:pt x="799" y="742"/>
                  </a:lnTo>
                  <a:lnTo>
                    <a:pt x="799" y="800"/>
                  </a:lnTo>
                  <a:lnTo>
                    <a:pt x="800" y="800"/>
                  </a:lnTo>
                  <a:lnTo>
                    <a:pt x="800" y="642"/>
                  </a:lnTo>
                  <a:lnTo>
                    <a:pt x="801" y="759"/>
                  </a:lnTo>
                  <a:lnTo>
                    <a:pt x="801" y="800"/>
                  </a:lnTo>
                  <a:lnTo>
                    <a:pt x="802" y="800"/>
                  </a:lnTo>
                  <a:lnTo>
                    <a:pt x="802" y="768"/>
                  </a:lnTo>
                  <a:lnTo>
                    <a:pt x="803" y="800"/>
                  </a:lnTo>
                  <a:lnTo>
                    <a:pt x="803" y="772"/>
                  </a:lnTo>
                  <a:lnTo>
                    <a:pt x="804" y="800"/>
                  </a:lnTo>
                  <a:lnTo>
                    <a:pt x="804" y="743"/>
                  </a:lnTo>
                  <a:lnTo>
                    <a:pt x="805" y="800"/>
                  </a:lnTo>
                  <a:lnTo>
                    <a:pt x="805" y="775"/>
                  </a:lnTo>
                  <a:lnTo>
                    <a:pt x="806" y="800"/>
                  </a:lnTo>
                  <a:lnTo>
                    <a:pt x="806" y="784"/>
                  </a:lnTo>
                  <a:lnTo>
                    <a:pt x="807" y="800"/>
                  </a:lnTo>
                  <a:lnTo>
                    <a:pt x="807" y="775"/>
                  </a:lnTo>
                  <a:lnTo>
                    <a:pt x="808" y="800"/>
                  </a:lnTo>
                  <a:lnTo>
                    <a:pt x="808" y="786"/>
                  </a:lnTo>
                  <a:lnTo>
                    <a:pt x="809" y="789"/>
                  </a:lnTo>
                  <a:lnTo>
                    <a:pt x="809" y="800"/>
                  </a:lnTo>
                  <a:lnTo>
                    <a:pt x="810" y="800"/>
                  </a:lnTo>
                  <a:lnTo>
                    <a:pt x="810" y="774"/>
                  </a:lnTo>
                  <a:lnTo>
                    <a:pt x="811" y="766"/>
                  </a:lnTo>
                  <a:lnTo>
                    <a:pt x="811" y="800"/>
                  </a:lnTo>
                  <a:lnTo>
                    <a:pt x="812" y="800"/>
                  </a:lnTo>
                  <a:lnTo>
                    <a:pt x="812" y="763"/>
                  </a:lnTo>
                  <a:lnTo>
                    <a:pt x="813" y="800"/>
                  </a:lnTo>
                  <a:lnTo>
                    <a:pt x="813" y="641"/>
                  </a:lnTo>
                  <a:lnTo>
                    <a:pt x="814" y="800"/>
                  </a:lnTo>
                  <a:lnTo>
                    <a:pt x="814" y="686"/>
                  </a:lnTo>
                  <a:lnTo>
                    <a:pt x="815" y="800"/>
                  </a:lnTo>
                  <a:lnTo>
                    <a:pt x="815" y="713"/>
                  </a:lnTo>
                  <a:lnTo>
                    <a:pt x="816" y="800"/>
                  </a:lnTo>
                  <a:lnTo>
                    <a:pt x="816" y="759"/>
                  </a:lnTo>
                  <a:lnTo>
                    <a:pt x="817" y="767"/>
                  </a:lnTo>
                  <a:lnTo>
                    <a:pt x="817" y="800"/>
                  </a:lnTo>
                  <a:lnTo>
                    <a:pt x="818" y="772"/>
                  </a:lnTo>
                  <a:lnTo>
                    <a:pt x="818" y="800"/>
                  </a:lnTo>
                  <a:lnTo>
                    <a:pt x="819" y="800"/>
                  </a:lnTo>
                  <a:lnTo>
                    <a:pt x="819" y="782"/>
                  </a:lnTo>
                  <a:lnTo>
                    <a:pt x="820" y="786"/>
                  </a:lnTo>
                  <a:lnTo>
                    <a:pt x="820" y="800"/>
                  </a:lnTo>
                  <a:lnTo>
                    <a:pt x="821" y="800"/>
                  </a:lnTo>
                  <a:lnTo>
                    <a:pt x="821" y="790"/>
                  </a:lnTo>
                  <a:lnTo>
                    <a:pt x="822" y="800"/>
                  </a:lnTo>
                  <a:lnTo>
                    <a:pt x="822" y="793"/>
                  </a:lnTo>
                  <a:lnTo>
                    <a:pt x="823" y="800"/>
                  </a:lnTo>
                  <a:lnTo>
                    <a:pt x="823" y="783"/>
                  </a:lnTo>
                  <a:lnTo>
                    <a:pt x="824" y="769"/>
                  </a:lnTo>
                  <a:lnTo>
                    <a:pt x="824" y="800"/>
                  </a:lnTo>
                  <a:lnTo>
                    <a:pt x="825" y="800"/>
                  </a:lnTo>
                  <a:lnTo>
                    <a:pt x="825" y="748"/>
                  </a:lnTo>
                  <a:lnTo>
                    <a:pt x="826" y="800"/>
                  </a:lnTo>
                  <a:lnTo>
                    <a:pt x="826" y="763"/>
                  </a:lnTo>
                  <a:lnTo>
                    <a:pt x="827" y="800"/>
                  </a:lnTo>
                  <a:lnTo>
                    <a:pt x="827" y="765"/>
                  </a:lnTo>
                  <a:lnTo>
                    <a:pt x="828" y="726"/>
                  </a:lnTo>
                  <a:lnTo>
                    <a:pt x="828" y="800"/>
                  </a:lnTo>
                  <a:lnTo>
                    <a:pt x="829" y="800"/>
                  </a:lnTo>
                  <a:lnTo>
                    <a:pt x="829" y="656"/>
                  </a:lnTo>
                  <a:lnTo>
                    <a:pt x="830" y="800"/>
                  </a:lnTo>
                  <a:lnTo>
                    <a:pt x="830" y="662"/>
                  </a:lnTo>
                  <a:lnTo>
                    <a:pt x="831" y="713"/>
                  </a:lnTo>
                  <a:lnTo>
                    <a:pt x="831" y="800"/>
                  </a:lnTo>
                  <a:lnTo>
                    <a:pt x="832" y="750"/>
                  </a:lnTo>
                  <a:lnTo>
                    <a:pt x="832" y="800"/>
                  </a:lnTo>
                  <a:lnTo>
                    <a:pt x="833" y="780"/>
                  </a:lnTo>
                  <a:lnTo>
                    <a:pt x="833" y="800"/>
                  </a:lnTo>
                  <a:lnTo>
                    <a:pt x="834" y="800"/>
                  </a:lnTo>
                  <a:lnTo>
                    <a:pt x="834" y="766"/>
                  </a:lnTo>
                  <a:lnTo>
                    <a:pt x="835" y="800"/>
                  </a:lnTo>
                  <a:lnTo>
                    <a:pt x="835" y="750"/>
                  </a:lnTo>
                  <a:lnTo>
                    <a:pt x="836" y="800"/>
                  </a:lnTo>
                  <a:lnTo>
                    <a:pt x="836" y="782"/>
                  </a:lnTo>
                  <a:lnTo>
                    <a:pt x="837" y="800"/>
                  </a:lnTo>
                  <a:lnTo>
                    <a:pt x="837" y="703"/>
                  </a:lnTo>
                  <a:lnTo>
                    <a:pt x="838" y="800"/>
                  </a:lnTo>
                  <a:lnTo>
                    <a:pt x="838" y="762"/>
                  </a:lnTo>
                  <a:lnTo>
                    <a:pt x="839" y="800"/>
                  </a:lnTo>
                  <a:lnTo>
                    <a:pt x="839" y="777"/>
                  </a:lnTo>
                  <a:lnTo>
                    <a:pt x="840" y="800"/>
                  </a:lnTo>
                  <a:lnTo>
                    <a:pt x="840" y="776"/>
                  </a:lnTo>
                  <a:lnTo>
                    <a:pt x="841" y="800"/>
                  </a:lnTo>
                  <a:lnTo>
                    <a:pt x="841" y="784"/>
                  </a:lnTo>
                  <a:lnTo>
                    <a:pt x="842" y="785"/>
                  </a:lnTo>
                  <a:lnTo>
                    <a:pt x="842" y="800"/>
                  </a:lnTo>
                  <a:lnTo>
                    <a:pt x="843" y="756"/>
                  </a:lnTo>
                  <a:lnTo>
                    <a:pt x="843" y="800"/>
                  </a:lnTo>
                  <a:lnTo>
                    <a:pt x="844" y="800"/>
                  </a:lnTo>
                  <a:lnTo>
                    <a:pt x="844" y="776"/>
                  </a:lnTo>
                  <a:lnTo>
                    <a:pt x="845" y="800"/>
                  </a:lnTo>
                  <a:lnTo>
                    <a:pt x="845" y="788"/>
                  </a:lnTo>
                  <a:lnTo>
                    <a:pt x="846" y="776"/>
                  </a:lnTo>
                  <a:lnTo>
                    <a:pt x="846" y="800"/>
                  </a:lnTo>
                  <a:lnTo>
                    <a:pt x="847" y="758"/>
                  </a:lnTo>
                  <a:lnTo>
                    <a:pt x="847" y="800"/>
                  </a:lnTo>
                  <a:lnTo>
                    <a:pt x="848" y="760"/>
                  </a:lnTo>
                  <a:lnTo>
                    <a:pt x="848" y="800"/>
                  </a:lnTo>
                  <a:lnTo>
                    <a:pt x="849" y="800"/>
                  </a:lnTo>
                  <a:lnTo>
                    <a:pt x="849" y="774"/>
                  </a:lnTo>
                  <a:lnTo>
                    <a:pt x="850" y="800"/>
                  </a:lnTo>
                  <a:lnTo>
                    <a:pt x="850" y="782"/>
                  </a:lnTo>
                  <a:lnTo>
                    <a:pt x="851" y="800"/>
                  </a:lnTo>
                  <a:lnTo>
                    <a:pt x="851" y="790"/>
                  </a:lnTo>
                  <a:lnTo>
                    <a:pt x="852" y="800"/>
                  </a:lnTo>
                  <a:lnTo>
                    <a:pt x="852" y="793"/>
                  </a:lnTo>
                  <a:lnTo>
                    <a:pt x="853" y="794"/>
                  </a:lnTo>
                  <a:lnTo>
                    <a:pt x="853" y="800"/>
                  </a:lnTo>
                  <a:lnTo>
                    <a:pt x="854" y="791"/>
                  </a:lnTo>
                  <a:lnTo>
                    <a:pt x="854" y="800"/>
                  </a:lnTo>
                  <a:lnTo>
                    <a:pt x="855" y="800"/>
                  </a:lnTo>
                  <a:lnTo>
                    <a:pt x="855" y="786"/>
                  </a:lnTo>
                  <a:lnTo>
                    <a:pt x="856" y="790"/>
                  </a:lnTo>
                  <a:lnTo>
                    <a:pt x="856" y="800"/>
                  </a:lnTo>
                  <a:lnTo>
                    <a:pt x="857" y="800"/>
                  </a:lnTo>
                  <a:lnTo>
                    <a:pt x="857" y="769"/>
                  </a:lnTo>
                  <a:lnTo>
                    <a:pt x="858" y="775"/>
                  </a:lnTo>
                  <a:lnTo>
                    <a:pt x="858" y="800"/>
                  </a:lnTo>
                  <a:lnTo>
                    <a:pt x="859" y="800"/>
                  </a:lnTo>
                  <a:lnTo>
                    <a:pt x="859" y="771"/>
                  </a:lnTo>
                  <a:lnTo>
                    <a:pt x="860" y="766"/>
                  </a:lnTo>
                  <a:lnTo>
                    <a:pt x="860" y="800"/>
                  </a:lnTo>
                  <a:lnTo>
                    <a:pt x="861" y="769"/>
                  </a:lnTo>
                  <a:lnTo>
                    <a:pt x="861" y="800"/>
                  </a:lnTo>
                  <a:lnTo>
                    <a:pt x="862" y="778"/>
                  </a:lnTo>
                  <a:lnTo>
                    <a:pt x="862" y="800"/>
                  </a:lnTo>
                  <a:lnTo>
                    <a:pt x="863" y="800"/>
                  </a:lnTo>
                  <a:lnTo>
                    <a:pt x="863" y="769"/>
                  </a:lnTo>
                  <a:lnTo>
                    <a:pt x="864" y="800"/>
                  </a:lnTo>
                  <a:lnTo>
                    <a:pt x="864" y="776"/>
                  </a:lnTo>
                  <a:lnTo>
                    <a:pt x="865" y="764"/>
                  </a:lnTo>
                  <a:lnTo>
                    <a:pt x="865" y="800"/>
                  </a:lnTo>
                  <a:lnTo>
                    <a:pt x="866" y="800"/>
                  </a:lnTo>
                  <a:lnTo>
                    <a:pt x="866" y="767"/>
                  </a:lnTo>
                  <a:lnTo>
                    <a:pt x="867" y="800"/>
                  </a:lnTo>
                  <a:lnTo>
                    <a:pt x="867" y="764"/>
                  </a:lnTo>
                  <a:lnTo>
                    <a:pt x="868" y="778"/>
                  </a:lnTo>
                  <a:lnTo>
                    <a:pt x="868" y="800"/>
                  </a:lnTo>
                  <a:lnTo>
                    <a:pt x="869" y="800"/>
                  </a:lnTo>
                  <a:lnTo>
                    <a:pt x="869" y="753"/>
                  </a:lnTo>
                  <a:lnTo>
                    <a:pt x="870" y="800"/>
                  </a:lnTo>
                  <a:lnTo>
                    <a:pt x="870" y="735"/>
                  </a:lnTo>
                  <a:lnTo>
                    <a:pt x="871" y="734"/>
                  </a:lnTo>
                  <a:lnTo>
                    <a:pt x="871" y="800"/>
                  </a:lnTo>
                  <a:lnTo>
                    <a:pt x="872" y="762"/>
                  </a:lnTo>
                  <a:lnTo>
                    <a:pt x="872" y="800"/>
                  </a:lnTo>
                  <a:lnTo>
                    <a:pt x="873" y="780"/>
                  </a:lnTo>
                  <a:lnTo>
                    <a:pt x="873" y="800"/>
                  </a:lnTo>
                  <a:lnTo>
                    <a:pt x="874" y="800"/>
                  </a:lnTo>
                  <a:lnTo>
                    <a:pt x="874" y="790"/>
                  </a:lnTo>
                  <a:lnTo>
                    <a:pt x="875" y="790"/>
                  </a:lnTo>
                  <a:lnTo>
                    <a:pt x="875" y="800"/>
                  </a:lnTo>
                  <a:lnTo>
                    <a:pt x="876" y="741"/>
                  </a:lnTo>
                  <a:lnTo>
                    <a:pt x="876" y="800"/>
                  </a:lnTo>
                  <a:lnTo>
                    <a:pt x="877" y="782"/>
                  </a:lnTo>
                  <a:lnTo>
                    <a:pt x="877" y="800"/>
                  </a:lnTo>
                  <a:lnTo>
                    <a:pt x="878" y="800"/>
                  </a:lnTo>
                  <a:lnTo>
                    <a:pt x="878" y="753"/>
                  </a:lnTo>
                  <a:lnTo>
                    <a:pt x="879" y="800"/>
                  </a:lnTo>
                  <a:lnTo>
                    <a:pt x="879" y="746"/>
                  </a:lnTo>
                  <a:lnTo>
                    <a:pt x="880" y="800"/>
                  </a:lnTo>
                  <a:lnTo>
                    <a:pt x="880" y="720"/>
                  </a:lnTo>
                  <a:lnTo>
                    <a:pt x="881" y="710"/>
                  </a:lnTo>
                  <a:lnTo>
                    <a:pt x="881" y="800"/>
                  </a:lnTo>
                  <a:lnTo>
                    <a:pt x="882" y="775"/>
                  </a:lnTo>
                  <a:lnTo>
                    <a:pt x="882" y="800"/>
                  </a:lnTo>
                  <a:lnTo>
                    <a:pt x="883" y="750"/>
                  </a:lnTo>
                  <a:lnTo>
                    <a:pt x="883" y="800"/>
                  </a:lnTo>
                  <a:lnTo>
                    <a:pt x="884" y="769"/>
                  </a:lnTo>
                  <a:lnTo>
                    <a:pt x="884" y="800"/>
                  </a:lnTo>
                  <a:lnTo>
                    <a:pt x="885" y="714"/>
                  </a:lnTo>
                  <a:lnTo>
                    <a:pt x="885" y="800"/>
                  </a:lnTo>
                  <a:lnTo>
                    <a:pt x="886" y="800"/>
                  </a:lnTo>
                  <a:lnTo>
                    <a:pt x="886" y="792"/>
                  </a:lnTo>
                  <a:lnTo>
                    <a:pt x="887" y="800"/>
                  </a:lnTo>
                  <a:lnTo>
                    <a:pt x="887" y="791"/>
                  </a:lnTo>
                  <a:lnTo>
                    <a:pt x="888" y="800"/>
                  </a:lnTo>
                  <a:lnTo>
                    <a:pt x="888" y="794"/>
                  </a:lnTo>
                  <a:lnTo>
                    <a:pt x="889" y="800"/>
                  </a:lnTo>
                  <a:lnTo>
                    <a:pt x="889" y="790"/>
                  </a:lnTo>
                  <a:lnTo>
                    <a:pt x="890" y="800"/>
                  </a:lnTo>
                  <a:lnTo>
                    <a:pt x="890" y="784"/>
                  </a:lnTo>
                  <a:lnTo>
                    <a:pt x="891" y="800"/>
                  </a:lnTo>
                  <a:lnTo>
                    <a:pt x="891" y="781"/>
                  </a:lnTo>
                  <a:lnTo>
                    <a:pt x="892" y="800"/>
                  </a:lnTo>
                  <a:lnTo>
                    <a:pt x="892" y="781"/>
                  </a:lnTo>
                  <a:lnTo>
                    <a:pt x="893" y="800"/>
                  </a:lnTo>
                  <a:lnTo>
                    <a:pt x="893" y="783"/>
                  </a:lnTo>
                  <a:lnTo>
                    <a:pt x="894" y="800"/>
                  </a:lnTo>
                  <a:lnTo>
                    <a:pt x="894" y="786"/>
                  </a:lnTo>
                  <a:lnTo>
                    <a:pt x="895" y="791"/>
                  </a:lnTo>
                  <a:lnTo>
                    <a:pt x="895" y="800"/>
                  </a:lnTo>
                  <a:lnTo>
                    <a:pt x="896" y="800"/>
                  </a:lnTo>
                  <a:lnTo>
                    <a:pt x="896" y="788"/>
                  </a:lnTo>
                  <a:lnTo>
                    <a:pt x="897" y="800"/>
                  </a:lnTo>
                  <a:lnTo>
                    <a:pt x="897" y="788"/>
                  </a:lnTo>
                  <a:lnTo>
                    <a:pt x="898" y="800"/>
                  </a:lnTo>
                  <a:lnTo>
                    <a:pt x="898" y="785"/>
                  </a:lnTo>
                  <a:lnTo>
                    <a:pt x="899" y="800"/>
                  </a:lnTo>
                  <a:lnTo>
                    <a:pt x="899" y="779"/>
                  </a:lnTo>
                  <a:lnTo>
                    <a:pt x="900" y="800"/>
                  </a:lnTo>
                  <a:lnTo>
                    <a:pt x="900" y="784"/>
                  </a:lnTo>
                  <a:lnTo>
                    <a:pt x="901" y="784"/>
                  </a:lnTo>
                  <a:lnTo>
                    <a:pt x="901" y="800"/>
                  </a:lnTo>
                  <a:lnTo>
                    <a:pt x="902" y="800"/>
                  </a:lnTo>
                  <a:lnTo>
                    <a:pt x="902" y="789"/>
                  </a:lnTo>
                  <a:lnTo>
                    <a:pt x="903" y="800"/>
                  </a:lnTo>
                  <a:lnTo>
                    <a:pt x="903" y="785"/>
                  </a:lnTo>
                  <a:lnTo>
                    <a:pt x="904" y="783"/>
                  </a:lnTo>
                  <a:lnTo>
                    <a:pt x="904" y="800"/>
                  </a:lnTo>
                  <a:lnTo>
                    <a:pt x="905" y="789"/>
                  </a:lnTo>
                  <a:lnTo>
                    <a:pt x="905" y="800"/>
                  </a:lnTo>
                  <a:lnTo>
                    <a:pt x="906" y="800"/>
                  </a:lnTo>
                  <a:lnTo>
                    <a:pt x="906" y="787"/>
                  </a:lnTo>
                  <a:lnTo>
                    <a:pt x="907" y="800"/>
                  </a:lnTo>
                  <a:lnTo>
                    <a:pt x="907" y="770"/>
                  </a:lnTo>
                  <a:lnTo>
                    <a:pt x="908" y="800"/>
                  </a:lnTo>
                  <a:lnTo>
                    <a:pt x="908" y="755"/>
                  </a:lnTo>
                  <a:lnTo>
                    <a:pt x="909" y="761"/>
                  </a:lnTo>
                  <a:lnTo>
                    <a:pt x="909" y="800"/>
                  </a:lnTo>
                  <a:lnTo>
                    <a:pt x="910" y="800"/>
                  </a:lnTo>
                  <a:lnTo>
                    <a:pt x="910" y="753"/>
                  </a:lnTo>
                  <a:lnTo>
                    <a:pt x="911" y="800"/>
                  </a:lnTo>
                  <a:lnTo>
                    <a:pt x="911" y="756"/>
                  </a:lnTo>
                  <a:lnTo>
                    <a:pt x="912" y="777"/>
                  </a:lnTo>
                  <a:lnTo>
                    <a:pt x="912" y="800"/>
                  </a:lnTo>
                  <a:lnTo>
                    <a:pt x="913" y="789"/>
                  </a:lnTo>
                  <a:lnTo>
                    <a:pt x="913" y="800"/>
                  </a:lnTo>
                  <a:lnTo>
                    <a:pt x="914" y="800"/>
                  </a:lnTo>
                  <a:lnTo>
                    <a:pt x="914" y="788"/>
                  </a:lnTo>
                  <a:lnTo>
                    <a:pt x="915" y="776"/>
                  </a:lnTo>
                  <a:lnTo>
                    <a:pt x="915" y="800"/>
                  </a:lnTo>
                  <a:lnTo>
                    <a:pt x="916" y="788"/>
                  </a:lnTo>
                  <a:lnTo>
                    <a:pt x="916" y="800"/>
                  </a:lnTo>
                  <a:lnTo>
                    <a:pt x="917" y="786"/>
                  </a:lnTo>
                  <a:lnTo>
                    <a:pt x="917" y="800"/>
                  </a:lnTo>
                  <a:lnTo>
                    <a:pt x="918" y="783"/>
                  </a:lnTo>
                  <a:lnTo>
                    <a:pt x="918" y="800"/>
                  </a:lnTo>
                  <a:lnTo>
                    <a:pt x="919" y="786"/>
                  </a:lnTo>
                  <a:lnTo>
                    <a:pt x="919" y="800"/>
                  </a:lnTo>
                  <a:lnTo>
                    <a:pt x="920" y="800"/>
                  </a:lnTo>
                  <a:lnTo>
                    <a:pt x="920" y="787"/>
                  </a:lnTo>
                  <a:lnTo>
                    <a:pt x="921" y="782"/>
                  </a:lnTo>
                  <a:lnTo>
                    <a:pt x="921" y="800"/>
                  </a:lnTo>
                  <a:lnTo>
                    <a:pt x="922" y="791"/>
                  </a:lnTo>
                  <a:lnTo>
                    <a:pt x="922" y="800"/>
                  </a:lnTo>
                  <a:lnTo>
                    <a:pt x="923" y="789"/>
                  </a:lnTo>
                  <a:lnTo>
                    <a:pt x="923" y="800"/>
                  </a:lnTo>
                  <a:lnTo>
                    <a:pt x="924" y="800"/>
                  </a:lnTo>
                  <a:lnTo>
                    <a:pt x="924" y="790"/>
                  </a:lnTo>
                  <a:lnTo>
                    <a:pt x="925" y="800"/>
                  </a:lnTo>
                  <a:lnTo>
                    <a:pt x="925" y="773"/>
                  </a:lnTo>
                  <a:lnTo>
                    <a:pt x="926" y="800"/>
                  </a:lnTo>
                  <a:lnTo>
                    <a:pt x="926" y="792"/>
                  </a:lnTo>
                  <a:lnTo>
                    <a:pt x="927" y="800"/>
                  </a:lnTo>
                  <a:lnTo>
                    <a:pt x="927" y="792"/>
                  </a:lnTo>
                  <a:lnTo>
                    <a:pt x="928" y="800"/>
                  </a:lnTo>
                  <a:lnTo>
                    <a:pt x="928" y="794"/>
                  </a:lnTo>
                  <a:lnTo>
                    <a:pt x="929" y="800"/>
                  </a:lnTo>
                  <a:lnTo>
                    <a:pt x="929" y="795"/>
                  </a:lnTo>
                  <a:lnTo>
                    <a:pt x="930" y="800"/>
                  </a:lnTo>
                  <a:lnTo>
                    <a:pt x="930" y="790"/>
                  </a:lnTo>
                  <a:lnTo>
                    <a:pt x="931" y="800"/>
                  </a:lnTo>
                  <a:lnTo>
                    <a:pt x="931" y="790"/>
                  </a:lnTo>
                  <a:lnTo>
                    <a:pt x="932" y="789"/>
                  </a:lnTo>
                  <a:lnTo>
                    <a:pt x="932" y="800"/>
                  </a:lnTo>
                  <a:lnTo>
                    <a:pt x="933" y="792"/>
                  </a:lnTo>
                  <a:lnTo>
                    <a:pt x="933" y="800"/>
                  </a:lnTo>
                  <a:lnTo>
                    <a:pt x="934" y="800"/>
                  </a:lnTo>
                  <a:lnTo>
                    <a:pt x="934" y="791"/>
                  </a:lnTo>
                  <a:lnTo>
                    <a:pt x="935" y="800"/>
                  </a:lnTo>
                  <a:lnTo>
                    <a:pt x="935" y="781"/>
                  </a:lnTo>
                  <a:lnTo>
                    <a:pt x="936" y="800"/>
                  </a:lnTo>
                  <a:lnTo>
                    <a:pt x="936" y="782"/>
                  </a:lnTo>
                  <a:lnTo>
                    <a:pt x="937" y="800"/>
                  </a:lnTo>
                  <a:lnTo>
                    <a:pt x="937" y="788"/>
                  </a:lnTo>
                  <a:lnTo>
                    <a:pt x="938" y="800"/>
                  </a:lnTo>
                  <a:lnTo>
                    <a:pt x="938" y="773"/>
                  </a:lnTo>
                  <a:lnTo>
                    <a:pt x="939" y="800"/>
                  </a:lnTo>
                  <a:lnTo>
                    <a:pt x="939" y="729"/>
                  </a:lnTo>
                  <a:lnTo>
                    <a:pt x="940" y="800"/>
                  </a:lnTo>
                  <a:lnTo>
                    <a:pt x="940" y="724"/>
                  </a:lnTo>
                  <a:lnTo>
                    <a:pt x="941" y="717"/>
                  </a:lnTo>
                  <a:lnTo>
                    <a:pt x="941" y="800"/>
                  </a:lnTo>
                  <a:lnTo>
                    <a:pt x="942" y="721"/>
                  </a:lnTo>
                  <a:lnTo>
                    <a:pt x="942" y="800"/>
                  </a:lnTo>
                  <a:lnTo>
                    <a:pt x="943" y="764"/>
                  </a:lnTo>
                  <a:lnTo>
                    <a:pt x="943" y="800"/>
                  </a:lnTo>
                  <a:lnTo>
                    <a:pt x="944" y="800"/>
                  </a:lnTo>
                  <a:lnTo>
                    <a:pt x="944" y="782"/>
                  </a:lnTo>
                  <a:lnTo>
                    <a:pt x="945" y="793"/>
                  </a:lnTo>
                  <a:lnTo>
                    <a:pt x="945" y="800"/>
                  </a:lnTo>
                  <a:lnTo>
                    <a:pt x="946" y="800"/>
                  </a:lnTo>
                  <a:lnTo>
                    <a:pt x="946" y="794"/>
                  </a:lnTo>
                  <a:lnTo>
                    <a:pt x="947" y="800"/>
                  </a:lnTo>
                  <a:lnTo>
                    <a:pt x="947" y="797"/>
                  </a:lnTo>
                  <a:lnTo>
                    <a:pt x="948" y="800"/>
                  </a:lnTo>
                  <a:lnTo>
                    <a:pt x="948" y="796"/>
                  </a:lnTo>
                  <a:lnTo>
                    <a:pt x="949" y="800"/>
                  </a:lnTo>
                  <a:lnTo>
                    <a:pt x="949" y="794"/>
                  </a:lnTo>
                  <a:lnTo>
                    <a:pt x="950" y="796"/>
                  </a:lnTo>
                  <a:lnTo>
                    <a:pt x="950" y="800"/>
                  </a:lnTo>
                  <a:lnTo>
                    <a:pt x="951" y="797"/>
                  </a:lnTo>
                  <a:lnTo>
                    <a:pt x="951" y="800"/>
                  </a:lnTo>
                  <a:lnTo>
                    <a:pt x="952" y="781"/>
                  </a:lnTo>
                  <a:lnTo>
                    <a:pt x="952" y="800"/>
                  </a:lnTo>
                  <a:lnTo>
                    <a:pt x="953" y="797"/>
                  </a:lnTo>
                  <a:lnTo>
                    <a:pt x="953" y="800"/>
                  </a:lnTo>
                  <a:lnTo>
                    <a:pt x="954" y="797"/>
                  </a:lnTo>
                  <a:lnTo>
                    <a:pt x="954" y="800"/>
                  </a:lnTo>
                  <a:lnTo>
                    <a:pt x="955" y="792"/>
                  </a:lnTo>
                  <a:lnTo>
                    <a:pt x="955" y="800"/>
                  </a:lnTo>
                  <a:lnTo>
                    <a:pt x="956" y="800"/>
                  </a:lnTo>
                  <a:lnTo>
                    <a:pt x="956" y="784"/>
                  </a:lnTo>
                  <a:lnTo>
                    <a:pt x="957" y="800"/>
                  </a:lnTo>
                  <a:lnTo>
                    <a:pt x="957" y="782"/>
                  </a:lnTo>
                  <a:lnTo>
                    <a:pt x="958" y="800"/>
                  </a:lnTo>
                  <a:lnTo>
                    <a:pt x="958" y="792"/>
                  </a:lnTo>
                  <a:lnTo>
                    <a:pt x="959" y="800"/>
                  </a:lnTo>
                  <a:lnTo>
                    <a:pt x="959" y="780"/>
                  </a:lnTo>
                  <a:lnTo>
                    <a:pt x="960" y="800"/>
                  </a:lnTo>
                  <a:lnTo>
                    <a:pt x="960" y="788"/>
                  </a:lnTo>
                  <a:lnTo>
                    <a:pt x="961" y="800"/>
                  </a:lnTo>
                  <a:lnTo>
                    <a:pt x="961" y="773"/>
                  </a:lnTo>
                  <a:lnTo>
                    <a:pt x="962" y="800"/>
                  </a:lnTo>
                  <a:lnTo>
                    <a:pt x="962" y="759"/>
                  </a:lnTo>
                  <a:lnTo>
                    <a:pt x="963" y="800"/>
                  </a:lnTo>
                  <a:lnTo>
                    <a:pt x="963" y="726"/>
                  </a:lnTo>
                  <a:lnTo>
                    <a:pt x="964" y="800"/>
                  </a:lnTo>
                  <a:lnTo>
                    <a:pt x="964" y="765"/>
                  </a:lnTo>
                  <a:lnTo>
                    <a:pt x="965" y="800"/>
                  </a:lnTo>
                  <a:lnTo>
                    <a:pt x="965" y="778"/>
                  </a:lnTo>
                  <a:lnTo>
                    <a:pt x="966" y="800"/>
                  </a:lnTo>
                  <a:lnTo>
                    <a:pt x="966" y="765"/>
                  </a:lnTo>
                  <a:lnTo>
                    <a:pt x="967" y="800"/>
                  </a:lnTo>
                  <a:lnTo>
                    <a:pt x="967" y="783"/>
                  </a:lnTo>
                  <a:lnTo>
                    <a:pt x="968" y="800"/>
                  </a:lnTo>
                  <a:lnTo>
                    <a:pt x="968" y="791"/>
                  </a:lnTo>
                  <a:lnTo>
                    <a:pt x="969" y="786"/>
                  </a:lnTo>
                  <a:lnTo>
                    <a:pt x="969" y="800"/>
                  </a:lnTo>
                  <a:lnTo>
                    <a:pt x="970" y="800"/>
                  </a:lnTo>
                  <a:lnTo>
                    <a:pt x="970" y="784"/>
                  </a:lnTo>
                  <a:lnTo>
                    <a:pt x="971" y="800"/>
                  </a:lnTo>
                  <a:lnTo>
                    <a:pt x="971" y="754"/>
                  </a:lnTo>
                  <a:lnTo>
                    <a:pt x="972" y="800"/>
                  </a:lnTo>
                  <a:lnTo>
                    <a:pt x="972" y="784"/>
                  </a:lnTo>
                  <a:lnTo>
                    <a:pt x="973" y="800"/>
                  </a:lnTo>
                  <a:lnTo>
                    <a:pt x="973" y="768"/>
                  </a:lnTo>
                  <a:lnTo>
                    <a:pt x="974" y="760"/>
                  </a:lnTo>
                  <a:lnTo>
                    <a:pt x="974" y="800"/>
                  </a:lnTo>
                  <a:lnTo>
                    <a:pt x="975" y="800"/>
                  </a:lnTo>
                  <a:lnTo>
                    <a:pt x="975" y="760"/>
                  </a:lnTo>
                  <a:lnTo>
                    <a:pt x="976" y="771"/>
                  </a:lnTo>
                  <a:lnTo>
                    <a:pt x="976" y="800"/>
                  </a:lnTo>
                  <a:lnTo>
                    <a:pt x="977" y="793"/>
                  </a:lnTo>
                  <a:lnTo>
                    <a:pt x="977" y="800"/>
                  </a:lnTo>
                  <a:lnTo>
                    <a:pt x="978" y="797"/>
                  </a:lnTo>
                  <a:lnTo>
                    <a:pt x="978" y="800"/>
                  </a:lnTo>
                  <a:lnTo>
                    <a:pt x="979" y="800"/>
                  </a:lnTo>
                  <a:lnTo>
                    <a:pt x="979" y="798"/>
                  </a:lnTo>
                  <a:lnTo>
                    <a:pt x="980" y="776"/>
                  </a:lnTo>
                  <a:lnTo>
                    <a:pt x="980" y="800"/>
                  </a:lnTo>
                  <a:lnTo>
                    <a:pt x="981" y="800"/>
                  </a:lnTo>
                  <a:lnTo>
                    <a:pt x="981" y="793"/>
                  </a:lnTo>
                  <a:lnTo>
                    <a:pt x="982" y="800"/>
                  </a:lnTo>
                  <a:lnTo>
                    <a:pt x="982" y="794"/>
                  </a:lnTo>
                  <a:lnTo>
                    <a:pt x="983" y="800"/>
                  </a:lnTo>
                  <a:lnTo>
                    <a:pt x="983" y="787"/>
                  </a:lnTo>
                  <a:lnTo>
                    <a:pt x="984" y="800"/>
                  </a:lnTo>
                  <a:lnTo>
                    <a:pt x="984" y="791"/>
                  </a:lnTo>
                  <a:lnTo>
                    <a:pt x="985" y="792"/>
                  </a:lnTo>
                  <a:lnTo>
                    <a:pt x="985" y="800"/>
                  </a:lnTo>
                  <a:lnTo>
                    <a:pt x="986" y="795"/>
                  </a:lnTo>
                  <a:lnTo>
                    <a:pt x="986" y="800"/>
                  </a:lnTo>
                  <a:lnTo>
                    <a:pt x="987" y="800"/>
                  </a:lnTo>
                  <a:lnTo>
                    <a:pt x="987" y="794"/>
                  </a:lnTo>
                  <a:lnTo>
                    <a:pt x="988" y="794"/>
                  </a:lnTo>
                  <a:lnTo>
                    <a:pt x="988" y="800"/>
                  </a:lnTo>
                  <a:lnTo>
                    <a:pt x="989" y="789"/>
                  </a:lnTo>
                  <a:lnTo>
                    <a:pt x="989" y="800"/>
                  </a:lnTo>
                  <a:lnTo>
                    <a:pt x="990" y="800"/>
                  </a:lnTo>
                  <a:lnTo>
                    <a:pt x="990" y="776"/>
                  </a:lnTo>
                  <a:lnTo>
                    <a:pt x="991" y="800"/>
                  </a:lnTo>
                  <a:lnTo>
                    <a:pt x="991" y="764"/>
                  </a:lnTo>
                  <a:lnTo>
                    <a:pt x="992" y="760"/>
                  </a:lnTo>
                  <a:lnTo>
                    <a:pt x="992" y="800"/>
                  </a:lnTo>
                  <a:lnTo>
                    <a:pt x="993" y="768"/>
                  </a:lnTo>
                  <a:lnTo>
                    <a:pt x="993" y="800"/>
                  </a:lnTo>
                  <a:lnTo>
                    <a:pt x="994" y="800"/>
                  </a:lnTo>
                  <a:lnTo>
                    <a:pt x="994" y="781"/>
                  </a:lnTo>
                  <a:lnTo>
                    <a:pt x="995" y="791"/>
                  </a:lnTo>
                  <a:lnTo>
                    <a:pt x="995" y="800"/>
                  </a:lnTo>
                  <a:lnTo>
                    <a:pt x="996" y="790"/>
                  </a:lnTo>
                  <a:lnTo>
                    <a:pt x="996" y="800"/>
                  </a:lnTo>
                  <a:lnTo>
                    <a:pt x="997" y="800"/>
                  </a:lnTo>
                  <a:lnTo>
                    <a:pt x="997" y="787"/>
                  </a:lnTo>
                  <a:lnTo>
                    <a:pt x="998" y="800"/>
                  </a:lnTo>
                  <a:lnTo>
                    <a:pt x="998" y="790"/>
                  </a:lnTo>
                  <a:lnTo>
                    <a:pt x="999" y="800"/>
                  </a:lnTo>
                  <a:lnTo>
                    <a:pt x="999" y="794"/>
                  </a:lnTo>
                  <a:lnTo>
                    <a:pt x="1000" y="800"/>
                  </a:lnTo>
                  <a:lnTo>
                    <a:pt x="1000" y="792"/>
                  </a:lnTo>
                  <a:lnTo>
                    <a:pt x="1001" y="800"/>
                  </a:lnTo>
                  <a:lnTo>
                    <a:pt x="1001" y="789"/>
                  </a:lnTo>
                  <a:lnTo>
                    <a:pt x="1002" y="800"/>
                  </a:lnTo>
                  <a:lnTo>
                    <a:pt x="1002" y="788"/>
                  </a:lnTo>
                  <a:lnTo>
                    <a:pt x="1003" y="800"/>
                  </a:lnTo>
                  <a:lnTo>
                    <a:pt x="1003" y="783"/>
                  </a:lnTo>
                  <a:lnTo>
                    <a:pt x="1004" y="800"/>
                  </a:lnTo>
                  <a:lnTo>
                    <a:pt x="1004" y="780"/>
                  </a:lnTo>
                  <a:lnTo>
                    <a:pt x="1005" y="800"/>
                  </a:lnTo>
                  <a:lnTo>
                    <a:pt x="1005" y="783"/>
                  </a:lnTo>
                  <a:lnTo>
                    <a:pt x="1006" y="800"/>
                  </a:lnTo>
                  <a:lnTo>
                    <a:pt x="1006" y="789"/>
                  </a:lnTo>
                  <a:lnTo>
                    <a:pt x="1007" y="800"/>
                  </a:lnTo>
                  <a:lnTo>
                    <a:pt x="1007" y="794"/>
                  </a:lnTo>
                  <a:lnTo>
                    <a:pt x="1008" y="800"/>
                  </a:lnTo>
                  <a:lnTo>
                    <a:pt x="1008" y="795"/>
                  </a:lnTo>
                  <a:lnTo>
                    <a:pt x="1009" y="800"/>
                  </a:lnTo>
                  <a:lnTo>
                    <a:pt x="1009" y="795"/>
                  </a:lnTo>
                  <a:lnTo>
                    <a:pt x="1010" y="794"/>
                  </a:lnTo>
                  <a:lnTo>
                    <a:pt x="1010" y="800"/>
                  </a:lnTo>
                  <a:lnTo>
                    <a:pt x="1011" y="800"/>
                  </a:lnTo>
                  <a:lnTo>
                    <a:pt x="1011" y="795"/>
                  </a:lnTo>
                  <a:lnTo>
                    <a:pt x="1012" y="795"/>
                  </a:lnTo>
                  <a:lnTo>
                    <a:pt x="1012" y="800"/>
                  </a:lnTo>
                  <a:lnTo>
                    <a:pt x="1013" y="800"/>
                  </a:lnTo>
                  <a:lnTo>
                    <a:pt x="1013" y="797"/>
                  </a:lnTo>
                  <a:lnTo>
                    <a:pt x="1014" y="800"/>
                  </a:lnTo>
                  <a:lnTo>
                    <a:pt x="1014" y="797"/>
                  </a:lnTo>
                  <a:lnTo>
                    <a:pt x="1015" y="798"/>
                  </a:lnTo>
                  <a:lnTo>
                    <a:pt x="1015" y="800"/>
                  </a:lnTo>
                  <a:lnTo>
                    <a:pt x="1016" y="800"/>
                  </a:lnTo>
                  <a:lnTo>
                    <a:pt x="1016" y="798"/>
                  </a:lnTo>
                  <a:lnTo>
                    <a:pt x="1017" y="799"/>
                  </a:lnTo>
                  <a:lnTo>
                    <a:pt x="1017" y="800"/>
                  </a:lnTo>
                  <a:lnTo>
                    <a:pt x="1018" y="800"/>
                  </a:lnTo>
                  <a:lnTo>
                    <a:pt x="1018" y="799"/>
                  </a:lnTo>
                  <a:lnTo>
                    <a:pt x="1019" y="799"/>
                  </a:lnTo>
                  <a:lnTo>
                    <a:pt x="1019" y="800"/>
                  </a:lnTo>
                  <a:lnTo>
                    <a:pt x="1020" y="800"/>
                  </a:lnTo>
                  <a:lnTo>
                    <a:pt x="1020" y="799"/>
                  </a:lnTo>
                  <a:lnTo>
                    <a:pt x="1021" y="800"/>
                  </a:lnTo>
                  <a:lnTo>
                    <a:pt x="1021" y="798"/>
                  </a:lnTo>
                  <a:lnTo>
                    <a:pt x="1022" y="800"/>
                  </a:lnTo>
                  <a:lnTo>
                    <a:pt x="1022" y="797"/>
                  </a:lnTo>
                  <a:lnTo>
                    <a:pt x="1023" y="795"/>
                  </a:lnTo>
                  <a:lnTo>
                    <a:pt x="1023" y="800"/>
                  </a:lnTo>
                  <a:lnTo>
                    <a:pt x="1024" y="795"/>
                  </a:lnTo>
                  <a:lnTo>
                    <a:pt x="1024" y="800"/>
                  </a:lnTo>
                  <a:lnTo>
                    <a:pt x="1025" y="797"/>
                  </a:lnTo>
                  <a:lnTo>
                    <a:pt x="1025" y="800"/>
                  </a:lnTo>
                  <a:lnTo>
                    <a:pt x="1026" y="796"/>
                  </a:lnTo>
                  <a:lnTo>
                    <a:pt x="1026" y="800"/>
                  </a:lnTo>
                  <a:lnTo>
                    <a:pt x="1027" y="784"/>
                  </a:lnTo>
                  <a:lnTo>
                    <a:pt x="1027" y="800"/>
                  </a:lnTo>
                  <a:lnTo>
                    <a:pt x="1028" y="759"/>
                  </a:lnTo>
                  <a:lnTo>
                    <a:pt x="1028" y="800"/>
                  </a:lnTo>
                  <a:lnTo>
                    <a:pt x="1029" y="800"/>
                  </a:lnTo>
                  <a:lnTo>
                    <a:pt x="1029" y="766"/>
                  </a:lnTo>
                  <a:lnTo>
                    <a:pt x="1030" y="780"/>
                  </a:lnTo>
                  <a:lnTo>
                    <a:pt x="1030" y="800"/>
                  </a:lnTo>
                  <a:lnTo>
                    <a:pt x="1031" y="790"/>
                  </a:lnTo>
                  <a:lnTo>
                    <a:pt x="1031" y="800"/>
                  </a:lnTo>
                  <a:lnTo>
                    <a:pt x="1032" y="791"/>
                  </a:lnTo>
                  <a:lnTo>
                    <a:pt x="1032" y="800"/>
                  </a:lnTo>
                  <a:lnTo>
                    <a:pt x="1033" y="791"/>
                  </a:lnTo>
                  <a:lnTo>
                    <a:pt x="1033" y="800"/>
                  </a:lnTo>
                  <a:lnTo>
                    <a:pt x="1034" y="792"/>
                  </a:lnTo>
                  <a:lnTo>
                    <a:pt x="1034" y="800"/>
                  </a:lnTo>
                  <a:lnTo>
                    <a:pt x="1035" y="791"/>
                  </a:lnTo>
                  <a:lnTo>
                    <a:pt x="1035" y="800"/>
                  </a:lnTo>
                  <a:lnTo>
                    <a:pt x="1036" y="785"/>
                  </a:lnTo>
                  <a:lnTo>
                    <a:pt x="1036" y="800"/>
                  </a:lnTo>
                  <a:lnTo>
                    <a:pt x="1037" y="791"/>
                  </a:lnTo>
                  <a:lnTo>
                    <a:pt x="1037" y="800"/>
                  </a:lnTo>
                  <a:lnTo>
                    <a:pt x="1038" y="800"/>
                  </a:lnTo>
                  <a:lnTo>
                    <a:pt x="1038" y="799"/>
                  </a:lnTo>
                  <a:lnTo>
                    <a:pt x="1039" y="799"/>
                  </a:lnTo>
                  <a:lnTo>
                    <a:pt x="1039" y="800"/>
                  </a:lnTo>
                  <a:lnTo>
                    <a:pt x="1040" y="800"/>
                  </a:lnTo>
                  <a:lnTo>
                    <a:pt x="1040" y="799"/>
                  </a:lnTo>
                  <a:lnTo>
                    <a:pt x="1041" y="800"/>
                  </a:lnTo>
                  <a:lnTo>
                    <a:pt x="1041" y="799"/>
                  </a:lnTo>
                  <a:lnTo>
                    <a:pt x="1042" y="794"/>
                  </a:lnTo>
                  <a:lnTo>
                    <a:pt x="1042" y="800"/>
                  </a:lnTo>
                  <a:lnTo>
                    <a:pt x="1043" y="800"/>
                  </a:lnTo>
                  <a:lnTo>
                    <a:pt x="1043" y="793"/>
                  </a:lnTo>
                  <a:lnTo>
                    <a:pt x="1044" y="800"/>
                  </a:lnTo>
                  <a:lnTo>
                    <a:pt x="1044" y="793"/>
                  </a:lnTo>
                  <a:lnTo>
                    <a:pt x="1045" y="800"/>
                  </a:lnTo>
                  <a:lnTo>
                    <a:pt x="1045" y="787"/>
                  </a:lnTo>
                  <a:lnTo>
                    <a:pt x="1046" y="792"/>
                  </a:lnTo>
                  <a:lnTo>
                    <a:pt x="1046" y="800"/>
                  </a:lnTo>
                  <a:lnTo>
                    <a:pt x="1047" y="800"/>
                  </a:lnTo>
                  <a:lnTo>
                    <a:pt x="1047" y="789"/>
                  </a:lnTo>
                  <a:lnTo>
                    <a:pt x="1048" y="790"/>
                  </a:lnTo>
                  <a:lnTo>
                    <a:pt x="1048" y="800"/>
                  </a:lnTo>
                  <a:lnTo>
                    <a:pt x="1049" y="794"/>
                  </a:lnTo>
                  <a:lnTo>
                    <a:pt x="1049" y="800"/>
                  </a:lnTo>
                  <a:lnTo>
                    <a:pt x="1050" y="797"/>
                  </a:lnTo>
                  <a:lnTo>
                    <a:pt x="1050" y="800"/>
                  </a:lnTo>
                  <a:lnTo>
                    <a:pt x="1051" y="798"/>
                  </a:lnTo>
                  <a:lnTo>
                    <a:pt x="1051" y="800"/>
                  </a:lnTo>
                  <a:lnTo>
                    <a:pt x="1052" y="797"/>
                  </a:lnTo>
                  <a:lnTo>
                    <a:pt x="1052" y="800"/>
                  </a:lnTo>
                  <a:lnTo>
                    <a:pt x="1053" y="793"/>
                  </a:lnTo>
                  <a:lnTo>
                    <a:pt x="1053" y="800"/>
                  </a:lnTo>
                  <a:lnTo>
                    <a:pt x="1054" y="800"/>
                  </a:lnTo>
                  <a:lnTo>
                    <a:pt x="1054" y="793"/>
                  </a:lnTo>
                  <a:lnTo>
                    <a:pt x="1055" y="794"/>
                  </a:lnTo>
                  <a:lnTo>
                    <a:pt x="1055" y="800"/>
                  </a:lnTo>
                  <a:lnTo>
                    <a:pt x="1056" y="791"/>
                  </a:lnTo>
                  <a:lnTo>
                    <a:pt x="1056" y="800"/>
                  </a:lnTo>
                  <a:lnTo>
                    <a:pt x="1057" y="800"/>
                  </a:lnTo>
                  <a:lnTo>
                    <a:pt x="1057" y="775"/>
                  </a:lnTo>
                  <a:lnTo>
                    <a:pt x="1058" y="758"/>
                  </a:lnTo>
                  <a:lnTo>
                    <a:pt x="1058" y="800"/>
                  </a:lnTo>
                  <a:lnTo>
                    <a:pt x="1059" y="800"/>
                  </a:lnTo>
                  <a:lnTo>
                    <a:pt x="1059" y="787"/>
                  </a:lnTo>
                  <a:lnTo>
                    <a:pt x="1060" y="793"/>
                  </a:lnTo>
                  <a:lnTo>
                    <a:pt x="1060" y="800"/>
                  </a:lnTo>
                  <a:lnTo>
                    <a:pt x="1061" y="800"/>
                  </a:lnTo>
                  <a:lnTo>
                    <a:pt x="1061" y="793"/>
                  </a:lnTo>
                  <a:lnTo>
                    <a:pt x="1062" y="800"/>
                  </a:lnTo>
                  <a:lnTo>
                    <a:pt x="1062" y="795"/>
                  </a:lnTo>
                  <a:lnTo>
                    <a:pt x="1063" y="791"/>
                  </a:lnTo>
                  <a:lnTo>
                    <a:pt x="1063" y="800"/>
                  </a:lnTo>
                  <a:lnTo>
                    <a:pt x="1064" y="778"/>
                  </a:lnTo>
                  <a:lnTo>
                    <a:pt x="1064" y="800"/>
                  </a:lnTo>
                  <a:lnTo>
                    <a:pt x="1065" y="800"/>
                  </a:lnTo>
                  <a:lnTo>
                    <a:pt x="1065" y="743"/>
                  </a:lnTo>
                  <a:lnTo>
                    <a:pt x="1066" y="800"/>
                  </a:lnTo>
                  <a:lnTo>
                    <a:pt x="1066" y="691"/>
                  </a:lnTo>
                  <a:lnTo>
                    <a:pt x="1067" y="723"/>
                  </a:lnTo>
                  <a:lnTo>
                    <a:pt x="1067" y="800"/>
                  </a:lnTo>
                  <a:lnTo>
                    <a:pt x="1068" y="732"/>
                  </a:lnTo>
                  <a:lnTo>
                    <a:pt x="1068" y="800"/>
                  </a:lnTo>
                  <a:lnTo>
                    <a:pt x="1069" y="771"/>
                  </a:lnTo>
                  <a:lnTo>
                    <a:pt x="1069" y="800"/>
                  </a:lnTo>
                  <a:lnTo>
                    <a:pt x="1070" y="800"/>
                  </a:lnTo>
                  <a:lnTo>
                    <a:pt x="1070" y="787"/>
                  </a:lnTo>
                  <a:lnTo>
                    <a:pt x="1071" y="800"/>
                  </a:lnTo>
                  <a:lnTo>
                    <a:pt x="1071" y="791"/>
                  </a:lnTo>
                  <a:lnTo>
                    <a:pt x="1072" y="788"/>
                  </a:lnTo>
                  <a:lnTo>
                    <a:pt x="1072" y="800"/>
                  </a:lnTo>
                  <a:lnTo>
                    <a:pt x="1073" y="800"/>
                  </a:lnTo>
                  <a:lnTo>
                    <a:pt x="1073" y="793"/>
                  </a:lnTo>
                  <a:lnTo>
                    <a:pt x="1074" y="800"/>
                  </a:lnTo>
                  <a:lnTo>
                    <a:pt x="1074" y="791"/>
                  </a:lnTo>
                  <a:lnTo>
                    <a:pt x="1075" y="788"/>
                  </a:lnTo>
                  <a:lnTo>
                    <a:pt x="1075" y="800"/>
                  </a:lnTo>
                  <a:lnTo>
                    <a:pt x="1076" y="800"/>
                  </a:lnTo>
                  <a:lnTo>
                    <a:pt x="1076" y="788"/>
                  </a:lnTo>
                  <a:lnTo>
                    <a:pt x="1077" y="790"/>
                  </a:lnTo>
                  <a:lnTo>
                    <a:pt x="1077" y="800"/>
                  </a:lnTo>
                  <a:lnTo>
                    <a:pt x="1078" y="793"/>
                  </a:lnTo>
                  <a:lnTo>
                    <a:pt x="1078" y="800"/>
                  </a:lnTo>
                  <a:lnTo>
                    <a:pt x="1079" y="800"/>
                  </a:lnTo>
                  <a:lnTo>
                    <a:pt x="1079" y="794"/>
                  </a:lnTo>
                  <a:lnTo>
                    <a:pt x="1080" y="800"/>
                  </a:lnTo>
                  <a:lnTo>
                    <a:pt x="1080" y="793"/>
                  </a:lnTo>
                  <a:lnTo>
                    <a:pt x="1081" y="800"/>
                  </a:lnTo>
                  <a:lnTo>
                    <a:pt x="1081" y="790"/>
                  </a:lnTo>
                  <a:lnTo>
                    <a:pt x="1082" y="800"/>
                  </a:lnTo>
                  <a:lnTo>
                    <a:pt x="1082" y="793"/>
                  </a:lnTo>
                  <a:lnTo>
                    <a:pt x="1083" y="800"/>
                  </a:lnTo>
                  <a:lnTo>
                    <a:pt x="1083" y="792"/>
                  </a:lnTo>
                  <a:lnTo>
                    <a:pt x="1084" y="800"/>
                  </a:lnTo>
                  <a:lnTo>
                    <a:pt x="1084" y="783"/>
                  </a:lnTo>
                  <a:lnTo>
                    <a:pt x="1085" y="781"/>
                  </a:lnTo>
                  <a:lnTo>
                    <a:pt x="1085" y="800"/>
                  </a:lnTo>
                  <a:lnTo>
                    <a:pt x="1086" y="782"/>
                  </a:lnTo>
                  <a:lnTo>
                    <a:pt x="1086" y="800"/>
                  </a:lnTo>
                  <a:lnTo>
                    <a:pt x="1087" y="779"/>
                  </a:lnTo>
                  <a:lnTo>
                    <a:pt x="1087" y="800"/>
                  </a:lnTo>
                  <a:lnTo>
                    <a:pt x="1088" y="786"/>
                  </a:lnTo>
                  <a:lnTo>
                    <a:pt x="1088" y="800"/>
                  </a:lnTo>
                  <a:lnTo>
                    <a:pt x="1089" y="800"/>
                  </a:lnTo>
                  <a:lnTo>
                    <a:pt x="1089" y="795"/>
                  </a:lnTo>
                  <a:lnTo>
                    <a:pt x="1090" y="800"/>
                  </a:lnTo>
                  <a:lnTo>
                    <a:pt x="1090" y="799"/>
                  </a:lnTo>
                  <a:lnTo>
                    <a:pt x="1091" y="800"/>
                  </a:lnTo>
                  <a:lnTo>
                    <a:pt x="1091" y="798"/>
                  </a:lnTo>
                  <a:lnTo>
                    <a:pt x="1092" y="800"/>
                  </a:lnTo>
                  <a:lnTo>
                    <a:pt x="1092" y="798"/>
                  </a:lnTo>
                  <a:lnTo>
                    <a:pt x="1093" y="800"/>
                  </a:lnTo>
                  <a:lnTo>
                    <a:pt x="1093" y="795"/>
                  </a:lnTo>
                  <a:lnTo>
                    <a:pt x="1094" y="800"/>
                  </a:lnTo>
                  <a:lnTo>
                    <a:pt x="1094" y="791"/>
                  </a:lnTo>
                  <a:lnTo>
                    <a:pt x="1095" y="800"/>
                  </a:lnTo>
                  <a:lnTo>
                    <a:pt x="1095" y="793"/>
                  </a:lnTo>
                  <a:lnTo>
                    <a:pt x="1096" y="800"/>
                  </a:lnTo>
                  <a:lnTo>
                    <a:pt x="1096" y="793"/>
                  </a:lnTo>
                  <a:lnTo>
                    <a:pt x="1097" y="800"/>
                  </a:lnTo>
                  <a:lnTo>
                    <a:pt x="1097" y="793"/>
                  </a:lnTo>
                  <a:lnTo>
                    <a:pt x="1098" y="800"/>
                  </a:lnTo>
                  <a:lnTo>
                    <a:pt x="1098" y="791"/>
                  </a:lnTo>
                  <a:lnTo>
                    <a:pt x="1099" y="800"/>
                  </a:lnTo>
                  <a:lnTo>
                    <a:pt x="1099" y="786"/>
                  </a:lnTo>
                  <a:lnTo>
                    <a:pt x="1100" y="800"/>
                  </a:lnTo>
                  <a:lnTo>
                    <a:pt x="1100" y="779"/>
                  </a:lnTo>
                  <a:lnTo>
                    <a:pt x="1101" y="800"/>
                  </a:lnTo>
                  <a:lnTo>
                    <a:pt x="1101" y="778"/>
                  </a:lnTo>
                  <a:lnTo>
                    <a:pt x="1102" y="800"/>
                  </a:lnTo>
                  <a:lnTo>
                    <a:pt x="1102" y="785"/>
                  </a:lnTo>
                  <a:lnTo>
                    <a:pt x="1103" y="800"/>
                  </a:lnTo>
                  <a:lnTo>
                    <a:pt x="1103" y="790"/>
                  </a:lnTo>
                  <a:lnTo>
                    <a:pt x="1104" y="775"/>
                  </a:lnTo>
                  <a:lnTo>
                    <a:pt x="1104" y="800"/>
                  </a:lnTo>
                  <a:lnTo>
                    <a:pt x="1105" y="745"/>
                  </a:lnTo>
                  <a:lnTo>
                    <a:pt x="1105" y="800"/>
                  </a:lnTo>
                  <a:lnTo>
                    <a:pt x="1106" y="726"/>
                  </a:lnTo>
                  <a:lnTo>
                    <a:pt x="1106" y="800"/>
                  </a:lnTo>
                  <a:lnTo>
                    <a:pt x="1107" y="800"/>
                  </a:lnTo>
                  <a:lnTo>
                    <a:pt x="1107" y="735"/>
                  </a:lnTo>
                  <a:lnTo>
                    <a:pt x="1108" y="800"/>
                  </a:lnTo>
                  <a:lnTo>
                    <a:pt x="1108" y="726"/>
                  </a:lnTo>
                  <a:lnTo>
                    <a:pt x="1109" y="738"/>
                  </a:lnTo>
                  <a:lnTo>
                    <a:pt x="1109" y="800"/>
                  </a:lnTo>
                  <a:lnTo>
                    <a:pt x="1110" y="800"/>
                  </a:lnTo>
                  <a:lnTo>
                    <a:pt x="1110" y="764"/>
                  </a:lnTo>
                  <a:lnTo>
                    <a:pt x="1111" y="800"/>
                  </a:lnTo>
                  <a:lnTo>
                    <a:pt x="1111" y="783"/>
                  </a:lnTo>
                  <a:lnTo>
                    <a:pt x="1112" y="789"/>
                  </a:lnTo>
                  <a:lnTo>
                    <a:pt x="1112" y="800"/>
                  </a:lnTo>
                  <a:lnTo>
                    <a:pt x="1113" y="800"/>
                  </a:lnTo>
                  <a:lnTo>
                    <a:pt x="1113" y="788"/>
                  </a:lnTo>
                  <a:lnTo>
                    <a:pt x="1114" y="800"/>
                  </a:lnTo>
                  <a:lnTo>
                    <a:pt x="1114" y="784"/>
                  </a:lnTo>
                  <a:lnTo>
                    <a:pt x="1115" y="800"/>
                  </a:lnTo>
                  <a:lnTo>
                    <a:pt x="1115" y="786"/>
                  </a:lnTo>
                  <a:lnTo>
                    <a:pt x="1116" y="800"/>
                  </a:lnTo>
                  <a:lnTo>
                    <a:pt x="1116" y="791"/>
                  </a:lnTo>
                  <a:lnTo>
                    <a:pt x="1117" y="788"/>
                  </a:lnTo>
                  <a:lnTo>
                    <a:pt x="1117" y="800"/>
                  </a:lnTo>
                  <a:lnTo>
                    <a:pt x="1118" y="800"/>
                  </a:lnTo>
                  <a:lnTo>
                    <a:pt x="1118" y="779"/>
                  </a:lnTo>
                  <a:lnTo>
                    <a:pt x="1119" y="777"/>
                  </a:lnTo>
                  <a:lnTo>
                    <a:pt x="1119" y="800"/>
                  </a:lnTo>
                  <a:lnTo>
                    <a:pt x="1120" y="800"/>
                  </a:lnTo>
                  <a:lnTo>
                    <a:pt x="1120" y="783"/>
                  </a:lnTo>
                  <a:lnTo>
                    <a:pt x="1121" y="789"/>
                  </a:lnTo>
                  <a:lnTo>
                    <a:pt x="1121" y="800"/>
                  </a:lnTo>
                  <a:lnTo>
                    <a:pt x="1122" y="787"/>
                  </a:lnTo>
                  <a:lnTo>
                    <a:pt x="1122" y="800"/>
                  </a:lnTo>
                  <a:lnTo>
                    <a:pt x="1123" y="800"/>
                  </a:lnTo>
                  <a:lnTo>
                    <a:pt x="1123" y="789"/>
                  </a:lnTo>
                  <a:lnTo>
                    <a:pt x="1124" y="781"/>
                  </a:lnTo>
                  <a:lnTo>
                    <a:pt x="1124" y="800"/>
                  </a:lnTo>
                  <a:lnTo>
                    <a:pt x="1125" y="800"/>
                  </a:lnTo>
                  <a:lnTo>
                    <a:pt x="1125" y="775"/>
                  </a:lnTo>
                  <a:lnTo>
                    <a:pt x="1126" y="782"/>
                  </a:lnTo>
                  <a:lnTo>
                    <a:pt x="1126" y="800"/>
                  </a:lnTo>
                  <a:lnTo>
                    <a:pt x="1127" y="800"/>
                  </a:lnTo>
                  <a:lnTo>
                    <a:pt x="1127" y="747"/>
                  </a:lnTo>
                  <a:lnTo>
                    <a:pt x="1128" y="800"/>
                  </a:lnTo>
                  <a:lnTo>
                    <a:pt x="1128" y="737"/>
                  </a:lnTo>
                  <a:lnTo>
                    <a:pt x="1129" y="800"/>
                  </a:lnTo>
                  <a:lnTo>
                    <a:pt x="1129" y="746"/>
                  </a:lnTo>
                  <a:lnTo>
                    <a:pt x="1130" y="800"/>
                  </a:lnTo>
                  <a:lnTo>
                    <a:pt x="1130" y="751"/>
                  </a:lnTo>
                  <a:lnTo>
                    <a:pt x="1131" y="800"/>
                  </a:lnTo>
                  <a:lnTo>
                    <a:pt x="1131" y="764"/>
                  </a:lnTo>
                  <a:lnTo>
                    <a:pt x="1132" y="800"/>
                  </a:lnTo>
                  <a:lnTo>
                    <a:pt x="1132" y="787"/>
                  </a:lnTo>
                  <a:lnTo>
                    <a:pt x="1133" y="800"/>
                  </a:lnTo>
                  <a:lnTo>
                    <a:pt x="1133" y="791"/>
                  </a:lnTo>
                  <a:lnTo>
                    <a:pt x="1134" y="795"/>
                  </a:lnTo>
                  <a:lnTo>
                    <a:pt x="1134" y="800"/>
                  </a:lnTo>
                  <a:lnTo>
                    <a:pt x="1135" y="797"/>
                  </a:lnTo>
                  <a:lnTo>
                    <a:pt x="1135" y="800"/>
                  </a:lnTo>
                  <a:lnTo>
                    <a:pt x="1136" y="800"/>
                  </a:lnTo>
                  <a:lnTo>
                    <a:pt x="1136" y="798"/>
                  </a:lnTo>
                  <a:lnTo>
                    <a:pt x="1137" y="798"/>
                  </a:lnTo>
                  <a:lnTo>
                    <a:pt x="1137" y="800"/>
                  </a:lnTo>
                  <a:lnTo>
                    <a:pt x="1138" y="799"/>
                  </a:lnTo>
                  <a:lnTo>
                    <a:pt x="1138" y="800"/>
                  </a:lnTo>
                  <a:lnTo>
                    <a:pt x="1139" y="800"/>
                  </a:lnTo>
                  <a:lnTo>
                    <a:pt x="1139" y="797"/>
                  </a:lnTo>
                  <a:lnTo>
                    <a:pt x="1140" y="800"/>
                  </a:lnTo>
                  <a:lnTo>
                    <a:pt x="1140" y="797"/>
                  </a:lnTo>
                  <a:lnTo>
                    <a:pt x="1141" y="797"/>
                  </a:lnTo>
                  <a:lnTo>
                    <a:pt x="1141" y="800"/>
                  </a:lnTo>
                  <a:lnTo>
                    <a:pt x="1142" y="800"/>
                  </a:lnTo>
                  <a:lnTo>
                    <a:pt x="1142" y="796"/>
                  </a:lnTo>
                  <a:lnTo>
                    <a:pt x="1143" y="800"/>
                  </a:lnTo>
                  <a:lnTo>
                    <a:pt x="1143" y="794"/>
                  </a:lnTo>
                  <a:lnTo>
                    <a:pt x="1144" y="800"/>
                  </a:lnTo>
                  <a:lnTo>
                    <a:pt x="1144" y="793"/>
                  </a:lnTo>
                  <a:lnTo>
                    <a:pt x="1145" y="791"/>
                  </a:lnTo>
                  <a:lnTo>
                    <a:pt x="1145" y="800"/>
                  </a:lnTo>
                  <a:lnTo>
                    <a:pt x="1146" y="789"/>
                  </a:lnTo>
                  <a:lnTo>
                    <a:pt x="1146" y="800"/>
                  </a:lnTo>
                  <a:lnTo>
                    <a:pt x="1147" y="800"/>
                  </a:lnTo>
                  <a:lnTo>
                    <a:pt x="1147" y="790"/>
                  </a:lnTo>
                  <a:lnTo>
                    <a:pt x="1148" y="800"/>
                  </a:lnTo>
                  <a:lnTo>
                    <a:pt x="1148" y="790"/>
                  </a:lnTo>
                  <a:lnTo>
                    <a:pt x="1149" y="793"/>
                  </a:lnTo>
                  <a:lnTo>
                    <a:pt x="1149" y="800"/>
                  </a:lnTo>
                  <a:lnTo>
                    <a:pt x="1150" y="800"/>
                  </a:lnTo>
                  <a:lnTo>
                    <a:pt x="1150" y="795"/>
                  </a:lnTo>
                  <a:lnTo>
                    <a:pt x="1151" y="800"/>
                  </a:lnTo>
                  <a:lnTo>
                    <a:pt x="1151" y="796"/>
                  </a:lnTo>
                  <a:lnTo>
                    <a:pt x="1152" y="800"/>
                  </a:lnTo>
                  <a:lnTo>
                    <a:pt x="1152" y="797"/>
                  </a:lnTo>
                  <a:lnTo>
                    <a:pt x="1153" y="800"/>
                  </a:lnTo>
                  <a:lnTo>
                    <a:pt x="1153" y="797"/>
                  </a:lnTo>
                  <a:lnTo>
                    <a:pt x="1154" y="798"/>
                  </a:lnTo>
                  <a:lnTo>
                    <a:pt x="1154" y="800"/>
                  </a:lnTo>
                  <a:lnTo>
                    <a:pt x="1155" y="798"/>
                  </a:lnTo>
                  <a:lnTo>
                    <a:pt x="1155" y="800"/>
                  </a:lnTo>
                  <a:lnTo>
                    <a:pt x="1156" y="800"/>
                  </a:lnTo>
                  <a:lnTo>
                    <a:pt x="1156" y="798"/>
                  </a:lnTo>
                  <a:lnTo>
                    <a:pt x="1157" y="797"/>
                  </a:lnTo>
                  <a:lnTo>
                    <a:pt x="1157" y="800"/>
                  </a:lnTo>
                  <a:lnTo>
                    <a:pt x="1158" y="791"/>
                  </a:lnTo>
                  <a:lnTo>
                    <a:pt x="1158" y="800"/>
                  </a:lnTo>
                  <a:lnTo>
                    <a:pt x="1159" y="800"/>
                  </a:lnTo>
                  <a:lnTo>
                    <a:pt x="1159" y="768"/>
                  </a:lnTo>
                  <a:lnTo>
                    <a:pt x="1160" y="800"/>
                  </a:lnTo>
                  <a:lnTo>
                    <a:pt x="1160" y="778"/>
                  </a:lnTo>
                  <a:lnTo>
                    <a:pt x="1161" y="800"/>
                  </a:lnTo>
                  <a:lnTo>
                    <a:pt x="1161" y="791"/>
                  </a:lnTo>
                  <a:lnTo>
                    <a:pt x="1162" y="800"/>
                  </a:lnTo>
                  <a:lnTo>
                    <a:pt x="1162" y="795"/>
                  </a:lnTo>
                  <a:lnTo>
                    <a:pt x="1163" y="798"/>
                  </a:lnTo>
                  <a:lnTo>
                    <a:pt x="1163" y="800"/>
                  </a:lnTo>
                  <a:lnTo>
                    <a:pt x="1164" y="800"/>
                  </a:lnTo>
                  <a:lnTo>
                    <a:pt x="1164" y="798"/>
                  </a:lnTo>
                  <a:lnTo>
                    <a:pt x="1165" y="800"/>
                  </a:lnTo>
                  <a:lnTo>
                    <a:pt x="1165" y="798"/>
                  </a:lnTo>
                  <a:lnTo>
                    <a:pt x="1166" y="800"/>
                  </a:lnTo>
                  <a:lnTo>
                    <a:pt x="1166" y="796"/>
                  </a:lnTo>
                  <a:lnTo>
                    <a:pt x="1167" y="800"/>
                  </a:lnTo>
                  <a:lnTo>
                    <a:pt x="1167" y="792"/>
                  </a:lnTo>
                  <a:lnTo>
                    <a:pt x="1168" y="800"/>
                  </a:lnTo>
                  <a:lnTo>
                    <a:pt x="1168" y="798"/>
                  </a:lnTo>
                  <a:lnTo>
                    <a:pt x="1169" y="800"/>
                  </a:lnTo>
                  <a:lnTo>
                    <a:pt x="1169" y="799"/>
                  </a:lnTo>
                  <a:lnTo>
                    <a:pt x="1170" y="800"/>
                  </a:lnTo>
                  <a:lnTo>
                    <a:pt x="1170" y="799"/>
                  </a:lnTo>
                  <a:lnTo>
                    <a:pt x="1171" y="795"/>
                  </a:lnTo>
                  <a:lnTo>
                    <a:pt x="1171" y="800"/>
                  </a:lnTo>
                  <a:lnTo>
                    <a:pt x="1172" y="800"/>
                  </a:lnTo>
                  <a:lnTo>
                    <a:pt x="1172" y="778"/>
                  </a:lnTo>
                  <a:lnTo>
                    <a:pt x="1173" y="733"/>
                  </a:lnTo>
                  <a:lnTo>
                    <a:pt x="1173" y="800"/>
                  </a:lnTo>
                  <a:lnTo>
                    <a:pt x="1174" y="795"/>
                  </a:lnTo>
                  <a:lnTo>
                    <a:pt x="1174" y="800"/>
                  </a:lnTo>
                  <a:lnTo>
                    <a:pt x="1175" y="795"/>
                  </a:lnTo>
                  <a:lnTo>
                    <a:pt x="1175" y="800"/>
                  </a:lnTo>
                  <a:lnTo>
                    <a:pt x="1176" y="794"/>
                  </a:lnTo>
                  <a:lnTo>
                    <a:pt x="1176" y="800"/>
                  </a:lnTo>
                  <a:lnTo>
                    <a:pt x="1177" y="798"/>
                  </a:lnTo>
                  <a:lnTo>
                    <a:pt x="1177" y="800"/>
                  </a:lnTo>
                  <a:lnTo>
                    <a:pt x="1178" y="800"/>
                  </a:lnTo>
                  <a:lnTo>
                    <a:pt x="1178" y="800"/>
                  </a:lnTo>
                  <a:lnTo>
                    <a:pt x="1179" y="800"/>
                  </a:lnTo>
                  <a:lnTo>
                    <a:pt x="1179" y="798"/>
                  </a:lnTo>
                  <a:lnTo>
                    <a:pt x="1180" y="798"/>
                  </a:lnTo>
                  <a:lnTo>
                    <a:pt x="1180" y="800"/>
                  </a:lnTo>
                  <a:lnTo>
                    <a:pt x="1181" y="800"/>
                  </a:lnTo>
                  <a:lnTo>
                    <a:pt x="1181" y="798"/>
                  </a:lnTo>
                  <a:lnTo>
                    <a:pt x="1182" y="799"/>
                  </a:lnTo>
                  <a:lnTo>
                    <a:pt x="1182" y="800"/>
                  </a:lnTo>
                  <a:lnTo>
                    <a:pt x="1183" y="798"/>
                  </a:lnTo>
                  <a:lnTo>
                    <a:pt x="1183" y="800"/>
                  </a:lnTo>
                  <a:lnTo>
                    <a:pt x="1184" y="797"/>
                  </a:lnTo>
                  <a:lnTo>
                    <a:pt x="1184" y="800"/>
                  </a:lnTo>
                  <a:lnTo>
                    <a:pt x="1185" y="797"/>
                  </a:lnTo>
                  <a:lnTo>
                    <a:pt x="1185" y="800"/>
                  </a:lnTo>
                  <a:lnTo>
                    <a:pt x="1186" y="798"/>
                  </a:lnTo>
                  <a:lnTo>
                    <a:pt x="1186" y="800"/>
                  </a:lnTo>
                  <a:lnTo>
                    <a:pt x="1187" y="800"/>
                  </a:lnTo>
                  <a:lnTo>
                    <a:pt x="1187" y="797"/>
                  </a:lnTo>
                  <a:lnTo>
                    <a:pt x="1188" y="797"/>
                  </a:lnTo>
                  <a:lnTo>
                    <a:pt x="1188" y="800"/>
                  </a:lnTo>
                  <a:lnTo>
                    <a:pt x="1189" y="800"/>
                  </a:lnTo>
                  <a:lnTo>
                    <a:pt x="1189" y="796"/>
                  </a:lnTo>
                  <a:lnTo>
                    <a:pt x="1190" y="800"/>
                  </a:lnTo>
                  <a:lnTo>
                    <a:pt x="1190" y="795"/>
                  </a:lnTo>
                  <a:lnTo>
                    <a:pt x="1191" y="800"/>
                  </a:lnTo>
                  <a:lnTo>
                    <a:pt x="1191" y="797"/>
                  </a:lnTo>
                  <a:lnTo>
                    <a:pt x="1192" y="800"/>
                  </a:lnTo>
                  <a:lnTo>
                    <a:pt x="1192" y="797"/>
                  </a:lnTo>
                  <a:lnTo>
                    <a:pt x="1193" y="800"/>
                  </a:lnTo>
                  <a:lnTo>
                    <a:pt x="1193" y="794"/>
                  </a:lnTo>
                  <a:lnTo>
                    <a:pt x="1194" y="794"/>
                  </a:lnTo>
                  <a:lnTo>
                    <a:pt x="1194" y="800"/>
                  </a:lnTo>
                  <a:lnTo>
                    <a:pt x="1195" y="800"/>
                  </a:lnTo>
                  <a:lnTo>
                    <a:pt x="1195" y="796"/>
                  </a:lnTo>
                  <a:lnTo>
                    <a:pt x="1196" y="800"/>
                  </a:lnTo>
                  <a:lnTo>
                    <a:pt x="1196" y="798"/>
                  </a:lnTo>
                  <a:lnTo>
                    <a:pt x="1197" y="800"/>
                  </a:lnTo>
                  <a:lnTo>
                    <a:pt x="1197" y="799"/>
                  </a:lnTo>
                  <a:lnTo>
                    <a:pt x="1198" y="799"/>
                  </a:lnTo>
                  <a:lnTo>
                    <a:pt x="1198" y="800"/>
                  </a:lnTo>
                  <a:lnTo>
                    <a:pt x="1199" y="800"/>
                  </a:lnTo>
                  <a:lnTo>
                    <a:pt x="1199" y="797"/>
                  </a:lnTo>
                  <a:lnTo>
                    <a:pt x="1200" y="793"/>
                  </a:lnTo>
                  <a:lnTo>
                    <a:pt x="1200" y="800"/>
                  </a:lnTo>
                  <a:lnTo>
                    <a:pt x="1201" y="800"/>
                  </a:lnTo>
                  <a:lnTo>
                    <a:pt x="1201" y="793"/>
                  </a:lnTo>
                  <a:lnTo>
                    <a:pt x="1202" y="800"/>
                  </a:lnTo>
                  <a:lnTo>
                    <a:pt x="1202" y="793"/>
                  </a:lnTo>
                  <a:lnTo>
                    <a:pt x="1203" y="800"/>
                  </a:lnTo>
                  <a:lnTo>
                    <a:pt x="1203" y="796"/>
                  </a:lnTo>
                  <a:lnTo>
                    <a:pt x="1204" y="791"/>
                  </a:lnTo>
                  <a:lnTo>
                    <a:pt x="1204" y="800"/>
                  </a:lnTo>
                  <a:lnTo>
                    <a:pt x="1205" y="800"/>
                  </a:lnTo>
                  <a:lnTo>
                    <a:pt x="1205" y="797"/>
                  </a:lnTo>
                  <a:lnTo>
                    <a:pt x="1206" y="800"/>
                  </a:lnTo>
                  <a:lnTo>
                    <a:pt x="1206" y="796"/>
                  </a:lnTo>
                  <a:lnTo>
                    <a:pt x="1207" y="796"/>
                  </a:lnTo>
                  <a:lnTo>
                    <a:pt x="1207" y="800"/>
                  </a:lnTo>
                  <a:lnTo>
                    <a:pt x="1208" y="800"/>
                  </a:lnTo>
                  <a:lnTo>
                    <a:pt x="1208" y="794"/>
                  </a:lnTo>
                  <a:lnTo>
                    <a:pt x="1209" y="788"/>
                  </a:lnTo>
                  <a:lnTo>
                    <a:pt x="1209" y="800"/>
                  </a:lnTo>
                  <a:lnTo>
                    <a:pt x="1210" y="794"/>
                  </a:lnTo>
                  <a:lnTo>
                    <a:pt x="1210" y="800"/>
                  </a:lnTo>
                  <a:lnTo>
                    <a:pt x="1211" y="755"/>
                  </a:lnTo>
                  <a:lnTo>
                    <a:pt x="1211" y="800"/>
                  </a:lnTo>
                  <a:lnTo>
                    <a:pt x="1212" y="800"/>
                  </a:lnTo>
                  <a:lnTo>
                    <a:pt x="1212" y="748"/>
                  </a:lnTo>
                  <a:lnTo>
                    <a:pt x="1213" y="800"/>
                  </a:lnTo>
                  <a:lnTo>
                    <a:pt x="1213" y="792"/>
                  </a:lnTo>
                  <a:lnTo>
                    <a:pt x="1214" y="800"/>
                  </a:lnTo>
                  <a:lnTo>
                    <a:pt x="1214" y="793"/>
                  </a:lnTo>
                  <a:lnTo>
                    <a:pt x="1215" y="800"/>
                  </a:lnTo>
                  <a:lnTo>
                    <a:pt x="1215" y="796"/>
                  </a:lnTo>
                  <a:lnTo>
                    <a:pt x="1216" y="800"/>
                  </a:lnTo>
                  <a:lnTo>
                    <a:pt x="1216" y="796"/>
                  </a:lnTo>
                  <a:lnTo>
                    <a:pt x="1217" y="798"/>
                  </a:lnTo>
                  <a:lnTo>
                    <a:pt x="1217" y="800"/>
                  </a:lnTo>
                  <a:lnTo>
                    <a:pt x="1218" y="797"/>
                  </a:lnTo>
                  <a:lnTo>
                    <a:pt x="1218" y="800"/>
                  </a:lnTo>
                  <a:lnTo>
                    <a:pt x="1219" y="800"/>
                  </a:lnTo>
                  <a:lnTo>
                    <a:pt x="1219" y="795"/>
                  </a:lnTo>
                  <a:lnTo>
                    <a:pt x="1220" y="800"/>
                  </a:lnTo>
                  <a:lnTo>
                    <a:pt x="1220" y="795"/>
                  </a:lnTo>
                  <a:lnTo>
                    <a:pt x="1221" y="800"/>
                  </a:lnTo>
                  <a:lnTo>
                    <a:pt x="1221" y="797"/>
                  </a:lnTo>
                  <a:lnTo>
                    <a:pt x="1222" y="800"/>
                  </a:lnTo>
                  <a:lnTo>
                    <a:pt x="1222" y="799"/>
                  </a:lnTo>
                  <a:lnTo>
                    <a:pt x="1223" y="799"/>
                  </a:lnTo>
                  <a:lnTo>
                    <a:pt x="1223" y="800"/>
                  </a:lnTo>
                  <a:lnTo>
                    <a:pt x="1224" y="800"/>
                  </a:lnTo>
                  <a:lnTo>
                    <a:pt x="1224" y="798"/>
                  </a:lnTo>
                  <a:lnTo>
                    <a:pt x="1225" y="797"/>
                  </a:lnTo>
                  <a:lnTo>
                    <a:pt x="1225" y="800"/>
                  </a:lnTo>
                  <a:lnTo>
                    <a:pt x="1226" y="800"/>
                  </a:lnTo>
                  <a:lnTo>
                    <a:pt x="1226" y="797"/>
                  </a:lnTo>
                  <a:lnTo>
                    <a:pt x="1227" y="800"/>
                  </a:lnTo>
                  <a:lnTo>
                    <a:pt x="1227" y="796"/>
                  </a:lnTo>
                  <a:lnTo>
                    <a:pt x="1228" y="800"/>
                  </a:lnTo>
                  <a:lnTo>
                    <a:pt x="1228" y="796"/>
                  </a:lnTo>
                  <a:lnTo>
                    <a:pt x="1229" y="800"/>
                  </a:lnTo>
                  <a:lnTo>
                    <a:pt x="1229" y="797"/>
                  </a:lnTo>
                  <a:lnTo>
                    <a:pt x="1230" y="800"/>
                  </a:lnTo>
                  <a:lnTo>
                    <a:pt x="1230" y="799"/>
                  </a:lnTo>
                  <a:lnTo>
                    <a:pt x="1231" y="790"/>
                  </a:lnTo>
                  <a:lnTo>
                    <a:pt x="1231" y="800"/>
                  </a:lnTo>
                  <a:lnTo>
                    <a:pt x="1232" y="800"/>
                  </a:lnTo>
                  <a:lnTo>
                    <a:pt x="1232" y="785"/>
                  </a:lnTo>
                  <a:lnTo>
                    <a:pt x="1233" y="800"/>
                  </a:lnTo>
                  <a:lnTo>
                    <a:pt x="1233" y="786"/>
                  </a:lnTo>
                  <a:lnTo>
                    <a:pt x="1234" y="800"/>
                  </a:lnTo>
                  <a:lnTo>
                    <a:pt x="1234" y="773"/>
                  </a:lnTo>
                  <a:lnTo>
                    <a:pt x="1235" y="800"/>
                  </a:lnTo>
                  <a:lnTo>
                    <a:pt x="1235" y="795"/>
                  </a:lnTo>
                  <a:lnTo>
                    <a:pt x="1236" y="800"/>
                  </a:lnTo>
                  <a:lnTo>
                    <a:pt x="1236" y="797"/>
                  </a:lnTo>
                  <a:lnTo>
                    <a:pt x="1237" y="798"/>
                  </a:lnTo>
                  <a:lnTo>
                    <a:pt x="1237" y="800"/>
                  </a:lnTo>
                  <a:lnTo>
                    <a:pt x="1238" y="800"/>
                  </a:lnTo>
                  <a:lnTo>
                    <a:pt x="1238" y="797"/>
                  </a:lnTo>
                  <a:lnTo>
                    <a:pt x="1239" y="797"/>
                  </a:lnTo>
                  <a:lnTo>
                    <a:pt x="1239" y="800"/>
                  </a:lnTo>
                  <a:lnTo>
                    <a:pt x="1240" y="796"/>
                  </a:lnTo>
                  <a:lnTo>
                    <a:pt x="1240" y="800"/>
                  </a:lnTo>
                  <a:lnTo>
                    <a:pt x="1241" y="800"/>
                  </a:lnTo>
                  <a:lnTo>
                    <a:pt x="1241" y="794"/>
                  </a:lnTo>
                  <a:lnTo>
                    <a:pt x="1242" y="791"/>
                  </a:lnTo>
                  <a:lnTo>
                    <a:pt x="1242" y="800"/>
                  </a:lnTo>
                  <a:lnTo>
                    <a:pt x="1243" y="800"/>
                  </a:lnTo>
                  <a:lnTo>
                    <a:pt x="1243" y="789"/>
                  </a:lnTo>
                  <a:lnTo>
                    <a:pt x="1244" y="790"/>
                  </a:lnTo>
                  <a:lnTo>
                    <a:pt x="1244" y="800"/>
                  </a:lnTo>
                  <a:lnTo>
                    <a:pt x="1245" y="800"/>
                  </a:lnTo>
                  <a:lnTo>
                    <a:pt x="1245" y="790"/>
                  </a:lnTo>
                  <a:lnTo>
                    <a:pt x="1246" y="793"/>
                  </a:lnTo>
                  <a:lnTo>
                    <a:pt x="1246" y="800"/>
                  </a:lnTo>
                  <a:lnTo>
                    <a:pt x="1247" y="800"/>
                  </a:lnTo>
                  <a:lnTo>
                    <a:pt x="1247" y="796"/>
                  </a:lnTo>
                  <a:lnTo>
                    <a:pt x="1248" y="800"/>
                  </a:lnTo>
                  <a:lnTo>
                    <a:pt x="1248" y="795"/>
                  </a:lnTo>
                  <a:lnTo>
                    <a:pt x="1249" y="800"/>
                  </a:lnTo>
                  <a:lnTo>
                    <a:pt x="1249" y="790"/>
                  </a:lnTo>
                  <a:lnTo>
                    <a:pt x="1250" y="800"/>
                  </a:lnTo>
                  <a:lnTo>
                    <a:pt x="1250" y="783"/>
                  </a:lnTo>
                  <a:lnTo>
                    <a:pt x="1251" y="800"/>
                  </a:lnTo>
                  <a:lnTo>
                    <a:pt x="1251" y="762"/>
                  </a:lnTo>
                  <a:lnTo>
                    <a:pt x="1252" y="757"/>
                  </a:lnTo>
                  <a:lnTo>
                    <a:pt x="1252" y="800"/>
                  </a:lnTo>
                  <a:lnTo>
                    <a:pt x="1253" y="800"/>
                  </a:lnTo>
                  <a:lnTo>
                    <a:pt x="1253" y="771"/>
                  </a:lnTo>
                  <a:lnTo>
                    <a:pt x="1254" y="800"/>
                  </a:lnTo>
                  <a:lnTo>
                    <a:pt x="1254" y="784"/>
                  </a:lnTo>
                  <a:lnTo>
                    <a:pt x="1255" y="800"/>
                  </a:lnTo>
                  <a:lnTo>
                    <a:pt x="1255" y="774"/>
                  </a:lnTo>
                  <a:lnTo>
                    <a:pt x="1256" y="800"/>
                  </a:lnTo>
                  <a:lnTo>
                    <a:pt x="1256" y="737"/>
                  </a:lnTo>
                  <a:lnTo>
                    <a:pt x="1257" y="781"/>
                  </a:lnTo>
                  <a:lnTo>
                    <a:pt x="1257" y="800"/>
                  </a:lnTo>
                  <a:lnTo>
                    <a:pt x="1258" y="800"/>
                  </a:lnTo>
                  <a:lnTo>
                    <a:pt x="1258" y="790"/>
                  </a:lnTo>
                  <a:lnTo>
                    <a:pt x="1259" y="795"/>
                  </a:lnTo>
                  <a:lnTo>
                    <a:pt x="1259" y="800"/>
                  </a:lnTo>
                  <a:lnTo>
                    <a:pt x="1260" y="800"/>
                  </a:lnTo>
                  <a:lnTo>
                    <a:pt x="1260" y="790"/>
                  </a:lnTo>
                  <a:lnTo>
                    <a:pt x="1261" y="800"/>
                  </a:lnTo>
                  <a:lnTo>
                    <a:pt x="1261" y="781"/>
                  </a:lnTo>
                  <a:lnTo>
                    <a:pt x="1262" y="800"/>
                  </a:lnTo>
                  <a:lnTo>
                    <a:pt x="1262" y="784"/>
                  </a:lnTo>
                  <a:lnTo>
                    <a:pt x="1263" y="800"/>
                  </a:lnTo>
                  <a:lnTo>
                    <a:pt x="1263" y="785"/>
                  </a:lnTo>
                  <a:lnTo>
                    <a:pt x="1264" y="800"/>
                  </a:lnTo>
                  <a:lnTo>
                    <a:pt x="1264" y="795"/>
                  </a:lnTo>
                  <a:lnTo>
                    <a:pt x="1265" y="800"/>
                  </a:lnTo>
                  <a:lnTo>
                    <a:pt x="1265" y="797"/>
                  </a:lnTo>
                  <a:lnTo>
                    <a:pt x="1266" y="800"/>
                  </a:lnTo>
                  <a:lnTo>
                    <a:pt x="1266" y="794"/>
                  </a:lnTo>
                  <a:lnTo>
                    <a:pt x="1267" y="800"/>
                  </a:lnTo>
                  <a:lnTo>
                    <a:pt x="1267" y="797"/>
                  </a:lnTo>
                  <a:lnTo>
                    <a:pt x="1268" y="797"/>
                  </a:lnTo>
                  <a:lnTo>
                    <a:pt x="1268" y="800"/>
                  </a:lnTo>
                  <a:lnTo>
                    <a:pt x="1269" y="798"/>
                  </a:lnTo>
                  <a:lnTo>
                    <a:pt x="1269" y="800"/>
                  </a:lnTo>
                  <a:lnTo>
                    <a:pt x="1270" y="799"/>
                  </a:lnTo>
                  <a:lnTo>
                    <a:pt x="1270" y="800"/>
                  </a:lnTo>
                  <a:lnTo>
                    <a:pt x="1271" y="800"/>
                  </a:lnTo>
                  <a:lnTo>
                    <a:pt x="1271" y="798"/>
                  </a:lnTo>
                  <a:lnTo>
                    <a:pt x="1272" y="800"/>
                  </a:lnTo>
                  <a:lnTo>
                    <a:pt x="1272" y="799"/>
                  </a:lnTo>
                  <a:lnTo>
                    <a:pt x="1273" y="798"/>
                  </a:lnTo>
                  <a:lnTo>
                    <a:pt x="1273" y="800"/>
                  </a:lnTo>
                  <a:lnTo>
                    <a:pt x="1274" y="798"/>
                  </a:lnTo>
                  <a:lnTo>
                    <a:pt x="1274" y="800"/>
                  </a:lnTo>
                  <a:lnTo>
                    <a:pt x="1275" y="800"/>
                  </a:lnTo>
                  <a:lnTo>
                    <a:pt x="1275" y="798"/>
                  </a:lnTo>
                  <a:lnTo>
                    <a:pt x="1276" y="800"/>
                  </a:lnTo>
                  <a:lnTo>
                    <a:pt x="1276" y="798"/>
                  </a:lnTo>
                  <a:lnTo>
                    <a:pt x="1277" y="800"/>
                  </a:lnTo>
                  <a:lnTo>
                    <a:pt x="1277" y="799"/>
                  </a:lnTo>
                  <a:lnTo>
                    <a:pt x="1278" y="800"/>
                  </a:lnTo>
                  <a:lnTo>
                    <a:pt x="1278" y="797"/>
                  </a:lnTo>
                  <a:lnTo>
                    <a:pt x="1279" y="800"/>
                  </a:lnTo>
                  <a:lnTo>
                    <a:pt x="1279" y="771"/>
                  </a:lnTo>
                  <a:lnTo>
                    <a:pt x="1280" y="800"/>
                  </a:lnTo>
                  <a:lnTo>
                    <a:pt x="1280" y="798"/>
                  </a:lnTo>
                  <a:lnTo>
                    <a:pt x="1281" y="799"/>
                  </a:lnTo>
                  <a:lnTo>
                    <a:pt x="1281" y="800"/>
                  </a:lnTo>
                  <a:lnTo>
                    <a:pt x="1282" y="800"/>
                  </a:lnTo>
                  <a:lnTo>
                    <a:pt x="1282" y="799"/>
                  </a:lnTo>
                  <a:lnTo>
                    <a:pt x="1283" y="800"/>
                  </a:lnTo>
                  <a:lnTo>
                    <a:pt x="1283" y="797"/>
                  </a:lnTo>
                  <a:lnTo>
                    <a:pt x="1284" y="796"/>
                  </a:lnTo>
                  <a:lnTo>
                    <a:pt x="1284" y="795"/>
                  </a:lnTo>
                  <a:lnTo>
                    <a:pt x="1285" y="796"/>
                  </a:lnTo>
                  <a:lnTo>
                    <a:pt x="1285" y="800"/>
                  </a:lnTo>
                  <a:lnTo>
                    <a:pt x="1286" y="798"/>
                  </a:lnTo>
                  <a:lnTo>
                    <a:pt x="1286" y="800"/>
                  </a:lnTo>
                  <a:lnTo>
                    <a:pt x="1287" y="800"/>
                  </a:lnTo>
                  <a:lnTo>
                    <a:pt x="1287" y="800"/>
                  </a:lnTo>
                  <a:lnTo>
                    <a:pt x="1288" y="800"/>
                  </a:lnTo>
                  <a:lnTo>
                    <a:pt x="1288" y="799"/>
                  </a:lnTo>
                  <a:lnTo>
                    <a:pt x="1289" y="798"/>
                  </a:lnTo>
                  <a:lnTo>
                    <a:pt x="1289" y="797"/>
                  </a:lnTo>
                  <a:lnTo>
                    <a:pt x="1290" y="797"/>
                  </a:lnTo>
                  <a:lnTo>
                    <a:pt x="1290" y="800"/>
                  </a:lnTo>
                  <a:lnTo>
                    <a:pt x="1291" y="797"/>
                  </a:lnTo>
                  <a:lnTo>
                    <a:pt x="1291" y="798"/>
                  </a:lnTo>
                  <a:lnTo>
                    <a:pt x="1292" y="798"/>
                  </a:lnTo>
                  <a:lnTo>
                    <a:pt x="1292" y="800"/>
                  </a:lnTo>
                  <a:lnTo>
                    <a:pt x="1293" y="800"/>
                  </a:lnTo>
                  <a:lnTo>
                    <a:pt x="1293" y="799"/>
                  </a:lnTo>
                  <a:lnTo>
                    <a:pt x="1294" y="799"/>
                  </a:lnTo>
                  <a:lnTo>
                    <a:pt x="1294" y="799"/>
                  </a:lnTo>
                  <a:lnTo>
                    <a:pt x="1295" y="800"/>
                  </a:lnTo>
                  <a:lnTo>
                    <a:pt x="1295" y="799"/>
                  </a:lnTo>
                  <a:lnTo>
                    <a:pt x="1296" y="799"/>
                  </a:lnTo>
                  <a:lnTo>
                    <a:pt x="1296" y="800"/>
                  </a:lnTo>
                  <a:lnTo>
                    <a:pt x="1297" y="799"/>
                  </a:lnTo>
                  <a:lnTo>
                    <a:pt x="1297" y="800"/>
                  </a:lnTo>
                  <a:lnTo>
                    <a:pt x="1298" y="799"/>
                  </a:lnTo>
                  <a:lnTo>
                    <a:pt x="1298" y="798"/>
                  </a:lnTo>
                  <a:lnTo>
                    <a:pt x="1299" y="799"/>
                  </a:lnTo>
                  <a:lnTo>
                    <a:pt x="1299" y="800"/>
                  </a:lnTo>
                  <a:lnTo>
                    <a:pt x="1300" y="799"/>
                  </a:lnTo>
                  <a:lnTo>
                    <a:pt x="1300" y="800"/>
                  </a:lnTo>
                  <a:lnTo>
                    <a:pt x="1301" y="799"/>
                  </a:lnTo>
                  <a:lnTo>
                    <a:pt x="1301" y="800"/>
                  </a:lnTo>
                  <a:lnTo>
                    <a:pt x="1302" y="799"/>
                  </a:lnTo>
                  <a:lnTo>
                    <a:pt x="1302" y="799"/>
                  </a:lnTo>
                  <a:lnTo>
                    <a:pt x="1303" y="800"/>
                  </a:lnTo>
                  <a:lnTo>
                    <a:pt x="1303" y="799"/>
                  </a:lnTo>
                  <a:lnTo>
                    <a:pt x="1304" y="799"/>
                  </a:lnTo>
                  <a:lnTo>
                    <a:pt x="1304" y="798"/>
                  </a:lnTo>
                  <a:lnTo>
                    <a:pt x="1305" y="798"/>
                  </a:lnTo>
                  <a:lnTo>
                    <a:pt x="1305" y="800"/>
                  </a:lnTo>
                  <a:lnTo>
                    <a:pt x="1306" y="798"/>
                  </a:lnTo>
                  <a:lnTo>
                    <a:pt x="1306" y="799"/>
                  </a:lnTo>
                  <a:lnTo>
                    <a:pt x="1307" y="799"/>
                  </a:lnTo>
                  <a:lnTo>
                    <a:pt x="1307" y="799"/>
                  </a:lnTo>
                  <a:lnTo>
                    <a:pt x="1308" y="799"/>
                  </a:lnTo>
                  <a:lnTo>
                    <a:pt x="1308" y="800"/>
                  </a:lnTo>
                  <a:lnTo>
                    <a:pt x="1309" y="800"/>
                  </a:lnTo>
                  <a:lnTo>
                    <a:pt x="1309" y="800"/>
                  </a:lnTo>
                  <a:lnTo>
                    <a:pt x="1310" y="800"/>
                  </a:lnTo>
                  <a:lnTo>
                    <a:pt x="1310" y="800"/>
                  </a:lnTo>
                  <a:lnTo>
                    <a:pt x="1311" y="800"/>
                  </a:lnTo>
                  <a:lnTo>
                    <a:pt x="1311" y="799"/>
                  </a:lnTo>
                  <a:lnTo>
                    <a:pt x="1312" y="799"/>
                  </a:lnTo>
                  <a:lnTo>
                    <a:pt x="1312" y="799"/>
                  </a:lnTo>
                  <a:lnTo>
                    <a:pt x="1313" y="799"/>
                  </a:lnTo>
                  <a:lnTo>
                    <a:pt x="1313" y="799"/>
                  </a:lnTo>
                  <a:lnTo>
                    <a:pt x="1314" y="799"/>
                  </a:lnTo>
                  <a:lnTo>
                    <a:pt x="1314" y="799"/>
                  </a:lnTo>
                  <a:lnTo>
                    <a:pt x="1315" y="799"/>
                  </a:lnTo>
                  <a:lnTo>
                    <a:pt x="1315" y="800"/>
                  </a:lnTo>
                  <a:lnTo>
                    <a:pt x="1316" y="799"/>
                  </a:lnTo>
                  <a:lnTo>
                    <a:pt x="1316" y="798"/>
                  </a:lnTo>
                  <a:lnTo>
                    <a:pt x="1317" y="798"/>
                  </a:lnTo>
                  <a:lnTo>
                    <a:pt x="1317" y="797"/>
                  </a:lnTo>
                  <a:lnTo>
                    <a:pt x="1318" y="797"/>
                  </a:lnTo>
                  <a:lnTo>
                    <a:pt x="1318" y="800"/>
                  </a:lnTo>
                  <a:lnTo>
                    <a:pt x="1319" y="798"/>
                  </a:lnTo>
                  <a:lnTo>
                    <a:pt x="1319" y="799"/>
                  </a:lnTo>
                  <a:lnTo>
                    <a:pt x="1320" y="799"/>
                  </a:lnTo>
                  <a:lnTo>
                    <a:pt x="1320" y="800"/>
                  </a:lnTo>
                  <a:lnTo>
                    <a:pt x="1321" y="800"/>
                  </a:lnTo>
                  <a:lnTo>
                    <a:pt x="1321" y="800"/>
                  </a:lnTo>
                  <a:lnTo>
                    <a:pt x="1322" y="800"/>
                  </a:lnTo>
                  <a:lnTo>
                    <a:pt x="1322" y="800"/>
                  </a:lnTo>
                  <a:lnTo>
                    <a:pt x="1323" y="799"/>
                  </a:lnTo>
                  <a:lnTo>
                    <a:pt x="1323" y="799"/>
                  </a:lnTo>
                  <a:lnTo>
                    <a:pt x="1324" y="799"/>
                  </a:lnTo>
                  <a:lnTo>
                    <a:pt x="1324" y="800"/>
                  </a:lnTo>
                  <a:lnTo>
                    <a:pt x="1325" y="800"/>
                  </a:lnTo>
                  <a:lnTo>
                    <a:pt x="1325" y="800"/>
                  </a:lnTo>
                  <a:lnTo>
                    <a:pt x="1326" y="800"/>
                  </a:lnTo>
                  <a:lnTo>
                    <a:pt x="1326" y="799"/>
                  </a:lnTo>
                  <a:lnTo>
                    <a:pt x="1327" y="799"/>
                  </a:lnTo>
                  <a:lnTo>
                    <a:pt x="1327" y="799"/>
                  </a:lnTo>
                  <a:lnTo>
                    <a:pt x="1328" y="800"/>
                  </a:lnTo>
                  <a:lnTo>
                    <a:pt x="1328" y="800"/>
                  </a:lnTo>
                  <a:lnTo>
                    <a:pt x="1329" y="799"/>
                  </a:lnTo>
                  <a:lnTo>
                    <a:pt x="1329" y="800"/>
                  </a:lnTo>
                  <a:lnTo>
                    <a:pt x="1330" y="800"/>
                  </a:lnTo>
                  <a:lnTo>
                    <a:pt x="1330" y="799"/>
                  </a:lnTo>
                  <a:lnTo>
                    <a:pt x="1331" y="799"/>
                  </a:lnTo>
                  <a:lnTo>
                    <a:pt x="1331" y="799"/>
                  </a:lnTo>
                  <a:lnTo>
                    <a:pt x="1332" y="799"/>
                  </a:lnTo>
                  <a:lnTo>
                    <a:pt x="1332" y="799"/>
                  </a:lnTo>
                  <a:lnTo>
                    <a:pt x="1333" y="800"/>
                  </a:lnTo>
                  <a:lnTo>
                    <a:pt x="1333" y="799"/>
                  </a:lnTo>
                  <a:lnTo>
                    <a:pt x="1334" y="799"/>
                  </a:lnTo>
                  <a:lnTo>
                    <a:pt x="1334" y="799"/>
                  </a:lnTo>
                  <a:lnTo>
                    <a:pt x="1335" y="799"/>
                  </a:lnTo>
                  <a:lnTo>
                    <a:pt x="1335" y="800"/>
                  </a:lnTo>
                  <a:lnTo>
                    <a:pt x="1336" y="799"/>
                  </a:lnTo>
                  <a:lnTo>
                    <a:pt x="1336" y="800"/>
                  </a:lnTo>
                  <a:lnTo>
                    <a:pt x="1337" y="800"/>
                  </a:lnTo>
                  <a:lnTo>
                    <a:pt x="1337" y="800"/>
                  </a:lnTo>
                  <a:lnTo>
                    <a:pt x="1338" y="800"/>
                  </a:lnTo>
                  <a:lnTo>
                    <a:pt x="1338" y="800"/>
                  </a:lnTo>
                  <a:lnTo>
                    <a:pt x="1339" y="800"/>
                  </a:lnTo>
                  <a:lnTo>
                    <a:pt x="1339" y="800"/>
                  </a:lnTo>
                  <a:lnTo>
                    <a:pt x="1340" y="800"/>
                  </a:lnTo>
                  <a:lnTo>
                    <a:pt x="1340" y="800"/>
                  </a:lnTo>
                  <a:lnTo>
                    <a:pt x="1341" y="800"/>
                  </a:lnTo>
                  <a:lnTo>
                    <a:pt x="1341" y="800"/>
                  </a:lnTo>
                  <a:lnTo>
                    <a:pt x="1342" y="800"/>
                  </a:lnTo>
                  <a:lnTo>
                    <a:pt x="1342" y="800"/>
                  </a:lnTo>
                  <a:lnTo>
                    <a:pt x="1343" y="800"/>
                  </a:lnTo>
                  <a:lnTo>
                    <a:pt x="1343" y="800"/>
                  </a:lnTo>
                  <a:lnTo>
                    <a:pt x="1344" y="800"/>
                  </a:lnTo>
                  <a:lnTo>
                    <a:pt x="1344" y="800"/>
                  </a:lnTo>
                  <a:lnTo>
                    <a:pt x="1345" y="800"/>
                  </a:lnTo>
                  <a:lnTo>
                    <a:pt x="1345" y="800"/>
                  </a:lnTo>
                  <a:lnTo>
                    <a:pt x="1346" y="800"/>
                  </a:lnTo>
                  <a:lnTo>
                    <a:pt x="1346" y="800"/>
                  </a:lnTo>
                  <a:lnTo>
                    <a:pt x="1347" y="800"/>
                  </a:lnTo>
                  <a:lnTo>
                    <a:pt x="1347" y="800"/>
                  </a:lnTo>
                  <a:lnTo>
                    <a:pt x="1348" y="800"/>
                  </a:lnTo>
                  <a:lnTo>
                    <a:pt x="1348" y="800"/>
                  </a:lnTo>
                  <a:lnTo>
                    <a:pt x="1349" y="800"/>
                  </a:lnTo>
                  <a:lnTo>
                    <a:pt x="1349" y="800"/>
                  </a:lnTo>
                  <a:lnTo>
                    <a:pt x="1350" y="800"/>
                  </a:lnTo>
                  <a:lnTo>
                    <a:pt x="1350" y="800"/>
                  </a:lnTo>
                  <a:lnTo>
                    <a:pt x="1351" y="800"/>
                  </a:lnTo>
                  <a:lnTo>
                    <a:pt x="1351" y="800"/>
                  </a:lnTo>
                  <a:lnTo>
                    <a:pt x="1352" y="800"/>
                  </a:lnTo>
                  <a:lnTo>
                    <a:pt x="1352" y="800"/>
                  </a:lnTo>
                  <a:lnTo>
                    <a:pt x="1353" y="800"/>
                  </a:lnTo>
                  <a:lnTo>
                    <a:pt x="1353" y="800"/>
                  </a:lnTo>
                  <a:lnTo>
                    <a:pt x="1354" y="800"/>
                  </a:lnTo>
                  <a:lnTo>
                    <a:pt x="1354" y="800"/>
                  </a:lnTo>
                  <a:lnTo>
                    <a:pt x="1355" y="800"/>
                  </a:lnTo>
                  <a:lnTo>
                    <a:pt x="1355" y="799"/>
                  </a:lnTo>
                  <a:lnTo>
                    <a:pt x="1356" y="798"/>
                  </a:lnTo>
                  <a:lnTo>
                    <a:pt x="1356" y="796"/>
                  </a:lnTo>
                  <a:lnTo>
                    <a:pt x="1357" y="795"/>
                  </a:lnTo>
                  <a:lnTo>
                    <a:pt x="1357" y="793"/>
                  </a:lnTo>
                  <a:lnTo>
                    <a:pt x="1358" y="794"/>
                  </a:lnTo>
                  <a:lnTo>
                    <a:pt x="1358" y="795"/>
                  </a:lnTo>
                  <a:lnTo>
                    <a:pt x="1359" y="795"/>
                  </a:lnTo>
                  <a:lnTo>
                    <a:pt x="1359" y="789"/>
                  </a:lnTo>
                  <a:lnTo>
                    <a:pt x="1360" y="788"/>
                  </a:lnTo>
                  <a:lnTo>
                    <a:pt x="1360" y="787"/>
                  </a:lnTo>
                  <a:lnTo>
                    <a:pt x="1361" y="789"/>
                  </a:lnTo>
                  <a:lnTo>
                    <a:pt x="1361" y="792"/>
                  </a:lnTo>
                  <a:lnTo>
                    <a:pt x="1362" y="789"/>
                  </a:lnTo>
                  <a:lnTo>
                    <a:pt x="1362" y="788"/>
                  </a:lnTo>
                  <a:lnTo>
                    <a:pt x="1363" y="788"/>
                  </a:lnTo>
                  <a:lnTo>
                    <a:pt x="1363" y="793"/>
                  </a:lnTo>
                  <a:lnTo>
                    <a:pt x="1364" y="792"/>
                  </a:lnTo>
                  <a:lnTo>
                    <a:pt x="1364" y="794"/>
                  </a:lnTo>
                  <a:lnTo>
                    <a:pt x="1365" y="794"/>
                  </a:lnTo>
                  <a:lnTo>
                    <a:pt x="1365" y="797"/>
                  </a:lnTo>
                  <a:lnTo>
                    <a:pt x="1366" y="797"/>
                  </a:lnTo>
                  <a:lnTo>
                    <a:pt x="1366" y="799"/>
                  </a:lnTo>
                  <a:lnTo>
                    <a:pt x="1367" y="800"/>
                  </a:lnTo>
                  <a:lnTo>
                    <a:pt x="1367" y="799"/>
                  </a:lnTo>
                  <a:lnTo>
                    <a:pt x="1368" y="800"/>
                  </a:lnTo>
                  <a:lnTo>
                    <a:pt x="1368" y="800"/>
                  </a:lnTo>
                  <a:lnTo>
                    <a:pt x="1369" y="800"/>
                  </a:lnTo>
                  <a:lnTo>
                    <a:pt x="1369" y="800"/>
                  </a:lnTo>
                  <a:lnTo>
                    <a:pt x="1370" y="800"/>
                  </a:lnTo>
                  <a:lnTo>
                    <a:pt x="1370" y="800"/>
                  </a:lnTo>
                  <a:lnTo>
                    <a:pt x="1371" y="800"/>
                  </a:lnTo>
                  <a:lnTo>
                    <a:pt x="1371" y="800"/>
                  </a:lnTo>
                  <a:lnTo>
                    <a:pt x="1372" y="800"/>
                  </a:lnTo>
                  <a:lnTo>
                    <a:pt x="1372" y="800"/>
                  </a:lnTo>
                  <a:lnTo>
                    <a:pt x="1373" y="800"/>
                  </a:lnTo>
                  <a:lnTo>
                    <a:pt x="1373" y="800"/>
                  </a:lnTo>
                  <a:lnTo>
                    <a:pt x="1374" y="800"/>
                  </a:lnTo>
                  <a:lnTo>
                    <a:pt x="1374" y="800"/>
                  </a:lnTo>
                  <a:lnTo>
                    <a:pt x="1375" y="800"/>
                  </a:lnTo>
                  <a:lnTo>
                    <a:pt x="1375" y="800"/>
                  </a:lnTo>
                  <a:lnTo>
                    <a:pt x="1376" y="800"/>
                  </a:lnTo>
                  <a:lnTo>
                    <a:pt x="1376" y="800"/>
                  </a:lnTo>
                  <a:lnTo>
                    <a:pt x="1377" y="800"/>
                  </a:lnTo>
                  <a:lnTo>
                    <a:pt x="1377" y="800"/>
                  </a:lnTo>
                  <a:lnTo>
                    <a:pt x="1378" y="800"/>
                  </a:lnTo>
                  <a:lnTo>
                    <a:pt x="1378" y="800"/>
                  </a:lnTo>
                  <a:lnTo>
                    <a:pt x="1379" y="800"/>
                  </a:lnTo>
                  <a:lnTo>
                    <a:pt x="1379" y="799"/>
                  </a:lnTo>
                  <a:lnTo>
                    <a:pt x="1380" y="800"/>
                  </a:lnTo>
                  <a:lnTo>
                    <a:pt x="1380" y="798"/>
                  </a:lnTo>
                  <a:lnTo>
                    <a:pt x="1381" y="797"/>
                  </a:lnTo>
                  <a:lnTo>
                    <a:pt x="1381" y="797"/>
                  </a:lnTo>
                  <a:lnTo>
                    <a:pt x="1382" y="797"/>
                  </a:lnTo>
                  <a:lnTo>
                    <a:pt x="1382" y="797"/>
                  </a:lnTo>
                  <a:lnTo>
                    <a:pt x="1383" y="797"/>
                  </a:lnTo>
                  <a:lnTo>
                    <a:pt x="1383" y="797"/>
                  </a:lnTo>
                  <a:lnTo>
                    <a:pt x="1384" y="796"/>
                  </a:lnTo>
                  <a:lnTo>
                    <a:pt x="1384" y="794"/>
                  </a:lnTo>
                  <a:lnTo>
                    <a:pt x="1385" y="800"/>
                  </a:lnTo>
                  <a:lnTo>
                    <a:pt x="1385" y="791"/>
                  </a:lnTo>
                  <a:lnTo>
                    <a:pt x="1386" y="791"/>
                  </a:lnTo>
                  <a:lnTo>
                    <a:pt x="1386" y="800"/>
                  </a:lnTo>
                  <a:lnTo>
                    <a:pt x="1387" y="792"/>
                  </a:lnTo>
                  <a:lnTo>
                    <a:pt x="1387" y="794"/>
                  </a:lnTo>
                  <a:lnTo>
                    <a:pt x="1388" y="795"/>
                  </a:lnTo>
                  <a:lnTo>
                    <a:pt x="1388" y="800"/>
                  </a:lnTo>
                  <a:lnTo>
                    <a:pt x="1389" y="798"/>
                  </a:lnTo>
                  <a:lnTo>
                    <a:pt x="1389" y="799"/>
                  </a:lnTo>
                  <a:lnTo>
                    <a:pt x="1390" y="799"/>
                  </a:lnTo>
                  <a:lnTo>
                    <a:pt x="1390" y="798"/>
                  </a:lnTo>
                  <a:lnTo>
                    <a:pt x="1391" y="798"/>
                  </a:lnTo>
                  <a:lnTo>
                    <a:pt x="1391" y="798"/>
                  </a:lnTo>
                  <a:lnTo>
                    <a:pt x="1392" y="798"/>
                  </a:lnTo>
                  <a:lnTo>
                    <a:pt x="1392" y="798"/>
                  </a:lnTo>
                  <a:lnTo>
                    <a:pt x="1393" y="798"/>
                  </a:lnTo>
                  <a:lnTo>
                    <a:pt x="1393" y="798"/>
                  </a:lnTo>
                  <a:lnTo>
                    <a:pt x="1394" y="798"/>
                  </a:lnTo>
                  <a:lnTo>
                    <a:pt x="1394" y="798"/>
                  </a:lnTo>
                  <a:lnTo>
                    <a:pt x="1395" y="798"/>
                  </a:lnTo>
                  <a:lnTo>
                    <a:pt x="1395" y="798"/>
                  </a:lnTo>
                  <a:lnTo>
                    <a:pt x="1396" y="798"/>
                  </a:lnTo>
                  <a:lnTo>
                    <a:pt x="1396" y="797"/>
                  </a:lnTo>
                  <a:lnTo>
                    <a:pt x="1397" y="797"/>
                  </a:lnTo>
                  <a:lnTo>
                    <a:pt x="1397" y="797"/>
                  </a:lnTo>
                  <a:lnTo>
                    <a:pt x="1398" y="800"/>
                  </a:lnTo>
                  <a:lnTo>
                    <a:pt x="1398" y="797"/>
                  </a:lnTo>
                  <a:lnTo>
                    <a:pt x="1399" y="797"/>
                  </a:lnTo>
                  <a:lnTo>
                    <a:pt x="1399" y="798"/>
                  </a:lnTo>
                  <a:lnTo>
                    <a:pt x="1400" y="798"/>
                  </a:lnTo>
                  <a:lnTo>
                    <a:pt x="1400" y="798"/>
                  </a:lnTo>
                  <a:lnTo>
                    <a:pt x="1401" y="799"/>
                  </a:lnTo>
                  <a:lnTo>
                    <a:pt x="1401" y="799"/>
                  </a:lnTo>
                  <a:lnTo>
                    <a:pt x="1402" y="799"/>
                  </a:lnTo>
                  <a:lnTo>
                    <a:pt x="1402" y="799"/>
                  </a:lnTo>
                  <a:lnTo>
                    <a:pt x="1403" y="799"/>
                  </a:lnTo>
                  <a:lnTo>
                    <a:pt x="1403" y="798"/>
                  </a:lnTo>
                  <a:lnTo>
                    <a:pt x="1404" y="798"/>
                  </a:lnTo>
                  <a:lnTo>
                    <a:pt x="1404" y="797"/>
                  </a:lnTo>
                  <a:lnTo>
                    <a:pt x="1405" y="797"/>
                  </a:lnTo>
                  <a:lnTo>
                    <a:pt x="1405" y="795"/>
                  </a:lnTo>
                  <a:lnTo>
                    <a:pt x="1406" y="794"/>
                  </a:lnTo>
                  <a:lnTo>
                    <a:pt x="1406" y="794"/>
                  </a:lnTo>
                  <a:lnTo>
                    <a:pt x="1407" y="794"/>
                  </a:lnTo>
                  <a:lnTo>
                    <a:pt x="1407" y="794"/>
                  </a:lnTo>
                  <a:lnTo>
                    <a:pt x="1408" y="795"/>
                  </a:lnTo>
                  <a:lnTo>
                    <a:pt x="1408" y="796"/>
                  </a:lnTo>
                  <a:lnTo>
                    <a:pt x="1409" y="796"/>
                  </a:lnTo>
                  <a:lnTo>
                    <a:pt x="1409" y="797"/>
                  </a:lnTo>
                  <a:lnTo>
                    <a:pt x="1410" y="797"/>
                  </a:lnTo>
                  <a:lnTo>
                    <a:pt x="1410" y="798"/>
                  </a:lnTo>
                  <a:lnTo>
                    <a:pt x="1411" y="798"/>
                  </a:lnTo>
                  <a:lnTo>
                    <a:pt x="1411" y="800"/>
                  </a:lnTo>
                  <a:lnTo>
                    <a:pt x="1412" y="798"/>
                  </a:lnTo>
                  <a:lnTo>
                    <a:pt x="1412" y="798"/>
                  </a:lnTo>
                  <a:lnTo>
                    <a:pt x="1413" y="800"/>
                  </a:lnTo>
                  <a:lnTo>
                    <a:pt x="1413" y="797"/>
                  </a:lnTo>
                  <a:lnTo>
                    <a:pt x="1414" y="800"/>
                  </a:lnTo>
                  <a:lnTo>
                    <a:pt x="1414" y="796"/>
                  </a:lnTo>
                  <a:lnTo>
                    <a:pt x="1415" y="795"/>
                  </a:lnTo>
                  <a:lnTo>
                    <a:pt x="1415" y="800"/>
                  </a:lnTo>
                  <a:lnTo>
                    <a:pt x="1416" y="795"/>
                  </a:lnTo>
                  <a:lnTo>
                    <a:pt x="1416" y="794"/>
                  </a:lnTo>
                  <a:lnTo>
                    <a:pt x="1417" y="800"/>
                  </a:lnTo>
                  <a:lnTo>
                    <a:pt x="1417" y="794"/>
                  </a:lnTo>
                  <a:lnTo>
                    <a:pt x="1418" y="794"/>
                  </a:lnTo>
                  <a:lnTo>
                    <a:pt x="1418" y="800"/>
                  </a:lnTo>
                  <a:lnTo>
                    <a:pt x="1419" y="795"/>
                  </a:lnTo>
                  <a:lnTo>
                    <a:pt x="1419" y="795"/>
                  </a:lnTo>
                  <a:lnTo>
                    <a:pt x="1420" y="795"/>
                  </a:lnTo>
                  <a:lnTo>
                    <a:pt x="1420" y="795"/>
                  </a:lnTo>
                  <a:lnTo>
                    <a:pt x="1421" y="796"/>
                  </a:lnTo>
                  <a:lnTo>
                    <a:pt x="1421" y="795"/>
                  </a:lnTo>
                  <a:lnTo>
                    <a:pt x="1422" y="796"/>
                  </a:lnTo>
                  <a:lnTo>
                    <a:pt x="1422" y="795"/>
                  </a:lnTo>
                  <a:lnTo>
                    <a:pt x="1423" y="796"/>
                  </a:lnTo>
                  <a:lnTo>
                    <a:pt x="1423" y="795"/>
                  </a:lnTo>
                  <a:lnTo>
                    <a:pt x="1424" y="796"/>
                  </a:lnTo>
                  <a:lnTo>
                    <a:pt x="1424" y="796"/>
                  </a:lnTo>
                  <a:lnTo>
                    <a:pt x="1425" y="796"/>
                  </a:lnTo>
                  <a:lnTo>
                    <a:pt x="1425" y="797"/>
                  </a:lnTo>
                  <a:lnTo>
                    <a:pt x="1426" y="797"/>
                  </a:lnTo>
                  <a:lnTo>
                    <a:pt x="1426" y="797"/>
                  </a:lnTo>
                  <a:lnTo>
                    <a:pt x="1427" y="797"/>
                  </a:lnTo>
                  <a:lnTo>
                    <a:pt x="1427" y="798"/>
                  </a:lnTo>
                  <a:lnTo>
                    <a:pt x="1428" y="798"/>
                  </a:lnTo>
                  <a:lnTo>
                    <a:pt x="1428" y="798"/>
                  </a:lnTo>
                  <a:lnTo>
                    <a:pt x="1429" y="798"/>
                  </a:lnTo>
                  <a:lnTo>
                    <a:pt x="1429" y="798"/>
                  </a:lnTo>
                  <a:lnTo>
                    <a:pt x="1430" y="800"/>
                  </a:lnTo>
                  <a:lnTo>
                    <a:pt x="1430" y="798"/>
                  </a:lnTo>
                  <a:lnTo>
                    <a:pt x="1431" y="798"/>
                  </a:lnTo>
                  <a:lnTo>
                    <a:pt x="1431" y="798"/>
                  </a:lnTo>
                  <a:lnTo>
                    <a:pt x="1432" y="798"/>
                  </a:lnTo>
                  <a:lnTo>
                    <a:pt x="1432" y="797"/>
                  </a:lnTo>
                  <a:lnTo>
                    <a:pt x="1433" y="798"/>
                  </a:lnTo>
                  <a:lnTo>
                    <a:pt x="1433" y="797"/>
                  </a:lnTo>
                  <a:lnTo>
                    <a:pt x="1434" y="797"/>
                  </a:lnTo>
                  <a:lnTo>
                    <a:pt x="1434" y="798"/>
                  </a:lnTo>
                  <a:lnTo>
                    <a:pt x="1435" y="798"/>
                  </a:lnTo>
                  <a:lnTo>
                    <a:pt x="1435" y="798"/>
                  </a:lnTo>
                  <a:lnTo>
                    <a:pt x="1436" y="798"/>
                  </a:lnTo>
                  <a:lnTo>
                    <a:pt x="1436" y="799"/>
                  </a:lnTo>
                  <a:lnTo>
                    <a:pt x="1437" y="799"/>
                  </a:lnTo>
                  <a:lnTo>
                    <a:pt x="1437" y="799"/>
                  </a:lnTo>
                  <a:lnTo>
                    <a:pt x="1438" y="799"/>
                  </a:lnTo>
                  <a:lnTo>
                    <a:pt x="1438" y="799"/>
                  </a:lnTo>
                  <a:lnTo>
                    <a:pt x="1439" y="799"/>
                  </a:lnTo>
                  <a:lnTo>
                    <a:pt x="1439" y="799"/>
                  </a:lnTo>
                  <a:lnTo>
                    <a:pt x="1440" y="799"/>
                  </a:lnTo>
                  <a:lnTo>
                    <a:pt x="1440" y="799"/>
                  </a:lnTo>
                  <a:lnTo>
                    <a:pt x="1441" y="799"/>
                  </a:lnTo>
                  <a:lnTo>
                    <a:pt x="1441" y="799"/>
                  </a:lnTo>
                  <a:lnTo>
                    <a:pt x="1442" y="799"/>
                  </a:lnTo>
                  <a:lnTo>
                    <a:pt x="1442" y="799"/>
                  </a:lnTo>
                  <a:lnTo>
                    <a:pt x="1443" y="799"/>
                  </a:lnTo>
                  <a:lnTo>
                    <a:pt x="1443" y="799"/>
                  </a:lnTo>
                  <a:lnTo>
                    <a:pt x="1444" y="799"/>
                  </a:lnTo>
                  <a:lnTo>
                    <a:pt x="1444" y="799"/>
                  </a:lnTo>
                  <a:lnTo>
                    <a:pt x="1445" y="799"/>
                  </a:lnTo>
                  <a:lnTo>
                    <a:pt x="1445" y="799"/>
                  </a:lnTo>
                  <a:lnTo>
                    <a:pt x="1446" y="799"/>
                  </a:lnTo>
                  <a:lnTo>
                    <a:pt x="1446" y="799"/>
                  </a:lnTo>
                  <a:lnTo>
                    <a:pt x="1447" y="799"/>
                  </a:lnTo>
                  <a:lnTo>
                    <a:pt x="1447" y="800"/>
                  </a:lnTo>
                  <a:lnTo>
                    <a:pt x="1448" y="799"/>
                  </a:lnTo>
                  <a:lnTo>
                    <a:pt x="1448" y="800"/>
                  </a:lnTo>
                  <a:lnTo>
                    <a:pt x="1449" y="800"/>
                  </a:lnTo>
                  <a:lnTo>
                    <a:pt x="1449" y="800"/>
                  </a:lnTo>
                  <a:lnTo>
                    <a:pt x="1450" y="800"/>
                  </a:lnTo>
                  <a:lnTo>
                    <a:pt x="1450" y="800"/>
                  </a:lnTo>
                  <a:lnTo>
                    <a:pt x="1451" y="800"/>
                  </a:lnTo>
                  <a:lnTo>
                    <a:pt x="1451" y="800"/>
                  </a:lnTo>
                  <a:lnTo>
                    <a:pt x="1452" y="800"/>
                  </a:lnTo>
                  <a:lnTo>
                    <a:pt x="1452" y="800"/>
                  </a:lnTo>
                  <a:lnTo>
                    <a:pt x="1453" y="800"/>
                  </a:lnTo>
                  <a:lnTo>
                    <a:pt x="1453" y="800"/>
                  </a:lnTo>
                  <a:lnTo>
                    <a:pt x="1454" y="799"/>
                  </a:lnTo>
                  <a:lnTo>
                    <a:pt x="1454" y="799"/>
                  </a:lnTo>
                  <a:lnTo>
                    <a:pt x="1455" y="799"/>
                  </a:lnTo>
                  <a:lnTo>
                    <a:pt x="1455" y="799"/>
                  </a:lnTo>
                  <a:lnTo>
                    <a:pt x="1456" y="799"/>
                  </a:lnTo>
                  <a:lnTo>
                    <a:pt x="1456" y="799"/>
                  </a:lnTo>
                  <a:lnTo>
                    <a:pt x="1457" y="799"/>
                  </a:lnTo>
                  <a:lnTo>
                    <a:pt x="1457" y="799"/>
                  </a:lnTo>
                  <a:lnTo>
                    <a:pt x="1458" y="799"/>
                  </a:lnTo>
                  <a:lnTo>
                    <a:pt x="1458" y="800"/>
                  </a:lnTo>
                  <a:lnTo>
                    <a:pt x="1459" y="800"/>
                  </a:lnTo>
                  <a:lnTo>
                    <a:pt x="1459" y="799"/>
                  </a:lnTo>
                  <a:lnTo>
                    <a:pt x="1460" y="800"/>
                  </a:lnTo>
                  <a:lnTo>
                    <a:pt x="1460" y="800"/>
                  </a:lnTo>
                  <a:lnTo>
                    <a:pt x="1461" y="800"/>
                  </a:lnTo>
                  <a:lnTo>
                    <a:pt x="1461" y="800"/>
                  </a:lnTo>
                  <a:lnTo>
                    <a:pt x="1462" y="800"/>
                  </a:lnTo>
                  <a:lnTo>
                    <a:pt x="1462" y="800"/>
                  </a:lnTo>
                  <a:lnTo>
                    <a:pt x="1463" y="800"/>
                  </a:lnTo>
                  <a:lnTo>
                    <a:pt x="1463" y="800"/>
                  </a:lnTo>
                  <a:lnTo>
                    <a:pt x="1464" y="800"/>
                  </a:lnTo>
                  <a:lnTo>
                    <a:pt x="1464" y="800"/>
                  </a:lnTo>
                  <a:lnTo>
                    <a:pt x="1465" y="799"/>
                  </a:lnTo>
                  <a:lnTo>
                    <a:pt x="1465" y="800"/>
                  </a:lnTo>
                  <a:lnTo>
                    <a:pt x="1466" y="799"/>
                  </a:lnTo>
                  <a:lnTo>
                    <a:pt x="1466" y="798"/>
                  </a:lnTo>
                  <a:lnTo>
                    <a:pt x="1467" y="798"/>
                  </a:lnTo>
                  <a:lnTo>
                    <a:pt x="1467" y="798"/>
                  </a:lnTo>
                  <a:lnTo>
                    <a:pt x="1468" y="798"/>
                  </a:lnTo>
                  <a:lnTo>
                    <a:pt x="1468" y="798"/>
                  </a:lnTo>
                  <a:lnTo>
                    <a:pt x="1469" y="80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9" name="Rectangle 233"/>
            <p:cNvSpPr>
              <a:spLocks noChangeArrowheads="1"/>
            </p:cNvSpPr>
            <p:nvPr/>
          </p:nvSpPr>
          <p:spPr bwMode="auto">
            <a:xfrm>
              <a:off x="3248025" y="676275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6.66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234"/>
            <p:cNvSpPr>
              <a:spLocks noChangeArrowheads="1"/>
            </p:cNvSpPr>
            <p:nvPr/>
          </p:nvSpPr>
          <p:spPr bwMode="auto">
            <a:xfrm>
              <a:off x="3219450" y="727075"/>
              <a:ext cx="20955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53.13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235"/>
            <p:cNvSpPr>
              <a:spLocks noChangeArrowheads="1"/>
            </p:cNvSpPr>
            <p:nvPr/>
          </p:nvSpPr>
          <p:spPr bwMode="auto">
            <a:xfrm>
              <a:off x="3340100" y="1905000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6.78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236"/>
            <p:cNvSpPr>
              <a:spLocks noChangeArrowheads="1"/>
            </p:cNvSpPr>
            <p:nvPr/>
          </p:nvSpPr>
          <p:spPr bwMode="auto">
            <a:xfrm>
              <a:off x="3325813" y="1955800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69.09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Line 237"/>
            <p:cNvSpPr>
              <a:spLocks noChangeShapeType="1"/>
            </p:cNvSpPr>
            <p:nvPr/>
          </p:nvSpPr>
          <p:spPr bwMode="auto">
            <a:xfrm flipV="1">
              <a:off x="3336925" y="2001838"/>
              <a:ext cx="79375" cy="6350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4" name="Rectangle 238"/>
            <p:cNvSpPr>
              <a:spLocks noChangeArrowheads="1"/>
            </p:cNvSpPr>
            <p:nvPr/>
          </p:nvSpPr>
          <p:spPr bwMode="auto">
            <a:xfrm>
              <a:off x="3159125" y="1973263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6.58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239"/>
            <p:cNvSpPr>
              <a:spLocks noChangeArrowheads="1"/>
            </p:cNvSpPr>
            <p:nvPr/>
          </p:nvSpPr>
          <p:spPr bwMode="auto">
            <a:xfrm>
              <a:off x="3144838" y="2025650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0.44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Line 240"/>
            <p:cNvSpPr>
              <a:spLocks noChangeShapeType="1"/>
            </p:cNvSpPr>
            <p:nvPr/>
          </p:nvSpPr>
          <p:spPr bwMode="auto">
            <a:xfrm flipH="1" flipV="1">
              <a:off x="3235325" y="2070100"/>
              <a:ext cx="80962" cy="6350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7" name="Rectangle 241"/>
            <p:cNvSpPr>
              <a:spLocks noChangeArrowheads="1"/>
            </p:cNvSpPr>
            <p:nvPr/>
          </p:nvSpPr>
          <p:spPr bwMode="auto">
            <a:xfrm>
              <a:off x="2895600" y="2162175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3.3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242"/>
            <p:cNvSpPr>
              <a:spLocks noChangeArrowheads="1"/>
            </p:cNvSpPr>
            <p:nvPr/>
          </p:nvSpPr>
          <p:spPr bwMode="auto">
            <a:xfrm>
              <a:off x="2881313" y="2214563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47.03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243"/>
            <p:cNvSpPr>
              <a:spLocks noChangeArrowheads="1"/>
            </p:cNvSpPr>
            <p:nvPr/>
          </p:nvSpPr>
          <p:spPr bwMode="auto">
            <a:xfrm>
              <a:off x="2992438" y="2338388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3.49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244"/>
            <p:cNvSpPr>
              <a:spLocks noChangeArrowheads="1"/>
            </p:cNvSpPr>
            <p:nvPr/>
          </p:nvSpPr>
          <p:spPr bwMode="auto">
            <a:xfrm>
              <a:off x="2978150" y="2389188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63.11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Line 245"/>
            <p:cNvSpPr>
              <a:spLocks noChangeShapeType="1"/>
            </p:cNvSpPr>
            <p:nvPr/>
          </p:nvSpPr>
          <p:spPr bwMode="auto">
            <a:xfrm flipV="1">
              <a:off x="2989263" y="2435225"/>
              <a:ext cx="79375" cy="6350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2" name="Rectangle 246"/>
            <p:cNvSpPr>
              <a:spLocks noChangeArrowheads="1"/>
            </p:cNvSpPr>
            <p:nvPr/>
          </p:nvSpPr>
          <p:spPr bwMode="auto">
            <a:xfrm>
              <a:off x="2317750" y="2463800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.88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247"/>
            <p:cNvSpPr>
              <a:spLocks noChangeArrowheads="1"/>
            </p:cNvSpPr>
            <p:nvPr/>
          </p:nvSpPr>
          <p:spPr bwMode="auto">
            <a:xfrm>
              <a:off x="2303463" y="2516188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29.2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248"/>
            <p:cNvSpPr>
              <a:spLocks noChangeArrowheads="1"/>
            </p:cNvSpPr>
            <p:nvPr/>
          </p:nvSpPr>
          <p:spPr bwMode="auto">
            <a:xfrm>
              <a:off x="3360738" y="2516188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7.18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249"/>
            <p:cNvSpPr>
              <a:spLocks noChangeArrowheads="1"/>
            </p:cNvSpPr>
            <p:nvPr/>
          </p:nvSpPr>
          <p:spPr bwMode="auto">
            <a:xfrm>
              <a:off x="3332163" y="2566988"/>
              <a:ext cx="20955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25.6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Line 250"/>
            <p:cNvSpPr>
              <a:spLocks noChangeShapeType="1"/>
            </p:cNvSpPr>
            <p:nvPr/>
          </p:nvSpPr>
          <p:spPr bwMode="auto">
            <a:xfrm flipV="1">
              <a:off x="3379788" y="2613025"/>
              <a:ext cx="57150" cy="6350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7" name="Rectangle 251"/>
            <p:cNvSpPr>
              <a:spLocks noChangeArrowheads="1"/>
            </p:cNvSpPr>
            <p:nvPr/>
          </p:nvSpPr>
          <p:spPr bwMode="auto">
            <a:xfrm>
              <a:off x="2538413" y="2541588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9.96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252"/>
            <p:cNvSpPr>
              <a:spLocks noChangeArrowheads="1"/>
            </p:cNvSpPr>
            <p:nvPr/>
          </p:nvSpPr>
          <p:spPr bwMode="auto">
            <a:xfrm>
              <a:off x="2524125" y="2593975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71.79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Rectangle 253"/>
            <p:cNvSpPr>
              <a:spLocks noChangeArrowheads="1"/>
            </p:cNvSpPr>
            <p:nvPr/>
          </p:nvSpPr>
          <p:spPr bwMode="auto">
            <a:xfrm>
              <a:off x="3076575" y="2547938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5.04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254"/>
            <p:cNvSpPr>
              <a:spLocks noChangeArrowheads="1"/>
            </p:cNvSpPr>
            <p:nvPr/>
          </p:nvSpPr>
          <p:spPr bwMode="auto">
            <a:xfrm>
              <a:off x="3062288" y="2598738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57.51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255"/>
            <p:cNvSpPr>
              <a:spLocks noChangeArrowheads="1"/>
            </p:cNvSpPr>
            <p:nvPr/>
          </p:nvSpPr>
          <p:spPr bwMode="auto">
            <a:xfrm>
              <a:off x="2803525" y="2573338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3.2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256"/>
            <p:cNvSpPr>
              <a:spLocks noChangeArrowheads="1"/>
            </p:cNvSpPr>
            <p:nvPr/>
          </p:nvSpPr>
          <p:spPr bwMode="auto">
            <a:xfrm>
              <a:off x="2789238" y="2625725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92.6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Line 257"/>
            <p:cNvSpPr>
              <a:spLocks noChangeShapeType="1"/>
            </p:cNvSpPr>
            <p:nvPr/>
          </p:nvSpPr>
          <p:spPr bwMode="auto">
            <a:xfrm flipH="1" flipV="1">
              <a:off x="2879725" y="2670175"/>
              <a:ext cx="80962" cy="6350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4" name="Rectangle 258"/>
            <p:cNvSpPr>
              <a:spLocks noChangeArrowheads="1"/>
            </p:cNvSpPr>
            <p:nvPr/>
          </p:nvSpPr>
          <p:spPr bwMode="auto">
            <a:xfrm>
              <a:off x="2225675" y="2584450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.3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Rectangle 259"/>
            <p:cNvSpPr>
              <a:spLocks noChangeArrowheads="1"/>
            </p:cNvSpPr>
            <p:nvPr/>
          </p:nvSpPr>
          <p:spPr bwMode="auto">
            <a:xfrm>
              <a:off x="2211388" y="2636838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99.08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Line 260"/>
            <p:cNvSpPr>
              <a:spLocks noChangeShapeType="1"/>
            </p:cNvSpPr>
            <p:nvPr/>
          </p:nvSpPr>
          <p:spPr bwMode="auto">
            <a:xfrm flipH="1" flipV="1">
              <a:off x="2301875" y="2682875"/>
              <a:ext cx="34925" cy="4762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7" name="Rectangle 261"/>
            <p:cNvSpPr>
              <a:spLocks noChangeArrowheads="1"/>
            </p:cNvSpPr>
            <p:nvPr/>
          </p:nvSpPr>
          <p:spPr bwMode="auto">
            <a:xfrm>
              <a:off x="1898650" y="2622550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3.9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262"/>
            <p:cNvSpPr>
              <a:spLocks noChangeArrowheads="1"/>
            </p:cNvSpPr>
            <p:nvPr/>
          </p:nvSpPr>
          <p:spPr bwMode="auto">
            <a:xfrm>
              <a:off x="1884363" y="2673350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15.3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263"/>
            <p:cNvSpPr>
              <a:spLocks noChangeArrowheads="1"/>
            </p:cNvSpPr>
            <p:nvPr/>
          </p:nvSpPr>
          <p:spPr bwMode="auto">
            <a:xfrm>
              <a:off x="4030663" y="2659063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4.06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Rectangle 264"/>
            <p:cNvSpPr>
              <a:spLocks noChangeArrowheads="1"/>
            </p:cNvSpPr>
            <p:nvPr/>
          </p:nvSpPr>
          <p:spPr bwMode="auto">
            <a:xfrm>
              <a:off x="4002088" y="2711450"/>
              <a:ext cx="20955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82.5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Rectangle 265"/>
            <p:cNvSpPr>
              <a:spLocks noChangeArrowheads="1"/>
            </p:cNvSpPr>
            <p:nvPr/>
          </p:nvSpPr>
          <p:spPr bwMode="auto">
            <a:xfrm>
              <a:off x="3441700" y="2693988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7.85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Rectangle 266"/>
            <p:cNvSpPr>
              <a:spLocks noChangeArrowheads="1"/>
            </p:cNvSpPr>
            <p:nvPr/>
          </p:nvSpPr>
          <p:spPr bwMode="auto">
            <a:xfrm>
              <a:off x="3427413" y="2746375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84.50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Line 267"/>
            <p:cNvSpPr>
              <a:spLocks noChangeShapeType="1"/>
            </p:cNvSpPr>
            <p:nvPr/>
          </p:nvSpPr>
          <p:spPr bwMode="auto">
            <a:xfrm flipV="1">
              <a:off x="3448050" y="2790825"/>
              <a:ext cx="69850" cy="6350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" name="Rectangle 268"/>
            <p:cNvSpPr>
              <a:spLocks noChangeArrowheads="1"/>
            </p:cNvSpPr>
            <p:nvPr/>
          </p:nvSpPr>
          <p:spPr bwMode="auto">
            <a:xfrm>
              <a:off x="3613150" y="2714625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9.0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Rectangle 269"/>
            <p:cNvSpPr>
              <a:spLocks noChangeArrowheads="1"/>
            </p:cNvSpPr>
            <p:nvPr/>
          </p:nvSpPr>
          <p:spPr bwMode="auto">
            <a:xfrm>
              <a:off x="3598863" y="2765425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36.44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Line 270"/>
            <p:cNvSpPr>
              <a:spLocks noChangeShapeType="1"/>
            </p:cNvSpPr>
            <p:nvPr/>
          </p:nvSpPr>
          <p:spPr bwMode="auto">
            <a:xfrm flipV="1">
              <a:off x="3575050" y="2811463"/>
              <a:ext cx="114300" cy="6350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7" name="Rectangle 271"/>
            <p:cNvSpPr>
              <a:spLocks noChangeArrowheads="1"/>
            </p:cNvSpPr>
            <p:nvPr/>
          </p:nvSpPr>
          <p:spPr bwMode="auto">
            <a:xfrm>
              <a:off x="3786188" y="2733675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.66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Rectangle 272"/>
            <p:cNvSpPr>
              <a:spLocks noChangeArrowheads="1"/>
            </p:cNvSpPr>
            <p:nvPr/>
          </p:nvSpPr>
          <p:spPr bwMode="auto">
            <a:xfrm>
              <a:off x="3771900" y="2786063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76.41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Line 273"/>
            <p:cNvSpPr>
              <a:spLocks noChangeShapeType="1"/>
            </p:cNvSpPr>
            <p:nvPr/>
          </p:nvSpPr>
          <p:spPr bwMode="auto">
            <a:xfrm flipV="1">
              <a:off x="3748088" y="2832100"/>
              <a:ext cx="114300" cy="4762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0" name="Rectangle 274"/>
            <p:cNvSpPr>
              <a:spLocks noChangeArrowheads="1"/>
            </p:cNvSpPr>
            <p:nvPr/>
          </p:nvSpPr>
          <p:spPr bwMode="auto">
            <a:xfrm>
              <a:off x="4225925" y="2760663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5.14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Rectangle 275"/>
            <p:cNvSpPr>
              <a:spLocks noChangeArrowheads="1"/>
            </p:cNvSpPr>
            <p:nvPr/>
          </p:nvSpPr>
          <p:spPr bwMode="auto">
            <a:xfrm>
              <a:off x="4197350" y="2811463"/>
              <a:ext cx="20955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28.57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Line 276"/>
            <p:cNvSpPr>
              <a:spLocks noChangeShapeType="1"/>
            </p:cNvSpPr>
            <p:nvPr/>
          </p:nvSpPr>
          <p:spPr bwMode="auto">
            <a:xfrm flipV="1">
              <a:off x="4221163" y="2857500"/>
              <a:ext cx="80962" cy="6350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" name="Rectangle 277"/>
            <p:cNvSpPr>
              <a:spLocks noChangeArrowheads="1"/>
            </p:cNvSpPr>
            <p:nvPr/>
          </p:nvSpPr>
          <p:spPr bwMode="auto">
            <a:xfrm>
              <a:off x="4418013" y="2779713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6.98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Rectangle 278"/>
            <p:cNvSpPr>
              <a:spLocks noChangeArrowheads="1"/>
            </p:cNvSpPr>
            <p:nvPr/>
          </p:nvSpPr>
          <p:spPr bwMode="auto">
            <a:xfrm>
              <a:off x="4389438" y="2832100"/>
              <a:ext cx="20955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37.5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" name="Line 279"/>
            <p:cNvSpPr>
              <a:spLocks noChangeShapeType="1"/>
            </p:cNvSpPr>
            <p:nvPr/>
          </p:nvSpPr>
          <p:spPr bwMode="auto">
            <a:xfrm flipV="1">
              <a:off x="4414838" y="2878138"/>
              <a:ext cx="79375" cy="4762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6" name="Rectangle 280"/>
            <p:cNvSpPr>
              <a:spLocks noChangeArrowheads="1"/>
            </p:cNvSpPr>
            <p:nvPr/>
          </p:nvSpPr>
          <p:spPr bwMode="auto">
            <a:xfrm>
              <a:off x="4610100" y="2790825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9.2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" name="Rectangle 281"/>
            <p:cNvSpPr>
              <a:spLocks noChangeArrowheads="1"/>
            </p:cNvSpPr>
            <p:nvPr/>
          </p:nvSpPr>
          <p:spPr bwMode="auto">
            <a:xfrm>
              <a:off x="4581525" y="2843213"/>
              <a:ext cx="20955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92.11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Line 282"/>
            <p:cNvSpPr>
              <a:spLocks noChangeShapeType="1"/>
            </p:cNvSpPr>
            <p:nvPr/>
          </p:nvSpPr>
          <p:spPr bwMode="auto">
            <a:xfrm flipV="1">
              <a:off x="4652963" y="2889250"/>
              <a:ext cx="33337" cy="4762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9" name="Rectangle 283"/>
            <p:cNvSpPr>
              <a:spLocks noChangeArrowheads="1"/>
            </p:cNvSpPr>
            <p:nvPr/>
          </p:nvSpPr>
          <p:spPr bwMode="auto">
            <a:xfrm>
              <a:off x="1792288" y="2808288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2.99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Rectangle 284"/>
            <p:cNvSpPr>
              <a:spLocks noChangeArrowheads="1"/>
            </p:cNvSpPr>
            <p:nvPr/>
          </p:nvSpPr>
          <p:spPr bwMode="auto">
            <a:xfrm>
              <a:off x="1778000" y="2860675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98.47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1" name="Line 285"/>
            <p:cNvSpPr>
              <a:spLocks noChangeShapeType="1"/>
            </p:cNvSpPr>
            <p:nvPr/>
          </p:nvSpPr>
          <p:spPr bwMode="auto">
            <a:xfrm flipH="1" flipV="1">
              <a:off x="1868488" y="2906713"/>
              <a:ext cx="11112" cy="4762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2" name="Rectangle 286"/>
            <p:cNvSpPr>
              <a:spLocks noChangeArrowheads="1"/>
            </p:cNvSpPr>
            <p:nvPr/>
          </p:nvSpPr>
          <p:spPr bwMode="auto">
            <a:xfrm>
              <a:off x="2041525" y="2808288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5.26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3" name="Rectangle 287"/>
            <p:cNvSpPr>
              <a:spLocks noChangeArrowheads="1"/>
            </p:cNvSpPr>
            <p:nvPr/>
          </p:nvSpPr>
          <p:spPr bwMode="auto">
            <a:xfrm>
              <a:off x="2027238" y="2860675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30.43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Rectangle 288"/>
            <p:cNvSpPr>
              <a:spLocks noChangeArrowheads="1"/>
            </p:cNvSpPr>
            <p:nvPr/>
          </p:nvSpPr>
          <p:spPr bwMode="auto">
            <a:xfrm>
              <a:off x="3825875" y="2840038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1.48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Rectangle 289"/>
            <p:cNvSpPr>
              <a:spLocks noChangeArrowheads="1"/>
            </p:cNvSpPr>
            <p:nvPr/>
          </p:nvSpPr>
          <p:spPr bwMode="auto">
            <a:xfrm>
              <a:off x="3811588" y="2892425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87.35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Line 290"/>
            <p:cNvSpPr>
              <a:spLocks noChangeShapeType="1"/>
            </p:cNvSpPr>
            <p:nvPr/>
          </p:nvSpPr>
          <p:spPr bwMode="auto">
            <a:xfrm flipV="1">
              <a:off x="3833813" y="2938463"/>
              <a:ext cx="68262" cy="4762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7" name="Rectangle 291"/>
            <p:cNvSpPr>
              <a:spLocks noChangeArrowheads="1"/>
            </p:cNvSpPr>
            <p:nvPr/>
          </p:nvSpPr>
          <p:spPr bwMode="auto">
            <a:xfrm>
              <a:off x="1619250" y="2854325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2.46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8" name="Rectangle 292"/>
            <p:cNvSpPr>
              <a:spLocks noChangeArrowheads="1"/>
            </p:cNvSpPr>
            <p:nvPr/>
          </p:nvSpPr>
          <p:spPr bwMode="auto">
            <a:xfrm>
              <a:off x="1604963" y="2906713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52.24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Line 293"/>
            <p:cNvSpPr>
              <a:spLocks noChangeShapeType="1"/>
            </p:cNvSpPr>
            <p:nvPr/>
          </p:nvSpPr>
          <p:spPr bwMode="auto">
            <a:xfrm flipH="1" flipV="1">
              <a:off x="1695450" y="2952750"/>
              <a:ext cx="127000" cy="4762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0" name="Rectangle 294"/>
            <p:cNvSpPr>
              <a:spLocks noChangeArrowheads="1"/>
            </p:cNvSpPr>
            <p:nvPr/>
          </p:nvSpPr>
          <p:spPr bwMode="auto">
            <a:xfrm>
              <a:off x="1300163" y="2857500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8.26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Rectangle 295"/>
            <p:cNvSpPr>
              <a:spLocks noChangeArrowheads="1"/>
            </p:cNvSpPr>
            <p:nvPr/>
          </p:nvSpPr>
          <p:spPr bwMode="auto">
            <a:xfrm>
              <a:off x="1285875" y="2909888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09.3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Rectangle 296"/>
            <p:cNvSpPr>
              <a:spLocks noChangeArrowheads="1"/>
            </p:cNvSpPr>
            <p:nvPr/>
          </p:nvSpPr>
          <p:spPr bwMode="auto">
            <a:xfrm>
              <a:off x="4875213" y="2935288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2.06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3" name="Rectangle 297"/>
            <p:cNvSpPr>
              <a:spLocks noChangeArrowheads="1"/>
            </p:cNvSpPr>
            <p:nvPr/>
          </p:nvSpPr>
          <p:spPr bwMode="auto">
            <a:xfrm>
              <a:off x="4860925" y="2986088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84.2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4" name="Rectangle 298"/>
            <p:cNvSpPr>
              <a:spLocks noChangeArrowheads="1"/>
            </p:cNvSpPr>
            <p:nvPr/>
          </p:nvSpPr>
          <p:spPr bwMode="auto">
            <a:xfrm>
              <a:off x="1125538" y="2938463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7.1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5" name="Rectangle 299"/>
            <p:cNvSpPr>
              <a:spLocks noChangeArrowheads="1"/>
            </p:cNvSpPr>
            <p:nvPr/>
          </p:nvSpPr>
          <p:spPr bwMode="auto">
            <a:xfrm>
              <a:off x="1111250" y="2989263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88.35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6" name="Line 300"/>
            <p:cNvSpPr>
              <a:spLocks noChangeShapeType="1"/>
            </p:cNvSpPr>
            <p:nvPr/>
          </p:nvSpPr>
          <p:spPr bwMode="auto">
            <a:xfrm flipH="1" flipV="1">
              <a:off x="1201738" y="3035300"/>
              <a:ext cx="57150" cy="6350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7" name="Rectangle 301"/>
            <p:cNvSpPr>
              <a:spLocks noChangeArrowheads="1"/>
            </p:cNvSpPr>
            <p:nvPr/>
          </p:nvSpPr>
          <p:spPr bwMode="auto">
            <a:xfrm>
              <a:off x="5041900" y="2946400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2.75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8" name="Rectangle 302"/>
            <p:cNvSpPr>
              <a:spLocks noChangeArrowheads="1"/>
            </p:cNvSpPr>
            <p:nvPr/>
          </p:nvSpPr>
          <p:spPr bwMode="auto">
            <a:xfrm>
              <a:off x="5027613" y="2998788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29.19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" name="Line 303"/>
            <p:cNvSpPr>
              <a:spLocks noChangeShapeType="1"/>
            </p:cNvSpPr>
            <p:nvPr/>
          </p:nvSpPr>
          <p:spPr bwMode="auto">
            <a:xfrm flipV="1">
              <a:off x="5026025" y="3043238"/>
              <a:ext cx="92075" cy="6350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0" name="Rectangle 304"/>
            <p:cNvSpPr>
              <a:spLocks noChangeArrowheads="1"/>
            </p:cNvSpPr>
            <p:nvPr/>
          </p:nvSpPr>
          <p:spPr bwMode="auto">
            <a:xfrm>
              <a:off x="1527175" y="2957513"/>
              <a:ext cx="152400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9.75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" name="Rectangle 305"/>
            <p:cNvSpPr>
              <a:spLocks noChangeArrowheads="1"/>
            </p:cNvSpPr>
            <p:nvPr/>
          </p:nvSpPr>
          <p:spPr bwMode="auto">
            <a:xfrm>
              <a:off x="1512888" y="3009900"/>
              <a:ext cx="180975" cy="71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4.72</a:t>
              </a:r>
              <a:endParaRPr kumimoji="0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" name="Line 306"/>
            <p:cNvSpPr>
              <a:spLocks noChangeShapeType="1"/>
            </p:cNvSpPr>
            <p:nvPr/>
          </p:nvSpPr>
          <p:spPr bwMode="auto">
            <a:xfrm flipV="1">
              <a:off x="1535113" y="3055938"/>
              <a:ext cx="68262" cy="4762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</p:grpSp>
      <p:sp>
        <p:nvSpPr>
          <p:cNvPr id="362" name="아래쪽 화살표 361"/>
          <p:cNvSpPr/>
          <p:nvPr/>
        </p:nvSpPr>
        <p:spPr>
          <a:xfrm>
            <a:off x="8641007" y="2801324"/>
            <a:ext cx="470316" cy="853944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63" name="TextBox 362"/>
          <p:cNvSpPr txBox="1"/>
          <p:nvPr/>
        </p:nvSpPr>
        <p:spPr>
          <a:xfrm>
            <a:off x="9096646" y="2965056"/>
            <a:ext cx="24218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DB Search (abalone)</a:t>
            </a:r>
            <a:endParaRPr lang="ko-KR" altLang="en-US" b="1" dirty="0"/>
          </a:p>
        </p:txBody>
      </p:sp>
      <p:cxnSp>
        <p:nvCxnSpPr>
          <p:cNvPr id="379" name="직선 화살표 연결선 378"/>
          <p:cNvCxnSpPr/>
          <p:nvPr/>
        </p:nvCxnSpPr>
        <p:spPr>
          <a:xfrm flipH="1">
            <a:off x="2483500" y="951359"/>
            <a:ext cx="3660401" cy="127775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1" name="직선 연결선 380"/>
          <p:cNvCxnSpPr/>
          <p:nvPr/>
        </p:nvCxnSpPr>
        <p:spPr>
          <a:xfrm flipV="1">
            <a:off x="6119203" y="409414"/>
            <a:ext cx="525527" cy="561603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3" name="직선 연결선 382"/>
          <p:cNvCxnSpPr/>
          <p:nvPr/>
        </p:nvCxnSpPr>
        <p:spPr>
          <a:xfrm>
            <a:off x="6143901" y="951359"/>
            <a:ext cx="592829" cy="155635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6" name="직선 화살표 연결선 385"/>
          <p:cNvCxnSpPr/>
          <p:nvPr/>
        </p:nvCxnSpPr>
        <p:spPr>
          <a:xfrm flipH="1" flipV="1">
            <a:off x="2450347" y="2240065"/>
            <a:ext cx="131295" cy="108076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949010" y="498125"/>
            <a:ext cx="24090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Chromatogram (BG)</a:t>
            </a:r>
            <a:endParaRPr lang="ko-KR" altLang="en-US" b="1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4353" y="3416612"/>
            <a:ext cx="6010727" cy="2817763"/>
          </a:xfrm>
          <a:prstGeom prst="rect">
            <a:avLst/>
          </a:prstGeom>
          <a:ln>
            <a:noFill/>
          </a:ln>
        </p:spPr>
      </p:pic>
      <p:sp>
        <p:nvSpPr>
          <p:cNvPr id="2" name="TextBox 1"/>
          <p:cNvSpPr txBox="1"/>
          <p:nvPr/>
        </p:nvSpPr>
        <p:spPr>
          <a:xfrm>
            <a:off x="115408" y="53262"/>
            <a:ext cx="2732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Supplementary Fig. S1.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41391304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313113" y="171857"/>
            <a:ext cx="11565774" cy="55707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 smtClean="0"/>
              <a:t>Identification : </a:t>
            </a:r>
            <a:r>
              <a:rPr lang="ko-KR" altLang="en-US" dirty="0" err="1" smtClean="0"/>
              <a:t>Raw</a:t>
            </a:r>
            <a:r>
              <a:rPr lang="ko-KR" altLang="en-US" dirty="0" smtClean="0"/>
              <a:t> </a:t>
            </a:r>
            <a:r>
              <a:rPr lang="ko-KR" altLang="en-US" dirty="0" err="1"/>
              <a:t>data</a:t>
            </a:r>
            <a:r>
              <a:rPr lang="ko-KR" altLang="en-US" dirty="0"/>
              <a:t> </a:t>
            </a:r>
            <a:r>
              <a:rPr lang="ko-KR" altLang="en-US" dirty="0" err="1"/>
              <a:t>were</a:t>
            </a:r>
            <a:r>
              <a:rPr lang="ko-KR" altLang="en-US" dirty="0"/>
              <a:t> </a:t>
            </a:r>
            <a:r>
              <a:rPr lang="ko-KR" altLang="en-US" dirty="0" err="1"/>
              <a:t>processed</a:t>
            </a:r>
            <a:r>
              <a:rPr lang="ko-KR" altLang="en-US" dirty="0"/>
              <a:t> </a:t>
            </a:r>
            <a:r>
              <a:rPr lang="ko-KR" altLang="en-US" dirty="0" err="1"/>
              <a:t>with</a:t>
            </a:r>
            <a:r>
              <a:rPr lang="ko-KR" altLang="en-US" dirty="0"/>
              <a:t> </a:t>
            </a:r>
            <a:r>
              <a:rPr lang="ko-KR" altLang="en-US" dirty="0" err="1" smtClean="0"/>
              <a:t>MaxQuant</a:t>
            </a:r>
            <a:r>
              <a:rPr lang="en-US" altLang="ko-KR" b="1" baseline="30000" dirty="0" smtClean="0"/>
              <a:t>1,2</a:t>
            </a:r>
            <a:r>
              <a:rPr lang="ko-KR" altLang="en-US" dirty="0" smtClean="0"/>
              <a:t> and </a:t>
            </a:r>
            <a:r>
              <a:rPr lang="ko-KR" altLang="en-US" dirty="0" err="1"/>
              <a:t>its</a:t>
            </a:r>
            <a:r>
              <a:rPr lang="ko-KR" altLang="en-US" dirty="0"/>
              <a:t> </a:t>
            </a:r>
            <a:r>
              <a:rPr lang="ko-KR" altLang="en-US" dirty="0" err="1"/>
              <a:t>built-in</a:t>
            </a:r>
            <a:r>
              <a:rPr lang="ko-KR" altLang="en-US" dirty="0"/>
              <a:t> </a:t>
            </a:r>
            <a:r>
              <a:rPr lang="ko-KR" altLang="en-US" dirty="0" err="1" smtClean="0"/>
              <a:t>Andromeda</a:t>
            </a:r>
            <a:r>
              <a:rPr lang="en-US" altLang="ko-KR" b="1" baseline="30000" dirty="0" smtClean="0"/>
              <a:t>3</a:t>
            </a:r>
            <a:r>
              <a:rPr lang="ko-KR" altLang="en-US" dirty="0" smtClean="0"/>
              <a:t> </a:t>
            </a:r>
            <a:r>
              <a:rPr lang="ko-KR" altLang="en-US" dirty="0" err="1"/>
              <a:t>search</a:t>
            </a:r>
            <a:r>
              <a:rPr lang="ko-KR" altLang="en-US" dirty="0"/>
              <a:t> </a:t>
            </a:r>
            <a:r>
              <a:rPr lang="ko-KR" altLang="en-US" dirty="0" err="1" smtClean="0"/>
              <a:t>engine</a:t>
            </a:r>
            <a:r>
              <a:rPr lang="ko-KR" altLang="en-US" dirty="0" smtClean="0"/>
              <a:t> </a:t>
            </a:r>
            <a:r>
              <a:rPr lang="ko-KR" altLang="en-US" dirty="0" err="1"/>
              <a:t>for</a:t>
            </a:r>
            <a:r>
              <a:rPr lang="ko-KR" altLang="en-US" dirty="0"/>
              <a:t> </a:t>
            </a:r>
            <a:r>
              <a:rPr lang="ko-KR" altLang="en-US" dirty="0" err="1"/>
              <a:t>feature</a:t>
            </a:r>
            <a:r>
              <a:rPr lang="ko-KR" altLang="en-US" dirty="0"/>
              <a:t> </a:t>
            </a:r>
            <a:r>
              <a:rPr lang="ko-KR" altLang="en-US" dirty="0" err="1"/>
              <a:t>extraction</a:t>
            </a:r>
            <a:r>
              <a:rPr lang="ko-KR" altLang="en-US" dirty="0"/>
              <a:t>, </a:t>
            </a:r>
            <a:r>
              <a:rPr lang="ko-KR" altLang="en-US" dirty="0" err="1"/>
              <a:t>peptide</a:t>
            </a:r>
            <a:r>
              <a:rPr lang="ko-KR" altLang="en-US" dirty="0"/>
              <a:t> </a:t>
            </a:r>
            <a:r>
              <a:rPr lang="ko-KR" altLang="en-US" dirty="0" err="1" smtClean="0"/>
              <a:t>identification</a:t>
            </a:r>
            <a:r>
              <a:rPr lang="en-US" altLang="ko-KR" dirty="0" smtClean="0"/>
              <a:t>.</a:t>
            </a:r>
            <a:r>
              <a:rPr lang="ko-KR" altLang="en-US" dirty="0" smtClean="0"/>
              <a:t> </a:t>
            </a:r>
            <a:r>
              <a:rPr lang="ko-KR" altLang="en-US" dirty="0" err="1" smtClean="0"/>
              <a:t>Peptide</a:t>
            </a:r>
            <a:r>
              <a:rPr lang="ko-KR" altLang="en-US" dirty="0" smtClean="0"/>
              <a:t> </a:t>
            </a:r>
            <a:r>
              <a:rPr lang="ko-KR" altLang="en-US" dirty="0" err="1" smtClean="0"/>
              <a:t>false</a:t>
            </a:r>
            <a:r>
              <a:rPr lang="ko-KR" altLang="en-US" dirty="0" smtClean="0"/>
              <a:t> </a:t>
            </a:r>
            <a:r>
              <a:rPr lang="ko-KR" altLang="en-US" dirty="0" err="1"/>
              <a:t>discovery</a:t>
            </a:r>
            <a:r>
              <a:rPr lang="ko-KR" altLang="en-US" dirty="0"/>
              <a:t> </a:t>
            </a:r>
            <a:r>
              <a:rPr lang="ko-KR" altLang="en-US" dirty="0" err="1"/>
              <a:t>rates</a:t>
            </a:r>
            <a:r>
              <a:rPr lang="ko-KR" altLang="en-US" dirty="0"/>
              <a:t> (FDR) </a:t>
            </a:r>
            <a:r>
              <a:rPr lang="ko-KR" altLang="en-US" dirty="0" err="1"/>
              <a:t>were</a:t>
            </a:r>
            <a:r>
              <a:rPr lang="ko-KR" altLang="en-US" dirty="0"/>
              <a:t> </a:t>
            </a:r>
            <a:r>
              <a:rPr lang="ko-KR" altLang="en-US" dirty="0" err="1" smtClean="0"/>
              <a:t>set</a:t>
            </a:r>
            <a:r>
              <a:rPr lang="ko-KR" altLang="en-US" dirty="0" smtClean="0"/>
              <a:t> </a:t>
            </a:r>
            <a:r>
              <a:rPr lang="ko-KR" altLang="en-US" dirty="0" err="1"/>
              <a:t>to</a:t>
            </a:r>
            <a:r>
              <a:rPr lang="ko-KR" altLang="en-US" dirty="0"/>
              <a:t> 1</a:t>
            </a:r>
            <a:r>
              <a:rPr lang="ko-KR" altLang="en-US" dirty="0" smtClean="0"/>
              <a:t>%. </a:t>
            </a:r>
            <a:endParaRPr lang="en-US" altLang="ko-KR" dirty="0" smtClean="0"/>
          </a:p>
          <a:p>
            <a:endParaRPr lang="en-US" altLang="ko-KR" dirty="0" smtClean="0"/>
          </a:p>
          <a:p>
            <a:r>
              <a:rPr lang="en-US" altLang="ko-KR" dirty="0" smtClean="0"/>
              <a:t>Quantification : Quantification method based on the label free quantification</a:t>
            </a:r>
            <a:r>
              <a:rPr lang="en-US" altLang="ko-KR" i="1" dirty="0"/>
              <a:t>.</a:t>
            </a:r>
            <a:r>
              <a:rPr lang="en-US" altLang="ko-KR" i="1" dirty="0" smtClean="0"/>
              <a:t> </a:t>
            </a:r>
            <a:r>
              <a:rPr lang="en-US" altLang="ko-KR" dirty="0" smtClean="0"/>
              <a:t>This </a:t>
            </a:r>
            <a:r>
              <a:rPr lang="en-US" altLang="ko-KR" dirty="0"/>
              <a:t>is the relative </a:t>
            </a:r>
            <a:r>
              <a:rPr lang="en-US" altLang="ko-KR" dirty="0" smtClean="0"/>
              <a:t>protein(peptide) </a:t>
            </a:r>
            <a:r>
              <a:rPr lang="en-US" altLang="ko-KR" dirty="0"/>
              <a:t>quantification across all samples, and is represented by a normalized intensity profile that is generated according to the algorithms described </a:t>
            </a:r>
            <a:r>
              <a:rPr lang="en-US" altLang="ko-KR" dirty="0" smtClean="0"/>
              <a:t>in </a:t>
            </a:r>
            <a:r>
              <a:rPr lang="en-US" altLang="ko-KR" dirty="0"/>
              <a:t>Cox J and Mann </a:t>
            </a:r>
            <a:r>
              <a:rPr lang="en-US" altLang="ko-KR" dirty="0" smtClean="0"/>
              <a:t>M papers</a:t>
            </a:r>
            <a:r>
              <a:rPr lang="en-US" altLang="ko-KR" b="1" baseline="30000" dirty="0" smtClean="0"/>
              <a:t>1,2</a:t>
            </a:r>
            <a:r>
              <a:rPr lang="en-US" altLang="ko-KR" dirty="0" smtClean="0"/>
              <a:t>.  </a:t>
            </a:r>
          </a:p>
          <a:p>
            <a:endParaRPr lang="en-US" altLang="ko-KR" b="1" dirty="0"/>
          </a:p>
          <a:p>
            <a:endParaRPr lang="en-US" altLang="ko-KR" b="1" dirty="0"/>
          </a:p>
          <a:p>
            <a:endParaRPr lang="en-US" altLang="ko-KR" sz="1400" dirty="0" smtClean="0"/>
          </a:p>
          <a:p>
            <a:r>
              <a:rPr lang="en-US" altLang="ko-KR" sz="1400" b="1" dirty="0"/>
              <a:t>1</a:t>
            </a:r>
            <a:r>
              <a:rPr lang="en-US" altLang="ko-KR" sz="1400" b="1" dirty="0" smtClean="0"/>
              <a:t>. </a:t>
            </a:r>
            <a:r>
              <a:rPr lang="en-US" altLang="ko-KR" sz="1400" b="1" dirty="0"/>
              <a:t>Cox J and Mann M (2008) </a:t>
            </a:r>
            <a:r>
              <a:rPr lang="en-US" altLang="ko-KR" sz="1400" b="1" dirty="0" err="1"/>
              <a:t>MaxQuant</a:t>
            </a:r>
            <a:r>
              <a:rPr lang="en-US" altLang="ko-KR" sz="1400" b="1" dirty="0"/>
              <a:t> enables high peptide identification rates, individualized </a:t>
            </a:r>
            <a:r>
              <a:rPr lang="en-US" altLang="ko-KR" sz="1400" b="1" dirty="0" err="1"/>
              <a:t>p.p.b</a:t>
            </a:r>
            <a:r>
              <a:rPr lang="en-US" altLang="ko-KR" sz="1400" b="1" dirty="0"/>
              <a:t>.-range mass accuracies and proteome-wide protein quantification. Nat </a:t>
            </a:r>
            <a:r>
              <a:rPr lang="en-US" altLang="ko-KR" sz="1400" b="1" dirty="0" err="1"/>
              <a:t>Biotechnol</a:t>
            </a:r>
            <a:r>
              <a:rPr lang="en-US" altLang="ko-KR" sz="1400" b="1" dirty="0"/>
              <a:t> 26:1367-72. </a:t>
            </a:r>
            <a:r>
              <a:rPr lang="en-US" altLang="ko-KR" sz="1400" b="1" dirty="0" err="1"/>
              <a:t>doi</a:t>
            </a:r>
            <a:r>
              <a:rPr lang="en-US" altLang="ko-KR" sz="1400" b="1" dirty="0"/>
              <a:t>: </a:t>
            </a:r>
            <a:r>
              <a:rPr lang="en-US" altLang="ko-KR" sz="1400" b="1" dirty="0" smtClean="0"/>
              <a:t>10.1038/nbt.1511</a:t>
            </a:r>
          </a:p>
          <a:p>
            <a:endParaRPr lang="en-US" altLang="ko-KR" sz="1400" b="1" dirty="0"/>
          </a:p>
          <a:p>
            <a:r>
              <a:rPr lang="en-US" altLang="ko-KR" sz="1400" b="1" dirty="0"/>
              <a:t>2</a:t>
            </a:r>
            <a:r>
              <a:rPr lang="en-US" altLang="ko-KR" sz="1400" b="1" dirty="0" smtClean="0"/>
              <a:t>. </a:t>
            </a:r>
            <a:r>
              <a:rPr lang="en-US" altLang="ko-KR" sz="1400" b="1" dirty="0"/>
              <a:t>Cox J and Mann M </a:t>
            </a:r>
            <a:r>
              <a:rPr lang="en-US" altLang="ko-KR" sz="1400" b="1" dirty="0" smtClean="0"/>
              <a:t>(2014) </a:t>
            </a:r>
            <a:r>
              <a:rPr lang="en-US" altLang="ko-KR" sz="1400" b="1" dirty="0"/>
              <a:t>Accurate Proteome-wide Label-free Quantification by Delayed Normalization and Maximal Peptide Ratio Extraction, Termed </a:t>
            </a:r>
            <a:r>
              <a:rPr lang="en-US" altLang="ko-KR" sz="1400" b="1" dirty="0" err="1" smtClean="0"/>
              <a:t>MaxLFQ</a:t>
            </a:r>
            <a:r>
              <a:rPr lang="en-US" altLang="ko-KR" sz="1400" b="1" dirty="0"/>
              <a:t>. </a:t>
            </a:r>
            <a:r>
              <a:rPr lang="en-US" altLang="ko-KR" sz="1400" b="1" dirty="0" err="1"/>
              <a:t>Mol</a:t>
            </a:r>
            <a:r>
              <a:rPr lang="en-US" altLang="ko-KR" sz="1400" b="1" dirty="0"/>
              <a:t> Cell Proteomics. 2014 Sep; 13(9): 2513–2526</a:t>
            </a:r>
            <a:r>
              <a:rPr lang="en-US" altLang="ko-KR" sz="1400" b="1" dirty="0" smtClean="0"/>
              <a:t>.</a:t>
            </a:r>
          </a:p>
          <a:p>
            <a:endParaRPr lang="en-US" altLang="ko-KR" sz="1400" b="1" dirty="0"/>
          </a:p>
          <a:p>
            <a:r>
              <a:rPr lang="en-US" altLang="ko-KR" sz="1400" b="1" dirty="0"/>
              <a:t>3. Cox J, </a:t>
            </a:r>
            <a:r>
              <a:rPr lang="en-US" altLang="ko-KR" sz="1400" b="1" dirty="0" err="1"/>
              <a:t>Neuhauser</a:t>
            </a:r>
            <a:r>
              <a:rPr lang="en-US" altLang="ko-KR" sz="1400" b="1" dirty="0"/>
              <a:t> N, Michalski A, </a:t>
            </a:r>
            <a:r>
              <a:rPr lang="en-US" altLang="ko-KR" sz="1400" b="1" dirty="0" err="1"/>
              <a:t>Scheltema</a:t>
            </a:r>
            <a:r>
              <a:rPr lang="en-US" altLang="ko-KR" sz="1400" b="1" dirty="0"/>
              <a:t> RA, Olsen JV and Mann M (2011) Andromeda: a peptide search engine integrated into the </a:t>
            </a:r>
            <a:r>
              <a:rPr lang="en-US" altLang="ko-KR" sz="1400" b="1" dirty="0" err="1"/>
              <a:t>MaxQuant</a:t>
            </a:r>
            <a:r>
              <a:rPr lang="en-US" altLang="ko-KR" sz="1400" b="1" dirty="0"/>
              <a:t> environment. J Proteome Res 10:1794-805. </a:t>
            </a:r>
            <a:r>
              <a:rPr lang="en-US" altLang="ko-KR" sz="1400" b="1" dirty="0" err="1"/>
              <a:t>doi</a:t>
            </a:r>
            <a:r>
              <a:rPr lang="en-US" altLang="ko-KR" sz="1400" b="1" dirty="0"/>
              <a:t>: 10.1021/pr101065j </a:t>
            </a:r>
          </a:p>
          <a:p>
            <a:endParaRPr lang="en-US" altLang="ko-KR" sz="1400" b="1" dirty="0"/>
          </a:p>
          <a:p>
            <a:endParaRPr lang="en-US" altLang="ko-KR" b="1" dirty="0"/>
          </a:p>
          <a:p>
            <a:endParaRPr lang="en-US" altLang="ko-KR" dirty="0"/>
          </a:p>
          <a:p>
            <a:endParaRPr lang="en-US" altLang="ko-KR" dirty="0" smtClean="0"/>
          </a:p>
          <a:p>
            <a:endParaRPr lang="en-US" altLang="ko-KR" dirty="0"/>
          </a:p>
        </p:txBody>
      </p:sp>
    </p:spTree>
    <p:extLst>
      <p:ext uri="{BB962C8B-B14F-4D97-AF65-F5344CB8AC3E}">
        <p14:creationId xmlns:p14="http://schemas.microsoft.com/office/powerpoint/2010/main" val="6468443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7</TotalTime>
  <Words>324</Words>
  <Application>Microsoft Office PowerPoint</Application>
  <PresentationFormat>와이드스크린</PresentationFormat>
  <Paragraphs>118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5" baseType="lpstr">
      <vt:lpstr>맑은 고딕</vt:lpstr>
      <vt:lpstr>Arial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 종문</dc:creator>
  <cp:lastModifiedBy>user</cp:lastModifiedBy>
  <cp:revision>23</cp:revision>
  <dcterms:created xsi:type="dcterms:W3CDTF">2019-02-25T04:24:15Z</dcterms:created>
  <dcterms:modified xsi:type="dcterms:W3CDTF">2019-03-11T01:04:48Z</dcterms:modified>
</cp:coreProperties>
</file>